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56" r:id="rId2"/>
    <p:sldId id="257" r:id="rId3"/>
    <p:sldId id="258" r:id="rId4"/>
    <p:sldId id="259" r:id="rId5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085" autoAdjust="0"/>
    <p:restoredTop sz="93891" autoAdjust="0"/>
  </p:normalViewPr>
  <p:slideViewPr>
    <p:cSldViewPr snapToGrid="0">
      <p:cViewPr varScale="1">
        <p:scale>
          <a:sx n="67" d="100"/>
          <a:sy n="67" d="100"/>
        </p:scale>
        <p:origin x="868" y="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11" Type="http://schemas.microsoft.com/office/2016/11/relationships/changesInfo" Target="changesInfos/changesInfo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li li" userId="3d7a94fd48c86d40" providerId="LiveId" clId="{2345AA29-D5AE-4783-9A1B-7E86E6AD882B}"/>
    <pc:docChg chg="undo redo custSel addSld modSld">
      <pc:chgData name="li li" userId="3d7a94fd48c86d40" providerId="LiveId" clId="{2345AA29-D5AE-4783-9A1B-7E86E6AD882B}" dt="2018-05-21T05:07:40.562" v="2471" actId="20577"/>
      <pc:docMkLst>
        <pc:docMk/>
      </pc:docMkLst>
      <pc:sldChg chg="addSp delSp modSp">
        <pc:chgData name="li li" userId="3d7a94fd48c86d40" providerId="LiveId" clId="{2345AA29-D5AE-4783-9A1B-7E86E6AD882B}" dt="2018-05-21T05:05:36.074" v="2464" actId="14100"/>
        <pc:sldMkLst>
          <pc:docMk/>
          <pc:sldMk cId="2613171354" sldId="256"/>
        </pc:sldMkLst>
        <pc:spChg chg="mod topLvl">
          <ac:chgData name="li li" userId="3d7a94fd48c86d40" providerId="LiveId" clId="{2345AA29-D5AE-4783-9A1B-7E86E6AD882B}" dt="2018-05-08T17:40:49.541" v="1130" actId="165"/>
          <ac:spMkLst>
            <pc:docMk/>
            <pc:sldMk cId="2613171354" sldId="256"/>
            <ac:spMk id="58" creationId="{71FCC91F-3ED8-439D-A808-735D6AB09F27}"/>
          </ac:spMkLst>
        </pc:spChg>
        <pc:spChg chg="mod topLvl">
          <ac:chgData name="li li" userId="3d7a94fd48c86d40" providerId="LiveId" clId="{2345AA29-D5AE-4783-9A1B-7E86E6AD882B}" dt="2018-05-08T17:40:49.541" v="1130" actId="165"/>
          <ac:spMkLst>
            <pc:docMk/>
            <pc:sldMk cId="2613171354" sldId="256"/>
            <ac:spMk id="66" creationId="{ED468AB6-F891-4F97-B5E0-EB340DF76014}"/>
          </ac:spMkLst>
        </pc:spChg>
        <pc:spChg chg="mod topLvl">
          <ac:chgData name="li li" userId="3d7a94fd48c86d40" providerId="LiveId" clId="{2345AA29-D5AE-4783-9A1B-7E86E6AD882B}" dt="2018-05-08T17:40:49.541" v="1130" actId="165"/>
          <ac:spMkLst>
            <pc:docMk/>
            <pc:sldMk cId="2613171354" sldId="256"/>
            <ac:spMk id="67" creationId="{036F5477-69B7-41E3-A38B-D3B0AFE45118}"/>
          </ac:spMkLst>
        </pc:spChg>
        <pc:spChg chg="mod topLvl">
          <ac:chgData name="li li" userId="3d7a94fd48c86d40" providerId="LiveId" clId="{2345AA29-D5AE-4783-9A1B-7E86E6AD882B}" dt="2018-05-08T17:43:10.441" v="1139" actId="164"/>
          <ac:spMkLst>
            <pc:docMk/>
            <pc:sldMk cId="2613171354" sldId="256"/>
            <ac:spMk id="68" creationId="{9240592A-3492-4F66-9A73-C3AE65EC6B07}"/>
          </ac:spMkLst>
        </pc:spChg>
        <pc:spChg chg="mod topLvl">
          <ac:chgData name="li li" userId="3d7a94fd48c86d40" providerId="LiveId" clId="{2345AA29-D5AE-4783-9A1B-7E86E6AD882B}" dt="2018-05-08T17:40:49.541" v="1130" actId="165"/>
          <ac:spMkLst>
            <pc:docMk/>
            <pc:sldMk cId="2613171354" sldId="256"/>
            <ac:spMk id="69" creationId="{365B7DC8-D43E-4302-9855-4A884537F91F}"/>
          </ac:spMkLst>
        </pc:spChg>
        <pc:spChg chg="mod topLvl">
          <ac:chgData name="li li" userId="3d7a94fd48c86d40" providerId="LiveId" clId="{2345AA29-D5AE-4783-9A1B-7E86E6AD882B}" dt="2018-05-08T17:41:05.065" v="1131" actId="165"/>
          <ac:spMkLst>
            <pc:docMk/>
            <pc:sldMk cId="2613171354" sldId="256"/>
            <ac:spMk id="70" creationId="{3FD1F979-3C15-476F-A658-A7F235713658}"/>
          </ac:spMkLst>
        </pc:spChg>
        <pc:spChg chg="mod topLvl">
          <ac:chgData name="li li" userId="3d7a94fd48c86d40" providerId="LiveId" clId="{2345AA29-D5AE-4783-9A1B-7E86E6AD882B}" dt="2018-05-08T17:41:05.065" v="1131" actId="165"/>
          <ac:spMkLst>
            <pc:docMk/>
            <pc:sldMk cId="2613171354" sldId="256"/>
            <ac:spMk id="71" creationId="{D2D7A332-77C2-4CE7-81BE-C68A0E8C7B5D}"/>
          </ac:spMkLst>
        </pc:spChg>
        <pc:spChg chg="mod topLvl">
          <ac:chgData name="li li" userId="3d7a94fd48c86d40" providerId="LiveId" clId="{2345AA29-D5AE-4783-9A1B-7E86E6AD882B}" dt="2018-05-08T17:41:05.065" v="1131" actId="165"/>
          <ac:spMkLst>
            <pc:docMk/>
            <pc:sldMk cId="2613171354" sldId="256"/>
            <ac:spMk id="72" creationId="{7E559086-4121-4485-B7BA-26056684237C}"/>
          </ac:spMkLst>
        </pc:spChg>
        <pc:spChg chg="mod topLvl">
          <ac:chgData name="li li" userId="3d7a94fd48c86d40" providerId="LiveId" clId="{2345AA29-D5AE-4783-9A1B-7E86E6AD882B}" dt="2018-05-08T17:43:51.480" v="1142" actId="164"/>
          <ac:spMkLst>
            <pc:docMk/>
            <pc:sldMk cId="2613171354" sldId="256"/>
            <ac:spMk id="73" creationId="{CD8F9CF8-BFB7-42DA-82D7-F8B281DDF588}"/>
          </ac:spMkLst>
        </pc:spChg>
        <pc:spChg chg="mod topLvl">
          <ac:chgData name="li li" userId="3d7a94fd48c86d40" providerId="LiveId" clId="{2345AA29-D5AE-4783-9A1B-7E86E6AD882B}" dt="2018-05-21T05:05:36.074" v="2464" actId="14100"/>
          <ac:spMkLst>
            <pc:docMk/>
            <pc:sldMk cId="2613171354" sldId="256"/>
            <ac:spMk id="104" creationId="{BA7184DB-B692-48F3-8E90-81A9C2F8C0D2}"/>
          </ac:spMkLst>
        </pc:spChg>
        <pc:grpChg chg="del mod topLvl">
          <ac:chgData name="li li" userId="3d7a94fd48c86d40" providerId="LiveId" clId="{2345AA29-D5AE-4783-9A1B-7E86E6AD882B}" dt="2018-05-08T17:41:05.065" v="1131" actId="165"/>
          <ac:grpSpMkLst>
            <pc:docMk/>
            <pc:sldMk cId="2613171354" sldId="256"/>
            <ac:grpSpMk id="2" creationId="{36EF4452-9E25-418A-A062-CAB97B5F72E4}"/>
          </ac:grpSpMkLst>
        </pc:grpChg>
        <pc:grpChg chg="del mod topLvl">
          <ac:chgData name="li li" userId="3d7a94fd48c86d40" providerId="LiveId" clId="{2345AA29-D5AE-4783-9A1B-7E86E6AD882B}" dt="2018-05-08T17:41:05.065" v="1131" actId="165"/>
          <ac:grpSpMkLst>
            <pc:docMk/>
            <pc:sldMk cId="2613171354" sldId="256"/>
            <ac:grpSpMk id="3" creationId="{91A00B7F-DDC3-4B86-9117-0978B460EF0C}"/>
          </ac:grpSpMkLst>
        </pc:grpChg>
        <pc:grpChg chg="del mod topLvl">
          <ac:chgData name="li li" userId="3d7a94fd48c86d40" providerId="LiveId" clId="{2345AA29-D5AE-4783-9A1B-7E86E6AD882B}" dt="2018-05-08T17:41:05.065" v="1131" actId="165"/>
          <ac:grpSpMkLst>
            <pc:docMk/>
            <pc:sldMk cId="2613171354" sldId="256"/>
            <ac:grpSpMk id="4" creationId="{23A0EADA-A09E-4B86-A43F-5FF89527E450}"/>
          </ac:grpSpMkLst>
        </pc:grpChg>
        <pc:grpChg chg="del mod topLvl">
          <ac:chgData name="li li" userId="3d7a94fd48c86d40" providerId="LiveId" clId="{2345AA29-D5AE-4783-9A1B-7E86E6AD882B}" dt="2018-05-08T17:41:05.065" v="1131" actId="165"/>
          <ac:grpSpMkLst>
            <pc:docMk/>
            <pc:sldMk cId="2613171354" sldId="256"/>
            <ac:grpSpMk id="6" creationId="{093A0CA7-D3B9-417D-B050-6A3921416C97}"/>
          </ac:grpSpMkLst>
        </pc:grpChg>
        <pc:grpChg chg="del mod">
          <ac:chgData name="li li" userId="3d7a94fd48c86d40" providerId="LiveId" clId="{2345AA29-D5AE-4783-9A1B-7E86E6AD882B}" dt="2018-05-08T17:40:49.541" v="1130" actId="165"/>
          <ac:grpSpMkLst>
            <pc:docMk/>
            <pc:sldMk cId="2613171354" sldId="256"/>
            <ac:grpSpMk id="18" creationId="{D123B9B7-D44A-400A-A74B-4695F14E5DA3}"/>
          </ac:grpSpMkLst>
        </pc:grpChg>
        <pc:grpChg chg="add mod">
          <ac:chgData name="li li" userId="3d7a94fd48c86d40" providerId="LiveId" clId="{2345AA29-D5AE-4783-9A1B-7E86E6AD882B}" dt="2018-05-08T17:41:21.800" v="1132" actId="164"/>
          <ac:grpSpMkLst>
            <pc:docMk/>
            <pc:sldMk cId="2613171354" sldId="256"/>
            <ac:grpSpMk id="78" creationId="{CBAE31F3-0B59-4601-9536-D9F7FEA714B1}"/>
          </ac:grpSpMkLst>
        </pc:grpChg>
        <pc:grpChg chg="add mod">
          <ac:chgData name="li li" userId="3d7a94fd48c86d40" providerId="LiveId" clId="{2345AA29-D5AE-4783-9A1B-7E86E6AD882B}" dt="2018-05-08T17:42:28.279" v="1136" actId="164"/>
          <ac:grpSpMkLst>
            <pc:docMk/>
            <pc:sldMk cId="2613171354" sldId="256"/>
            <ac:grpSpMk id="79" creationId="{57F47AC7-F615-4D07-B528-32543B41E13F}"/>
          </ac:grpSpMkLst>
        </pc:grpChg>
        <pc:grpChg chg="add mod">
          <ac:chgData name="li li" userId="3d7a94fd48c86d40" providerId="LiveId" clId="{2345AA29-D5AE-4783-9A1B-7E86E6AD882B}" dt="2018-05-08T17:43:10.441" v="1139" actId="164"/>
          <ac:grpSpMkLst>
            <pc:docMk/>
            <pc:sldMk cId="2613171354" sldId="256"/>
            <ac:grpSpMk id="80" creationId="{BB805CEC-1018-4B12-A9B5-3DE55D630932}"/>
          </ac:grpSpMkLst>
        </pc:grpChg>
        <pc:grpChg chg="add mod">
          <ac:chgData name="li li" userId="3d7a94fd48c86d40" providerId="LiveId" clId="{2345AA29-D5AE-4783-9A1B-7E86E6AD882B}" dt="2018-05-08T17:51:22.684" v="1173" actId="164"/>
          <ac:grpSpMkLst>
            <pc:docMk/>
            <pc:sldMk cId="2613171354" sldId="256"/>
            <ac:grpSpMk id="81" creationId="{9268CC44-385D-49BF-801F-6120892F1D24}"/>
          </ac:grpSpMkLst>
        </pc:grpChg>
        <pc:grpChg chg="add mod">
          <ac:chgData name="li li" userId="3d7a94fd48c86d40" providerId="LiveId" clId="{2345AA29-D5AE-4783-9A1B-7E86E6AD882B}" dt="2018-05-08T17:51:22.684" v="1173" actId="164"/>
          <ac:grpSpMkLst>
            <pc:docMk/>
            <pc:sldMk cId="2613171354" sldId="256"/>
            <ac:grpSpMk id="82" creationId="{5E389521-083D-466E-9962-DA177B848DD1}"/>
          </ac:grpSpMkLst>
        </pc:grpChg>
        <pc:graphicFrameChg chg="add del">
          <ac:chgData name="li li" userId="3d7a94fd48c86d40" providerId="LiveId" clId="{2345AA29-D5AE-4783-9A1B-7E86E6AD882B}" dt="2018-05-08T15:57:08.676" v="99" actId="164"/>
          <ac:graphicFrameMkLst>
            <pc:docMk/>
            <pc:sldMk cId="2613171354" sldId="256"/>
            <ac:graphicFrameMk id="7" creationId="{40D4618E-FC6C-4224-993E-7DA913959FF9}"/>
          </ac:graphicFrameMkLst>
        </pc:graphicFrameChg>
        <pc:graphicFrameChg chg="add del">
          <ac:chgData name="li li" userId="3d7a94fd48c86d40" providerId="LiveId" clId="{2345AA29-D5AE-4783-9A1B-7E86E6AD882B}" dt="2018-05-08T16:19:23.158" v="109" actId="164"/>
          <ac:graphicFrameMkLst>
            <pc:docMk/>
            <pc:sldMk cId="2613171354" sldId="256"/>
            <ac:graphicFrameMk id="11" creationId="{92B8E44E-C742-4508-90FE-04B8EA6299D0}"/>
          </ac:graphicFrameMkLst>
        </pc:graphicFrameChg>
        <pc:graphicFrameChg chg="add del">
          <ac:chgData name="li li" userId="3d7a94fd48c86d40" providerId="LiveId" clId="{2345AA29-D5AE-4783-9A1B-7E86E6AD882B}" dt="2018-05-08T16:19:39.899" v="114" actId="164"/>
          <ac:graphicFrameMkLst>
            <pc:docMk/>
            <pc:sldMk cId="2613171354" sldId="256"/>
            <ac:graphicFrameMk id="19" creationId="{033B16A4-0643-4CCE-96C6-354EEDD81E92}"/>
          </ac:graphicFrameMkLst>
        </pc:graphicFrameChg>
        <pc:graphicFrameChg chg="add del">
          <ac:chgData name="li li" userId="3d7a94fd48c86d40" providerId="LiveId" clId="{2345AA29-D5AE-4783-9A1B-7E86E6AD882B}" dt="2018-05-08T16:19:42.789" v="116" actId="164"/>
          <ac:graphicFrameMkLst>
            <pc:docMk/>
            <pc:sldMk cId="2613171354" sldId="256"/>
            <ac:graphicFrameMk id="20" creationId="{8D8D6FF4-38DC-45D9-9954-844955BD5AD8}"/>
          </ac:graphicFrameMkLst>
        </pc:graphicFrameChg>
        <pc:graphicFrameChg chg="add del">
          <ac:chgData name="li li" userId="3d7a94fd48c86d40" providerId="LiveId" clId="{2345AA29-D5AE-4783-9A1B-7E86E6AD882B}" dt="2018-05-08T16:19:57.520" v="121" actId="164"/>
          <ac:graphicFrameMkLst>
            <pc:docMk/>
            <pc:sldMk cId="2613171354" sldId="256"/>
            <ac:graphicFrameMk id="22" creationId="{B6D161B1-3EF2-4FD6-806F-62F3502CC5F3}"/>
          </ac:graphicFrameMkLst>
        </pc:graphicFrameChg>
        <pc:graphicFrameChg chg="add del">
          <ac:chgData name="li li" userId="3d7a94fd48c86d40" providerId="LiveId" clId="{2345AA29-D5AE-4783-9A1B-7E86E6AD882B}" dt="2018-05-08T16:20:40.333" v="137" actId="164"/>
          <ac:graphicFrameMkLst>
            <pc:docMk/>
            <pc:sldMk cId="2613171354" sldId="256"/>
            <ac:graphicFrameMk id="24" creationId="{2B81C213-815A-4DEA-8E3C-3E93C62FC3D2}"/>
          </ac:graphicFrameMkLst>
        </pc:graphicFrameChg>
        <pc:graphicFrameChg chg="add del">
          <ac:chgData name="li li" userId="3d7a94fd48c86d40" providerId="LiveId" clId="{2345AA29-D5AE-4783-9A1B-7E86E6AD882B}" dt="2018-05-08T16:20:58.596" v="142" actId="164"/>
          <ac:graphicFrameMkLst>
            <pc:docMk/>
            <pc:sldMk cId="2613171354" sldId="256"/>
            <ac:graphicFrameMk id="26" creationId="{DEBC095A-818C-4DEC-8198-F6ACE556F5D1}"/>
          </ac:graphicFrameMkLst>
        </pc:graphicFrameChg>
        <pc:graphicFrameChg chg="add del">
          <ac:chgData name="li li" userId="3d7a94fd48c86d40" providerId="LiveId" clId="{2345AA29-D5AE-4783-9A1B-7E86E6AD882B}" dt="2018-05-08T16:21:18.961" v="151" actId="164"/>
          <ac:graphicFrameMkLst>
            <pc:docMk/>
            <pc:sldMk cId="2613171354" sldId="256"/>
            <ac:graphicFrameMk id="28" creationId="{D5FF9096-3391-43FC-B258-9EEE8EE42BC6}"/>
          </ac:graphicFrameMkLst>
        </pc:graphicFrameChg>
        <pc:graphicFrameChg chg="add del">
          <ac:chgData name="li li" userId="3d7a94fd48c86d40" providerId="LiveId" clId="{2345AA29-D5AE-4783-9A1B-7E86E6AD882B}" dt="2018-05-08T16:21:33.440" v="160" actId="164"/>
          <ac:graphicFrameMkLst>
            <pc:docMk/>
            <pc:sldMk cId="2613171354" sldId="256"/>
            <ac:graphicFrameMk id="30" creationId="{17601A12-06D5-41CF-8603-E755AD55DBAE}"/>
          </ac:graphicFrameMkLst>
        </pc:graphicFrameChg>
        <pc:graphicFrameChg chg="add del">
          <ac:chgData name="li li" userId="3d7a94fd48c86d40" providerId="LiveId" clId="{2345AA29-D5AE-4783-9A1B-7E86E6AD882B}" dt="2018-05-08T16:22:03.332" v="165" actId="164"/>
          <ac:graphicFrameMkLst>
            <pc:docMk/>
            <pc:sldMk cId="2613171354" sldId="256"/>
            <ac:graphicFrameMk id="32" creationId="{8A928AFF-9D17-4F97-8A32-35AF874B3677}"/>
          </ac:graphicFrameMkLst>
        </pc:graphicFrameChg>
        <pc:graphicFrameChg chg="add del">
          <ac:chgData name="li li" userId="3d7a94fd48c86d40" providerId="LiveId" clId="{2345AA29-D5AE-4783-9A1B-7E86E6AD882B}" dt="2018-05-08T16:22:22.474" v="174" actId="164"/>
          <ac:graphicFrameMkLst>
            <pc:docMk/>
            <pc:sldMk cId="2613171354" sldId="256"/>
            <ac:graphicFrameMk id="36" creationId="{EDDCF073-C416-4039-8DEE-2A98370C78E0}"/>
          </ac:graphicFrameMkLst>
        </pc:graphicFrameChg>
        <pc:graphicFrameChg chg="add del">
          <ac:chgData name="li li" userId="3d7a94fd48c86d40" providerId="LiveId" clId="{2345AA29-D5AE-4783-9A1B-7E86E6AD882B}" dt="2018-05-08T16:22:52.412" v="183" actId="164"/>
          <ac:graphicFrameMkLst>
            <pc:docMk/>
            <pc:sldMk cId="2613171354" sldId="256"/>
            <ac:graphicFrameMk id="40" creationId="{2E194AE4-D595-441D-8867-9E5B6FEDCB56}"/>
          </ac:graphicFrameMkLst>
        </pc:graphicFrameChg>
        <pc:graphicFrameChg chg="add del">
          <ac:chgData name="li li" userId="3d7a94fd48c86d40" providerId="LiveId" clId="{2345AA29-D5AE-4783-9A1B-7E86E6AD882B}" dt="2018-05-08T16:23:05.623" v="188" actId="164"/>
          <ac:graphicFrameMkLst>
            <pc:docMk/>
            <pc:sldMk cId="2613171354" sldId="256"/>
            <ac:graphicFrameMk id="44" creationId="{2CCF23E8-2413-4717-8583-5E04D6D2235C}"/>
          </ac:graphicFrameMkLst>
        </pc:graphicFrameChg>
        <pc:graphicFrameChg chg="add del">
          <ac:chgData name="li li" userId="3d7a94fd48c86d40" providerId="LiveId" clId="{2345AA29-D5AE-4783-9A1B-7E86E6AD882B}" dt="2018-05-08T16:23:19.423" v="195" actId="164"/>
          <ac:graphicFrameMkLst>
            <pc:docMk/>
            <pc:sldMk cId="2613171354" sldId="256"/>
            <ac:graphicFrameMk id="48" creationId="{771C33F0-D1EB-4D12-B2F8-84058D7BB478}"/>
          </ac:graphicFrameMkLst>
        </pc:graphicFrameChg>
        <pc:graphicFrameChg chg="add del">
          <ac:chgData name="li li" userId="3d7a94fd48c86d40" providerId="LiveId" clId="{2345AA29-D5AE-4783-9A1B-7E86E6AD882B}" dt="2018-05-08T16:23:39.437" v="204" actId="164"/>
          <ac:graphicFrameMkLst>
            <pc:docMk/>
            <pc:sldMk cId="2613171354" sldId="256"/>
            <ac:graphicFrameMk id="52" creationId="{FCBE47F8-74E3-4857-BC66-2D424E9115EA}"/>
          </ac:graphicFrameMkLst>
        </pc:graphicFrameChg>
        <pc:graphicFrameChg chg="add del">
          <ac:chgData name="li li" userId="3d7a94fd48c86d40" providerId="LiveId" clId="{2345AA29-D5AE-4783-9A1B-7E86E6AD882B}" dt="2018-05-08T16:23:58.742" v="211" actId="164"/>
          <ac:graphicFrameMkLst>
            <pc:docMk/>
            <pc:sldMk cId="2613171354" sldId="256"/>
            <ac:graphicFrameMk id="56" creationId="{BFF1DE59-2804-45D8-801C-426727B7F275}"/>
          </ac:graphicFrameMkLst>
        </pc:graphicFrameChg>
        <pc:graphicFrameChg chg="add del">
          <ac:chgData name="li li" userId="3d7a94fd48c86d40" providerId="LiveId" clId="{2345AA29-D5AE-4783-9A1B-7E86E6AD882B}" dt="2018-05-08T16:24:15.209" v="218" actId="164"/>
          <ac:graphicFrameMkLst>
            <pc:docMk/>
            <pc:sldMk cId="2613171354" sldId="256"/>
            <ac:graphicFrameMk id="59" creationId="{48BBC8D3-B04D-4C76-83CC-563852C8EB2D}"/>
          </ac:graphicFrameMkLst>
        </pc:graphicFrameChg>
        <pc:graphicFrameChg chg="add del">
          <ac:chgData name="li li" userId="3d7a94fd48c86d40" providerId="LiveId" clId="{2345AA29-D5AE-4783-9A1B-7E86E6AD882B}" dt="2018-05-08T16:24:28.732" v="223" actId="164"/>
          <ac:graphicFrameMkLst>
            <pc:docMk/>
            <pc:sldMk cId="2613171354" sldId="256"/>
            <ac:graphicFrameMk id="61" creationId="{8D77FAED-9739-4881-BB5C-FE9DB1293E99}"/>
          </ac:graphicFrameMkLst>
        </pc:graphicFrameChg>
        <pc:graphicFrameChg chg="add del">
          <ac:chgData name="li li" userId="3d7a94fd48c86d40" providerId="LiveId" clId="{2345AA29-D5AE-4783-9A1B-7E86E6AD882B}" dt="2018-05-08T16:24:32.818" v="225" actId="164"/>
          <ac:graphicFrameMkLst>
            <pc:docMk/>
            <pc:sldMk cId="2613171354" sldId="256"/>
            <ac:graphicFrameMk id="62" creationId="{0187EA80-0484-47BF-BB46-8128C2043808}"/>
          </ac:graphicFrameMkLst>
        </pc:graphicFrameChg>
        <pc:graphicFrameChg chg="add del">
          <ac:chgData name="li li" userId="3d7a94fd48c86d40" providerId="LiveId" clId="{2345AA29-D5AE-4783-9A1B-7E86E6AD882B}" dt="2018-05-08T16:24:47.894" v="232" actId="164"/>
          <ac:graphicFrameMkLst>
            <pc:docMk/>
            <pc:sldMk cId="2613171354" sldId="256"/>
            <ac:graphicFrameMk id="64" creationId="{2CFF7450-D4CA-4FB6-B5DE-4AFA60A7975D}"/>
          </ac:graphicFrameMkLst>
        </pc:graphicFrameChg>
        <pc:graphicFrameChg chg="add del">
          <ac:chgData name="li li" userId="3d7a94fd48c86d40" providerId="LiveId" clId="{2345AA29-D5AE-4783-9A1B-7E86E6AD882B}" dt="2018-05-08T16:25:04.279" v="237" actId="164"/>
          <ac:graphicFrameMkLst>
            <pc:docMk/>
            <pc:sldMk cId="2613171354" sldId="256"/>
            <ac:graphicFrameMk id="74" creationId="{14C23304-E14A-4365-9737-1EB47AA23F31}"/>
          </ac:graphicFrameMkLst>
        </pc:graphicFrameChg>
        <pc:graphicFrameChg chg="add del">
          <ac:chgData name="li li" userId="3d7a94fd48c86d40" providerId="LiveId" clId="{2345AA29-D5AE-4783-9A1B-7E86E6AD882B}" dt="2018-05-08T16:25:19.483" v="242" actId="164"/>
          <ac:graphicFrameMkLst>
            <pc:docMk/>
            <pc:sldMk cId="2613171354" sldId="256"/>
            <ac:graphicFrameMk id="76" creationId="{EEC4EA1F-4647-4B88-B050-A62D3F40B74D}"/>
          </ac:graphicFrameMkLst>
        </pc:graphicFrameChg>
        <pc:picChg chg="mod topLvl">
          <ac:chgData name="li li" userId="3d7a94fd48c86d40" providerId="LiveId" clId="{2345AA29-D5AE-4783-9A1B-7E86E6AD882B}" dt="2018-05-08T17:41:05.065" v="1131" actId="165"/>
          <ac:picMkLst>
            <pc:docMk/>
            <pc:sldMk cId="2613171354" sldId="256"/>
            <ac:picMk id="5" creationId="{53CD8DA8-F391-4C57-9432-1BD0553FE498}"/>
          </ac:picMkLst>
        </pc:picChg>
        <pc:picChg chg="mod topLvl">
          <ac:chgData name="li li" userId="3d7a94fd48c86d40" providerId="LiveId" clId="{2345AA29-D5AE-4783-9A1B-7E86E6AD882B}" dt="2018-05-08T17:40:49.541" v="1130" actId="165"/>
          <ac:picMkLst>
            <pc:docMk/>
            <pc:sldMk cId="2613171354" sldId="256"/>
            <ac:picMk id="8" creationId="{A5691991-B6F3-4DB1-9C87-2615ED90B771}"/>
          </ac:picMkLst>
        </pc:picChg>
        <pc:picChg chg="add mod">
          <ac:chgData name="li li" userId="3d7a94fd48c86d40" providerId="LiveId" clId="{2345AA29-D5AE-4783-9A1B-7E86E6AD882B}" dt="2018-05-08T16:28:33.535" v="269" actId="1076"/>
          <ac:picMkLst>
            <pc:docMk/>
            <pc:sldMk cId="2613171354" sldId="256"/>
            <ac:picMk id="9" creationId="{AF9E7B81-0E55-4C0E-9781-C628CC4D3B3E}"/>
          </ac:picMkLst>
        </pc:picChg>
        <pc:picChg chg="mod topLvl">
          <ac:chgData name="li li" userId="3d7a94fd48c86d40" providerId="LiveId" clId="{2345AA29-D5AE-4783-9A1B-7E86E6AD882B}" dt="2018-05-08T17:40:49.541" v="1130" actId="165"/>
          <ac:picMkLst>
            <pc:docMk/>
            <pc:sldMk cId="2613171354" sldId="256"/>
            <ac:picMk id="10" creationId="{692AF0C6-3FB7-4411-A6BA-7149D8FB4DD9}"/>
          </ac:picMkLst>
        </pc:picChg>
        <pc:picChg chg="mod topLvl">
          <ac:chgData name="li li" userId="3d7a94fd48c86d40" providerId="LiveId" clId="{2345AA29-D5AE-4783-9A1B-7E86E6AD882B}" dt="2018-05-08T17:41:21.800" v="1132" actId="164"/>
          <ac:picMkLst>
            <pc:docMk/>
            <pc:sldMk cId="2613171354" sldId="256"/>
            <ac:picMk id="12" creationId="{5E2FD90E-425B-485B-B1C1-52F8945008BD}"/>
          </ac:picMkLst>
        </pc:picChg>
        <pc:picChg chg="mod topLvl">
          <ac:chgData name="li li" userId="3d7a94fd48c86d40" providerId="LiveId" clId="{2345AA29-D5AE-4783-9A1B-7E86E6AD882B}" dt="2018-05-08T17:43:10.441" v="1139" actId="164"/>
          <ac:picMkLst>
            <pc:docMk/>
            <pc:sldMk cId="2613171354" sldId="256"/>
            <ac:picMk id="13" creationId="{9DD3D374-E7F7-4EFC-89D9-CA7AA5B4E339}"/>
          </ac:picMkLst>
        </pc:picChg>
        <pc:picChg chg="mod topLvl">
          <ac:chgData name="li li" userId="3d7a94fd48c86d40" providerId="LiveId" clId="{2345AA29-D5AE-4783-9A1B-7E86E6AD882B}" dt="2018-05-08T17:41:21.800" v="1132" actId="164"/>
          <ac:picMkLst>
            <pc:docMk/>
            <pc:sldMk cId="2613171354" sldId="256"/>
            <ac:picMk id="14" creationId="{BF73CBAA-41E5-4062-A88E-EA3B228FCD75}"/>
          </ac:picMkLst>
        </pc:picChg>
        <pc:picChg chg="add mod">
          <ac:chgData name="li li" userId="3d7a94fd48c86d40" providerId="LiveId" clId="{2345AA29-D5AE-4783-9A1B-7E86E6AD882B}" dt="2018-05-08T17:41:21.800" v="1132" actId="164"/>
          <ac:picMkLst>
            <pc:docMk/>
            <pc:sldMk cId="2613171354" sldId="256"/>
            <ac:picMk id="15" creationId="{711FF840-569C-4E0A-BD44-2566EA244F8A}"/>
          </ac:picMkLst>
        </pc:picChg>
        <pc:picChg chg="mod topLvl">
          <ac:chgData name="li li" userId="3d7a94fd48c86d40" providerId="LiveId" clId="{2345AA29-D5AE-4783-9A1B-7E86E6AD882B}" dt="2018-05-08T17:41:05.065" v="1131" actId="165"/>
          <ac:picMkLst>
            <pc:docMk/>
            <pc:sldMk cId="2613171354" sldId="256"/>
            <ac:picMk id="16" creationId="{0B493EFB-3D23-4A82-B113-5A82583B3E10}"/>
          </ac:picMkLst>
        </pc:picChg>
        <pc:picChg chg="mod ord topLvl">
          <ac:chgData name="li li" userId="3d7a94fd48c86d40" providerId="LiveId" clId="{2345AA29-D5AE-4783-9A1B-7E86E6AD882B}" dt="2018-05-08T17:40:49.541" v="1130" actId="165"/>
          <ac:picMkLst>
            <pc:docMk/>
            <pc:sldMk cId="2613171354" sldId="256"/>
            <ac:picMk id="17" creationId="{38FA655B-23E0-4813-9256-F2BC68E5E767}"/>
          </ac:picMkLst>
        </pc:picChg>
        <pc:picChg chg="add mod">
          <ac:chgData name="li li" userId="3d7a94fd48c86d40" providerId="LiveId" clId="{2345AA29-D5AE-4783-9A1B-7E86E6AD882B}" dt="2018-05-08T17:41:21.800" v="1132" actId="164"/>
          <ac:picMkLst>
            <pc:docMk/>
            <pc:sldMk cId="2613171354" sldId="256"/>
            <ac:picMk id="21" creationId="{44FD1EEC-3ED3-4E74-B163-3420A9BF124A}"/>
          </ac:picMkLst>
        </pc:picChg>
        <pc:picChg chg="add mod">
          <ac:chgData name="li li" userId="3d7a94fd48c86d40" providerId="LiveId" clId="{2345AA29-D5AE-4783-9A1B-7E86E6AD882B}" dt="2018-05-08T16:30:17.448" v="279" actId="1076"/>
          <ac:picMkLst>
            <pc:docMk/>
            <pc:sldMk cId="2613171354" sldId="256"/>
            <ac:picMk id="23" creationId="{36E95F3E-8920-42D3-BE37-D010FF076755}"/>
          </ac:picMkLst>
        </pc:picChg>
        <pc:picChg chg="add mod">
          <ac:chgData name="li li" userId="3d7a94fd48c86d40" providerId="LiveId" clId="{2345AA29-D5AE-4783-9A1B-7E86E6AD882B}" dt="2018-05-08T16:30:28.349" v="280" actId="1076"/>
          <ac:picMkLst>
            <pc:docMk/>
            <pc:sldMk cId="2613171354" sldId="256"/>
            <ac:picMk id="25" creationId="{B430805E-61CC-401B-B731-855755D5D5C0}"/>
          </ac:picMkLst>
        </pc:picChg>
        <pc:picChg chg="add mod">
          <ac:chgData name="li li" userId="3d7a94fd48c86d40" providerId="LiveId" clId="{2345AA29-D5AE-4783-9A1B-7E86E6AD882B}" dt="2018-05-08T16:41:52.529" v="293" actId="1076"/>
          <ac:picMkLst>
            <pc:docMk/>
            <pc:sldMk cId="2613171354" sldId="256"/>
            <ac:picMk id="27" creationId="{21723287-402B-4929-AA1E-CD6A962DD06A}"/>
          </ac:picMkLst>
        </pc:picChg>
        <pc:picChg chg="add mod">
          <ac:chgData name="li li" userId="3d7a94fd48c86d40" providerId="LiveId" clId="{2345AA29-D5AE-4783-9A1B-7E86E6AD882B}" dt="2018-05-08T16:42:02.939" v="294" actId="1076"/>
          <ac:picMkLst>
            <pc:docMk/>
            <pc:sldMk cId="2613171354" sldId="256"/>
            <ac:picMk id="29" creationId="{C8C447C7-8430-4306-AC7C-F07BBAF44A46}"/>
          </ac:picMkLst>
        </pc:picChg>
        <pc:picChg chg="add mod">
          <ac:chgData name="li li" userId="3d7a94fd48c86d40" providerId="LiveId" clId="{2345AA29-D5AE-4783-9A1B-7E86E6AD882B}" dt="2018-05-08T16:42:07.514" v="295" actId="1076"/>
          <ac:picMkLst>
            <pc:docMk/>
            <pc:sldMk cId="2613171354" sldId="256"/>
            <ac:picMk id="31" creationId="{FFA1609B-32EA-4898-BC9C-91562315BEAF}"/>
          </ac:picMkLst>
        </pc:picChg>
        <pc:picChg chg="mod topLvl">
          <ac:chgData name="li li" userId="3d7a94fd48c86d40" providerId="LiveId" clId="{2345AA29-D5AE-4783-9A1B-7E86E6AD882B}" dt="2018-05-08T17:41:05.065" v="1131" actId="165"/>
          <ac:picMkLst>
            <pc:docMk/>
            <pc:sldMk cId="2613171354" sldId="256"/>
            <ac:picMk id="33" creationId="{FA395E19-B23C-4453-85FC-46941985F433}"/>
          </ac:picMkLst>
        </pc:picChg>
        <pc:picChg chg="add mod">
          <ac:chgData name="li li" userId="3d7a94fd48c86d40" providerId="LiveId" clId="{2345AA29-D5AE-4783-9A1B-7E86E6AD882B}" dt="2018-05-08T16:42:10.558" v="296" actId="1076"/>
          <ac:picMkLst>
            <pc:docMk/>
            <pc:sldMk cId="2613171354" sldId="256"/>
            <ac:picMk id="34" creationId="{AE2FEA3A-2298-4301-A601-A45905590B23}"/>
          </ac:picMkLst>
        </pc:picChg>
        <pc:picChg chg="mod topLvl">
          <ac:chgData name="li li" userId="3d7a94fd48c86d40" providerId="LiveId" clId="{2345AA29-D5AE-4783-9A1B-7E86E6AD882B}" dt="2018-05-08T17:41:05.065" v="1131" actId="165"/>
          <ac:picMkLst>
            <pc:docMk/>
            <pc:sldMk cId="2613171354" sldId="256"/>
            <ac:picMk id="35" creationId="{11BE5B32-92C2-482C-9300-61793DC20A5E}"/>
          </ac:picMkLst>
        </pc:picChg>
        <pc:picChg chg="mod topLvl">
          <ac:chgData name="li li" userId="3d7a94fd48c86d40" providerId="LiveId" clId="{2345AA29-D5AE-4783-9A1B-7E86E6AD882B}" dt="2018-05-08T17:41:05.065" v="1131" actId="165"/>
          <ac:picMkLst>
            <pc:docMk/>
            <pc:sldMk cId="2613171354" sldId="256"/>
            <ac:picMk id="37" creationId="{712F5884-3C60-4F47-BCE7-93C1802A6266}"/>
          </ac:picMkLst>
        </pc:picChg>
        <pc:picChg chg="add mod">
          <ac:chgData name="li li" userId="3d7a94fd48c86d40" providerId="LiveId" clId="{2345AA29-D5AE-4783-9A1B-7E86E6AD882B}" dt="2018-05-08T16:42:17.098" v="297" actId="1076"/>
          <ac:picMkLst>
            <pc:docMk/>
            <pc:sldMk cId="2613171354" sldId="256"/>
            <ac:picMk id="38" creationId="{B83C2652-26EF-49EB-AE8A-813EF0BC8621}"/>
          </ac:picMkLst>
        </pc:picChg>
        <pc:picChg chg="mod topLvl">
          <ac:chgData name="li li" userId="3d7a94fd48c86d40" providerId="LiveId" clId="{2345AA29-D5AE-4783-9A1B-7E86E6AD882B}" dt="2018-05-08T17:41:05.065" v="1131" actId="165"/>
          <ac:picMkLst>
            <pc:docMk/>
            <pc:sldMk cId="2613171354" sldId="256"/>
            <ac:picMk id="39" creationId="{7DE6171F-BF0F-4B5C-AE63-6F989C2D2391}"/>
          </ac:picMkLst>
        </pc:picChg>
        <pc:picChg chg="mod topLvl">
          <ac:chgData name="li li" userId="3d7a94fd48c86d40" providerId="LiveId" clId="{2345AA29-D5AE-4783-9A1B-7E86E6AD882B}" dt="2018-05-08T17:42:28.279" v="1136" actId="164"/>
          <ac:picMkLst>
            <pc:docMk/>
            <pc:sldMk cId="2613171354" sldId="256"/>
            <ac:picMk id="41" creationId="{D3A9974A-5628-4524-91B2-FD11824D896E}"/>
          </ac:picMkLst>
        </pc:picChg>
        <pc:picChg chg="add mod">
          <ac:chgData name="li li" userId="3d7a94fd48c86d40" providerId="LiveId" clId="{2345AA29-D5AE-4783-9A1B-7E86E6AD882B}" dt="2018-05-08T17:42:28.279" v="1136" actId="164"/>
          <ac:picMkLst>
            <pc:docMk/>
            <pc:sldMk cId="2613171354" sldId="256"/>
            <ac:picMk id="42" creationId="{F6DC64ED-B7F1-4E1B-BFB8-F04BAB5152CC}"/>
          </ac:picMkLst>
        </pc:picChg>
        <pc:picChg chg="mod topLvl">
          <ac:chgData name="li li" userId="3d7a94fd48c86d40" providerId="LiveId" clId="{2345AA29-D5AE-4783-9A1B-7E86E6AD882B}" dt="2018-05-08T17:41:05.065" v="1131" actId="165"/>
          <ac:picMkLst>
            <pc:docMk/>
            <pc:sldMk cId="2613171354" sldId="256"/>
            <ac:picMk id="43" creationId="{95464C73-45FD-4F09-A195-7B02B3E2FA62}"/>
          </ac:picMkLst>
        </pc:picChg>
        <pc:picChg chg="mod topLvl">
          <ac:chgData name="li li" userId="3d7a94fd48c86d40" providerId="LiveId" clId="{2345AA29-D5AE-4783-9A1B-7E86E6AD882B}" dt="2018-05-08T17:41:05.065" v="1131" actId="165"/>
          <ac:picMkLst>
            <pc:docMk/>
            <pc:sldMk cId="2613171354" sldId="256"/>
            <ac:picMk id="45" creationId="{3EE1BAF5-9036-4402-B960-4A41148740D6}"/>
          </ac:picMkLst>
        </pc:picChg>
        <pc:picChg chg="add mod">
          <ac:chgData name="li li" userId="3d7a94fd48c86d40" providerId="LiveId" clId="{2345AA29-D5AE-4783-9A1B-7E86E6AD882B}" dt="2018-05-08T16:54:58.326" v="459" actId="1076"/>
          <ac:picMkLst>
            <pc:docMk/>
            <pc:sldMk cId="2613171354" sldId="256"/>
            <ac:picMk id="46" creationId="{7B85E758-B11E-4698-90F3-FAC53631147C}"/>
          </ac:picMkLst>
        </pc:picChg>
        <pc:picChg chg="mod topLvl">
          <ac:chgData name="li li" userId="3d7a94fd48c86d40" providerId="LiveId" clId="{2345AA29-D5AE-4783-9A1B-7E86E6AD882B}" dt="2018-05-08T17:41:05.065" v="1131" actId="165"/>
          <ac:picMkLst>
            <pc:docMk/>
            <pc:sldMk cId="2613171354" sldId="256"/>
            <ac:picMk id="47" creationId="{A42CD7F2-D9FB-4DFD-8B14-321955DB6882}"/>
          </ac:picMkLst>
        </pc:picChg>
        <pc:picChg chg="mod topLvl">
          <ac:chgData name="li li" userId="3d7a94fd48c86d40" providerId="LiveId" clId="{2345AA29-D5AE-4783-9A1B-7E86E6AD882B}" dt="2018-05-08T17:41:05.065" v="1131" actId="165"/>
          <ac:picMkLst>
            <pc:docMk/>
            <pc:sldMk cId="2613171354" sldId="256"/>
            <ac:picMk id="49" creationId="{A92027E4-64C0-496C-9B97-5C73084B2D97}"/>
          </ac:picMkLst>
        </pc:picChg>
        <pc:picChg chg="add mod">
          <ac:chgData name="li li" userId="3d7a94fd48c86d40" providerId="LiveId" clId="{2345AA29-D5AE-4783-9A1B-7E86E6AD882B}" dt="2018-05-08T16:42:48.127" v="299" actId="1076"/>
          <ac:picMkLst>
            <pc:docMk/>
            <pc:sldMk cId="2613171354" sldId="256"/>
            <ac:picMk id="50" creationId="{B8A93F98-98BA-43FF-A8EB-AD44C055C275}"/>
          </ac:picMkLst>
        </pc:picChg>
        <pc:picChg chg="mod topLvl">
          <ac:chgData name="li li" userId="3d7a94fd48c86d40" providerId="LiveId" clId="{2345AA29-D5AE-4783-9A1B-7E86E6AD882B}" dt="2018-05-08T17:41:05.065" v="1131" actId="165"/>
          <ac:picMkLst>
            <pc:docMk/>
            <pc:sldMk cId="2613171354" sldId="256"/>
            <ac:picMk id="51" creationId="{F00AC756-07A1-475A-9434-8C988F01F5D1}"/>
          </ac:picMkLst>
        </pc:picChg>
        <pc:picChg chg="mod topLvl">
          <ac:chgData name="li li" userId="3d7a94fd48c86d40" providerId="LiveId" clId="{2345AA29-D5AE-4783-9A1B-7E86E6AD882B}" dt="2018-05-08T17:43:51.480" v="1142" actId="164"/>
          <ac:picMkLst>
            <pc:docMk/>
            <pc:sldMk cId="2613171354" sldId="256"/>
            <ac:picMk id="53" creationId="{077BF0AE-8EF6-4A69-AF20-90F633EFC1ED}"/>
          </ac:picMkLst>
        </pc:picChg>
        <pc:picChg chg="add mod">
          <ac:chgData name="li li" userId="3d7a94fd48c86d40" providerId="LiveId" clId="{2345AA29-D5AE-4783-9A1B-7E86E6AD882B}" dt="2018-05-08T16:42:50.566" v="300" actId="1076"/>
          <ac:picMkLst>
            <pc:docMk/>
            <pc:sldMk cId="2613171354" sldId="256"/>
            <ac:picMk id="54" creationId="{68165BE7-F08A-42FC-87CE-9F06C44C3CCC}"/>
          </ac:picMkLst>
        </pc:picChg>
        <pc:picChg chg="mod topLvl">
          <ac:chgData name="li li" userId="3d7a94fd48c86d40" providerId="LiveId" clId="{2345AA29-D5AE-4783-9A1B-7E86E6AD882B}" dt="2018-05-08T17:41:05.065" v="1131" actId="165"/>
          <ac:picMkLst>
            <pc:docMk/>
            <pc:sldMk cId="2613171354" sldId="256"/>
            <ac:picMk id="55" creationId="{272F96D1-B8F2-43BC-B938-A3F8F9A0C413}"/>
          </ac:picMkLst>
        </pc:picChg>
        <pc:picChg chg="add mod">
          <ac:chgData name="li li" userId="3d7a94fd48c86d40" providerId="LiveId" clId="{2345AA29-D5AE-4783-9A1B-7E86E6AD882B}" dt="2018-05-08T17:43:10.441" v="1139" actId="164"/>
          <ac:picMkLst>
            <pc:docMk/>
            <pc:sldMk cId="2613171354" sldId="256"/>
            <ac:picMk id="57" creationId="{FDCE9C6A-5FBF-4554-B581-B2D3989D7917}"/>
          </ac:picMkLst>
        </pc:picChg>
        <pc:picChg chg="add mod">
          <ac:chgData name="li li" userId="3d7a94fd48c86d40" providerId="LiveId" clId="{2345AA29-D5AE-4783-9A1B-7E86E6AD882B}" dt="2018-05-08T16:43:05.823" v="302" actId="1076"/>
          <ac:picMkLst>
            <pc:docMk/>
            <pc:sldMk cId="2613171354" sldId="256"/>
            <ac:picMk id="60" creationId="{06B109DD-F0E5-411A-944D-8F5752997738}"/>
          </ac:picMkLst>
        </pc:picChg>
        <pc:picChg chg="add mod">
          <ac:chgData name="li li" userId="3d7a94fd48c86d40" providerId="LiveId" clId="{2345AA29-D5AE-4783-9A1B-7E86E6AD882B}" dt="2018-05-08T16:43:10.273" v="303" actId="1076"/>
          <ac:picMkLst>
            <pc:docMk/>
            <pc:sldMk cId="2613171354" sldId="256"/>
            <ac:picMk id="63" creationId="{2D50A5A0-6ABB-477B-B63D-1D035F35728F}"/>
          </ac:picMkLst>
        </pc:picChg>
        <pc:picChg chg="add mod">
          <ac:chgData name="li li" userId="3d7a94fd48c86d40" providerId="LiveId" clId="{2345AA29-D5AE-4783-9A1B-7E86E6AD882B}" dt="2018-05-08T17:51:22.684" v="1173" actId="164"/>
          <ac:picMkLst>
            <pc:docMk/>
            <pc:sldMk cId="2613171354" sldId="256"/>
            <ac:picMk id="65" creationId="{41C832E9-9497-4003-9DF9-A2B5F746B2B3}"/>
          </ac:picMkLst>
        </pc:picChg>
        <pc:picChg chg="add mod">
          <ac:chgData name="li li" userId="3d7a94fd48c86d40" providerId="LiveId" clId="{2345AA29-D5AE-4783-9A1B-7E86E6AD882B}" dt="2018-05-08T16:43:23.095" v="305" actId="1076"/>
          <ac:picMkLst>
            <pc:docMk/>
            <pc:sldMk cId="2613171354" sldId="256"/>
            <ac:picMk id="75" creationId="{B184A420-8AE0-48D9-BEA5-F97E8D833DFA}"/>
          </ac:picMkLst>
        </pc:picChg>
        <pc:picChg chg="add mod">
          <ac:chgData name="li li" userId="3d7a94fd48c86d40" providerId="LiveId" clId="{2345AA29-D5AE-4783-9A1B-7E86E6AD882B}" dt="2018-05-08T16:43:26.221" v="306" actId="1076"/>
          <ac:picMkLst>
            <pc:docMk/>
            <pc:sldMk cId="2613171354" sldId="256"/>
            <ac:picMk id="77" creationId="{33981570-33EE-4665-9128-109CBF876F83}"/>
          </ac:picMkLst>
        </pc:picChg>
        <pc:picChg chg="mod topLvl">
          <ac:chgData name="li li" userId="3d7a94fd48c86d40" providerId="LiveId" clId="{2345AA29-D5AE-4783-9A1B-7E86E6AD882B}" dt="2018-05-08T17:40:49.541" v="1130" actId="165"/>
          <ac:picMkLst>
            <pc:docMk/>
            <pc:sldMk cId="2613171354" sldId="256"/>
            <ac:picMk id="106" creationId="{AC95B704-1E95-4FC2-87AF-9582B31B6B14}"/>
          </ac:picMkLst>
        </pc:picChg>
        <pc:picChg chg="mod topLvl">
          <ac:chgData name="li li" userId="3d7a94fd48c86d40" providerId="LiveId" clId="{2345AA29-D5AE-4783-9A1B-7E86E6AD882B}" dt="2018-05-08T17:40:49.541" v="1130" actId="165"/>
          <ac:picMkLst>
            <pc:docMk/>
            <pc:sldMk cId="2613171354" sldId="256"/>
            <ac:picMk id="108" creationId="{0FD55338-E78C-41DE-B9AE-373C7474D0F9}"/>
          </ac:picMkLst>
        </pc:picChg>
        <pc:cxnChg chg="add del mod">
          <ac:chgData name="li li" userId="3d7a94fd48c86d40" providerId="LiveId" clId="{2345AA29-D5AE-4783-9A1B-7E86E6AD882B}" dt="2018-05-21T05:05:18.846" v="2462" actId="478"/>
          <ac:cxnSpMkLst>
            <pc:docMk/>
            <pc:sldMk cId="2613171354" sldId="256"/>
            <ac:cxnSpMk id="3" creationId="{2C5C40B2-95F6-4DB2-A5E0-84D48EDD0413}"/>
          </ac:cxnSpMkLst>
        </pc:cxnChg>
      </pc:sldChg>
      <pc:sldChg chg="addSp delSp modSp">
        <pc:chgData name="li li" userId="3d7a94fd48c86d40" providerId="LiveId" clId="{2345AA29-D5AE-4783-9A1B-7E86E6AD882B}" dt="2018-05-09T07:25:14.282" v="2404" actId="1076"/>
        <pc:sldMkLst>
          <pc:docMk/>
          <pc:sldMk cId="1714374443" sldId="257"/>
        </pc:sldMkLst>
        <pc:spChg chg="mod topLvl">
          <ac:chgData name="li li" userId="3d7a94fd48c86d40" providerId="LiveId" clId="{2345AA29-D5AE-4783-9A1B-7E86E6AD882B}" dt="2018-05-09T07:24:50.450" v="2401" actId="1076"/>
          <ac:spMkLst>
            <pc:docMk/>
            <pc:sldMk cId="1714374443" sldId="257"/>
            <ac:spMk id="5" creationId="{4EB527AC-F0A8-4129-8CAE-A3D1F1924313}"/>
          </ac:spMkLst>
        </pc:spChg>
        <pc:spChg chg="mod topLvl">
          <ac:chgData name="li li" userId="3d7a94fd48c86d40" providerId="LiveId" clId="{2345AA29-D5AE-4783-9A1B-7E86E6AD882B}" dt="2018-05-09T07:25:01.911" v="2402" actId="1076"/>
          <ac:spMkLst>
            <pc:docMk/>
            <pc:sldMk cId="1714374443" sldId="257"/>
            <ac:spMk id="6" creationId="{F0342969-4392-48A1-87D2-A132D4F04ABD}"/>
          </ac:spMkLst>
        </pc:spChg>
        <pc:spChg chg="mod topLvl">
          <ac:chgData name="li li" userId="3d7a94fd48c86d40" providerId="LiveId" clId="{2345AA29-D5AE-4783-9A1B-7E86E6AD882B}" dt="2018-05-09T07:25:05.140" v="2403" actId="1076"/>
          <ac:spMkLst>
            <pc:docMk/>
            <pc:sldMk cId="1714374443" sldId="257"/>
            <ac:spMk id="7" creationId="{FB66408A-1D3E-48DB-B1DC-B13F1650AC6E}"/>
          </ac:spMkLst>
        </pc:spChg>
        <pc:spChg chg="mod topLvl">
          <ac:chgData name="li li" userId="3d7a94fd48c86d40" providerId="LiveId" clId="{2345AA29-D5AE-4783-9A1B-7E86E6AD882B}" dt="2018-05-09T07:25:14.282" v="2404" actId="1076"/>
          <ac:spMkLst>
            <pc:docMk/>
            <pc:sldMk cId="1714374443" sldId="257"/>
            <ac:spMk id="8" creationId="{EDBA89AD-1A2B-45A8-B2BD-A817EF054EF4}"/>
          </ac:spMkLst>
        </pc:spChg>
        <pc:spChg chg="add">
          <ac:chgData name="li li" userId="3d7a94fd48c86d40" providerId="LiveId" clId="{2345AA29-D5AE-4783-9A1B-7E86E6AD882B}" dt="2018-05-08T14:30:14.269" v="24" actId="164"/>
          <ac:spMkLst>
            <pc:docMk/>
            <pc:sldMk cId="1714374443" sldId="257"/>
            <ac:spMk id="35" creationId="{91910854-5A30-4DAB-B8A3-D797CD56E448}"/>
          </ac:spMkLst>
        </pc:spChg>
        <pc:spChg chg="mod topLvl">
          <ac:chgData name="li li" userId="3d7a94fd48c86d40" providerId="LiveId" clId="{2345AA29-D5AE-4783-9A1B-7E86E6AD882B}" dt="2018-05-08T17:37:11.967" v="1125" actId="164"/>
          <ac:spMkLst>
            <pc:docMk/>
            <pc:sldMk cId="1714374443" sldId="257"/>
            <ac:spMk id="45" creationId="{017D63E5-29AC-4D82-9C71-F1FC94F8AECC}"/>
          </ac:spMkLst>
        </pc:spChg>
        <pc:spChg chg="mod topLvl">
          <ac:chgData name="li li" userId="3d7a94fd48c86d40" providerId="LiveId" clId="{2345AA29-D5AE-4783-9A1B-7E86E6AD882B}" dt="2018-05-08T17:44:44.302" v="1145" actId="165"/>
          <ac:spMkLst>
            <pc:docMk/>
            <pc:sldMk cId="1714374443" sldId="257"/>
            <ac:spMk id="48" creationId="{374B877B-93BC-4435-825E-1BC3072C3342}"/>
          </ac:spMkLst>
        </pc:spChg>
        <pc:spChg chg="mod topLvl">
          <ac:chgData name="li li" userId="3d7a94fd48c86d40" providerId="LiveId" clId="{2345AA29-D5AE-4783-9A1B-7E86E6AD882B}" dt="2018-05-08T17:44:44.302" v="1145" actId="165"/>
          <ac:spMkLst>
            <pc:docMk/>
            <pc:sldMk cId="1714374443" sldId="257"/>
            <ac:spMk id="49" creationId="{448A78B7-4073-4FA4-AD94-7E8F27DDEF40}"/>
          </ac:spMkLst>
        </pc:spChg>
        <pc:spChg chg="mod topLvl">
          <ac:chgData name="li li" userId="3d7a94fd48c86d40" providerId="LiveId" clId="{2345AA29-D5AE-4783-9A1B-7E86E6AD882B}" dt="2018-05-08T17:44:44.302" v="1145" actId="165"/>
          <ac:spMkLst>
            <pc:docMk/>
            <pc:sldMk cId="1714374443" sldId="257"/>
            <ac:spMk id="50" creationId="{AF6AB94A-6DA6-4DA4-A159-B8021763B922}"/>
          </ac:spMkLst>
        </pc:spChg>
        <pc:spChg chg="mod topLvl">
          <ac:chgData name="li li" userId="3d7a94fd48c86d40" providerId="LiveId" clId="{2345AA29-D5AE-4783-9A1B-7E86E6AD882B}" dt="2018-05-08T17:44:44.302" v="1145" actId="165"/>
          <ac:spMkLst>
            <pc:docMk/>
            <pc:sldMk cId="1714374443" sldId="257"/>
            <ac:spMk id="51" creationId="{E42E0EF4-3DCD-41CF-A582-1562A916DC30}"/>
          </ac:spMkLst>
        </pc:spChg>
        <pc:grpChg chg="add del mod">
          <ac:chgData name="li li" userId="3d7a94fd48c86d40" providerId="LiveId" clId="{2345AA29-D5AE-4783-9A1B-7E86E6AD882B}" dt="2018-05-08T17:44:44.302" v="1145" actId="165"/>
          <ac:grpSpMkLst>
            <pc:docMk/>
            <pc:sldMk cId="1714374443" sldId="257"/>
            <ac:grpSpMk id="2" creationId="{3F5B6B28-FB14-4914-BAF9-513CF41924D1}"/>
          </ac:grpSpMkLst>
        </pc:grpChg>
        <pc:grpChg chg="add del mod">
          <ac:chgData name="li li" userId="3d7a94fd48c86d40" providerId="LiveId" clId="{2345AA29-D5AE-4783-9A1B-7E86E6AD882B}" dt="2018-05-08T17:44:44.302" v="1145" actId="165"/>
          <ac:grpSpMkLst>
            <pc:docMk/>
            <pc:sldMk cId="1714374443" sldId="257"/>
            <ac:grpSpMk id="3" creationId="{D7C71473-DAC8-42D5-A1C1-DA89136116D8}"/>
          </ac:grpSpMkLst>
        </pc:grpChg>
        <pc:grpChg chg="add del mod">
          <ac:chgData name="li li" userId="3d7a94fd48c86d40" providerId="LiveId" clId="{2345AA29-D5AE-4783-9A1B-7E86E6AD882B}" dt="2018-05-08T17:44:44.302" v="1145" actId="165"/>
          <ac:grpSpMkLst>
            <pc:docMk/>
            <pc:sldMk cId="1714374443" sldId="257"/>
            <ac:grpSpMk id="4" creationId="{31881678-575A-4A2D-9488-96331EA9B039}"/>
          </ac:grpSpMkLst>
        </pc:grpChg>
        <pc:grpChg chg="add del mod">
          <ac:chgData name="li li" userId="3d7a94fd48c86d40" providerId="LiveId" clId="{2345AA29-D5AE-4783-9A1B-7E86E6AD882B}" dt="2018-05-08T17:44:44.302" v="1145" actId="165"/>
          <ac:grpSpMkLst>
            <pc:docMk/>
            <pc:sldMk cId="1714374443" sldId="257"/>
            <ac:grpSpMk id="9" creationId="{AC5DE28A-350E-4D4D-9354-6C540BBC923C}"/>
          </ac:grpSpMkLst>
        </pc:grpChg>
        <pc:grpChg chg="del">
          <ac:chgData name="li li" userId="3d7a94fd48c86d40" providerId="LiveId" clId="{2345AA29-D5AE-4783-9A1B-7E86E6AD882B}" dt="2018-05-08T13:46:54.242" v="0" actId="165"/>
          <ac:grpSpMkLst>
            <pc:docMk/>
            <pc:sldMk cId="1714374443" sldId="257"/>
            <ac:grpSpMk id="55" creationId="{0F5CDD76-FF77-4E43-809E-0EF54ADA7FC6}"/>
          </ac:grpSpMkLst>
        </pc:grpChg>
        <pc:grpChg chg="add mod">
          <ac:chgData name="li li" userId="3d7a94fd48c86d40" providerId="LiveId" clId="{2345AA29-D5AE-4783-9A1B-7E86E6AD882B}" dt="2018-05-08T17:44:52.141" v="1146" actId="164"/>
          <ac:grpSpMkLst>
            <pc:docMk/>
            <pc:sldMk cId="1714374443" sldId="257"/>
            <ac:grpSpMk id="83" creationId="{BD6975D6-90DD-474C-A587-14E3CA401FCD}"/>
          </ac:grpSpMkLst>
        </pc:grpChg>
        <pc:grpChg chg="add mod">
          <ac:chgData name="li li" userId="3d7a94fd48c86d40" providerId="LiveId" clId="{2345AA29-D5AE-4783-9A1B-7E86E6AD882B}" dt="2018-05-08T17:45:36.746" v="1149" actId="164"/>
          <ac:grpSpMkLst>
            <pc:docMk/>
            <pc:sldMk cId="1714374443" sldId="257"/>
            <ac:grpSpMk id="84" creationId="{957E93B1-272C-44E9-A8C8-665DE8CF7771}"/>
          </ac:grpSpMkLst>
        </pc:grpChg>
        <pc:grpChg chg="add mod">
          <ac:chgData name="li li" userId="3d7a94fd48c86d40" providerId="LiveId" clId="{2345AA29-D5AE-4783-9A1B-7E86E6AD882B}" dt="2018-05-08T17:46:33.207" v="1152" actId="164"/>
          <ac:grpSpMkLst>
            <pc:docMk/>
            <pc:sldMk cId="1714374443" sldId="257"/>
            <ac:grpSpMk id="85" creationId="{6D632F06-7267-4364-AAF4-C18517A8D37F}"/>
          </ac:grpSpMkLst>
        </pc:grpChg>
        <pc:graphicFrameChg chg="add del">
          <ac:chgData name="li li" userId="3d7a94fd48c86d40" providerId="LiveId" clId="{2345AA29-D5AE-4783-9A1B-7E86E6AD882B}" dt="2018-05-08T16:44:04.403" v="308" actId="164"/>
          <ac:graphicFrameMkLst>
            <pc:docMk/>
            <pc:sldMk cId="1714374443" sldId="257"/>
            <ac:graphicFrameMk id="23" creationId="{89C589F9-EF99-4A25-9EBF-8F8482B9103F}"/>
          </ac:graphicFrameMkLst>
        </pc:graphicFrameChg>
        <pc:graphicFrameChg chg="add del">
          <ac:chgData name="li li" userId="3d7a94fd48c86d40" providerId="LiveId" clId="{2345AA29-D5AE-4783-9A1B-7E86E6AD882B}" dt="2018-05-08T16:44:29.708" v="313" actId="164"/>
          <ac:graphicFrameMkLst>
            <pc:docMk/>
            <pc:sldMk cId="1714374443" sldId="257"/>
            <ac:graphicFrameMk id="27" creationId="{CE7F719F-415A-4D2C-958F-85008D3E79C9}"/>
          </ac:graphicFrameMkLst>
        </pc:graphicFrameChg>
        <pc:graphicFrameChg chg="add del">
          <ac:chgData name="li li" userId="3d7a94fd48c86d40" providerId="LiveId" clId="{2345AA29-D5AE-4783-9A1B-7E86E6AD882B}" dt="2018-05-08T16:44:48.926" v="320" actId="164"/>
          <ac:graphicFrameMkLst>
            <pc:docMk/>
            <pc:sldMk cId="1714374443" sldId="257"/>
            <ac:graphicFrameMk id="31" creationId="{F6C53F6A-6C34-48D6-9C4D-53EC1A58A68D}"/>
          </ac:graphicFrameMkLst>
        </pc:graphicFrameChg>
        <pc:graphicFrameChg chg="add del">
          <ac:chgData name="li li" userId="3d7a94fd48c86d40" providerId="LiveId" clId="{2345AA29-D5AE-4783-9A1B-7E86E6AD882B}" dt="2018-05-08T16:45:04.370" v="325" actId="164"/>
          <ac:graphicFrameMkLst>
            <pc:docMk/>
            <pc:sldMk cId="1714374443" sldId="257"/>
            <ac:graphicFrameMk id="37" creationId="{EE9F5DFF-433E-4774-9938-E5F33FD10AF1}"/>
          </ac:graphicFrameMkLst>
        </pc:graphicFrameChg>
        <pc:graphicFrameChg chg="add del">
          <ac:chgData name="li li" userId="3d7a94fd48c86d40" providerId="LiveId" clId="{2345AA29-D5AE-4783-9A1B-7E86E6AD882B}" dt="2018-05-08T16:45:20.320" v="330" actId="164"/>
          <ac:graphicFrameMkLst>
            <pc:docMk/>
            <pc:sldMk cId="1714374443" sldId="257"/>
            <ac:graphicFrameMk id="41" creationId="{30C762DC-DF69-4067-AA23-B681E62D77E4}"/>
          </ac:graphicFrameMkLst>
        </pc:graphicFrameChg>
        <pc:graphicFrameChg chg="add del">
          <ac:chgData name="li li" userId="3d7a94fd48c86d40" providerId="LiveId" clId="{2345AA29-D5AE-4783-9A1B-7E86E6AD882B}" dt="2018-05-08T16:45:39.645" v="337" actId="164"/>
          <ac:graphicFrameMkLst>
            <pc:docMk/>
            <pc:sldMk cId="1714374443" sldId="257"/>
            <ac:graphicFrameMk id="52" creationId="{7F3AE432-34CF-43D2-B60A-B5F66979B207}"/>
          </ac:graphicFrameMkLst>
        </pc:graphicFrameChg>
        <pc:graphicFrameChg chg="add del">
          <ac:chgData name="li li" userId="3d7a94fd48c86d40" providerId="LiveId" clId="{2345AA29-D5AE-4783-9A1B-7E86E6AD882B}" dt="2018-05-08T16:45:55.065" v="342" actId="164"/>
          <ac:graphicFrameMkLst>
            <pc:docMk/>
            <pc:sldMk cId="1714374443" sldId="257"/>
            <ac:graphicFrameMk id="54" creationId="{8BDAD4DD-A4A7-475F-980C-CB54293D3A58}"/>
          </ac:graphicFrameMkLst>
        </pc:graphicFrameChg>
        <pc:graphicFrameChg chg="add del">
          <ac:chgData name="li li" userId="3d7a94fd48c86d40" providerId="LiveId" clId="{2345AA29-D5AE-4783-9A1B-7E86E6AD882B}" dt="2018-05-08T16:46:11.020" v="349" actId="164"/>
          <ac:graphicFrameMkLst>
            <pc:docMk/>
            <pc:sldMk cId="1714374443" sldId="257"/>
            <ac:graphicFrameMk id="57" creationId="{0FB62CA0-724C-4C83-833B-C6846DFA73E1}"/>
          </ac:graphicFrameMkLst>
        </pc:graphicFrameChg>
        <pc:graphicFrameChg chg="add del">
          <ac:chgData name="li li" userId="3d7a94fd48c86d40" providerId="LiveId" clId="{2345AA29-D5AE-4783-9A1B-7E86E6AD882B}" dt="2018-05-08T16:46:24.500" v="354" actId="164"/>
          <ac:graphicFrameMkLst>
            <pc:docMk/>
            <pc:sldMk cId="1714374443" sldId="257"/>
            <ac:graphicFrameMk id="59" creationId="{2A4CC2FE-0609-48F6-9AB5-20CCFA1DCE52}"/>
          </ac:graphicFrameMkLst>
        </pc:graphicFrameChg>
        <pc:graphicFrameChg chg="add del">
          <ac:chgData name="li li" userId="3d7a94fd48c86d40" providerId="LiveId" clId="{2345AA29-D5AE-4783-9A1B-7E86E6AD882B}" dt="2018-05-08T16:46:39.026" v="363" actId="164"/>
          <ac:graphicFrameMkLst>
            <pc:docMk/>
            <pc:sldMk cId="1714374443" sldId="257"/>
            <ac:graphicFrameMk id="61" creationId="{36F23B27-3B3E-4718-ADFA-0983474A3AF0}"/>
          </ac:graphicFrameMkLst>
        </pc:graphicFrameChg>
        <pc:graphicFrameChg chg="add del">
          <ac:chgData name="li li" userId="3d7a94fd48c86d40" providerId="LiveId" clId="{2345AA29-D5AE-4783-9A1B-7E86E6AD882B}" dt="2018-05-08T16:47:03.167" v="368" actId="164"/>
          <ac:graphicFrameMkLst>
            <pc:docMk/>
            <pc:sldMk cId="1714374443" sldId="257"/>
            <ac:graphicFrameMk id="63" creationId="{3A0FD986-B72E-4D90-86DF-FDDD0E160FFF}"/>
          </ac:graphicFrameMkLst>
        </pc:graphicFrameChg>
        <pc:graphicFrameChg chg="add del">
          <ac:chgData name="li li" userId="3d7a94fd48c86d40" providerId="LiveId" clId="{2345AA29-D5AE-4783-9A1B-7E86E6AD882B}" dt="2018-05-08T16:47:23.205" v="373" actId="164"/>
          <ac:graphicFrameMkLst>
            <pc:docMk/>
            <pc:sldMk cId="1714374443" sldId="257"/>
            <ac:graphicFrameMk id="65" creationId="{DD851EA0-93F7-43E3-AF2A-4786FBC26CD6}"/>
          </ac:graphicFrameMkLst>
        </pc:graphicFrameChg>
        <pc:graphicFrameChg chg="add del">
          <ac:chgData name="li li" userId="3d7a94fd48c86d40" providerId="LiveId" clId="{2345AA29-D5AE-4783-9A1B-7E86E6AD882B}" dt="2018-05-08T16:47:42.827" v="382" actId="164"/>
          <ac:graphicFrameMkLst>
            <pc:docMk/>
            <pc:sldMk cId="1714374443" sldId="257"/>
            <ac:graphicFrameMk id="67" creationId="{07FDAD64-F0F4-435E-A18F-23E7A8B219B1}"/>
          </ac:graphicFrameMkLst>
        </pc:graphicFrameChg>
        <pc:graphicFrameChg chg="add del">
          <ac:chgData name="li li" userId="3d7a94fd48c86d40" providerId="LiveId" clId="{2345AA29-D5AE-4783-9A1B-7E86E6AD882B}" dt="2018-05-08T16:47:57.417" v="387" actId="164"/>
          <ac:graphicFrameMkLst>
            <pc:docMk/>
            <pc:sldMk cId="1714374443" sldId="257"/>
            <ac:graphicFrameMk id="69" creationId="{70924528-02A0-4663-B4CE-95FF030422D4}"/>
          </ac:graphicFrameMkLst>
        </pc:graphicFrameChg>
        <pc:graphicFrameChg chg="add del">
          <ac:chgData name="li li" userId="3d7a94fd48c86d40" providerId="LiveId" clId="{2345AA29-D5AE-4783-9A1B-7E86E6AD882B}" dt="2018-05-08T16:48:11.942" v="394" actId="164"/>
          <ac:graphicFrameMkLst>
            <pc:docMk/>
            <pc:sldMk cId="1714374443" sldId="257"/>
            <ac:graphicFrameMk id="71" creationId="{87CDC4ED-0ED7-4C28-B498-B49C095510E4}"/>
          </ac:graphicFrameMkLst>
        </pc:graphicFrameChg>
        <pc:graphicFrameChg chg="add del">
          <ac:chgData name="li li" userId="3d7a94fd48c86d40" providerId="LiveId" clId="{2345AA29-D5AE-4783-9A1B-7E86E6AD882B}" dt="2018-05-08T16:48:57.083" v="401" actId="164"/>
          <ac:graphicFrameMkLst>
            <pc:docMk/>
            <pc:sldMk cId="1714374443" sldId="257"/>
            <ac:graphicFrameMk id="73" creationId="{FDBEDE5C-E943-496C-A525-40CB8BC0C938}"/>
          </ac:graphicFrameMkLst>
        </pc:graphicFrameChg>
        <pc:graphicFrameChg chg="add del">
          <ac:chgData name="li li" userId="3d7a94fd48c86d40" providerId="LiveId" clId="{2345AA29-D5AE-4783-9A1B-7E86E6AD882B}" dt="2018-05-08T16:49:13.011" v="406" actId="164"/>
          <ac:graphicFrameMkLst>
            <pc:docMk/>
            <pc:sldMk cId="1714374443" sldId="257"/>
            <ac:graphicFrameMk id="75" creationId="{5CBC499B-1E6E-40C4-B847-506647E5A2C1}"/>
          </ac:graphicFrameMkLst>
        </pc:graphicFrameChg>
        <pc:graphicFrameChg chg="add del">
          <ac:chgData name="li li" userId="3d7a94fd48c86d40" providerId="LiveId" clId="{2345AA29-D5AE-4783-9A1B-7E86E6AD882B}" dt="2018-05-08T16:49:41.844" v="416" actId="164"/>
          <ac:graphicFrameMkLst>
            <pc:docMk/>
            <pc:sldMk cId="1714374443" sldId="257"/>
            <ac:graphicFrameMk id="77" creationId="{08501CFB-BEC6-4406-92E9-A0DD59A1085D}"/>
          </ac:graphicFrameMkLst>
        </pc:graphicFrameChg>
        <pc:graphicFrameChg chg="add del">
          <ac:chgData name="li li" userId="3d7a94fd48c86d40" providerId="LiveId" clId="{2345AA29-D5AE-4783-9A1B-7E86E6AD882B}" dt="2018-05-08T16:49:59.731" v="421" actId="164"/>
          <ac:graphicFrameMkLst>
            <pc:docMk/>
            <pc:sldMk cId="1714374443" sldId="257"/>
            <ac:graphicFrameMk id="79" creationId="{8ABCA404-7F6C-463D-AB73-621AB98B1287}"/>
          </ac:graphicFrameMkLst>
        </pc:graphicFrameChg>
        <pc:graphicFrameChg chg="add del">
          <ac:chgData name="li li" userId="3d7a94fd48c86d40" providerId="LiveId" clId="{2345AA29-D5AE-4783-9A1B-7E86E6AD882B}" dt="2018-05-08T16:50:12.920" v="426" actId="164"/>
          <ac:graphicFrameMkLst>
            <pc:docMk/>
            <pc:sldMk cId="1714374443" sldId="257"/>
            <ac:graphicFrameMk id="81" creationId="{0E8E0300-7DD3-4BDA-A1AF-B3A8A411DBF4}"/>
          </ac:graphicFrameMkLst>
        </pc:graphicFrameChg>
        <pc:picChg chg="add mod">
          <ac:chgData name="li li" userId="3d7a94fd48c86d40" providerId="LiveId" clId="{2345AA29-D5AE-4783-9A1B-7E86E6AD882B}" dt="2018-05-08T14:36:22.412" v="78" actId="1076"/>
          <ac:picMkLst>
            <pc:docMk/>
            <pc:sldMk cId="1714374443" sldId="257"/>
            <ac:picMk id="11" creationId="{AFCBAF14-AA5D-4688-A8A3-560B3627A707}"/>
          </ac:picMkLst>
        </pc:picChg>
        <pc:picChg chg="add mod">
          <ac:chgData name="li li" userId="3d7a94fd48c86d40" providerId="LiveId" clId="{2345AA29-D5AE-4783-9A1B-7E86E6AD882B}" dt="2018-05-08T14:36:15.040" v="77" actId="1076"/>
          <ac:picMkLst>
            <pc:docMk/>
            <pc:sldMk cId="1714374443" sldId="257"/>
            <ac:picMk id="13" creationId="{316E98FF-F807-470F-978E-C5E424B44CE5}"/>
          </ac:picMkLst>
        </pc:picChg>
        <pc:picChg chg="mod topLvl">
          <ac:chgData name="li li" userId="3d7a94fd48c86d40" providerId="LiveId" clId="{2345AA29-D5AE-4783-9A1B-7E86E6AD882B}" dt="2018-05-08T17:44:44.302" v="1145" actId="165"/>
          <ac:picMkLst>
            <pc:docMk/>
            <pc:sldMk cId="1714374443" sldId="257"/>
            <ac:picMk id="14" creationId="{35AC36A9-B988-4116-A690-66CA62A5E6FD}"/>
          </ac:picMkLst>
        </pc:picChg>
        <pc:picChg chg="mod topLvl">
          <ac:chgData name="li li" userId="3d7a94fd48c86d40" providerId="LiveId" clId="{2345AA29-D5AE-4783-9A1B-7E86E6AD882B}" dt="2018-05-08T17:44:52.141" v="1146" actId="164"/>
          <ac:picMkLst>
            <pc:docMk/>
            <pc:sldMk cId="1714374443" sldId="257"/>
            <ac:picMk id="16" creationId="{28DEE7EC-E4A5-4675-9F1A-540EDE679A0E}"/>
          </ac:picMkLst>
        </pc:picChg>
        <pc:picChg chg="add mod">
          <ac:chgData name="li li" userId="3d7a94fd48c86d40" providerId="LiveId" clId="{2345AA29-D5AE-4783-9A1B-7E86E6AD882B}" dt="2018-05-08T14:35:49.605" v="74" actId="1076"/>
          <ac:picMkLst>
            <pc:docMk/>
            <pc:sldMk cId="1714374443" sldId="257"/>
            <ac:picMk id="17" creationId="{0CF522B4-E4B0-4EAD-8ABB-7531E3E619F6}"/>
          </ac:picMkLst>
        </pc:picChg>
        <pc:picChg chg="mod topLvl">
          <ac:chgData name="li li" userId="3d7a94fd48c86d40" providerId="LiveId" clId="{2345AA29-D5AE-4783-9A1B-7E86E6AD882B}" dt="2018-05-08T17:44:44.302" v="1145" actId="165"/>
          <ac:picMkLst>
            <pc:docMk/>
            <pc:sldMk cId="1714374443" sldId="257"/>
            <ac:picMk id="18" creationId="{BFE89F43-6D77-41C3-B21C-EDCF87B01BE1}"/>
          </ac:picMkLst>
        </pc:picChg>
        <pc:picChg chg="mod topLvl">
          <ac:chgData name="li li" userId="3d7a94fd48c86d40" providerId="LiveId" clId="{2345AA29-D5AE-4783-9A1B-7E86E6AD882B}" dt="2018-05-08T17:44:44.302" v="1145" actId="165"/>
          <ac:picMkLst>
            <pc:docMk/>
            <pc:sldMk cId="1714374443" sldId="257"/>
            <ac:picMk id="20" creationId="{E7DF944E-1B49-486D-B843-97548BEEF49C}"/>
          </ac:picMkLst>
        </pc:picChg>
        <pc:picChg chg="add mod">
          <ac:chgData name="li li" userId="3d7a94fd48c86d40" providerId="LiveId" clId="{2345AA29-D5AE-4783-9A1B-7E86E6AD882B}" dt="2018-05-08T14:35:39.085" v="73" actId="1076"/>
          <ac:picMkLst>
            <pc:docMk/>
            <pc:sldMk cId="1714374443" sldId="257"/>
            <ac:picMk id="21" creationId="{5D93B257-5861-4A00-8AD2-91BF84B431FB}"/>
          </ac:picMkLst>
        </pc:picChg>
        <pc:picChg chg="mod topLvl">
          <ac:chgData name="li li" userId="3d7a94fd48c86d40" providerId="LiveId" clId="{2345AA29-D5AE-4783-9A1B-7E86E6AD882B}" dt="2018-05-08T17:44:44.302" v="1145" actId="165"/>
          <ac:picMkLst>
            <pc:docMk/>
            <pc:sldMk cId="1714374443" sldId="257"/>
            <ac:picMk id="22" creationId="{CC17A50D-0408-4AC6-8D4F-5389032E9215}"/>
          </ac:picMkLst>
        </pc:picChg>
        <pc:picChg chg="mod topLvl">
          <ac:chgData name="li li" userId="3d7a94fd48c86d40" providerId="LiveId" clId="{2345AA29-D5AE-4783-9A1B-7E86E6AD882B}" dt="2018-05-08T17:44:44.302" v="1145" actId="165"/>
          <ac:picMkLst>
            <pc:docMk/>
            <pc:sldMk cId="1714374443" sldId="257"/>
            <ac:picMk id="24" creationId="{A961A0CE-6DA5-42AE-986C-DB9972D7F9F8}"/>
          </ac:picMkLst>
        </pc:picChg>
        <pc:picChg chg="add mod">
          <ac:chgData name="li li" userId="3d7a94fd48c86d40" providerId="LiveId" clId="{2345AA29-D5AE-4783-9A1B-7E86E6AD882B}" dt="2018-05-08T16:51:18.878" v="431" actId="1076"/>
          <ac:picMkLst>
            <pc:docMk/>
            <pc:sldMk cId="1714374443" sldId="257"/>
            <ac:picMk id="25" creationId="{E7331110-8131-47C5-9CAC-64F58F905D71}"/>
          </ac:picMkLst>
        </pc:picChg>
        <pc:picChg chg="mod topLvl">
          <ac:chgData name="li li" userId="3d7a94fd48c86d40" providerId="LiveId" clId="{2345AA29-D5AE-4783-9A1B-7E86E6AD882B}" dt="2018-05-08T17:44:44.302" v="1145" actId="165"/>
          <ac:picMkLst>
            <pc:docMk/>
            <pc:sldMk cId="1714374443" sldId="257"/>
            <ac:picMk id="26" creationId="{D03BB8ED-7F9A-4ECE-BFAC-CD323EDBD1E0}"/>
          </ac:picMkLst>
        </pc:picChg>
        <pc:picChg chg="mod topLvl">
          <ac:chgData name="li li" userId="3d7a94fd48c86d40" providerId="LiveId" clId="{2345AA29-D5AE-4783-9A1B-7E86E6AD882B}" dt="2018-05-08T17:44:44.302" v="1145" actId="165"/>
          <ac:picMkLst>
            <pc:docMk/>
            <pc:sldMk cId="1714374443" sldId="257"/>
            <ac:picMk id="28" creationId="{72151227-A4BC-4667-BD22-7755407C3CE7}"/>
          </ac:picMkLst>
        </pc:picChg>
        <pc:picChg chg="add mod">
          <ac:chgData name="li li" userId="3d7a94fd48c86d40" providerId="LiveId" clId="{2345AA29-D5AE-4783-9A1B-7E86E6AD882B}" dt="2018-05-08T17:44:52.141" v="1146" actId="164"/>
          <ac:picMkLst>
            <pc:docMk/>
            <pc:sldMk cId="1714374443" sldId="257"/>
            <ac:picMk id="29" creationId="{3B587D0F-143F-4DD3-B833-42695755185C}"/>
          </ac:picMkLst>
        </pc:picChg>
        <pc:picChg chg="mod topLvl">
          <ac:chgData name="li li" userId="3d7a94fd48c86d40" providerId="LiveId" clId="{2345AA29-D5AE-4783-9A1B-7E86E6AD882B}" dt="2018-05-08T17:45:36.746" v="1149" actId="164"/>
          <ac:picMkLst>
            <pc:docMk/>
            <pc:sldMk cId="1714374443" sldId="257"/>
            <ac:picMk id="30" creationId="{BDCEFE3A-36E1-41F5-AF22-D5827F754121}"/>
          </ac:picMkLst>
        </pc:picChg>
        <pc:picChg chg="mod topLvl">
          <ac:chgData name="li li" userId="3d7a94fd48c86d40" providerId="LiveId" clId="{2345AA29-D5AE-4783-9A1B-7E86E6AD882B}" dt="2018-05-08T17:46:33.207" v="1152" actId="164"/>
          <ac:picMkLst>
            <pc:docMk/>
            <pc:sldMk cId="1714374443" sldId="257"/>
            <ac:picMk id="32" creationId="{D9EA22DE-5D7A-463E-B2BF-3FA38E03C184}"/>
          </ac:picMkLst>
        </pc:picChg>
        <pc:picChg chg="add mod">
          <ac:chgData name="li li" userId="3d7a94fd48c86d40" providerId="LiveId" clId="{2345AA29-D5AE-4783-9A1B-7E86E6AD882B}" dt="2018-05-08T16:52:44.576" v="443" actId="1076"/>
          <ac:picMkLst>
            <pc:docMk/>
            <pc:sldMk cId="1714374443" sldId="257"/>
            <ac:picMk id="33" creationId="{09378CF4-103F-456E-AAD3-AB6B0695CA27}"/>
          </ac:picMkLst>
        </pc:picChg>
        <pc:picChg chg="mod topLvl">
          <ac:chgData name="li li" userId="3d7a94fd48c86d40" providerId="LiveId" clId="{2345AA29-D5AE-4783-9A1B-7E86E6AD882B}" dt="2018-05-08T17:44:44.302" v="1145" actId="165"/>
          <ac:picMkLst>
            <pc:docMk/>
            <pc:sldMk cId="1714374443" sldId="257"/>
            <ac:picMk id="34" creationId="{3B0DDD21-8D92-4BC5-BF4D-E56C411184EC}"/>
          </ac:picMkLst>
        </pc:picChg>
        <pc:picChg chg="mod topLvl">
          <ac:chgData name="li li" userId="3d7a94fd48c86d40" providerId="LiveId" clId="{2345AA29-D5AE-4783-9A1B-7E86E6AD882B}" dt="2018-05-08T17:44:44.302" v="1145" actId="165"/>
          <ac:picMkLst>
            <pc:docMk/>
            <pc:sldMk cId="1714374443" sldId="257"/>
            <ac:picMk id="36" creationId="{AB18E8BC-A1AD-495B-8FA5-423F3F7F49BB}"/>
          </ac:picMkLst>
        </pc:picChg>
        <pc:picChg chg="mod topLvl">
          <ac:chgData name="li li" userId="3d7a94fd48c86d40" providerId="LiveId" clId="{2345AA29-D5AE-4783-9A1B-7E86E6AD882B}" dt="2018-05-08T17:44:44.302" v="1145" actId="165"/>
          <ac:picMkLst>
            <pc:docMk/>
            <pc:sldMk cId="1714374443" sldId="257"/>
            <ac:picMk id="38" creationId="{6C925F81-FA6D-4A75-92E1-6265879A94BD}"/>
          </ac:picMkLst>
        </pc:picChg>
        <pc:picChg chg="add mod">
          <ac:chgData name="li li" userId="3d7a94fd48c86d40" providerId="LiveId" clId="{2345AA29-D5AE-4783-9A1B-7E86E6AD882B}" dt="2018-05-08T16:53:49.808" v="451" actId="1076"/>
          <ac:picMkLst>
            <pc:docMk/>
            <pc:sldMk cId="1714374443" sldId="257"/>
            <ac:picMk id="39" creationId="{46108A21-957A-443B-A91A-7FC10FC2980F}"/>
          </ac:picMkLst>
        </pc:picChg>
        <pc:picChg chg="mod topLvl">
          <ac:chgData name="li li" userId="3d7a94fd48c86d40" providerId="LiveId" clId="{2345AA29-D5AE-4783-9A1B-7E86E6AD882B}" dt="2018-05-08T17:44:44.302" v="1145" actId="165"/>
          <ac:picMkLst>
            <pc:docMk/>
            <pc:sldMk cId="1714374443" sldId="257"/>
            <ac:picMk id="40" creationId="{5002C336-BA3D-4F71-B6DE-D45DCAD7BDF9}"/>
          </ac:picMkLst>
        </pc:picChg>
        <pc:picChg chg="mod topLvl">
          <ac:chgData name="li li" userId="3d7a94fd48c86d40" providerId="LiveId" clId="{2345AA29-D5AE-4783-9A1B-7E86E6AD882B}" dt="2018-05-08T17:44:44.302" v="1145" actId="165"/>
          <ac:picMkLst>
            <pc:docMk/>
            <pc:sldMk cId="1714374443" sldId="257"/>
            <ac:picMk id="42" creationId="{CBC8C696-B0EE-46D1-98CE-F875E638C9D9}"/>
          </ac:picMkLst>
        </pc:picChg>
        <pc:picChg chg="add mod">
          <ac:chgData name="li li" userId="3d7a94fd48c86d40" providerId="LiveId" clId="{2345AA29-D5AE-4783-9A1B-7E86E6AD882B}" dt="2018-05-08T16:54:13.818" v="455" actId="1076"/>
          <ac:picMkLst>
            <pc:docMk/>
            <pc:sldMk cId="1714374443" sldId="257"/>
            <ac:picMk id="43" creationId="{85CABF0D-B8F7-4507-A5C5-7B720088F9CF}"/>
          </ac:picMkLst>
        </pc:picChg>
        <pc:picChg chg="mod topLvl">
          <ac:chgData name="li li" userId="3d7a94fd48c86d40" providerId="LiveId" clId="{2345AA29-D5AE-4783-9A1B-7E86E6AD882B}" dt="2018-05-08T17:44:44.302" v="1145" actId="165"/>
          <ac:picMkLst>
            <pc:docMk/>
            <pc:sldMk cId="1714374443" sldId="257"/>
            <ac:picMk id="44" creationId="{1C068310-2F96-4688-A3DA-C5050094F585}"/>
          </ac:picMkLst>
        </pc:picChg>
        <pc:picChg chg="mod topLvl">
          <ac:chgData name="li li" userId="3d7a94fd48c86d40" providerId="LiveId" clId="{2345AA29-D5AE-4783-9A1B-7E86E6AD882B}" dt="2018-05-08T13:46:54.242" v="0" actId="165"/>
          <ac:picMkLst>
            <pc:docMk/>
            <pc:sldMk cId="1714374443" sldId="257"/>
            <ac:picMk id="46" creationId="{0360250B-B419-449E-9AB0-79DF9F392AF5}"/>
          </ac:picMkLst>
        </pc:picChg>
        <pc:picChg chg="mod topLvl">
          <ac:chgData name="li li" userId="3d7a94fd48c86d40" providerId="LiveId" clId="{2345AA29-D5AE-4783-9A1B-7E86E6AD882B}" dt="2018-05-08T13:46:54.242" v="0" actId="165"/>
          <ac:picMkLst>
            <pc:docMk/>
            <pc:sldMk cId="1714374443" sldId="257"/>
            <ac:picMk id="47" creationId="{B31BFEE3-CE4A-4E7A-87C1-4947A989CDC5}"/>
          </ac:picMkLst>
        </pc:picChg>
        <pc:picChg chg="add mod">
          <ac:chgData name="li li" userId="3d7a94fd48c86d40" providerId="LiveId" clId="{2345AA29-D5AE-4783-9A1B-7E86E6AD882B}" dt="2018-05-08T17:34:17.362" v="1063" actId="1076"/>
          <ac:picMkLst>
            <pc:docMk/>
            <pc:sldMk cId="1714374443" sldId="257"/>
            <ac:picMk id="53" creationId="{BEECC29E-B499-4232-AC48-9B6ABE831417}"/>
          </ac:picMkLst>
        </pc:picChg>
        <pc:picChg chg="add mod">
          <ac:chgData name="li li" userId="3d7a94fd48c86d40" providerId="LiveId" clId="{2345AA29-D5AE-4783-9A1B-7E86E6AD882B}" dt="2018-05-08T16:56:21.151" v="479" actId="1076"/>
          <ac:picMkLst>
            <pc:docMk/>
            <pc:sldMk cId="1714374443" sldId="257"/>
            <ac:picMk id="56" creationId="{675A3558-9026-415F-A619-7CBAB4DAADFC}"/>
          </ac:picMkLst>
        </pc:picChg>
        <pc:picChg chg="add mod">
          <ac:chgData name="li li" userId="3d7a94fd48c86d40" providerId="LiveId" clId="{2345AA29-D5AE-4783-9A1B-7E86E6AD882B}" dt="2018-05-08T16:56:26.224" v="480" actId="1076"/>
          <ac:picMkLst>
            <pc:docMk/>
            <pc:sldMk cId="1714374443" sldId="257"/>
            <ac:picMk id="58" creationId="{A1D0D226-0EE0-4270-B4F8-1610307474A1}"/>
          </ac:picMkLst>
        </pc:picChg>
        <pc:picChg chg="add mod">
          <ac:chgData name="li li" userId="3d7a94fd48c86d40" providerId="LiveId" clId="{2345AA29-D5AE-4783-9A1B-7E86E6AD882B}" dt="2018-05-08T16:56:32.283" v="481" actId="1076"/>
          <ac:picMkLst>
            <pc:docMk/>
            <pc:sldMk cId="1714374443" sldId="257"/>
            <ac:picMk id="60" creationId="{6F324D4B-FEB1-48CF-A7B4-9B3466E7D98C}"/>
          </ac:picMkLst>
        </pc:picChg>
        <pc:picChg chg="add mod">
          <ac:chgData name="li li" userId="3d7a94fd48c86d40" providerId="LiveId" clId="{2345AA29-D5AE-4783-9A1B-7E86E6AD882B}" dt="2018-05-08T16:59:45.937" v="499" actId="1076"/>
          <ac:picMkLst>
            <pc:docMk/>
            <pc:sldMk cId="1714374443" sldId="257"/>
            <ac:picMk id="62" creationId="{A3333307-ABDD-4233-ACCA-75EE5404F6BB}"/>
          </ac:picMkLst>
        </pc:picChg>
        <pc:picChg chg="add mod">
          <ac:chgData name="li li" userId="3d7a94fd48c86d40" providerId="LiveId" clId="{2345AA29-D5AE-4783-9A1B-7E86E6AD882B}" dt="2018-05-08T17:45:36.746" v="1149" actId="164"/>
          <ac:picMkLst>
            <pc:docMk/>
            <pc:sldMk cId="1714374443" sldId="257"/>
            <ac:picMk id="64" creationId="{53945672-E166-4CCE-9066-AEB6D016CB46}"/>
          </ac:picMkLst>
        </pc:picChg>
        <pc:picChg chg="add mod">
          <ac:chgData name="li li" userId="3d7a94fd48c86d40" providerId="LiveId" clId="{2345AA29-D5AE-4783-9A1B-7E86E6AD882B}" dt="2018-05-08T17:46:33.207" v="1152" actId="164"/>
          <ac:picMkLst>
            <pc:docMk/>
            <pc:sldMk cId="1714374443" sldId="257"/>
            <ac:picMk id="66" creationId="{BD025E90-BABD-4188-9617-2A4D12FFD4E5}"/>
          </ac:picMkLst>
        </pc:picChg>
        <pc:picChg chg="add mod">
          <ac:chgData name="li li" userId="3d7a94fd48c86d40" providerId="LiveId" clId="{2345AA29-D5AE-4783-9A1B-7E86E6AD882B}" dt="2018-05-08T16:55:14.981" v="462" actId="1076"/>
          <ac:picMkLst>
            <pc:docMk/>
            <pc:sldMk cId="1714374443" sldId="257"/>
            <ac:picMk id="68" creationId="{E817F0E2-5A3A-4FAF-AA38-F3B1DCCD730C}"/>
          </ac:picMkLst>
        </pc:picChg>
        <pc:picChg chg="add mod">
          <ac:chgData name="li li" userId="3d7a94fd48c86d40" providerId="LiveId" clId="{2345AA29-D5AE-4783-9A1B-7E86E6AD882B}" dt="2018-05-08T16:55:17.908" v="463" actId="1076"/>
          <ac:picMkLst>
            <pc:docMk/>
            <pc:sldMk cId="1714374443" sldId="257"/>
            <ac:picMk id="70" creationId="{12C9D58E-C38B-40CA-8231-0CEAA932CEC0}"/>
          </ac:picMkLst>
        </pc:picChg>
        <pc:picChg chg="add mod">
          <ac:chgData name="li li" userId="3d7a94fd48c86d40" providerId="LiveId" clId="{2345AA29-D5AE-4783-9A1B-7E86E6AD882B}" dt="2018-05-08T16:55:22.325" v="464" actId="1076"/>
          <ac:picMkLst>
            <pc:docMk/>
            <pc:sldMk cId="1714374443" sldId="257"/>
            <ac:picMk id="72" creationId="{3922E27A-8038-4127-ADD9-0FE916A23256}"/>
          </ac:picMkLst>
        </pc:picChg>
        <pc:picChg chg="add mod">
          <ac:chgData name="li li" userId="3d7a94fd48c86d40" providerId="LiveId" clId="{2345AA29-D5AE-4783-9A1B-7E86E6AD882B}" dt="2018-05-08T16:57:09.553" v="483" actId="1076"/>
          <ac:picMkLst>
            <pc:docMk/>
            <pc:sldMk cId="1714374443" sldId="257"/>
            <ac:picMk id="74" creationId="{F2F7AE18-F2D7-44F2-AF73-EA69AEF6B6D4}"/>
          </ac:picMkLst>
        </pc:picChg>
        <pc:picChg chg="add mod">
          <ac:chgData name="li li" userId="3d7a94fd48c86d40" providerId="LiveId" clId="{2345AA29-D5AE-4783-9A1B-7E86E6AD882B}" dt="2018-05-08T16:55:44.593" v="465" actId="1076"/>
          <ac:picMkLst>
            <pc:docMk/>
            <pc:sldMk cId="1714374443" sldId="257"/>
            <ac:picMk id="76" creationId="{F88C9C09-A12D-4BCA-A3D2-2E9DBA0FBC39}"/>
          </ac:picMkLst>
        </pc:picChg>
        <pc:picChg chg="add mod">
          <ac:chgData name="li li" userId="3d7a94fd48c86d40" providerId="LiveId" clId="{2345AA29-D5AE-4783-9A1B-7E86E6AD882B}" dt="2018-05-08T16:57:18.608" v="484" actId="1076"/>
          <ac:picMkLst>
            <pc:docMk/>
            <pc:sldMk cId="1714374443" sldId="257"/>
            <ac:picMk id="78" creationId="{8624A35E-19DA-4F95-AFC3-48201A512413}"/>
          </ac:picMkLst>
        </pc:picChg>
        <pc:picChg chg="add mod">
          <ac:chgData name="li li" userId="3d7a94fd48c86d40" providerId="LiveId" clId="{2345AA29-D5AE-4783-9A1B-7E86E6AD882B}" dt="2018-05-08T16:57:21.471" v="485" actId="1076"/>
          <ac:picMkLst>
            <pc:docMk/>
            <pc:sldMk cId="1714374443" sldId="257"/>
            <ac:picMk id="80" creationId="{30D2B63C-04E8-4BB2-A805-FE6BAA73FFAC}"/>
          </ac:picMkLst>
        </pc:picChg>
        <pc:picChg chg="add mod">
          <ac:chgData name="li li" userId="3d7a94fd48c86d40" providerId="LiveId" clId="{2345AA29-D5AE-4783-9A1B-7E86E6AD882B}" dt="2018-05-08T17:05:54.771" v="582" actId="1038"/>
          <ac:picMkLst>
            <pc:docMk/>
            <pc:sldMk cId="1714374443" sldId="257"/>
            <ac:picMk id="82" creationId="{2B79CD73-F71B-41DE-807D-6B1D9F30DCD1}"/>
          </ac:picMkLst>
        </pc:picChg>
        <pc:cxnChg chg="add del mod">
          <ac:chgData name="li li" userId="3d7a94fd48c86d40" providerId="LiveId" clId="{2345AA29-D5AE-4783-9A1B-7E86E6AD882B}" dt="2018-05-09T07:23:21.530" v="2348" actId="478"/>
          <ac:cxnSpMkLst>
            <pc:docMk/>
            <pc:sldMk cId="1714374443" sldId="257"/>
            <ac:cxnSpMk id="3" creationId="{2396CED3-F7B1-44BA-BD83-F203F57D9CCA}"/>
          </ac:cxnSpMkLst>
        </pc:cxnChg>
      </pc:sldChg>
      <pc:sldChg chg="addSp delSp modSp">
        <pc:chgData name="li li" userId="3d7a94fd48c86d40" providerId="LiveId" clId="{2345AA29-D5AE-4783-9A1B-7E86E6AD882B}" dt="2018-05-08T17:49:32.908" v="1164" actId="164"/>
        <pc:sldMkLst>
          <pc:docMk/>
          <pc:sldMk cId="1654897909" sldId="258"/>
        </pc:sldMkLst>
        <pc:spChg chg="mod topLvl">
          <ac:chgData name="li li" userId="3d7a94fd48c86d40" providerId="LiveId" clId="{2345AA29-D5AE-4783-9A1B-7E86E6AD882B}" dt="2018-05-08T17:37:05.212" v="1124" actId="164"/>
          <ac:spMkLst>
            <pc:docMk/>
            <pc:sldMk cId="1654897909" sldId="258"/>
            <ac:spMk id="2" creationId="{4876AAFE-3C69-409B-A1A1-D6AE874AED07}"/>
          </ac:spMkLst>
        </pc:spChg>
        <pc:spChg chg="mod topLvl">
          <ac:chgData name="li li" userId="3d7a94fd48c86d40" providerId="LiveId" clId="{2345AA29-D5AE-4783-9A1B-7E86E6AD882B}" dt="2018-05-08T17:47:43.744" v="1157" actId="165"/>
          <ac:spMkLst>
            <pc:docMk/>
            <pc:sldMk cId="1654897909" sldId="258"/>
            <ac:spMk id="5" creationId="{A2C6C48B-AC14-432E-B498-35EA8A961C9E}"/>
          </ac:spMkLst>
        </pc:spChg>
        <pc:spChg chg="mod topLvl">
          <ac:chgData name="li li" userId="3d7a94fd48c86d40" providerId="LiveId" clId="{2345AA29-D5AE-4783-9A1B-7E86E6AD882B}" dt="2018-05-08T17:49:32.908" v="1164" actId="164"/>
          <ac:spMkLst>
            <pc:docMk/>
            <pc:sldMk cId="1654897909" sldId="258"/>
            <ac:spMk id="6" creationId="{06B9D8AD-3BD7-44D1-997E-EAA9076BD25F}"/>
          </ac:spMkLst>
        </pc:spChg>
        <pc:spChg chg="mod topLvl">
          <ac:chgData name="li li" userId="3d7a94fd48c86d40" providerId="LiveId" clId="{2345AA29-D5AE-4783-9A1B-7E86E6AD882B}" dt="2018-05-08T17:47:43.744" v="1157" actId="165"/>
          <ac:spMkLst>
            <pc:docMk/>
            <pc:sldMk cId="1654897909" sldId="258"/>
            <ac:spMk id="7" creationId="{832CB6D3-B7BA-4FD1-8A75-D39E1B412A90}"/>
          </ac:spMkLst>
        </pc:spChg>
        <pc:spChg chg="mod topLvl">
          <ac:chgData name="li li" userId="3d7a94fd48c86d40" providerId="LiveId" clId="{2345AA29-D5AE-4783-9A1B-7E86E6AD882B}" dt="2018-05-08T17:47:43.744" v="1157" actId="165"/>
          <ac:spMkLst>
            <pc:docMk/>
            <pc:sldMk cId="1654897909" sldId="258"/>
            <ac:spMk id="8" creationId="{F7362119-5E2D-4F1B-894C-8B15B2087B14}"/>
          </ac:spMkLst>
        </pc:spChg>
        <pc:spChg chg="mod topLvl">
          <ac:chgData name="li li" userId="3d7a94fd48c86d40" providerId="LiveId" clId="{2345AA29-D5AE-4783-9A1B-7E86E6AD882B}" dt="2018-05-08T17:23:20.786" v="892" actId="1038"/>
          <ac:spMkLst>
            <pc:docMk/>
            <pc:sldMk cId="1654897909" sldId="258"/>
            <ac:spMk id="9" creationId="{264C7D05-A4A8-45C1-9F8D-AC4433ABDEC3}"/>
          </ac:spMkLst>
        </pc:spChg>
        <pc:spChg chg="mod topLvl">
          <ac:chgData name="li li" userId="3d7a94fd48c86d40" providerId="LiveId" clId="{2345AA29-D5AE-4783-9A1B-7E86E6AD882B}" dt="2018-05-08T17:23:10.113" v="875" actId="1037"/>
          <ac:spMkLst>
            <pc:docMk/>
            <pc:sldMk cId="1654897909" sldId="258"/>
            <ac:spMk id="10" creationId="{09DB2E7D-932C-4F92-BDDE-3DC207943EFF}"/>
          </ac:spMkLst>
        </pc:spChg>
        <pc:spChg chg="mod topLvl">
          <ac:chgData name="li li" userId="3d7a94fd48c86d40" providerId="LiveId" clId="{2345AA29-D5AE-4783-9A1B-7E86E6AD882B}" dt="2018-05-08T17:23:02.659" v="869" actId="1038"/>
          <ac:spMkLst>
            <pc:docMk/>
            <pc:sldMk cId="1654897909" sldId="258"/>
            <ac:spMk id="11" creationId="{5E456FB8-2C36-42E0-9337-E53488825FCA}"/>
          </ac:spMkLst>
        </pc:spChg>
        <pc:spChg chg="mod topLvl">
          <ac:chgData name="li li" userId="3d7a94fd48c86d40" providerId="LiveId" clId="{2345AA29-D5AE-4783-9A1B-7E86E6AD882B}" dt="2018-05-08T17:23:28.823" v="902" actId="1038"/>
          <ac:spMkLst>
            <pc:docMk/>
            <pc:sldMk cId="1654897909" sldId="258"/>
            <ac:spMk id="12" creationId="{BD666712-99E7-4056-AC8A-ABFE8E26539F}"/>
          </ac:spMkLst>
        </pc:spChg>
        <pc:spChg chg="add ord">
          <ac:chgData name="li li" userId="3d7a94fd48c86d40" providerId="LiveId" clId="{2345AA29-D5AE-4783-9A1B-7E86E6AD882B}" dt="2018-05-08T17:08:32.363" v="665" actId="167"/>
          <ac:spMkLst>
            <pc:docMk/>
            <pc:sldMk cId="1654897909" sldId="258"/>
            <ac:spMk id="34" creationId="{FED6F35A-35CD-4882-A17E-F76DF62E6B88}"/>
          </ac:spMkLst>
        </pc:spChg>
        <pc:grpChg chg="add del mod">
          <ac:chgData name="li li" userId="3d7a94fd48c86d40" providerId="LiveId" clId="{2345AA29-D5AE-4783-9A1B-7E86E6AD882B}" dt="2018-05-08T17:47:43.744" v="1157" actId="165"/>
          <ac:grpSpMkLst>
            <pc:docMk/>
            <pc:sldMk cId="1654897909" sldId="258"/>
            <ac:grpSpMk id="13" creationId="{9117BD98-2227-4955-861D-DAC614F9D473}"/>
          </ac:grpSpMkLst>
        </pc:grpChg>
        <pc:grpChg chg="add del mod">
          <ac:chgData name="li li" userId="3d7a94fd48c86d40" providerId="LiveId" clId="{2345AA29-D5AE-4783-9A1B-7E86E6AD882B}" dt="2018-05-08T17:47:43.744" v="1157" actId="165"/>
          <ac:grpSpMkLst>
            <pc:docMk/>
            <pc:sldMk cId="1654897909" sldId="258"/>
            <ac:grpSpMk id="15" creationId="{DFA53B43-AEF0-47D9-AF81-5463550B4A1A}"/>
          </ac:grpSpMkLst>
        </pc:grpChg>
        <pc:grpChg chg="add del mod">
          <ac:chgData name="li li" userId="3d7a94fd48c86d40" providerId="LiveId" clId="{2345AA29-D5AE-4783-9A1B-7E86E6AD882B}" dt="2018-05-08T17:47:43.744" v="1157" actId="165"/>
          <ac:grpSpMkLst>
            <pc:docMk/>
            <pc:sldMk cId="1654897909" sldId="258"/>
            <ac:grpSpMk id="17" creationId="{FD3445B5-DBA6-44D2-9289-AE66C6FDF83C}"/>
          </ac:grpSpMkLst>
        </pc:grpChg>
        <pc:grpChg chg="add del mod">
          <ac:chgData name="li li" userId="3d7a94fd48c86d40" providerId="LiveId" clId="{2345AA29-D5AE-4783-9A1B-7E86E6AD882B}" dt="2018-05-08T17:47:43.744" v="1157" actId="165"/>
          <ac:grpSpMkLst>
            <pc:docMk/>
            <pc:sldMk cId="1654897909" sldId="258"/>
            <ac:grpSpMk id="19" creationId="{0AD25FB4-6394-44FC-914A-11FA3C11D86C}"/>
          </ac:grpSpMkLst>
        </pc:grpChg>
        <pc:grpChg chg="del">
          <ac:chgData name="li li" userId="3d7a94fd48c86d40" providerId="LiveId" clId="{2345AA29-D5AE-4783-9A1B-7E86E6AD882B}" dt="2018-05-08T13:47:33.320" v="5" actId="165"/>
          <ac:grpSpMkLst>
            <pc:docMk/>
            <pc:sldMk cId="1654897909" sldId="258"/>
            <ac:grpSpMk id="48" creationId="{0D1B887B-DE99-423C-9D9B-CFAF4E783275}"/>
          </ac:grpSpMkLst>
        </pc:grpChg>
        <pc:grpChg chg="add mod">
          <ac:chgData name="li li" userId="3d7a94fd48c86d40" providerId="LiveId" clId="{2345AA29-D5AE-4783-9A1B-7E86E6AD882B}" dt="2018-05-08T17:47:50.273" v="1158" actId="164"/>
          <ac:grpSpMkLst>
            <pc:docMk/>
            <pc:sldMk cId="1654897909" sldId="258"/>
            <ac:grpSpMk id="86" creationId="{D1E1E568-FC6C-4CDC-B3FB-095433A44343}"/>
          </ac:grpSpMkLst>
        </pc:grpChg>
        <pc:grpChg chg="add mod">
          <ac:chgData name="li li" userId="3d7a94fd48c86d40" providerId="LiveId" clId="{2345AA29-D5AE-4783-9A1B-7E86E6AD882B}" dt="2018-05-08T17:48:43.206" v="1161" actId="164"/>
          <ac:grpSpMkLst>
            <pc:docMk/>
            <pc:sldMk cId="1654897909" sldId="258"/>
            <ac:grpSpMk id="87" creationId="{67544689-53D9-48B0-9B00-ED2B475ECADF}"/>
          </ac:grpSpMkLst>
        </pc:grpChg>
        <pc:grpChg chg="add mod">
          <ac:chgData name="li li" userId="3d7a94fd48c86d40" providerId="LiveId" clId="{2345AA29-D5AE-4783-9A1B-7E86E6AD882B}" dt="2018-05-08T17:49:32.908" v="1164" actId="164"/>
          <ac:grpSpMkLst>
            <pc:docMk/>
            <pc:sldMk cId="1654897909" sldId="258"/>
            <ac:grpSpMk id="88" creationId="{96A06CAD-8564-4834-A31A-B1578DDF003F}"/>
          </ac:grpSpMkLst>
        </pc:grpChg>
        <pc:graphicFrameChg chg="add del">
          <ac:chgData name="li li" userId="3d7a94fd48c86d40" providerId="LiveId" clId="{2345AA29-D5AE-4783-9A1B-7E86E6AD882B}" dt="2018-05-08T17:09:11.207" v="667" actId="164"/>
          <ac:graphicFrameMkLst>
            <pc:docMk/>
            <pc:sldMk cId="1654897909" sldId="258"/>
            <ac:graphicFrameMk id="37" creationId="{AC2955D9-74B4-4889-B0E9-6AD9ADDF4091}"/>
          </ac:graphicFrameMkLst>
        </pc:graphicFrameChg>
        <pc:graphicFrameChg chg="add del">
          <ac:chgData name="li li" userId="3d7a94fd48c86d40" providerId="LiveId" clId="{2345AA29-D5AE-4783-9A1B-7E86E6AD882B}" dt="2018-05-08T17:09:32.501" v="672" actId="164"/>
          <ac:graphicFrameMkLst>
            <pc:docMk/>
            <pc:sldMk cId="1654897909" sldId="258"/>
            <ac:graphicFrameMk id="40" creationId="{2E646DCB-1017-4956-A84B-01630F3DF03A}"/>
          </ac:graphicFrameMkLst>
        </pc:graphicFrameChg>
        <pc:graphicFrameChg chg="add del">
          <ac:chgData name="li li" userId="3d7a94fd48c86d40" providerId="LiveId" clId="{2345AA29-D5AE-4783-9A1B-7E86E6AD882B}" dt="2018-05-08T17:09:57.804" v="681" actId="164"/>
          <ac:graphicFrameMkLst>
            <pc:docMk/>
            <pc:sldMk cId="1654897909" sldId="258"/>
            <ac:graphicFrameMk id="44" creationId="{60565C92-DBA3-4EF2-814E-46EE607E517B}"/>
          </ac:graphicFrameMkLst>
        </pc:graphicFrameChg>
        <pc:graphicFrameChg chg="add del">
          <ac:chgData name="li li" userId="3d7a94fd48c86d40" providerId="LiveId" clId="{2345AA29-D5AE-4783-9A1B-7E86E6AD882B}" dt="2018-05-08T17:10:21.534" v="686" actId="164"/>
          <ac:graphicFrameMkLst>
            <pc:docMk/>
            <pc:sldMk cId="1654897909" sldId="258"/>
            <ac:graphicFrameMk id="49" creationId="{917888A3-22F5-4A55-92CA-C369B8E44530}"/>
          </ac:graphicFrameMkLst>
        </pc:graphicFrameChg>
        <pc:graphicFrameChg chg="add del">
          <ac:chgData name="li li" userId="3d7a94fd48c86d40" providerId="LiveId" clId="{2345AA29-D5AE-4783-9A1B-7E86E6AD882B}" dt="2018-05-08T17:10:44.069" v="691" actId="164"/>
          <ac:graphicFrameMkLst>
            <pc:docMk/>
            <pc:sldMk cId="1654897909" sldId="258"/>
            <ac:graphicFrameMk id="51" creationId="{4EC45A2C-5CBB-4EED-978B-768520119FC4}"/>
          </ac:graphicFrameMkLst>
        </pc:graphicFrameChg>
        <pc:graphicFrameChg chg="add del">
          <ac:chgData name="li li" userId="3d7a94fd48c86d40" providerId="LiveId" clId="{2345AA29-D5AE-4783-9A1B-7E86E6AD882B}" dt="2018-05-08T17:11:06.340" v="696" actId="164"/>
          <ac:graphicFrameMkLst>
            <pc:docMk/>
            <pc:sldMk cId="1654897909" sldId="258"/>
            <ac:graphicFrameMk id="53" creationId="{C799CFB2-D1B7-44C0-89C0-04D9878C73FF}"/>
          </ac:graphicFrameMkLst>
        </pc:graphicFrameChg>
        <pc:graphicFrameChg chg="add del modGraphic">
          <ac:chgData name="li li" userId="3d7a94fd48c86d40" providerId="LiveId" clId="{2345AA29-D5AE-4783-9A1B-7E86E6AD882B}" dt="2018-05-08T17:11:35.445" v="703" actId="164"/>
          <ac:graphicFrameMkLst>
            <pc:docMk/>
            <pc:sldMk cId="1654897909" sldId="258"/>
            <ac:graphicFrameMk id="55" creationId="{5034DD28-D86B-417B-9FA7-5B0636698E3B}"/>
          </ac:graphicFrameMkLst>
        </pc:graphicFrameChg>
        <pc:graphicFrameChg chg="add del">
          <ac:chgData name="li li" userId="3d7a94fd48c86d40" providerId="LiveId" clId="{2345AA29-D5AE-4783-9A1B-7E86E6AD882B}" dt="2018-05-08T17:11:39.465" v="705" actId="164"/>
          <ac:graphicFrameMkLst>
            <pc:docMk/>
            <pc:sldMk cId="1654897909" sldId="258"/>
            <ac:graphicFrameMk id="56" creationId="{9C318450-C819-4383-8538-F21C17A8735A}"/>
          </ac:graphicFrameMkLst>
        </pc:graphicFrameChg>
        <pc:graphicFrameChg chg="add del">
          <ac:chgData name="li li" userId="3d7a94fd48c86d40" providerId="LiveId" clId="{2345AA29-D5AE-4783-9A1B-7E86E6AD882B}" dt="2018-05-08T17:11:57.412" v="710" actId="164"/>
          <ac:graphicFrameMkLst>
            <pc:docMk/>
            <pc:sldMk cId="1654897909" sldId="258"/>
            <ac:graphicFrameMk id="58" creationId="{7C073E5F-0861-43A9-9FE8-991619572B8B}"/>
          </ac:graphicFrameMkLst>
        </pc:graphicFrameChg>
        <pc:graphicFrameChg chg="add del">
          <ac:chgData name="li li" userId="3d7a94fd48c86d40" providerId="LiveId" clId="{2345AA29-D5AE-4783-9A1B-7E86E6AD882B}" dt="2018-05-08T17:12:13.756" v="715" actId="164"/>
          <ac:graphicFrameMkLst>
            <pc:docMk/>
            <pc:sldMk cId="1654897909" sldId="258"/>
            <ac:graphicFrameMk id="60" creationId="{01E75824-BFC1-46F9-87D0-AF100F6CBDBD}"/>
          </ac:graphicFrameMkLst>
        </pc:graphicFrameChg>
        <pc:graphicFrameChg chg="add del">
          <ac:chgData name="li li" userId="3d7a94fd48c86d40" providerId="LiveId" clId="{2345AA29-D5AE-4783-9A1B-7E86E6AD882B}" dt="2018-05-08T17:12:30.774" v="720" actId="164"/>
          <ac:graphicFrameMkLst>
            <pc:docMk/>
            <pc:sldMk cId="1654897909" sldId="258"/>
            <ac:graphicFrameMk id="62" creationId="{D5306592-7A6F-4992-A23B-42DDC2952A8B}"/>
          </ac:graphicFrameMkLst>
        </pc:graphicFrameChg>
        <pc:graphicFrameChg chg="add del">
          <ac:chgData name="li li" userId="3d7a94fd48c86d40" providerId="LiveId" clId="{2345AA29-D5AE-4783-9A1B-7E86E6AD882B}" dt="2018-05-08T17:13:06.295" v="725" actId="164"/>
          <ac:graphicFrameMkLst>
            <pc:docMk/>
            <pc:sldMk cId="1654897909" sldId="258"/>
            <ac:graphicFrameMk id="64" creationId="{D38F60CE-73D2-4C88-BC30-C816EE7C2A08}"/>
          </ac:graphicFrameMkLst>
        </pc:graphicFrameChg>
        <pc:graphicFrameChg chg="add del">
          <ac:chgData name="li li" userId="3d7a94fd48c86d40" providerId="LiveId" clId="{2345AA29-D5AE-4783-9A1B-7E86E6AD882B}" dt="2018-05-08T17:13:25.101" v="730" actId="164"/>
          <ac:graphicFrameMkLst>
            <pc:docMk/>
            <pc:sldMk cId="1654897909" sldId="258"/>
            <ac:graphicFrameMk id="66" creationId="{A7EC31C6-F64F-436A-B758-E35AAEA03651}"/>
          </ac:graphicFrameMkLst>
        </pc:graphicFrameChg>
        <pc:graphicFrameChg chg="add del">
          <ac:chgData name="li li" userId="3d7a94fd48c86d40" providerId="LiveId" clId="{2345AA29-D5AE-4783-9A1B-7E86E6AD882B}" dt="2018-05-08T17:13:43.144" v="739" actId="164"/>
          <ac:graphicFrameMkLst>
            <pc:docMk/>
            <pc:sldMk cId="1654897909" sldId="258"/>
            <ac:graphicFrameMk id="68" creationId="{96F84FAF-83BA-47D3-B8C7-FCB5CFF231AE}"/>
          </ac:graphicFrameMkLst>
        </pc:graphicFrameChg>
        <pc:graphicFrameChg chg="add del">
          <ac:chgData name="li li" userId="3d7a94fd48c86d40" providerId="LiveId" clId="{2345AA29-D5AE-4783-9A1B-7E86E6AD882B}" dt="2018-05-08T17:14:01.489" v="744" actId="164"/>
          <ac:graphicFrameMkLst>
            <pc:docMk/>
            <pc:sldMk cId="1654897909" sldId="258"/>
            <ac:graphicFrameMk id="70" creationId="{F0923BF7-44AC-4FAA-B580-D2978257713B}"/>
          </ac:graphicFrameMkLst>
        </pc:graphicFrameChg>
        <pc:graphicFrameChg chg="add del">
          <ac:chgData name="li li" userId="3d7a94fd48c86d40" providerId="LiveId" clId="{2345AA29-D5AE-4783-9A1B-7E86E6AD882B}" dt="2018-05-08T17:14:19.002" v="751" actId="164"/>
          <ac:graphicFrameMkLst>
            <pc:docMk/>
            <pc:sldMk cId="1654897909" sldId="258"/>
            <ac:graphicFrameMk id="72" creationId="{C5856C19-2159-46BC-8FE3-00F2656B8102}"/>
          </ac:graphicFrameMkLst>
        </pc:graphicFrameChg>
        <pc:graphicFrameChg chg="add del">
          <ac:chgData name="li li" userId="3d7a94fd48c86d40" providerId="LiveId" clId="{2345AA29-D5AE-4783-9A1B-7E86E6AD882B}" dt="2018-05-08T17:14:50.742" v="758" actId="164"/>
          <ac:graphicFrameMkLst>
            <pc:docMk/>
            <pc:sldMk cId="1654897909" sldId="258"/>
            <ac:graphicFrameMk id="74" creationId="{8A12E234-6AC2-4243-AF66-08D4DF31CC61}"/>
          </ac:graphicFrameMkLst>
        </pc:graphicFrameChg>
        <pc:graphicFrameChg chg="add del">
          <ac:chgData name="li li" userId="3d7a94fd48c86d40" providerId="LiveId" clId="{2345AA29-D5AE-4783-9A1B-7E86E6AD882B}" dt="2018-05-08T17:14:58.793" v="760" actId="164"/>
          <ac:graphicFrameMkLst>
            <pc:docMk/>
            <pc:sldMk cId="1654897909" sldId="258"/>
            <ac:graphicFrameMk id="75" creationId="{39A8B5A4-9AC6-4C62-986F-71BFD7555C7F}"/>
          </ac:graphicFrameMkLst>
        </pc:graphicFrameChg>
        <pc:graphicFrameChg chg="add del">
          <ac:chgData name="li li" userId="3d7a94fd48c86d40" providerId="LiveId" clId="{2345AA29-D5AE-4783-9A1B-7E86E6AD882B}" dt="2018-05-08T17:15:02.438" v="764" actId="164"/>
          <ac:graphicFrameMkLst>
            <pc:docMk/>
            <pc:sldMk cId="1654897909" sldId="258"/>
            <ac:graphicFrameMk id="76" creationId="{1E3EFE5B-1B59-48EA-9106-5351A880C16A}"/>
          </ac:graphicFrameMkLst>
        </pc:graphicFrameChg>
        <pc:graphicFrameChg chg="add del">
          <ac:chgData name="li li" userId="3d7a94fd48c86d40" providerId="LiveId" clId="{2345AA29-D5AE-4783-9A1B-7E86E6AD882B}" dt="2018-05-08T17:15:21.713" v="771" actId="164"/>
          <ac:graphicFrameMkLst>
            <pc:docMk/>
            <pc:sldMk cId="1654897909" sldId="258"/>
            <ac:graphicFrameMk id="78" creationId="{223DED64-A193-4EE9-8110-1C5419481EFA}"/>
          </ac:graphicFrameMkLst>
        </pc:graphicFrameChg>
        <pc:graphicFrameChg chg="add del">
          <ac:chgData name="li li" userId="3d7a94fd48c86d40" providerId="LiveId" clId="{2345AA29-D5AE-4783-9A1B-7E86E6AD882B}" dt="2018-05-08T17:15:36.910" v="776" actId="164"/>
          <ac:graphicFrameMkLst>
            <pc:docMk/>
            <pc:sldMk cId="1654897909" sldId="258"/>
            <ac:graphicFrameMk id="80" creationId="{0329C58E-6661-49E9-BA70-29F5BF505AFE}"/>
          </ac:graphicFrameMkLst>
        </pc:graphicFrameChg>
        <pc:graphicFrameChg chg="add del">
          <ac:chgData name="li li" userId="3d7a94fd48c86d40" providerId="LiveId" clId="{2345AA29-D5AE-4783-9A1B-7E86E6AD882B}" dt="2018-05-08T17:15:53.505" v="781" actId="164"/>
          <ac:graphicFrameMkLst>
            <pc:docMk/>
            <pc:sldMk cId="1654897909" sldId="258"/>
            <ac:graphicFrameMk id="82" creationId="{85FE7E47-D933-4B01-A3EF-7ABE67E4D9E6}"/>
          </ac:graphicFrameMkLst>
        </pc:graphicFrameChg>
        <pc:graphicFrameChg chg="add del">
          <ac:chgData name="li li" userId="3d7a94fd48c86d40" providerId="LiveId" clId="{2345AA29-D5AE-4783-9A1B-7E86E6AD882B}" dt="2018-05-08T17:16:13.969" v="788" actId="164"/>
          <ac:graphicFrameMkLst>
            <pc:docMk/>
            <pc:sldMk cId="1654897909" sldId="258"/>
            <ac:graphicFrameMk id="84" creationId="{11B61890-98B7-4DF7-8C04-4E879E77A93E}"/>
          </ac:graphicFrameMkLst>
        </pc:graphicFrameChg>
        <pc:picChg chg="mod topLvl">
          <ac:chgData name="li li" userId="3d7a94fd48c86d40" providerId="LiveId" clId="{2345AA29-D5AE-4783-9A1B-7E86E6AD882B}" dt="2018-05-08T13:47:33.320" v="5" actId="165"/>
          <ac:picMkLst>
            <pc:docMk/>
            <pc:sldMk cId="1654897909" sldId="258"/>
            <ac:picMk id="3" creationId="{A3FD2853-2F02-4DFC-84D6-1E322418A279}"/>
          </ac:picMkLst>
        </pc:picChg>
        <pc:picChg chg="mod topLvl">
          <ac:chgData name="li li" userId="3d7a94fd48c86d40" providerId="LiveId" clId="{2345AA29-D5AE-4783-9A1B-7E86E6AD882B}" dt="2018-05-08T13:47:33.320" v="5" actId="165"/>
          <ac:picMkLst>
            <pc:docMk/>
            <pc:sldMk cId="1654897909" sldId="258"/>
            <ac:picMk id="4" creationId="{EB39CE57-9EAC-4FD1-B144-882322AD877F}"/>
          </ac:picMkLst>
        </pc:picChg>
        <pc:picChg chg="mod topLvl">
          <ac:chgData name="li li" userId="3d7a94fd48c86d40" providerId="LiveId" clId="{2345AA29-D5AE-4783-9A1B-7E86E6AD882B}" dt="2018-05-08T17:47:43.744" v="1157" actId="165"/>
          <ac:picMkLst>
            <pc:docMk/>
            <pc:sldMk cId="1654897909" sldId="258"/>
            <ac:picMk id="14" creationId="{0AAD148A-CE7B-4D20-AD29-6E0C8AA6B295}"/>
          </ac:picMkLst>
        </pc:picChg>
        <pc:picChg chg="mod topLvl">
          <ac:chgData name="li li" userId="3d7a94fd48c86d40" providerId="LiveId" clId="{2345AA29-D5AE-4783-9A1B-7E86E6AD882B}" dt="2018-05-08T17:47:43.744" v="1157" actId="165"/>
          <ac:picMkLst>
            <pc:docMk/>
            <pc:sldMk cId="1654897909" sldId="258"/>
            <ac:picMk id="16" creationId="{77DB3502-F068-4BCF-A354-AECB5702027F}"/>
          </ac:picMkLst>
        </pc:picChg>
        <pc:picChg chg="mod topLvl">
          <ac:chgData name="li li" userId="3d7a94fd48c86d40" providerId="LiveId" clId="{2345AA29-D5AE-4783-9A1B-7E86E6AD882B}" dt="2018-05-08T17:47:43.744" v="1157" actId="165"/>
          <ac:picMkLst>
            <pc:docMk/>
            <pc:sldMk cId="1654897909" sldId="258"/>
            <ac:picMk id="18" creationId="{CC140376-5F1E-46DD-82CF-D9463FBBE593}"/>
          </ac:picMkLst>
        </pc:picChg>
        <pc:picChg chg="mod topLvl">
          <ac:chgData name="li li" userId="3d7a94fd48c86d40" providerId="LiveId" clId="{2345AA29-D5AE-4783-9A1B-7E86E6AD882B}" dt="2018-05-08T17:47:50.273" v="1158" actId="164"/>
          <ac:picMkLst>
            <pc:docMk/>
            <pc:sldMk cId="1654897909" sldId="258"/>
            <ac:picMk id="20" creationId="{559B9982-45A2-49C6-9963-B30AD0DEEEB3}"/>
          </ac:picMkLst>
        </pc:picChg>
        <pc:picChg chg="mod topLvl">
          <ac:chgData name="li li" userId="3d7a94fd48c86d40" providerId="LiveId" clId="{2345AA29-D5AE-4783-9A1B-7E86E6AD882B}" dt="2018-05-08T17:47:43.744" v="1157" actId="165"/>
          <ac:picMkLst>
            <pc:docMk/>
            <pc:sldMk cId="1654897909" sldId="258"/>
            <ac:picMk id="22" creationId="{B32F1441-213D-4243-AA42-6D64A638B856}"/>
          </ac:picMkLst>
        </pc:picChg>
        <pc:picChg chg="add mod ord">
          <ac:chgData name="li li" userId="3d7a94fd48c86d40" providerId="LiveId" clId="{2345AA29-D5AE-4783-9A1B-7E86E6AD882B}" dt="2018-05-08T17:08:32.363" v="665" actId="167"/>
          <ac:picMkLst>
            <pc:docMk/>
            <pc:sldMk cId="1654897909" sldId="258"/>
            <ac:picMk id="23" creationId="{33C9B594-8B8A-478F-B397-56031CAD008A}"/>
          </ac:picMkLst>
        </pc:picChg>
        <pc:picChg chg="mod topLvl">
          <ac:chgData name="li li" userId="3d7a94fd48c86d40" providerId="LiveId" clId="{2345AA29-D5AE-4783-9A1B-7E86E6AD882B}" dt="2018-05-08T17:48:43.206" v="1161" actId="164"/>
          <ac:picMkLst>
            <pc:docMk/>
            <pc:sldMk cId="1654897909" sldId="258"/>
            <ac:picMk id="24" creationId="{DE30FC1E-8795-4F80-8F5B-1B6DEB872A85}"/>
          </ac:picMkLst>
        </pc:picChg>
        <pc:picChg chg="mod topLvl">
          <ac:chgData name="li li" userId="3d7a94fd48c86d40" providerId="LiveId" clId="{2345AA29-D5AE-4783-9A1B-7E86E6AD882B}" dt="2018-05-08T17:47:43.744" v="1157" actId="165"/>
          <ac:picMkLst>
            <pc:docMk/>
            <pc:sldMk cId="1654897909" sldId="258"/>
            <ac:picMk id="26" creationId="{D13EAF73-7872-4A51-A779-833162433E29}"/>
          </ac:picMkLst>
        </pc:picChg>
        <pc:picChg chg="add mod ord">
          <ac:chgData name="li li" userId="3d7a94fd48c86d40" providerId="LiveId" clId="{2345AA29-D5AE-4783-9A1B-7E86E6AD882B}" dt="2018-05-08T17:08:32.363" v="665" actId="167"/>
          <ac:picMkLst>
            <pc:docMk/>
            <pc:sldMk cId="1654897909" sldId="258"/>
            <ac:picMk id="27" creationId="{335FD575-6B05-4A35-B501-BAC38C864450}"/>
          </ac:picMkLst>
        </pc:picChg>
        <pc:picChg chg="mod topLvl">
          <ac:chgData name="li li" userId="3d7a94fd48c86d40" providerId="LiveId" clId="{2345AA29-D5AE-4783-9A1B-7E86E6AD882B}" dt="2018-05-08T17:47:43.744" v="1157" actId="165"/>
          <ac:picMkLst>
            <pc:docMk/>
            <pc:sldMk cId="1654897909" sldId="258"/>
            <ac:picMk id="28" creationId="{41857FEB-052F-46C0-9C3B-45BF4584A8C7}"/>
          </ac:picMkLst>
        </pc:picChg>
        <pc:picChg chg="mod topLvl">
          <ac:chgData name="li li" userId="3d7a94fd48c86d40" providerId="LiveId" clId="{2345AA29-D5AE-4783-9A1B-7E86E6AD882B}" dt="2018-05-08T17:47:43.744" v="1157" actId="165"/>
          <ac:picMkLst>
            <pc:docMk/>
            <pc:sldMk cId="1654897909" sldId="258"/>
            <ac:picMk id="30" creationId="{110B5CCF-06CE-4B0A-99DF-807EC1277785}"/>
          </ac:picMkLst>
        </pc:picChg>
        <pc:picChg chg="add mod ord">
          <ac:chgData name="li li" userId="3d7a94fd48c86d40" providerId="LiveId" clId="{2345AA29-D5AE-4783-9A1B-7E86E6AD882B}" dt="2018-05-08T17:08:32.363" v="665" actId="167"/>
          <ac:picMkLst>
            <pc:docMk/>
            <pc:sldMk cId="1654897909" sldId="258"/>
            <ac:picMk id="31" creationId="{15C45F00-CA7C-488E-9CED-A3AFCDE6E8D0}"/>
          </ac:picMkLst>
        </pc:picChg>
        <pc:picChg chg="mod topLvl">
          <ac:chgData name="li li" userId="3d7a94fd48c86d40" providerId="LiveId" clId="{2345AA29-D5AE-4783-9A1B-7E86E6AD882B}" dt="2018-05-08T17:47:43.744" v="1157" actId="165"/>
          <ac:picMkLst>
            <pc:docMk/>
            <pc:sldMk cId="1654897909" sldId="258"/>
            <ac:picMk id="32" creationId="{C98B9769-4085-44D6-AE48-1587257041C0}"/>
          </ac:picMkLst>
        </pc:picChg>
        <pc:picChg chg="add mod ord">
          <ac:chgData name="li li" userId="3d7a94fd48c86d40" providerId="LiveId" clId="{2345AA29-D5AE-4783-9A1B-7E86E6AD882B}" dt="2018-05-08T17:08:32.363" v="665" actId="167"/>
          <ac:picMkLst>
            <pc:docMk/>
            <pc:sldMk cId="1654897909" sldId="258"/>
            <ac:picMk id="35" creationId="{AFE38163-A7FB-43FB-8944-E9F9DB5EAAB5}"/>
          </ac:picMkLst>
        </pc:picChg>
        <pc:picChg chg="mod topLvl">
          <ac:chgData name="li li" userId="3d7a94fd48c86d40" providerId="LiveId" clId="{2345AA29-D5AE-4783-9A1B-7E86E6AD882B}" dt="2018-05-08T17:47:43.744" v="1157" actId="165"/>
          <ac:picMkLst>
            <pc:docMk/>
            <pc:sldMk cId="1654897909" sldId="258"/>
            <ac:picMk id="36" creationId="{77C76196-2823-4267-991F-764855522F1B}"/>
          </ac:picMkLst>
        </pc:picChg>
        <pc:picChg chg="mod topLvl">
          <ac:chgData name="li li" userId="3d7a94fd48c86d40" providerId="LiveId" clId="{2345AA29-D5AE-4783-9A1B-7E86E6AD882B}" dt="2018-05-08T17:47:43.744" v="1157" actId="165"/>
          <ac:picMkLst>
            <pc:docMk/>
            <pc:sldMk cId="1654897909" sldId="258"/>
            <ac:picMk id="38" creationId="{7E798A0E-4CA2-4EDE-B1DA-1030B71F2E7E}"/>
          </ac:picMkLst>
        </pc:picChg>
        <pc:picChg chg="add mod">
          <ac:chgData name="li li" userId="3d7a94fd48c86d40" providerId="LiveId" clId="{2345AA29-D5AE-4783-9A1B-7E86E6AD882B}" dt="2018-05-08T17:16:43.271" v="793" actId="1076"/>
          <ac:picMkLst>
            <pc:docMk/>
            <pc:sldMk cId="1654897909" sldId="258"/>
            <ac:picMk id="39" creationId="{EDE769B0-78A7-4DAF-A811-5DCDDA0FBD58}"/>
          </ac:picMkLst>
        </pc:picChg>
        <pc:picChg chg="mod topLvl">
          <ac:chgData name="li li" userId="3d7a94fd48c86d40" providerId="LiveId" clId="{2345AA29-D5AE-4783-9A1B-7E86E6AD882B}" dt="2018-05-08T17:47:43.744" v="1157" actId="165"/>
          <ac:picMkLst>
            <pc:docMk/>
            <pc:sldMk cId="1654897909" sldId="258"/>
            <ac:picMk id="41" creationId="{92F6704F-1E6F-4613-B32B-068521294389}"/>
          </ac:picMkLst>
        </pc:picChg>
        <pc:picChg chg="add mod">
          <ac:chgData name="li li" userId="3d7a94fd48c86d40" providerId="LiveId" clId="{2345AA29-D5AE-4783-9A1B-7E86E6AD882B}" dt="2018-05-08T17:19:52.872" v="814" actId="1076"/>
          <ac:picMkLst>
            <pc:docMk/>
            <pc:sldMk cId="1654897909" sldId="258"/>
            <ac:picMk id="42" creationId="{28AA3418-5E47-4528-BBBB-2CA5A8C2D522}"/>
          </ac:picMkLst>
        </pc:picChg>
        <pc:picChg chg="mod topLvl">
          <ac:chgData name="li li" userId="3d7a94fd48c86d40" providerId="LiveId" clId="{2345AA29-D5AE-4783-9A1B-7E86E6AD882B}" dt="2018-05-08T17:49:32.908" v="1164" actId="164"/>
          <ac:picMkLst>
            <pc:docMk/>
            <pc:sldMk cId="1654897909" sldId="258"/>
            <ac:picMk id="43" creationId="{CCBB06B0-ABD8-4729-95C2-F44CA6DF6483}"/>
          </ac:picMkLst>
        </pc:picChg>
        <pc:picChg chg="mod topLvl">
          <ac:chgData name="li li" userId="3d7a94fd48c86d40" providerId="LiveId" clId="{2345AA29-D5AE-4783-9A1B-7E86E6AD882B}" dt="2018-05-08T17:47:43.744" v="1157" actId="165"/>
          <ac:picMkLst>
            <pc:docMk/>
            <pc:sldMk cId="1654897909" sldId="258"/>
            <ac:picMk id="45" creationId="{E421A4B4-7A4A-4CC4-9CDA-B4436D57C427}"/>
          </ac:picMkLst>
        </pc:picChg>
        <pc:picChg chg="add mod">
          <ac:chgData name="li li" userId="3d7a94fd48c86d40" providerId="LiveId" clId="{2345AA29-D5AE-4783-9A1B-7E86E6AD882B}" dt="2018-05-08T17:19:56.529" v="815" actId="1076"/>
          <ac:picMkLst>
            <pc:docMk/>
            <pc:sldMk cId="1654897909" sldId="258"/>
            <ac:picMk id="46" creationId="{5B523630-0CDB-4279-A7FE-A59662C61891}"/>
          </ac:picMkLst>
        </pc:picChg>
        <pc:picChg chg="mod topLvl">
          <ac:chgData name="li li" userId="3d7a94fd48c86d40" providerId="LiveId" clId="{2345AA29-D5AE-4783-9A1B-7E86E6AD882B}" dt="2018-05-08T17:47:43.744" v="1157" actId="165"/>
          <ac:picMkLst>
            <pc:docMk/>
            <pc:sldMk cId="1654897909" sldId="258"/>
            <ac:picMk id="47" creationId="{FA5FED11-1822-487A-A8EA-E4C09407C9EC}"/>
          </ac:picMkLst>
        </pc:picChg>
        <pc:picChg chg="add mod">
          <ac:chgData name="li li" userId="3d7a94fd48c86d40" providerId="LiveId" clId="{2345AA29-D5AE-4783-9A1B-7E86E6AD882B}" dt="2018-05-08T17:47:50.273" v="1158" actId="164"/>
          <ac:picMkLst>
            <pc:docMk/>
            <pc:sldMk cId="1654897909" sldId="258"/>
            <ac:picMk id="50" creationId="{81C050FB-7AF5-4833-997F-39724A61B68F}"/>
          </ac:picMkLst>
        </pc:picChg>
        <pc:picChg chg="add mod">
          <ac:chgData name="li li" userId="3d7a94fd48c86d40" providerId="LiveId" clId="{2345AA29-D5AE-4783-9A1B-7E86E6AD882B}" dt="2018-05-08T17:20:03.729" v="817" actId="1076"/>
          <ac:picMkLst>
            <pc:docMk/>
            <pc:sldMk cId="1654897909" sldId="258"/>
            <ac:picMk id="52" creationId="{6F7D5956-759C-430F-854F-2D3D3F0C2D68}"/>
          </ac:picMkLst>
        </pc:picChg>
        <pc:picChg chg="add mod">
          <ac:chgData name="li li" userId="3d7a94fd48c86d40" providerId="LiveId" clId="{2345AA29-D5AE-4783-9A1B-7E86E6AD882B}" dt="2018-05-08T17:20:27.089" v="818" actId="1076"/>
          <ac:picMkLst>
            <pc:docMk/>
            <pc:sldMk cId="1654897909" sldId="258"/>
            <ac:picMk id="54" creationId="{B52CC6ED-DCE5-44EC-A735-581018BD866B}"/>
          </ac:picMkLst>
        </pc:picChg>
        <pc:picChg chg="add mod">
          <ac:chgData name="li li" userId="3d7a94fd48c86d40" providerId="LiveId" clId="{2345AA29-D5AE-4783-9A1B-7E86E6AD882B}" dt="2018-05-08T17:48:43.206" v="1161" actId="164"/>
          <ac:picMkLst>
            <pc:docMk/>
            <pc:sldMk cId="1654897909" sldId="258"/>
            <ac:picMk id="57" creationId="{CDA0A13F-756E-4FA1-9CA3-2D066532CE8F}"/>
          </ac:picMkLst>
        </pc:picChg>
        <pc:picChg chg="add mod">
          <ac:chgData name="li li" userId="3d7a94fd48c86d40" providerId="LiveId" clId="{2345AA29-D5AE-4783-9A1B-7E86E6AD882B}" dt="2018-05-08T17:20:34.495" v="820" actId="1076"/>
          <ac:picMkLst>
            <pc:docMk/>
            <pc:sldMk cId="1654897909" sldId="258"/>
            <ac:picMk id="59" creationId="{9DAAD65D-3AF6-4D58-B778-B26E8528E842}"/>
          </ac:picMkLst>
        </pc:picChg>
        <pc:picChg chg="add mod">
          <ac:chgData name="li li" userId="3d7a94fd48c86d40" providerId="LiveId" clId="{2345AA29-D5AE-4783-9A1B-7E86E6AD882B}" dt="2018-05-08T17:20:37.443" v="821" actId="1076"/>
          <ac:picMkLst>
            <pc:docMk/>
            <pc:sldMk cId="1654897909" sldId="258"/>
            <ac:picMk id="61" creationId="{10E88AE5-E137-49BE-9B95-551E44A4D4AC}"/>
          </ac:picMkLst>
        </pc:picChg>
        <pc:picChg chg="add mod">
          <ac:chgData name="li li" userId="3d7a94fd48c86d40" providerId="LiveId" clId="{2345AA29-D5AE-4783-9A1B-7E86E6AD882B}" dt="2018-05-08T17:20:41.499" v="822" actId="1076"/>
          <ac:picMkLst>
            <pc:docMk/>
            <pc:sldMk cId="1654897909" sldId="258"/>
            <ac:picMk id="63" creationId="{E1018EF6-5688-4319-946E-06EA5BD0339C}"/>
          </ac:picMkLst>
        </pc:picChg>
        <pc:picChg chg="add mod">
          <ac:chgData name="li li" userId="3d7a94fd48c86d40" providerId="LiveId" clId="{2345AA29-D5AE-4783-9A1B-7E86E6AD882B}" dt="2018-05-08T17:21:05.125" v="823" actId="1076"/>
          <ac:picMkLst>
            <pc:docMk/>
            <pc:sldMk cId="1654897909" sldId="258"/>
            <ac:picMk id="65" creationId="{EE0A56CD-C69B-435D-97E8-DCE86C4108A1}"/>
          </ac:picMkLst>
        </pc:picChg>
        <pc:picChg chg="add mod">
          <ac:chgData name="li li" userId="3d7a94fd48c86d40" providerId="LiveId" clId="{2345AA29-D5AE-4783-9A1B-7E86E6AD882B}" dt="2018-05-08T17:21:08.095" v="824" actId="1076"/>
          <ac:picMkLst>
            <pc:docMk/>
            <pc:sldMk cId="1654897909" sldId="258"/>
            <ac:picMk id="67" creationId="{4A15C23E-28FD-459A-8627-3CC103102600}"/>
          </ac:picMkLst>
        </pc:picChg>
        <pc:picChg chg="add mod">
          <ac:chgData name="li li" userId="3d7a94fd48c86d40" providerId="LiveId" clId="{2345AA29-D5AE-4783-9A1B-7E86E6AD882B}" dt="2018-05-08T17:21:20.847" v="829" actId="1076"/>
          <ac:picMkLst>
            <pc:docMk/>
            <pc:sldMk cId="1654897909" sldId="258"/>
            <ac:picMk id="69" creationId="{CA6783DF-935E-4BAB-B483-B703735CB69B}"/>
          </ac:picMkLst>
        </pc:picChg>
        <pc:picChg chg="add mod">
          <ac:chgData name="li li" userId="3d7a94fd48c86d40" providerId="LiveId" clId="{2345AA29-D5AE-4783-9A1B-7E86E6AD882B}" dt="2018-05-08T17:21:23.283" v="830" actId="1076"/>
          <ac:picMkLst>
            <pc:docMk/>
            <pc:sldMk cId="1654897909" sldId="258"/>
            <ac:picMk id="71" creationId="{2949A272-2616-4CDC-91FA-9C55A1396C29}"/>
          </ac:picMkLst>
        </pc:picChg>
        <pc:picChg chg="add mod">
          <ac:chgData name="li li" userId="3d7a94fd48c86d40" providerId="LiveId" clId="{2345AA29-D5AE-4783-9A1B-7E86E6AD882B}" dt="2018-05-08T17:21:27.277" v="831" actId="1076"/>
          <ac:picMkLst>
            <pc:docMk/>
            <pc:sldMk cId="1654897909" sldId="258"/>
            <ac:picMk id="73" creationId="{120CEC13-F125-4405-8BDA-BB9E9093340E}"/>
          </ac:picMkLst>
        </pc:picChg>
        <pc:picChg chg="add mod">
          <ac:chgData name="li li" userId="3d7a94fd48c86d40" providerId="LiveId" clId="{2345AA29-D5AE-4783-9A1B-7E86E6AD882B}" dt="2018-05-08T17:21:48.941" v="832" actId="1076"/>
          <ac:picMkLst>
            <pc:docMk/>
            <pc:sldMk cId="1654897909" sldId="258"/>
            <ac:picMk id="77" creationId="{478F1BE0-C375-4D4D-B24B-35B4B143CC9B}"/>
          </ac:picMkLst>
        </pc:picChg>
        <pc:picChg chg="add mod">
          <ac:chgData name="li li" userId="3d7a94fd48c86d40" providerId="LiveId" clId="{2345AA29-D5AE-4783-9A1B-7E86E6AD882B}" dt="2018-05-08T17:49:32.908" v="1164" actId="164"/>
          <ac:picMkLst>
            <pc:docMk/>
            <pc:sldMk cId="1654897909" sldId="258"/>
            <ac:picMk id="79" creationId="{4F33C8BD-56F4-4B7E-B58C-F98EEC932850}"/>
          </ac:picMkLst>
        </pc:picChg>
        <pc:picChg chg="add mod">
          <ac:chgData name="li li" userId="3d7a94fd48c86d40" providerId="LiveId" clId="{2345AA29-D5AE-4783-9A1B-7E86E6AD882B}" dt="2018-05-08T17:21:56.068" v="834" actId="1076"/>
          <ac:picMkLst>
            <pc:docMk/>
            <pc:sldMk cId="1654897909" sldId="258"/>
            <ac:picMk id="81" creationId="{2A6FEB93-BC4D-4FD5-AE8C-AAD8A22EAB65}"/>
          </ac:picMkLst>
        </pc:picChg>
        <pc:picChg chg="add mod">
          <ac:chgData name="li li" userId="3d7a94fd48c86d40" providerId="LiveId" clId="{2345AA29-D5AE-4783-9A1B-7E86E6AD882B}" dt="2018-05-08T17:21:59.532" v="835" actId="1076"/>
          <ac:picMkLst>
            <pc:docMk/>
            <pc:sldMk cId="1654897909" sldId="258"/>
            <ac:picMk id="83" creationId="{770DB8B7-C9E7-4676-A7CA-8ABB3B9E3C24}"/>
          </ac:picMkLst>
        </pc:picChg>
        <pc:picChg chg="add mod">
          <ac:chgData name="li li" userId="3d7a94fd48c86d40" providerId="LiveId" clId="{2345AA29-D5AE-4783-9A1B-7E86E6AD882B}" dt="2018-05-08T17:22:02.832" v="836" actId="1076"/>
          <ac:picMkLst>
            <pc:docMk/>
            <pc:sldMk cId="1654897909" sldId="258"/>
            <ac:picMk id="85" creationId="{0E7BDC32-0A04-4421-9B4E-97E96A9F7F2F}"/>
          </ac:picMkLst>
        </pc:picChg>
      </pc:sldChg>
      <pc:sldChg chg="addSp delSp modSp">
        <pc:chgData name="li li" userId="3d7a94fd48c86d40" providerId="LiveId" clId="{2345AA29-D5AE-4783-9A1B-7E86E6AD882B}" dt="2018-05-21T05:07:40.562" v="2471" actId="20577"/>
        <pc:sldMkLst>
          <pc:docMk/>
          <pc:sldMk cId="3206879506" sldId="259"/>
        </pc:sldMkLst>
        <pc:spChg chg="mod topLvl">
          <ac:chgData name="li li" userId="3d7a94fd48c86d40" providerId="LiveId" clId="{2345AA29-D5AE-4783-9A1B-7E86E6AD882B}" dt="2018-05-08T17:36:48.774" v="1123" actId="5793"/>
          <ac:spMkLst>
            <pc:docMk/>
            <pc:sldMk cId="3206879506" sldId="259"/>
            <ac:spMk id="2" creationId="{8ECF5750-A97A-4B20-878A-C169D1B928F0}"/>
          </ac:spMkLst>
        </pc:spChg>
        <pc:spChg chg="mod topLvl">
          <ac:chgData name="li li" userId="3d7a94fd48c86d40" providerId="LiveId" clId="{2345AA29-D5AE-4783-9A1B-7E86E6AD882B}" dt="2018-05-08T13:48:22.226" v="11" actId="164"/>
          <ac:spMkLst>
            <pc:docMk/>
            <pc:sldMk cId="3206879506" sldId="259"/>
            <ac:spMk id="5" creationId="{8DBF6B4C-BEF6-4603-A7C3-EFF633D97264}"/>
          </ac:spMkLst>
        </pc:spChg>
        <pc:spChg chg="mod topLvl">
          <ac:chgData name="li li" userId="3d7a94fd48c86d40" providerId="LiveId" clId="{2345AA29-D5AE-4783-9A1B-7E86E6AD882B}" dt="2018-05-08T13:48:29.144" v="12" actId="164"/>
          <ac:spMkLst>
            <pc:docMk/>
            <pc:sldMk cId="3206879506" sldId="259"/>
            <ac:spMk id="6" creationId="{2FDF4D24-51FB-4131-A3F7-1512B2F7BDDA}"/>
          </ac:spMkLst>
        </pc:spChg>
        <pc:spChg chg="mod topLvl">
          <ac:chgData name="li li" userId="3d7a94fd48c86d40" providerId="LiveId" clId="{2345AA29-D5AE-4783-9A1B-7E86E6AD882B}" dt="2018-05-08T13:48:34.351" v="13" actId="164"/>
          <ac:spMkLst>
            <pc:docMk/>
            <pc:sldMk cId="3206879506" sldId="259"/>
            <ac:spMk id="7" creationId="{434F75C7-4E6C-4687-8EFC-EA499B17DA9D}"/>
          </ac:spMkLst>
        </pc:spChg>
        <pc:spChg chg="mod topLvl">
          <ac:chgData name="li li" userId="3d7a94fd48c86d40" providerId="LiveId" clId="{2345AA29-D5AE-4783-9A1B-7E86E6AD882B}" dt="2018-05-08T13:48:44.784" v="14" actId="164"/>
          <ac:spMkLst>
            <pc:docMk/>
            <pc:sldMk cId="3206879506" sldId="259"/>
            <ac:spMk id="8" creationId="{10E100B5-6D97-4EBD-91BA-14FEDE4301C3}"/>
          </ac:spMkLst>
        </pc:spChg>
        <pc:spChg chg="mod">
          <ac:chgData name="li li" userId="3d7a94fd48c86d40" providerId="LiveId" clId="{2345AA29-D5AE-4783-9A1B-7E86E6AD882B}" dt="2018-05-09T07:25:38.001" v="2405" actId="1076"/>
          <ac:spMkLst>
            <pc:docMk/>
            <pc:sldMk cId="3206879506" sldId="259"/>
            <ac:spMk id="9" creationId="{89C1CCCC-C5DF-4D2E-BAEB-353ECE01FED2}"/>
          </ac:spMkLst>
        </pc:spChg>
        <pc:spChg chg="mod topLvl">
          <ac:chgData name="li li" userId="3d7a94fd48c86d40" providerId="LiveId" clId="{2345AA29-D5AE-4783-9A1B-7E86E6AD882B}" dt="2018-05-09T07:25:43.602" v="2406" actId="1076"/>
          <ac:spMkLst>
            <pc:docMk/>
            <pc:sldMk cId="3206879506" sldId="259"/>
            <ac:spMk id="10" creationId="{DF459E47-613F-4B41-A52E-FFAB56743D89}"/>
          </ac:spMkLst>
        </pc:spChg>
        <pc:spChg chg="mod topLvl">
          <ac:chgData name="li li" userId="3d7a94fd48c86d40" providerId="LiveId" clId="{2345AA29-D5AE-4783-9A1B-7E86E6AD882B}" dt="2018-05-09T07:25:48.503" v="2407" actId="1076"/>
          <ac:spMkLst>
            <pc:docMk/>
            <pc:sldMk cId="3206879506" sldId="259"/>
            <ac:spMk id="11" creationId="{E65F402D-53E8-4765-81BA-A62F9B4ABBF4}"/>
          </ac:spMkLst>
        </pc:spChg>
        <pc:spChg chg="mod topLvl">
          <ac:chgData name="li li" userId="3d7a94fd48c86d40" providerId="LiveId" clId="{2345AA29-D5AE-4783-9A1B-7E86E6AD882B}" dt="2018-05-09T07:25:52.849" v="2408" actId="1076"/>
          <ac:spMkLst>
            <pc:docMk/>
            <pc:sldMk cId="3206879506" sldId="259"/>
            <ac:spMk id="12" creationId="{70E9510A-E9E2-4E2E-8936-9E56F6C001D2}"/>
          </ac:spMkLst>
        </pc:spChg>
        <pc:spChg chg="add mod">
          <ac:chgData name="li li" userId="3d7a94fd48c86d40" providerId="LiveId" clId="{2345AA29-D5AE-4783-9A1B-7E86E6AD882B}" dt="2018-05-21T05:07:40.562" v="2471" actId="20577"/>
          <ac:spMkLst>
            <pc:docMk/>
            <pc:sldMk cId="3206879506" sldId="259"/>
            <ac:spMk id="34" creationId="{02182ED5-8AD7-4F88-8F81-95E9BD197D11}"/>
          </ac:spMkLst>
        </pc:spChg>
        <pc:spChg chg="add del mod">
          <ac:chgData name="li li" userId="3d7a94fd48c86d40" providerId="LiveId" clId="{2345AA29-D5AE-4783-9A1B-7E86E6AD882B}" dt="2018-05-21T05:07:29.919" v="2470" actId="478"/>
          <ac:spMkLst>
            <pc:docMk/>
            <pc:sldMk cId="3206879506" sldId="259"/>
            <ac:spMk id="59" creationId="{D1018580-A2BE-4114-95C3-B82EFB875F85}"/>
          </ac:spMkLst>
        </pc:spChg>
        <pc:spChg chg="add del">
          <ac:chgData name="li li" userId="3d7a94fd48c86d40" providerId="LiveId" clId="{2345AA29-D5AE-4783-9A1B-7E86E6AD882B}" dt="2018-05-08T17:29:57.508" v="1019" actId="5793"/>
          <ac:spMkLst>
            <pc:docMk/>
            <pc:sldMk cId="3206879506" sldId="259"/>
            <ac:spMk id="83" creationId="{AACA6CBE-F27B-4582-AF86-D3C348E52C4D}"/>
          </ac:spMkLst>
        </pc:spChg>
        <pc:grpChg chg="add mod">
          <ac:chgData name="li li" userId="3d7a94fd48c86d40" providerId="LiveId" clId="{2345AA29-D5AE-4783-9A1B-7E86E6AD882B}" dt="2018-05-08T13:48:22.226" v="11" actId="164"/>
          <ac:grpSpMkLst>
            <pc:docMk/>
            <pc:sldMk cId="3206879506" sldId="259"/>
            <ac:grpSpMk id="13" creationId="{0CDCF96C-5BAE-4AA9-A5FC-3ECE9FCBC6DA}"/>
          </ac:grpSpMkLst>
        </pc:grpChg>
        <pc:grpChg chg="add mod">
          <ac:chgData name="li li" userId="3d7a94fd48c86d40" providerId="LiveId" clId="{2345AA29-D5AE-4783-9A1B-7E86E6AD882B}" dt="2018-05-08T13:48:59.759" v="15" actId="1076"/>
          <ac:grpSpMkLst>
            <pc:docMk/>
            <pc:sldMk cId="3206879506" sldId="259"/>
            <ac:grpSpMk id="15" creationId="{3CF95868-F3BC-4CA4-8629-886F2B6CC1FE}"/>
          </ac:grpSpMkLst>
        </pc:grpChg>
        <pc:grpChg chg="add mod">
          <ac:chgData name="li li" userId="3d7a94fd48c86d40" providerId="LiveId" clId="{2345AA29-D5AE-4783-9A1B-7E86E6AD882B}" dt="2018-05-08T13:49:57.825" v="20" actId="1076"/>
          <ac:grpSpMkLst>
            <pc:docMk/>
            <pc:sldMk cId="3206879506" sldId="259"/>
            <ac:grpSpMk id="17" creationId="{A9090A6F-E877-4B5F-8B33-C10C5A317F7F}"/>
          </ac:grpSpMkLst>
        </pc:grpChg>
        <pc:grpChg chg="add mod">
          <ac:chgData name="li li" userId="3d7a94fd48c86d40" providerId="LiveId" clId="{2345AA29-D5AE-4783-9A1B-7E86E6AD882B}" dt="2018-05-08T13:50:36.224" v="23" actId="1076"/>
          <ac:grpSpMkLst>
            <pc:docMk/>
            <pc:sldMk cId="3206879506" sldId="259"/>
            <ac:grpSpMk id="18" creationId="{DDB38682-9AB5-4C76-B536-345E8CAC5531}"/>
          </ac:grpSpMkLst>
        </pc:grpChg>
        <pc:grpChg chg="del">
          <ac:chgData name="li li" userId="3d7a94fd48c86d40" providerId="LiveId" clId="{2345AA29-D5AE-4783-9A1B-7E86E6AD882B}" dt="2018-05-08T13:48:15.746" v="10" actId="165"/>
          <ac:grpSpMkLst>
            <pc:docMk/>
            <pc:sldMk cId="3206879506" sldId="259"/>
            <ac:grpSpMk id="47" creationId="{5495CD0D-7AAC-446A-AF09-12156B8FB13B}"/>
          </ac:grpSpMkLst>
        </pc:grpChg>
        <pc:grpChg chg="add mod">
          <ac:chgData name="li li" userId="3d7a94fd48c86d40" providerId="LiveId" clId="{2345AA29-D5AE-4783-9A1B-7E86E6AD882B}" dt="2018-05-21T05:07:04.672" v="2466" actId="14100"/>
          <ac:grpSpMkLst>
            <pc:docMk/>
            <pc:sldMk cId="3206879506" sldId="259"/>
            <ac:grpSpMk id="61" creationId="{86C09A28-2415-4F72-9388-821D60A34D10}"/>
          </ac:grpSpMkLst>
        </pc:grpChg>
        <pc:graphicFrameChg chg="add del">
          <ac:chgData name="li li" userId="3d7a94fd48c86d40" providerId="LiveId" clId="{2345AA29-D5AE-4783-9A1B-7E86E6AD882B}" dt="2018-05-08T17:23:59.314" v="904" actId="5793"/>
          <ac:graphicFrameMkLst>
            <pc:docMk/>
            <pc:sldMk cId="3206879506" sldId="259"/>
            <ac:graphicFrameMk id="38" creationId="{B8A0F18E-D460-4098-A97B-C94D20CD61CD}"/>
          </ac:graphicFrameMkLst>
        </pc:graphicFrameChg>
        <pc:graphicFrameChg chg="add del">
          <ac:chgData name="li li" userId="3d7a94fd48c86d40" providerId="LiveId" clId="{2345AA29-D5AE-4783-9A1B-7E86E6AD882B}" dt="2018-05-08T17:24:19.023" v="911" actId="5793"/>
          <ac:graphicFrameMkLst>
            <pc:docMk/>
            <pc:sldMk cId="3206879506" sldId="259"/>
            <ac:graphicFrameMk id="42" creationId="{A583610B-B22F-4948-9E0A-BBA358C3EC0F}"/>
          </ac:graphicFrameMkLst>
        </pc:graphicFrameChg>
        <pc:graphicFrameChg chg="add del">
          <ac:chgData name="li li" userId="3d7a94fd48c86d40" providerId="LiveId" clId="{2345AA29-D5AE-4783-9A1B-7E86E6AD882B}" dt="2018-05-08T17:24:35.117" v="916" actId="5793"/>
          <ac:graphicFrameMkLst>
            <pc:docMk/>
            <pc:sldMk cId="3206879506" sldId="259"/>
            <ac:graphicFrameMk id="45" creationId="{AAA9E9B1-04C3-45A5-AC6D-731AFF4FF901}"/>
          </ac:graphicFrameMkLst>
        </pc:graphicFrameChg>
        <pc:graphicFrameChg chg="add del">
          <ac:chgData name="li li" userId="3d7a94fd48c86d40" providerId="LiveId" clId="{2345AA29-D5AE-4783-9A1B-7E86E6AD882B}" dt="2018-05-08T17:24:51.548" v="921" actId="5793"/>
          <ac:graphicFrameMkLst>
            <pc:docMk/>
            <pc:sldMk cId="3206879506" sldId="259"/>
            <ac:graphicFrameMk id="49" creationId="{BFE18EE6-F9FB-438C-8709-DF6E179F8676}"/>
          </ac:graphicFrameMkLst>
        </pc:graphicFrameChg>
        <pc:graphicFrameChg chg="add del">
          <ac:chgData name="li li" userId="3d7a94fd48c86d40" providerId="LiveId" clId="{2345AA29-D5AE-4783-9A1B-7E86E6AD882B}" dt="2018-05-08T17:25:10.646" v="926" actId="5793"/>
          <ac:graphicFrameMkLst>
            <pc:docMk/>
            <pc:sldMk cId="3206879506" sldId="259"/>
            <ac:graphicFrameMk id="51" creationId="{7DE334BA-3153-4D90-8069-DA83D9421311}"/>
          </ac:graphicFrameMkLst>
        </pc:graphicFrameChg>
        <pc:graphicFrameChg chg="add del">
          <ac:chgData name="li li" userId="3d7a94fd48c86d40" providerId="LiveId" clId="{2345AA29-D5AE-4783-9A1B-7E86E6AD882B}" dt="2018-05-08T17:25:46.845" v="931" actId="5793"/>
          <ac:graphicFrameMkLst>
            <pc:docMk/>
            <pc:sldMk cId="3206879506" sldId="259"/>
            <ac:graphicFrameMk id="53" creationId="{678D28BF-BAAD-48CE-BDCA-F60C71841A43}"/>
          </ac:graphicFrameMkLst>
        </pc:graphicFrameChg>
        <pc:graphicFrameChg chg="add del">
          <ac:chgData name="li li" userId="3d7a94fd48c86d40" providerId="LiveId" clId="{2345AA29-D5AE-4783-9A1B-7E86E6AD882B}" dt="2018-05-08T17:26:02.939" v="938" actId="5793"/>
          <ac:graphicFrameMkLst>
            <pc:docMk/>
            <pc:sldMk cId="3206879506" sldId="259"/>
            <ac:graphicFrameMk id="55" creationId="{02A7EC56-B510-4E6A-8B86-C3E2512D8E2D}"/>
          </ac:graphicFrameMkLst>
        </pc:graphicFrameChg>
        <pc:graphicFrameChg chg="add del">
          <ac:chgData name="li li" userId="3d7a94fd48c86d40" providerId="LiveId" clId="{2345AA29-D5AE-4783-9A1B-7E86E6AD882B}" dt="2018-05-08T17:26:22.086" v="943" actId="5793"/>
          <ac:graphicFrameMkLst>
            <pc:docMk/>
            <pc:sldMk cId="3206879506" sldId="259"/>
            <ac:graphicFrameMk id="57" creationId="{CD4A8EE9-6067-4BED-84A9-81D968BCF647}"/>
          </ac:graphicFrameMkLst>
        </pc:graphicFrameChg>
        <pc:graphicFrameChg chg="add del">
          <ac:chgData name="li li" userId="3d7a94fd48c86d40" providerId="LiveId" clId="{2345AA29-D5AE-4783-9A1B-7E86E6AD882B}" dt="2018-05-08T17:26:36.982" v="948" actId="5793"/>
          <ac:graphicFrameMkLst>
            <pc:docMk/>
            <pc:sldMk cId="3206879506" sldId="259"/>
            <ac:graphicFrameMk id="59" creationId="{66C5D6BD-A2C2-4075-9EB5-ADD78D509E4B}"/>
          </ac:graphicFrameMkLst>
        </pc:graphicFrameChg>
        <pc:graphicFrameChg chg="add del">
          <ac:chgData name="li li" userId="3d7a94fd48c86d40" providerId="LiveId" clId="{2345AA29-D5AE-4783-9A1B-7E86E6AD882B}" dt="2018-05-08T17:26:51.607" v="953" actId="5793"/>
          <ac:graphicFrameMkLst>
            <pc:docMk/>
            <pc:sldMk cId="3206879506" sldId="259"/>
            <ac:graphicFrameMk id="61" creationId="{5D4C1A17-72C4-4B95-9022-19557432DE73}"/>
          </ac:graphicFrameMkLst>
        </pc:graphicFrameChg>
        <pc:graphicFrameChg chg="add del modGraphic">
          <ac:chgData name="li li" userId="3d7a94fd48c86d40" providerId="LiveId" clId="{2345AA29-D5AE-4783-9A1B-7E86E6AD882B}" dt="2018-05-08T17:27:14.699" v="960" actId="5793"/>
          <ac:graphicFrameMkLst>
            <pc:docMk/>
            <pc:sldMk cId="3206879506" sldId="259"/>
            <ac:graphicFrameMk id="63" creationId="{5D74E729-53CA-4567-B215-1C69F461828D}"/>
          </ac:graphicFrameMkLst>
        </pc:graphicFrameChg>
        <pc:graphicFrameChg chg="add del">
          <ac:chgData name="li li" userId="3d7a94fd48c86d40" providerId="LiveId" clId="{2345AA29-D5AE-4783-9A1B-7E86E6AD882B}" dt="2018-05-08T17:27:18.709" v="962" actId="5793"/>
          <ac:graphicFrameMkLst>
            <pc:docMk/>
            <pc:sldMk cId="3206879506" sldId="259"/>
            <ac:graphicFrameMk id="64" creationId="{058C8EF3-5499-4771-9B64-43A59C1E297B}"/>
          </ac:graphicFrameMkLst>
        </pc:graphicFrameChg>
        <pc:graphicFrameChg chg="add del">
          <ac:chgData name="li li" userId="3d7a94fd48c86d40" providerId="LiveId" clId="{2345AA29-D5AE-4783-9A1B-7E86E6AD882B}" dt="2018-05-08T17:27:36.412" v="967" actId="5793"/>
          <ac:graphicFrameMkLst>
            <pc:docMk/>
            <pc:sldMk cId="3206879506" sldId="259"/>
            <ac:graphicFrameMk id="66" creationId="{AF3CAF56-8152-4B92-B6B3-863F0F24BAB2}"/>
          </ac:graphicFrameMkLst>
        </pc:graphicFrameChg>
        <pc:graphicFrameChg chg="add del">
          <ac:chgData name="li li" userId="3d7a94fd48c86d40" providerId="LiveId" clId="{2345AA29-D5AE-4783-9A1B-7E86E6AD882B}" dt="2018-05-08T17:27:51.238" v="972" actId="5793"/>
          <ac:graphicFrameMkLst>
            <pc:docMk/>
            <pc:sldMk cId="3206879506" sldId="259"/>
            <ac:graphicFrameMk id="68" creationId="{7E03D133-EFB1-45BB-AA98-6565A6414CE0}"/>
          </ac:graphicFrameMkLst>
        </pc:graphicFrameChg>
        <pc:graphicFrameChg chg="add del">
          <ac:chgData name="li li" userId="3d7a94fd48c86d40" providerId="LiveId" clId="{2345AA29-D5AE-4783-9A1B-7E86E6AD882B}" dt="2018-05-08T17:28:07.688" v="981" actId="5793"/>
          <ac:graphicFrameMkLst>
            <pc:docMk/>
            <pc:sldMk cId="3206879506" sldId="259"/>
            <ac:graphicFrameMk id="70" creationId="{BAA904AE-D665-4DF4-90F3-2F48C989D3FE}"/>
          </ac:graphicFrameMkLst>
        </pc:graphicFrameChg>
        <pc:graphicFrameChg chg="add del">
          <ac:chgData name="li li" userId="3d7a94fd48c86d40" providerId="LiveId" clId="{2345AA29-D5AE-4783-9A1B-7E86E6AD882B}" dt="2018-05-08T17:28:27.347" v="987" actId="5793"/>
          <ac:graphicFrameMkLst>
            <pc:docMk/>
            <pc:sldMk cId="3206879506" sldId="259"/>
            <ac:graphicFrameMk id="72" creationId="{A2AE4EDD-78D3-4883-ACD8-3FC6355D4785}"/>
          </ac:graphicFrameMkLst>
        </pc:graphicFrameChg>
        <pc:graphicFrameChg chg="add del">
          <ac:chgData name="li li" userId="3d7a94fd48c86d40" providerId="LiveId" clId="{2345AA29-D5AE-4783-9A1B-7E86E6AD882B}" dt="2018-05-08T17:28:31.842" v="989" actId="5793"/>
          <ac:graphicFrameMkLst>
            <pc:docMk/>
            <pc:sldMk cId="3206879506" sldId="259"/>
            <ac:graphicFrameMk id="73" creationId="{E06DAC81-BE63-4262-A86F-41EE36352DD1}"/>
          </ac:graphicFrameMkLst>
        </pc:graphicFrameChg>
        <pc:graphicFrameChg chg="add del">
          <ac:chgData name="li li" userId="3d7a94fd48c86d40" providerId="LiveId" clId="{2345AA29-D5AE-4783-9A1B-7E86E6AD882B}" dt="2018-05-08T17:28:51.360" v="994" actId="5793"/>
          <ac:graphicFrameMkLst>
            <pc:docMk/>
            <pc:sldMk cId="3206879506" sldId="259"/>
            <ac:graphicFrameMk id="75" creationId="{BE7C80D7-2BDC-460E-A7A8-1F1CA4DE47CC}"/>
          </ac:graphicFrameMkLst>
        </pc:graphicFrameChg>
        <pc:graphicFrameChg chg="add del">
          <ac:chgData name="li li" userId="3d7a94fd48c86d40" providerId="LiveId" clId="{2345AA29-D5AE-4783-9A1B-7E86E6AD882B}" dt="2018-05-08T17:29:09.652" v="1000" actId="5793"/>
          <ac:graphicFrameMkLst>
            <pc:docMk/>
            <pc:sldMk cId="3206879506" sldId="259"/>
            <ac:graphicFrameMk id="77" creationId="{C8340D9E-A10F-4C10-B382-DAB8389F44EF}"/>
          </ac:graphicFrameMkLst>
        </pc:graphicFrameChg>
        <pc:graphicFrameChg chg="add del">
          <ac:chgData name="li li" userId="3d7a94fd48c86d40" providerId="LiveId" clId="{2345AA29-D5AE-4783-9A1B-7E86E6AD882B}" dt="2018-05-08T17:29:26.913" v="1006" actId="5793"/>
          <ac:graphicFrameMkLst>
            <pc:docMk/>
            <pc:sldMk cId="3206879506" sldId="259"/>
            <ac:graphicFrameMk id="79" creationId="{0087EA02-2D96-4C1B-A23B-F24FBB1898A4}"/>
          </ac:graphicFrameMkLst>
        </pc:graphicFrameChg>
        <pc:graphicFrameChg chg="add del">
          <ac:chgData name="li li" userId="3d7a94fd48c86d40" providerId="LiveId" clId="{2345AA29-D5AE-4783-9A1B-7E86E6AD882B}" dt="2018-05-08T17:29:43.147" v="1011" actId="5793"/>
          <ac:graphicFrameMkLst>
            <pc:docMk/>
            <pc:sldMk cId="3206879506" sldId="259"/>
            <ac:graphicFrameMk id="81" creationId="{AE589F02-631A-417F-B1B9-E14DF8FFABF1}"/>
          </ac:graphicFrameMkLst>
        </pc:graphicFrameChg>
        <pc:graphicFrameChg chg="add del">
          <ac:chgData name="li li" userId="3d7a94fd48c86d40" providerId="LiveId" clId="{2345AA29-D5AE-4783-9A1B-7E86E6AD882B}" dt="2018-05-08T17:29:46.872" v="1013" actId="5793"/>
          <ac:graphicFrameMkLst>
            <pc:docMk/>
            <pc:sldMk cId="3206879506" sldId="259"/>
            <ac:graphicFrameMk id="82" creationId="{877CFE9F-593D-4A3C-8691-91079B377901}"/>
          </ac:graphicFrameMkLst>
        </pc:graphicFrameChg>
        <pc:graphicFrameChg chg="add del">
          <ac:chgData name="li li" userId="3d7a94fd48c86d40" providerId="LiveId" clId="{2345AA29-D5AE-4783-9A1B-7E86E6AD882B}" dt="2018-05-08T17:30:13.425" v="1026" actId="5793"/>
          <ac:graphicFrameMkLst>
            <pc:docMk/>
            <pc:sldMk cId="3206879506" sldId="259"/>
            <ac:graphicFrameMk id="85" creationId="{8934F376-D16C-469D-A462-364BC4DEAF10}"/>
          </ac:graphicFrameMkLst>
        </pc:graphicFrameChg>
        <pc:picChg chg="mod topLvl">
          <ac:chgData name="li li" userId="3d7a94fd48c86d40" providerId="LiveId" clId="{2345AA29-D5AE-4783-9A1B-7E86E6AD882B}" dt="2018-05-08T13:48:15.746" v="10" actId="165"/>
          <ac:picMkLst>
            <pc:docMk/>
            <pc:sldMk cId="3206879506" sldId="259"/>
            <ac:picMk id="3" creationId="{4EDA3692-9F35-4F3E-A0EB-CC537AEA1A5D}"/>
          </ac:picMkLst>
        </pc:picChg>
        <pc:picChg chg="del mod topLvl">
          <ac:chgData name="li li" userId="3d7a94fd48c86d40" providerId="LiveId" clId="{2345AA29-D5AE-4783-9A1B-7E86E6AD882B}" dt="2018-05-21T05:07:08.081" v="2467" actId="478"/>
          <ac:picMkLst>
            <pc:docMk/>
            <pc:sldMk cId="3206879506" sldId="259"/>
            <ac:picMk id="4" creationId="{F8ED729A-A246-49CE-859E-A86E7DAB044A}"/>
          </ac:picMkLst>
        </pc:picChg>
        <pc:picChg chg="mod topLvl">
          <ac:chgData name="li li" userId="3d7a94fd48c86d40" providerId="LiveId" clId="{2345AA29-D5AE-4783-9A1B-7E86E6AD882B}" dt="2018-05-08T13:48:22.226" v="11" actId="164"/>
          <ac:picMkLst>
            <pc:docMk/>
            <pc:sldMk cId="3206879506" sldId="259"/>
            <ac:picMk id="14" creationId="{4C9968AD-CFE1-4763-A2D6-172C1C4AA36F}"/>
          </ac:picMkLst>
        </pc:picChg>
        <pc:picChg chg="mod topLvl">
          <ac:chgData name="li li" userId="3d7a94fd48c86d40" providerId="LiveId" clId="{2345AA29-D5AE-4783-9A1B-7E86E6AD882B}" dt="2018-05-08T13:48:29.144" v="12" actId="164"/>
          <ac:picMkLst>
            <pc:docMk/>
            <pc:sldMk cId="3206879506" sldId="259"/>
            <ac:picMk id="16" creationId="{91D9DA41-B204-4599-9D93-A0A1325130AF}"/>
          </ac:picMkLst>
        </pc:picChg>
        <pc:picChg chg="mod topLvl">
          <ac:chgData name="li li" userId="3d7a94fd48c86d40" providerId="LiveId" clId="{2345AA29-D5AE-4783-9A1B-7E86E6AD882B}" dt="2018-05-08T13:48:34.351" v="13" actId="164"/>
          <ac:picMkLst>
            <pc:docMk/>
            <pc:sldMk cId="3206879506" sldId="259"/>
            <ac:picMk id="19" creationId="{ACCD8A90-9F6E-4458-87D1-D948176DFC6A}"/>
          </ac:picMkLst>
        </pc:picChg>
        <pc:picChg chg="mod topLvl">
          <ac:chgData name="li li" userId="3d7a94fd48c86d40" providerId="LiveId" clId="{2345AA29-D5AE-4783-9A1B-7E86E6AD882B}" dt="2018-05-08T13:48:44.784" v="14" actId="164"/>
          <ac:picMkLst>
            <pc:docMk/>
            <pc:sldMk cId="3206879506" sldId="259"/>
            <ac:picMk id="21" creationId="{B1CF4F17-2CF4-4D9B-9BB2-8CB0F80193A5}"/>
          </ac:picMkLst>
        </pc:picChg>
        <pc:picChg chg="add mod">
          <ac:chgData name="li li" userId="3d7a94fd48c86d40" providerId="LiveId" clId="{2345AA29-D5AE-4783-9A1B-7E86E6AD882B}" dt="2018-05-08T14:37:53.741" v="89" actId="1076"/>
          <ac:picMkLst>
            <pc:docMk/>
            <pc:sldMk cId="3206879506" sldId="259"/>
            <ac:picMk id="22" creationId="{C3603B3F-8798-409A-B4E4-86C327F3032A}"/>
          </ac:picMkLst>
        </pc:picChg>
        <pc:picChg chg="mod topLvl">
          <ac:chgData name="li li" userId="3d7a94fd48c86d40" providerId="LiveId" clId="{2345AA29-D5AE-4783-9A1B-7E86E6AD882B}" dt="2018-05-08T13:48:22.226" v="11" actId="164"/>
          <ac:picMkLst>
            <pc:docMk/>
            <pc:sldMk cId="3206879506" sldId="259"/>
            <ac:picMk id="23" creationId="{C3D1F259-5B4A-4323-9434-356D12F07F49}"/>
          </ac:picMkLst>
        </pc:picChg>
        <pc:picChg chg="mod topLvl">
          <ac:chgData name="li li" userId="3d7a94fd48c86d40" providerId="LiveId" clId="{2345AA29-D5AE-4783-9A1B-7E86E6AD882B}" dt="2018-05-08T13:48:29.144" v="12" actId="164"/>
          <ac:picMkLst>
            <pc:docMk/>
            <pc:sldMk cId="3206879506" sldId="259"/>
            <ac:picMk id="25" creationId="{A7798304-20D0-49C4-BEDC-78C0574B8A97}"/>
          </ac:picMkLst>
        </pc:picChg>
        <pc:picChg chg="add mod">
          <ac:chgData name="li li" userId="3d7a94fd48c86d40" providerId="LiveId" clId="{2345AA29-D5AE-4783-9A1B-7E86E6AD882B}" dt="2018-05-08T14:38:35.094" v="93" actId="1076"/>
          <ac:picMkLst>
            <pc:docMk/>
            <pc:sldMk cId="3206879506" sldId="259"/>
            <ac:picMk id="26" creationId="{6B4BEF62-04E8-4391-9292-5C0AE3293C15}"/>
          </ac:picMkLst>
        </pc:picChg>
        <pc:picChg chg="mod topLvl">
          <ac:chgData name="li li" userId="3d7a94fd48c86d40" providerId="LiveId" clId="{2345AA29-D5AE-4783-9A1B-7E86E6AD882B}" dt="2018-05-08T13:48:34.351" v="13" actId="164"/>
          <ac:picMkLst>
            <pc:docMk/>
            <pc:sldMk cId="3206879506" sldId="259"/>
            <ac:picMk id="27" creationId="{286D59DA-1D17-4E64-A190-0D1A6D0AFA02}"/>
          </ac:picMkLst>
        </pc:picChg>
        <pc:picChg chg="mod topLvl">
          <ac:chgData name="li li" userId="3d7a94fd48c86d40" providerId="LiveId" clId="{2345AA29-D5AE-4783-9A1B-7E86E6AD882B}" dt="2018-05-08T13:48:44.784" v="14" actId="164"/>
          <ac:picMkLst>
            <pc:docMk/>
            <pc:sldMk cId="3206879506" sldId="259"/>
            <ac:picMk id="29" creationId="{E8825178-8C70-4CA6-9C9A-CDF6174F8668}"/>
          </ac:picMkLst>
        </pc:picChg>
        <pc:picChg chg="add mod">
          <ac:chgData name="li li" userId="3d7a94fd48c86d40" providerId="LiveId" clId="{2345AA29-D5AE-4783-9A1B-7E86E6AD882B}" dt="2018-05-08T14:38:43.045" v="94" actId="1076"/>
          <ac:picMkLst>
            <pc:docMk/>
            <pc:sldMk cId="3206879506" sldId="259"/>
            <ac:picMk id="30" creationId="{A99C91D4-C03A-4088-86BB-40E053A5A634}"/>
          </ac:picMkLst>
        </pc:picChg>
        <pc:picChg chg="mod topLvl">
          <ac:chgData name="li li" userId="3d7a94fd48c86d40" providerId="LiveId" clId="{2345AA29-D5AE-4783-9A1B-7E86E6AD882B}" dt="2018-05-08T13:48:22.226" v="11" actId="164"/>
          <ac:picMkLst>
            <pc:docMk/>
            <pc:sldMk cId="3206879506" sldId="259"/>
            <ac:picMk id="31" creationId="{8BC450BF-0529-460A-AB0C-00B7835E7A44}"/>
          </ac:picMkLst>
        </pc:picChg>
        <pc:picChg chg="mod topLvl">
          <ac:chgData name="li li" userId="3d7a94fd48c86d40" providerId="LiveId" clId="{2345AA29-D5AE-4783-9A1B-7E86E6AD882B}" dt="2018-05-08T13:48:29.144" v="12" actId="164"/>
          <ac:picMkLst>
            <pc:docMk/>
            <pc:sldMk cId="3206879506" sldId="259"/>
            <ac:picMk id="33" creationId="{A1853B95-00B9-492B-B2A1-92D525483633}"/>
          </ac:picMkLst>
        </pc:picChg>
        <pc:picChg chg="mod topLvl">
          <ac:chgData name="li li" userId="3d7a94fd48c86d40" providerId="LiveId" clId="{2345AA29-D5AE-4783-9A1B-7E86E6AD882B}" dt="2018-05-08T13:48:34.351" v="13" actId="164"/>
          <ac:picMkLst>
            <pc:docMk/>
            <pc:sldMk cId="3206879506" sldId="259"/>
            <ac:picMk id="35" creationId="{CC58C8E9-6F08-4670-9344-F7B9D34D9552}"/>
          </ac:picMkLst>
        </pc:picChg>
        <pc:picChg chg="add mod">
          <ac:chgData name="li li" userId="3d7a94fd48c86d40" providerId="LiveId" clId="{2345AA29-D5AE-4783-9A1B-7E86E6AD882B}" dt="2018-05-08T14:38:03.836" v="92" actId="1076"/>
          <ac:picMkLst>
            <pc:docMk/>
            <pc:sldMk cId="3206879506" sldId="259"/>
            <ac:picMk id="36" creationId="{7E379B18-18D3-46CA-B76F-A6BD6B9D7278}"/>
          </ac:picMkLst>
        </pc:picChg>
        <pc:picChg chg="mod topLvl">
          <ac:chgData name="li li" userId="3d7a94fd48c86d40" providerId="LiveId" clId="{2345AA29-D5AE-4783-9A1B-7E86E6AD882B}" dt="2018-05-08T13:48:44.784" v="14" actId="164"/>
          <ac:picMkLst>
            <pc:docMk/>
            <pc:sldMk cId="3206879506" sldId="259"/>
            <ac:picMk id="37" creationId="{5F53773D-A328-4514-9173-D3E65A7C2884}"/>
          </ac:picMkLst>
        </pc:picChg>
        <pc:picChg chg="mod topLvl">
          <ac:chgData name="li li" userId="3d7a94fd48c86d40" providerId="LiveId" clId="{2345AA29-D5AE-4783-9A1B-7E86E6AD882B}" dt="2018-05-08T13:48:22.226" v="11" actId="164"/>
          <ac:picMkLst>
            <pc:docMk/>
            <pc:sldMk cId="3206879506" sldId="259"/>
            <ac:picMk id="39" creationId="{2CCA85F7-7324-40DE-A515-97967A06DD3D}"/>
          </ac:picMkLst>
        </pc:picChg>
        <pc:picChg chg="add mod">
          <ac:chgData name="li li" userId="3d7a94fd48c86d40" providerId="LiveId" clId="{2345AA29-D5AE-4783-9A1B-7E86E6AD882B}" dt="2018-05-08T17:30:42.928" v="1032" actId="1076"/>
          <ac:picMkLst>
            <pc:docMk/>
            <pc:sldMk cId="3206879506" sldId="259"/>
            <ac:picMk id="40" creationId="{0F41F581-B47F-42E9-925D-5B7C2234C9B9}"/>
          </ac:picMkLst>
        </pc:picChg>
        <pc:picChg chg="mod topLvl">
          <ac:chgData name="li li" userId="3d7a94fd48c86d40" providerId="LiveId" clId="{2345AA29-D5AE-4783-9A1B-7E86E6AD882B}" dt="2018-05-08T13:48:29.144" v="12" actId="164"/>
          <ac:picMkLst>
            <pc:docMk/>
            <pc:sldMk cId="3206879506" sldId="259"/>
            <ac:picMk id="41" creationId="{8F50B0BD-16A4-45D5-9655-9E2F2BBFA279}"/>
          </ac:picMkLst>
        </pc:picChg>
        <pc:picChg chg="mod topLvl">
          <ac:chgData name="li li" userId="3d7a94fd48c86d40" providerId="LiveId" clId="{2345AA29-D5AE-4783-9A1B-7E86E6AD882B}" dt="2018-05-08T13:48:34.351" v="13" actId="164"/>
          <ac:picMkLst>
            <pc:docMk/>
            <pc:sldMk cId="3206879506" sldId="259"/>
            <ac:picMk id="43" creationId="{0A7314F0-F3E8-495E-B1F1-EC36E57BF6F4}"/>
          </ac:picMkLst>
        </pc:picChg>
        <pc:picChg chg="add mod">
          <ac:chgData name="li li" userId="3d7a94fd48c86d40" providerId="LiveId" clId="{2345AA29-D5AE-4783-9A1B-7E86E6AD882B}" dt="2018-05-08T17:33:56.648" v="1061" actId="1076"/>
          <ac:picMkLst>
            <pc:docMk/>
            <pc:sldMk cId="3206879506" sldId="259"/>
            <ac:picMk id="44" creationId="{D43E3D09-B28C-4924-A3EF-6D14D00CBC27}"/>
          </ac:picMkLst>
        </pc:picChg>
        <pc:picChg chg="mod topLvl">
          <ac:chgData name="li li" userId="3d7a94fd48c86d40" providerId="LiveId" clId="{2345AA29-D5AE-4783-9A1B-7E86E6AD882B}" dt="2018-05-08T13:48:44.784" v="14" actId="164"/>
          <ac:picMkLst>
            <pc:docMk/>
            <pc:sldMk cId="3206879506" sldId="259"/>
            <ac:picMk id="46" creationId="{BBBE6E9C-39FA-488E-A6D8-532A443B1EB8}"/>
          </ac:picMkLst>
        </pc:picChg>
        <pc:picChg chg="add mod">
          <ac:chgData name="li li" userId="3d7a94fd48c86d40" providerId="LiveId" clId="{2345AA29-D5AE-4783-9A1B-7E86E6AD882B}" dt="2018-05-08T17:33:39.430" v="1058" actId="1076"/>
          <ac:picMkLst>
            <pc:docMk/>
            <pc:sldMk cId="3206879506" sldId="259"/>
            <ac:picMk id="48" creationId="{EA3AEC25-F958-442C-9804-D4AC5EE1862D}"/>
          </ac:picMkLst>
        </pc:picChg>
        <pc:picChg chg="add mod">
          <ac:chgData name="li li" userId="3d7a94fd48c86d40" providerId="LiveId" clId="{2345AA29-D5AE-4783-9A1B-7E86E6AD882B}" dt="2018-05-08T17:33:42.863" v="1059" actId="1076"/>
          <ac:picMkLst>
            <pc:docMk/>
            <pc:sldMk cId="3206879506" sldId="259"/>
            <ac:picMk id="50" creationId="{EB570217-5F00-4170-94D3-0D73D993A1B4}"/>
          </ac:picMkLst>
        </pc:picChg>
        <pc:picChg chg="add mod">
          <ac:chgData name="li li" userId="3d7a94fd48c86d40" providerId="LiveId" clId="{2345AA29-D5AE-4783-9A1B-7E86E6AD882B}" dt="2018-05-08T17:33:46.597" v="1060" actId="1076"/>
          <ac:picMkLst>
            <pc:docMk/>
            <pc:sldMk cId="3206879506" sldId="259"/>
            <ac:picMk id="52" creationId="{8E8EE303-A336-47E2-93D5-C0768877EA1C}"/>
          </ac:picMkLst>
        </pc:picChg>
        <pc:picChg chg="add mod">
          <ac:chgData name="li li" userId="3d7a94fd48c86d40" providerId="LiveId" clId="{2345AA29-D5AE-4783-9A1B-7E86E6AD882B}" dt="2018-05-08T17:34:31.100" v="1064" actId="1076"/>
          <ac:picMkLst>
            <pc:docMk/>
            <pc:sldMk cId="3206879506" sldId="259"/>
            <ac:picMk id="54" creationId="{40599A3C-1003-44FC-8BC2-73D48B142EAE}"/>
          </ac:picMkLst>
        </pc:picChg>
        <pc:picChg chg="add mod">
          <ac:chgData name="li li" userId="3d7a94fd48c86d40" providerId="LiveId" clId="{2345AA29-D5AE-4783-9A1B-7E86E6AD882B}" dt="2018-05-08T17:34:34.526" v="1065" actId="1076"/>
          <ac:picMkLst>
            <pc:docMk/>
            <pc:sldMk cId="3206879506" sldId="259"/>
            <ac:picMk id="56" creationId="{7B1D45DF-4331-4022-AD6B-783A3DFD102D}"/>
          </ac:picMkLst>
        </pc:picChg>
        <pc:picChg chg="add mod">
          <ac:chgData name="li li" userId="3d7a94fd48c86d40" providerId="LiveId" clId="{2345AA29-D5AE-4783-9A1B-7E86E6AD882B}" dt="2018-05-08T17:34:37.212" v="1066" actId="1076"/>
          <ac:picMkLst>
            <pc:docMk/>
            <pc:sldMk cId="3206879506" sldId="259"/>
            <ac:picMk id="58" creationId="{2460004F-21DA-40E2-81F9-9EFA2E370748}"/>
          </ac:picMkLst>
        </pc:picChg>
        <pc:picChg chg="add mod">
          <ac:chgData name="li li" userId="3d7a94fd48c86d40" providerId="LiveId" clId="{2345AA29-D5AE-4783-9A1B-7E86E6AD882B}" dt="2018-05-08T17:34:40.256" v="1067" actId="1076"/>
          <ac:picMkLst>
            <pc:docMk/>
            <pc:sldMk cId="3206879506" sldId="259"/>
            <ac:picMk id="60" creationId="{55F9EECD-9AB0-426E-8F1B-C9D5BA30D28A}"/>
          </ac:picMkLst>
        </pc:picChg>
        <pc:picChg chg="add mod">
          <ac:chgData name="li li" userId="3d7a94fd48c86d40" providerId="LiveId" clId="{2345AA29-D5AE-4783-9A1B-7E86E6AD882B}" dt="2018-05-08T17:34:44.492" v="1068" actId="1076"/>
          <ac:picMkLst>
            <pc:docMk/>
            <pc:sldMk cId="3206879506" sldId="259"/>
            <ac:picMk id="62" creationId="{970925A7-E277-4A76-B0E7-0AEB534B045D}"/>
          </ac:picMkLst>
        </pc:picChg>
        <pc:picChg chg="add mod">
          <ac:chgData name="li li" userId="3d7a94fd48c86d40" providerId="LiveId" clId="{2345AA29-D5AE-4783-9A1B-7E86E6AD882B}" dt="2018-05-08T17:35:46.528" v="1110" actId="1035"/>
          <ac:picMkLst>
            <pc:docMk/>
            <pc:sldMk cId="3206879506" sldId="259"/>
            <ac:picMk id="65" creationId="{6027A3EB-167A-49DB-8648-7B9B6B3D2942}"/>
          </ac:picMkLst>
        </pc:picChg>
        <pc:picChg chg="add mod">
          <ac:chgData name="li li" userId="3d7a94fd48c86d40" providerId="LiveId" clId="{2345AA29-D5AE-4783-9A1B-7E86E6AD882B}" dt="2018-05-08T17:35:54.461" v="1111" actId="1076"/>
          <ac:picMkLst>
            <pc:docMk/>
            <pc:sldMk cId="3206879506" sldId="259"/>
            <ac:picMk id="67" creationId="{B40EB074-6CAE-43D4-A72C-0F119413D9F0}"/>
          </ac:picMkLst>
        </pc:picChg>
        <pc:picChg chg="add mod">
          <ac:chgData name="li li" userId="3d7a94fd48c86d40" providerId="LiveId" clId="{2345AA29-D5AE-4783-9A1B-7E86E6AD882B}" dt="2018-05-08T17:35:57.326" v="1112" actId="1076"/>
          <ac:picMkLst>
            <pc:docMk/>
            <pc:sldMk cId="3206879506" sldId="259"/>
            <ac:picMk id="69" creationId="{277DD0B7-3227-4511-954C-C77D760EF317}"/>
          </ac:picMkLst>
        </pc:picChg>
        <pc:picChg chg="add mod">
          <ac:chgData name="li li" userId="3d7a94fd48c86d40" providerId="LiveId" clId="{2345AA29-D5AE-4783-9A1B-7E86E6AD882B}" dt="2018-05-08T17:35:59.862" v="1113" actId="1076"/>
          <ac:picMkLst>
            <pc:docMk/>
            <pc:sldMk cId="3206879506" sldId="259"/>
            <ac:picMk id="71" creationId="{32941478-2066-4796-8908-F2AB9A22E605}"/>
          </ac:picMkLst>
        </pc:picChg>
        <pc:picChg chg="add mod">
          <ac:chgData name="li li" userId="3d7a94fd48c86d40" providerId="LiveId" clId="{2345AA29-D5AE-4783-9A1B-7E86E6AD882B}" dt="2018-05-08T17:36:03.559" v="1114" actId="1076"/>
          <ac:picMkLst>
            <pc:docMk/>
            <pc:sldMk cId="3206879506" sldId="259"/>
            <ac:picMk id="74" creationId="{0E0FEA54-8A19-4F70-83E2-7E1C175868E7}"/>
          </ac:picMkLst>
        </pc:picChg>
        <pc:picChg chg="add mod">
          <ac:chgData name="li li" userId="3d7a94fd48c86d40" providerId="LiveId" clId="{2345AA29-D5AE-4783-9A1B-7E86E6AD882B}" dt="2018-05-08T17:35:06.147" v="1069" actId="1076"/>
          <ac:picMkLst>
            <pc:docMk/>
            <pc:sldMk cId="3206879506" sldId="259"/>
            <ac:picMk id="76" creationId="{225F29AB-70D5-4907-AA38-81C1A6D3623B}"/>
          </ac:picMkLst>
        </pc:picChg>
        <pc:picChg chg="add mod">
          <ac:chgData name="li li" userId="3d7a94fd48c86d40" providerId="LiveId" clId="{2345AA29-D5AE-4783-9A1B-7E86E6AD882B}" dt="2018-05-08T17:35:09.287" v="1070" actId="1076"/>
          <ac:picMkLst>
            <pc:docMk/>
            <pc:sldMk cId="3206879506" sldId="259"/>
            <ac:picMk id="78" creationId="{E1EC08A5-A7B0-4AF7-AAD6-F9D9FE83F7D8}"/>
          </ac:picMkLst>
        </pc:picChg>
        <pc:picChg chg="add mod">
          <ac:chgData name="li li" userId="3d7a94fd48c86d40" providerId="LiveId" clId="{2345AA29-D5AE-4783-9A1B-7E86E6AD882B}" dt="2018-05-08T17:35:13.054" v="1071" actId="1076"/>
          <ac:picMkLst>
            <pc:docMk/>
            <pc:sldMk cId="3206879506" sldId="259"/>
            <ac:picMk id="80" creationId="{9F4EFF54-CC4B-4A52-A1A5-2A298013659E}"/>
          </ac:picMkLst>
        </pc:picChg>
        <pc:picChg chg="add mod">
          <ac:chgData name="li li" userId="3d7a94fd48c86d40" providerId="LiveId" clId="{2345AA29-D5AE-4783-9A1B-7E86E6AD882B}" dt="2018-05-08T17:35:15.863" v="1072" actId="1076"/>
          <ac:picMkLst>
            <pc:docMk/>
            <pc:sldMk cId="3206879506" sldId="259"/>
            <ac:picMk id="84" creationId="{C2104A2B-F8BC-4181-9FD8-A8DFA6422A79}"/>
          </ac:picMkLst>
        </pc:picChg>
        <pc:picChg chg="add mod">
          <ac:chgData name="li li" userId="3d7a94fd48c86d40" providerId="LiveId" clId="{2345AA29-D5AE-4783-9A1B-7E86E6AD882B}" dt="2018-05-08T17:35:19.030" v="1073" actId="1076"/>
          <ac:picMkLst>
            <pc:docMk/>
            <pc:sldMk cId="3206879506" sldId="259"/>
            <ac:picMk id="86" creationId="{45505145-95C4-497F-8DA9-34851A6F6FB9}"/>
          </ac:picMkLst>
        </pc:picChg>
      </pc:sldChg>
      <pc:sldChg chg="addSp delSp modSp add">
        <pc:chgData name="li li" userId="3d7a94fd48c86d40" providerId="LiveId" clId="{2345AA29-D5AE-4783-9A1B-7E86E6AD882B}" dt="2018-05-21T05:04:11.222" v="2460" actId="1038"/>
        <pc:sldMkLst>
          <pc:docMk/>
          <pc:sldMk cId="789831365" sldId="260"/>
        </pc:sldMkLst>
        <pc:spChg chg="del">
          <ac:chgData name="li li" userId="3d7a94fd48c86d40" providerId="LiveId" clId="{2345AA29-D5AE-4783-9A1B-7E86E6AD882B}" dt="2018-05-08T17:38:07.333" v="1128" actId="478"/>
          <ac:spMkLst>
            <pc:docMk/>
            <pc:sldMk cId="789831365" sldId="260"/>
            <ac:spMk id="2" creationId="{4CD9EBC0-F1FC-436F-A696-F572EC35D0A5}"/>
          </ac:spMkLst>
        </pc:spChg>
        <pc:spChg chg="del">
          <ac:chgData name="li li" userId="3d7a94fd48c86d40" providerId="LiveId" clId="{2345AA29-D5AE-4783-9A1B-7E86E6AD882B}" dt="2018-05-08T17:38:09.388" v="1129" actId="478"/>
          <ac:spMkLst>
            <pc:docMk/>
            <pc:sldMk cId="789831365" sldId="260"/>
            <ac:spMk id="3" creationId="{733C6996-8FD4-4D4A-A029-E975CB31231A}"/>
          </ac:spMkLst>
        </pc:spChg>
        <pc:spChg chg="mod topLvl">
          <ac:chgData name="li li" userId="3d7a94fd48c86d40" providerId="LiveId" clId="{2345AA29-D5AE-4783-9A1B-7E86E6AD882B}" dt="2018-05-09T07:21:36.792" v="2342" actId="1037"/>
          <ac:spMkLst>
            <pc:docMk/>
            <pc:sldMk cId="789831365" sldId="260"/>
            <ac:spMk id="13" creationId="{B4F65041-6C9C-400E-A1E4-5595216EF5FC}"/>
          </ac:spMkLst>
        </pc:spChg>
        <pc:spChg chg="add del mod">
          <ac:chgData name="li li" userId="3d7a94fd48c86d40" providerId="LiveId" clId="{2345AA29-D5AE-4783-9A1B-7E86E6AD882B}" dt="2018-05-09T07:21:05.781" v="2305" actId="478"/>
          <ac:spMkLst>
            <pc:docMk/>
            <pc:sldMk cId="789831365" sldId="260"/>
            <ac:spMk id="28" creationId="{3CC870FE-C977-45A0-AEB3-CD4A00BAD515}"/>
          </ac:spMkLst>
        </pc:spChg>
        <pc:spChg chg="del">
          <ac:chgData name="li li" userId="3d7a94fd48c86d40" providerId="LiveId" clId="{2345AA29-D5AE-4783-9A1B-7E86E6AD882B}" dt="2018-05-08T17:57:59.001" v="1222" actId="478"/>
          <ac:spMkLst>
            <pc:docMk/>
            <pc:sldMk cId="789831365" sldId="260"/>
            <ac:spMk id="38" creationId="{EFFEF081-5397-4A42-AA21-62250C28CB44}"/>
          </ac:spMkLst>
        </pc:spChg>
        <pc:spChg chg="del">
          <ac:chgData name="li li" userId="3d7a94fd48c86d40" providerId="LiveId" clId="{2345AA29-D5AE-4783-9A1B-7E86E6AD882B}" dt="2018-05-08T17:59:55.666" v="1514" actId="478"/>
          <ac:spMkLst>
            <pc:docMk/>
            <pc:sldMk cId="789831365" sldId="260"/>
            <ac:spMk id="45" creationId="{DCE1C1CA-618E-4CB3-BACD-760AB1508E84}"/>
          </ac:spMkLst>
        </pc:spChg>
        <pc:spChg chg="add mod">
          <ac:chgData name="li li" userId="3d7a94fd48c86d40" providerId="LiveId" clId="{2345AA29-D5AE-4783-9A1B-7E86E6AD882B}" dt="2018-05-09T07:21:36.792" v="2342" actId="1037"/>
          <ac:spMkLst>
            <pc:docMk/>
            <pc:sldMk cId="789831365" sldId="260"/>
            <ac:spMk id="49" creationId="{6A23E5D3-ED39-4D09-ABF7-BEEDFD7E4D7B}"/>
          </ac:spMkLst>
        </pc:spChg>
        <pc:spChg chg="add mod">
          <ac:chgData name="li li" userId="3d7a94fd48c86d40" providerId="LiveId" clId="{2345AA29-D5AE-4783-9A1B-7E86E6AD882B}" dt="2018-05-09T07:21:36.792" v="2342" actId="1037"/>
          <ac:spMkLst>
            <pc:docMk/>
            <pc:sldMk cId="789831365" sldId="260"/>
            <ac:spMk id="50" creationId="{E011AFBB-D1E3-40B2-86E8-679B5195AB63}"/>
          </ac:spMkLst>
        </pc:spChg>
        <pc:spChg chg="add mod">
          <ac:chgData name="li li" userId="3d7a94fd48c86d40" providerId="LiveId" clId="{2345AA29-D5AE-4783-9A1B-7E86E6AD882B}" dt="2018-05-09T07:21:36.792" v="2342" actId="1037"/>
          <ac:spMkLst>
            <pc:docMk/>
            <pc:sldMk cId="789831365" sldId="260"/>
            <ac:spMk id="51" creationId="{939018C3-B66A-4B60-AD99-9361CD02AB1B}"/>
          </ac:spMkLst>
        </pc:spChg>
        <pc:spChg chg="add mod">
          <ac:chgData name="li li" userId="3d7a94fd48c86d40" providerId="LiveId" clId="{2345AA29-D5AE-4783-9A1B-7E86E6AD882B}" dt="2018-05-09T07:21:36.792" v="2342" actId="1037"/>
          <ac:spMkLst>
            <pc:docMk/>
            <pc:sldMk cId="789831365" sldId="260"/>
            <ac:spMk id="52" creationId="{A5AB34EF-14D9-449B-BD31-5AA36C4F09DE}"/>
          </ac:spMkLst>
        </pc:spChg>
        <pc:spChg chg="add mod">
          <ac:chgData name="li li" userId="3d7a94fd48c86d40" providerId="LiveId" clId="{2345AA29-D5AE-4783-9A1B-7E86E6AD882B}" dt="2018-05-09T07:21:36.792" v="2342" actId="1037"/>
          <ac:spMkLst>
            <pc:docMk/>
            <pc:sldMk cId="789831365" sldId="260"/>
            <ac:spMk id="53" creationId="{31BE3A32-70BB-48F2-88E8-BAD35C5F726B}"/>
          </ac:spMkLst>
        </pc:spChg>
        <pc:spChg chg="add mod">
          <ac:chgData name="li li" userId="3d7a94fd48c86d40" providerId="LiveId" clId="{2345AA29-D5AE-4783-9A1B-7E86E6AD882B}" dt="2018-05-09T07:21:36.792" v="2342" actId="1037"/>
          <ac:spMkLst>
            <pc:docMk/>
            <pc:sldMk cId="789831365" sldId="260"/>
            <ac:spMk id="54" creationId="{4924647A-89D9-4109-B93D-107DF3052871}"/>
          </ac:spMkLst>
        </pc:spChg>
        <pc:spChg chg="add mod">
          <ac:chgData name="li li" userId="3d7a94fd48c86d40" providerId="LiveId" clId="{2345AA29-D5AE-4783-9A1B-7E86E6AD882B}" dt="2018-05-09T07:21:36.792" v="2342" actId="1037"/>
          <ac:spMkLst>
            <pc:docMk/>
            <pc:sldMk cId="789831365" sldId="260"/>
            <ac:spMk id="55" creationId="{96676F60-5907-4F21-AF2E-B788BFA362BE}"/>
          </ac:spMkLst>
        </pc:spChg>
        <pc:spChg chg="add mod">
          <ac:chgData name="li li" userId="3d7a94fd48c86d40" providerId="LiveId" clId="{2345AA29-D5AE-4783-9A1B-7E86E6AD882B}" dt="2018-05-09T07:21:36.792" v="2342" actId="1037"/>
          <ac:spMkLst>
            <pc:docMk/>
            <pc:sldMk cId="789831365" sldId="260"/>
            <ac:spMk id="56" creationId="{217C3E65-CD48-4FB5-B70B-98E38C250916}"/>
          </ac:spMkLst>
        </pc:spChg>
        <pc:spChg chg="add mod">
          <ac:chgData name="li li" userId="3d7a94fd48c86d40" providerId="LiveId" clId="{2345AA29-D5AE-4783-9A1B-7E86E6AD882B}" dt="2018-05-09T07:21:36.792" v="2342" actId="1037"/>
          <ac:spMkLst>
            <pc:docMk/>
            <pc:sldMk cId="789831365" sldId="260"/>
            <ac:spMk id="57" creationId="{76B3C4CC-F2E4-4623-B0C8-7588522DE313}"/>
          </ac:spMkLst>
        </pc:spChg>
        <pc:spChg chg="add mod">
          <ac:chgData name="li li" userId="3d7a94fd48c86d40" providerId="LiveId" clId="{2345AA29-D5AE-4783-9A1B-7E86E6AD882B}" dt="2018-05-09T07:21:36.792" v="2342" actId="1037"/>
          <ac:spMkLst>
            <pc:docMk/>
            <pc:sldMk cId="789831365" sldId="260"/>
            <ac:spMk id="58" creationId="{601C4E67-DBA3-4EB4-9368-4F792C7416D4}"/>
          </ac:spMkLst>
        </pc:spChg>
        <pc:spChg chg="add mod">
          <ac:chgData name="li li" userId="3d7a94fd48c86d40" providerId="LiveId" clId="{2345AA29-D5AE-4783-9A1B-7E86E6AD882B}" dt="2018-05-09T07:21:36.792" v="2342" actId="1037"/>
          <ac:spMkLst>
            <pc:docMk/>
            <pc:sldMk cId="789831365" sldId="260"/>
            <ac:spMk id="59" creationId="{7E020BC7-3F50-4A7F-B5C3-05A23D06954B}"/>
          </ac:spMkLst>
        </pc:spChg>
        <pc:spChg chg="add mod">
          <ac:chgData name="li li" userId="3d7a94fd48c86d40" providerId="LiveId" clId="{2345AA29-D5AE-4783-9A1B-7E86E6AD882B}" dt="2018-05-21T05:00:47.376" v="2411" actId="20577"/>
          <ac:spMkLst>
            <pc:docMk/>
            <pc:sldMk cId="789831365" sldId="260"/>
            <ac:spMk id="60" creationId="{0AB61ADB-7412-4CC5-9980-CEAD66C29A66}"/>
          </ac:spMkLst>
        </pc:spChg>
        <pc:grpChg chg="add mod">
          <ac:chgData name="li li" userId="3d7a94fd48c86d40" providerId="LiveId" clId="{2345AA29-D5AE-4783-9A1B-7E86E6AD882B}" dt="2018-05-09T07:21:05.423" v="2303" actId="164"/>
          <ac:grpSpMkLst>
            <pc:docMk/>
            <pc:sldMk cId="789831365" sldId="260"/>
            <ac:grpSpMk id="2" creationId="{5FAE934E-75D1-437E-B107-A351193DEB7F}"/>
          </ac:grpSpMkLst>
        </pc:grpChg>
        <pc:grpChg chg="add mod">
          <ac:chgData name="li li" userId="3d7a94fd48c86d40" providerId="LiveId" clId="{2345AA29-D5AE-4783-9A1B-7E86E6AD882B}" dt="2018-05-09T07:21:05.240" v="2302" actId="164"/>
          <ac:grpSpMkLst>
            <pc:docMk/>
            <pc:sldMk cId="789831365" sldId="260"/>
            <ac:grpSpMk id="3" creationId="{68416B19-D421-44CD-BB79-CB867B431F2C}"/>
          </ac:grpSpMkLst>
        </pc:grpChg>
        <pc:grpChg chg="add del mod">
          <ac:chgData name="li li" userId="3d7a94fd48c86d40" providerId="LiveId" clId="{2345AA29-D5AE-4783-9A1B-7E86E6AD882B}" dt="2018-05-08T17:52:56.021" v="1192" actId="165"/>
          <ac:grpSpMkLst>
            <pc:docMk/>
            <pc:sldMk cId="789831365" sldId="260"/>
            <ac:grpSpMk id="4" creationId="{A7FE0C14-FAD3-4860-B664-C4385F5B3234}"/>
          </ac:grpSpMkLst>
        </pc:grpChg>
        <pc:grpChg chg="add mod">
          <ac:chgData name="li li" userId="3d7a94fd48c86d40" providerId="LiveId" clId="{2345AA29-D5AE-4783-9A1B-7E86E6AD882B}" dt="2018-05-09T07:21:05.055" v="2301" actId="164"/>
          <ac:grpSpMkLst>
            <pc:docMk/>
            <pc:sldMk cId="789831365" sldId="260"/>
            <ac:grpSpMk id="4" creationId="{DAEC8A6F-0A57-43A8-9327-1926B1103D5F}"/>
          </ac:grpSpMkLst>
        </pc:grpChg>
        <pc:grpChg chg="add del mod">
          <ac:chgData name="li li" userId="3d7a94fd48c86d40" providerId="LiveId" clId="{2345AA29-D5AE-4783-9A1B-7E86E6AD882B}" dt="2018-05-09T07:21:36.792" v="2342" actId="1037"/>
          <ac:grpSpMkLst>
            <pc:docMk/>
            <pc:sldMk cId="789831365" sldId="260"/>
            <ac:grpSpMk id="9" creationId="{E2281A28-30EA-4233-9D80-D22B3BDB5663}"/>
          </ac:grpSpMkLst>
        </pc:grpChg>
        <pc:grpChg chg="add del mod">
          <ac:chgData name="li li" userId="3d7a94fd48c86d40" providerId="LiveId" clId="{2345AA29-D5AE-4783-9A1B-7E86E6AD882B}" dt="2018-05-08T17:59:11.291" v="1225" actId="165"/>
          <ac:grpSpMkLst>
            <pc:docMk/>
            <pc:sldMk cId="789831365" sldId="260"/>
            <ac:grpSpMk id="12" creationId="{70C4D449-14E0-43C6-A5DF-5764FE733F2A}"/>
          </ac:grpSpMkLst>
        </pc:grpChg>
        <pc:grpChg chg="add mod">
          <ac:chgData name="li li" userId="3d7a94fd48c86d40" providerId="LiveId" clId="{2345AA29-D5AE-4783-9A1B-7E86E6AD882B}" dt="2018-05-09T07:21:04.888" v="2300" actId="164"/>
          <ac:grpSpMkLst>
            <pc:docMk/>
            <pc:sldMk cId="789831365" sldId="260"/>
            <ac:grpSpMk id="12" creationId="{B6632B51-A2F0-49D2-B679-F50F78A2DAB4}"/>
          </ac:grpSpMkLst>
        </pc:grpChg>
        <pc:grpChg chg="add del mod">
          <ac:chgData name="li li" userId="3d7a94fd48c86d40" providerId="LiveId" clId="{2345AA29-D5AE-4783-9A1B-7E86E6AD882B}" dt="2018-05-08T17:51:32.157" v="1176" actId="478"/>
          <ac:grpSpMkLst>
            <pc:docMk/>
            <pc:sldMk cId="789831365" sldId="260"/>
            <ac:grpSpMk id="16" creationId="{78AEDBD6-B79E-417C-91B6-AC98CEA9BD20}"/>
          </ac:grpSpMkLst>
        </pc:grpChg>
        <pc:grpChg chg="add mod">
          <ac:chgData name="li li" userId="3d7a94fd48c86d40" providerId="LiveId" clId="{2345AA29-D5AE-4783-9A1B-7E86E6AD882B}" dt="2018-05-21T05:03:56.418" v="2412" actId="14100"/>
          <ac:grpSpMkLst>
            <pc:docMk/>
            <pc:sldMk cId="789831365" sldId="260"/>
            <ac:grpSpMk id="16" creationId="{7C6C8C59-5473-47CD-A29F-34F4333099A0}"/>
          </ac:grpSpMkLst>
        </pc:grpChg>
        <pc:grpChg chg="add del mod">
          <ac:chgData name="li li" userId="3d7a94fd48c86d40" providerId="LiveId" clId="{2345AA29-D5AE-4783-9A1B-7E86E6AD882B}" dt="2018-05-09T07:21:36.792" v="2342" actId="1037"/>
          <ac:grpSpMkLst>
            <pc:docMk/>
            <pc:sldMk cId="789831365" sldId="260"/>
            <ac:grpSpMk id="19" creationId="{E9895006-6AD0-4B6D-A1A2-0C35C4282A02}"/>
          </ac:grpSpMkLst>
        </pc:grpChg>
        <pc:grpChg chg="add del mod">
          <ac:chgData name="li li" userId="3d7a94fd48c86d40" providerId="LiveId" clId="{2345AA29-D5AE-4783-9A1B-7E86E6AD882B}" dt="2018-05-09T07:21:36.792" v="2342" actId="1037"/>
          <ac:grpSpMkLst>
            <pc:docMk/>
            <pc:sldMk cId="789831365" sldId="260"/>
            <ac:grpSpMk id="22" creationId="{1EE1ED6E-537E-4BEB-BE1A-7888261874C9}"/>
          </ac:grpSpMkLst>
        </pc:grpChg>
        <pc:grpChg chg="add del mod">
          <ac:chgData name="li li" userId="3d7a94fd48c86d40" providerId="LiveId" clId="{2345AA29-D5AE-4783-9A1B-7E86E6AD882B}" dt="2018-05-09T07:21:36.792" v="2342" actId="1037"/>
          <ac:grpSpMkLst>
            <pc:docMk/>
            <pc:sldMk cId="789831365" sldId="260"/>
            <ac:grpSpMk id="25" creationId="{32714315-D398-4B6B-92E4-3CBCE77F2BEC}"/>
          </ac:grpSpMkLst>
        </pc:grpChg>
        <pc:grpChg chg="add del mod">
          <ac:chgData name="li li" userId="3d7a94fd48c86d40" providerId="LiveId" clId="{2345AA29-D5AE-4783-9A1B-7E86E6AD882B}" dt="2018-05-09T07:21:36.792" v="2342" actId="1037"/>
          <ac:grpSpMkLst>
            <pc:docMk/>
            <pc:sldMk cId="789831365" sldId="260"/>
            <ac:grpSpMk id="31" creationId="{22F058CC-B076-4906-A17E-1DA6D7943F50}"/>
          </ac:grpSpMkLst>
        </pc:grpChg>
        <pc:grpChg chg="add del mod">
          <ac:chgData name="li li" userId="3d7a94fd48c86d40" providerId="LiveId" clId="{2345AA29-D5AE-4783-9A1B-7E86E6AD882B}" dt="2018-05-09T07:21:36.792" v="2342" actId="1037"/>
          <ac:grpSpMkLst>
            <pc:docMk/>
            <pc:sldMk cId="789831365" sldId="260"/>
            <ac:grpSpMk id="34" creationId="{8D6DCD42-56E4-43FD-A987-CE11AB5155C4}"/>
          </ac:grpSpMkLst>
        </pc:grpChg>
        <pc:grpChg chg="add del mod">
          <ac:chgData name="li li" userId="3d7a94fd48c86d40" providerId="LiveId" clId="{2345AA29-D5AE-4783-9A1B-7E86E6AD882B}" dt="2018-05-09T07:21:36.792" v="2342" actId="1037"/>
          <ac:grpSpMkLst>
            <pc:docMk/>
            <pc:sldMk cId="789831365" sldId="260"/>
            <ac:grpSpMk id="37" creationId="{558B9414-6739-47F8-BC69-2E4F17F6B0F2}"/>
          </ac:grpSpMkLst>
        </pc:grpChg>
        <pc:grpChg chg="add del mod">
          <ac:chgData name="li li" userId="3d7a94fd48c86d40" providerId="LiveId" clId="{2345AA29-D5AE-4783-9A1B-7E86E6AD882B}" dt="2018-05-09T07:21:36.792" v="2342" actId="1037"/>
          <ac:grpSpMkLst>
            <pc:docMk/>
            <pc:sldMk cId="789831365" sldId="260"/>
            <ac:grpSpMk id="41" creationId="{4287427F-E7E7-4C8E-BE7E-FA3F3E11BAF4}"/>
          </ac:grpSpMkLst>
        </pc:grpChg>
        <pc:grpChg chg="del">
          <ac:chgData name="li li" userId="3d7a94fd48c86d40" providerId="LiveId" clId="{2345AA29-D5AE-4783-9A1B-7E86E6AD882B}" dt="2018-05-08T17:59:55.666" v="1514" actId="478"/>
          <ac:grpSpMkLst>
            <pc:docMk/>
            <pc:sldMk cId="789831365" sldId="260"/>
            <ac:grpSpMk id="42" creationId="{10BAA86D-A525-4007-8E7C-ABFCA6F4E5E6}"/>
          </ac:grpSpMkLst>
        </pc:grpChg>
        <pc:grpChg chg="add del mod">
          <ac:chgData name="li li" userId="3d7a94fd48c86d40" providerId="LiveId" clId="{2345AA29-D5AE-4783-9A1B-7E86E6AD882B}" dt="2018-05-09T07:21:36.792" v="2342" actId="1037"/>
          <ac:grpSpMkLst>
            <pc:docMk/>
            <pc:sldMk cId="789831365" sldId="260"/>
            <ac:grpSpMk id="46" creationId="{EA5F9049-B01C-40C9-859B-6DDCCCD151A5}"/>
          </ac:grpSpMkLst>
        </pc:grpChg>
        <pc:grpChg chg="add del mod">
          <ac:chgData name="li li" userId="3d7a94fd48c86d40" providerId="LiveId" clId="{2345AA29-D5AE-4783-9A1B-7E86E6AD882B}" dt="2018-05-09T07:21:36.792" v="2342" actId="1037"/>
          <ac:grpSpMkLst>
            <pc:docMk/>
            <pc:sldMk cId="789831365" sldId="260"/>
            <ac:grpSpMk id="47" creationId="{06AAAC3D-8E98-4CE5-85F9-8BD869067E76}"/>
          </ac:grpSpMkLst>
        </pc:grpChg>
        <pc:grpChg chg="add del mod">
          <ac:chgData name="li li" userId="3d7a94fd48c86d40" providerId="LiveId" clId="{2345AA29-D5AE-4783-9A1B-7E86E6AD882B}" dt="2018-05-09T07:21:36.792" v="2342" actId="1037"/>
          <ac:grpSpMkLst>
            <pc:docMk/>
            <pc:sldMk cId="789831365" sldId="260"/>
            <ac:grpSpMk id="48" creationId="{304B68A4-248F-4BF0-9659-FAA21A5BC5E3}"/>
          </ac:grpSpMkLst>
        </pc:grpChg>
        <pc:picChg chg="mod topLvl">
          <ac:chgData name="li li" userId="3d7a94fd48c86d40" providerId="LiveId" clId="{2345AA29-D5AE-4783-9A1B-7E86E6AD882B}" dt="2018-05-09T07:21:05.604" v="2304" actId="165"/>
          <ac:picMkLst>
            <pc:docMk/>
            <pc:sldMk cId="789831365" sldId="260"/>
            <ac:picMk id="5" creationId="{CE95C887-44D7-41B6-AD0C-6B38356CDC24}"/>
          </ac:picMkLst>
        </pc:picChg>
        <pc:picChg chg="mod topLvl">
          <ac:chgData name="li li" userId="3d7a94fd48c86d40" providerId="LiveId" clId="{2345AA29-D5AE-4783-9A1B-7E86E6AD882B}" dt="2018-05-09T07:21:05.604" v="2304" actId="165"/>
          <ac:picMkLst>
            <pc:docMk/>
            <pc:sldMk cId="789831365" sldId="260"/>
            <ac:picMk id="6" creationId="{3B232D08-5F49-4F14-A36E-00521D806D63}"/>
          </ac:picMkLst>
        </pc:picChg>
        <pc:picChg chg="mod topLvl">
          <ac:chgData name="li li" userId="3d7a94fd48c86d40" providerId="LiveId" clId="{2345AA29-D5AE-4783-9A1B-7E86E6AD882B}" dt="2018-05-09T07:21:05.604" v="2304" actId="165"/>
          <ac:picMkLst>
            <pc:docMk/>
            <pc:sldMk cId="789831365" sldId="260"/>
            <ac:picMk id="7" creationId="{70D6AB11-7001-4A08-9867-676A591527CE}"/>
          </ac:picMkLst>
        </pc:picChg>
        <pc:picChg chg="mod topLvl">
          <ac:chgData name="li li" userId="3d7a94fd48c86d40" providerId="LiveId" clId="{2345AA29-D5AE-4783-9A1B-7E86E6AD882B}" dt="2018-05-09T07:21:05.604" v="2304" actId="165"/>
          <ac:picMkLst>
            <pc:docMk/>
            <pc:sldMk cId="789831365" sldId="260"/>
            <ac:picMk id="8" creationId="{BB394497-48E9-47D4-9C84-7463CA06F9B5}"/>
          </ac:picMkLst>
        </pc:picChg>
        <pc:picChg chg="mod topLvl">
          <ac:chgData name="li li" userId="3d7a94fd48c86d40" providerId="LiveId" clId="{2345AA29-D5AE-4783-9A1B-7E86E6AD882B}" dt="2018-05-09T07:21:05.604" v="2304" actId="165"/>
          <ac:picMkLst>
            <pc:docMk/>
            <pc:sldMk cId="789831365" sldId="260"/>
            <ac:picMk id="10" creationId="{93B0C971-1994-4181-B59E-2C2E2F2C0A37}"/>
          </ac:picMkLst>
        </pc:picChg>
        <pc:picChg chg="mod topLvl">
          <ac:chgData name="li li" userId="3d7a94fd48c86d40" providerId="LiveId" clId="{2345AA29-D5AE-4783-9A1B-7E86E6AD882B}" dt="2018-05-09T07:21:05.604" v="2304" actId="165"/>
          <ac:picMkLst>
            <pc:docMk/>
            <pc:sldMk cId="789831365" sldId="260"/>
            <ac:picMk id="11" creationId="{76C4F060-B9BA-4481-A3CB-E41DC073635E}"/>
          </ac:picMkLst>
        </pc:picChg>
        <pc:picChg chg="mod topLvl">
          <ac:chgData name="li li" userId="3d7a94fd48c86d40" providerId="LiveId" clId="{2345AA29-D5AE-4783-9A1B-7E86E6AD882B}" dt="2018-05-09T07:21:36.792" v="2342" actId="1037"/>
          <ac:picMkLst>
            <pc:docMk/>
            <pc:sldMk cId="789831365" sldId="260"/>
            <ac:picMk id="14" creationId="{5FDF8DB7-21A6-45F8-AC37-83A8FE2CF903}"/>
          </ac:picMkLst>
        </pc:picChg>
        <pc:picChg chg="mod topLvl">
          <ac:chgData name="li li" userId="3d7a94fd48c86d40" providerId="LiveId" clId="{2345AA29-D5AE-4783-9A1B-7E86E6AD882B}" dt="2018-05-09T07:21:36.792" v="2342" actId="1037"/>
          <ac:picMkLst>
            <pc:docMk/>
            <pc:sldMk cId="789831365" sldId="260"/>
            <ac:picMk id="15" creationId="{745C227B-8699-4502-9FC6-3211C816FD63}"/>
          </ac:picMkLst>
        </pc:picChg>
        <pc:picChg chg="mod topLvl">
          <ac:chgData name="li li" userId="3d7a94fd48c86d40" providerId="LiveId" clId="{2345AA29-D5AE-4783-9A1B-7E86E6AD882B}" dt="2018-05-09T07:21:05.604" v="2304" actId="165"/>
          <ac:picMkLst>
            <pc:docMk/>
            <pc:sldMk cId="789831365" sldId="260"/>
            <ac:picMk id="20" creationId="{A5EDA1D9-0675-4663-8A5E-B31B80CE77FE}"/>
          </ac:picMkLst>
        </pc:picChg>
        <pc:picChg chg="mod topLvl">
          <ac:chgData name="li li" userId="3d7a94fd48c86d40" providerId="LiveId" clId="{2345AA29-D5AE-4783-9A1B-7E86E6AD882B}" dt="2018-05-09T07:21:05.604" v="2304" actId="165"/>
          <ac:picMkLst>
            <pc:docMk/>
            <pc:sldMk cId="789831365" sldId="260"/>
            <ac:picMk id="21" creationId="{0A1A375B-1BB5-4298-85FA-6C857B419A97}"/>
          </ac:picMkLst>
        </pc:picChg>
        <pc:picChg chg="mod topLvl">
          <ac:chgData name="li li" userId="3d7a94fd48c86d40" providerId="LiveId" clId="{2345AA29-D5AE-4783-9A1B-7E86E6AD882B}" dt="2018-05-09T07:21:05.604" v="2304" actId="165"/>
          <ac:picMkLst>
            <pc:docMk/>
            <pc:sldMk cId="789831365" sldId="260"/>
            <ac:picMk id="23" creationId="{50EE91A8-94BD-4D2B-9F77-BA39FD48C7F8}"/>
          </ac:picMkLst>
        </pc:picChg>
        <pc:picChg chg="mod topLvl">
          <ac:chgData name="li li" userId="3d7a94fd48c86d40" providerId="LiveId" clId="{2345AA29-D5AE-4783-9A1B-7E86E6AD882B}" dt="2018-05-09T07:21:05.604" v="2304" actId="165"/>
          <ac:picMkLst>
            <pc:docMk/>
            <pc:sldMk cId="789831365" sldId="260"/>
            <ac:picMk id="24" creationId="{373581B7-0210-4E75-962B-2E1AF2A2E151}"/>
          </ac:picMkLst>
        </pc:picChg>
        <pc:picChg chg="mod topLvl">
          <ac:chgData name="li li" userId="3d7a94fd48c86d40" providerId="LiveId" clId="{2345AA29-D5AE-4783-9A1B-7E86E6AD882B}" dt="2018-05-09T07:21:05.604" v="2304" actId="165"/>
          <ac:picMkLst>
            <pc:docMk/>
            <pc:sldMk cId="789831365" sldId="260"/>
            <ac:picMk id="26" creationId="{40C96AB4-470F-4059-9BC1-4104725B935E}"/>
          </ac:picMkLst>
        </pc:picChg>
        <pc:picChg chg="mod topLvl">
          <ac:chgData name="li li" userId="3d7a94fd48c86d40" providerId="LiveId" clId="{2345AA29-D5AE-4783-9A1B-7E86E6AD882B}" dt="2018-05-09T07:21:05.604" v="2304" actId="165"/>
          <ac:picMkLst>
            <pc:docMk/>
            <pc:sldMk cId="789831365" sldId="260"/>
            <ac:picMk id="27" creationId="{5A018F87-94C9-44B0-AFC0-9174D2D380E0}"/>
          </ac:picMkLst>
        </pc:picChg>
        <pc:picChg chg="add mod topLvl">
          <ac:chgData name="li li" userId="3d7a94fd48c86d40" providerId="LiveId" clId="{2345AA29-D5AE-4783-9A1B-7E86E6AD882B}" dt="2018-05-09T07:21:05.604" v="2304" actId="165"/>
          <ac:picMkLst>
            <pc:docMk/>
            <pc:sldMk cId="789831365" sldId="260"/>
            <ac:picMk id="29" creationId="{8AC84FDD-492C-4969-98C7-B2E2139A77E6}"/>
          </ac:picMkLst>
        </pc:picChg>
        <pc:picChg chg="add mod topLvl">
          <ac:chgData name="li li" userId="3d7a94fd48c86d40" providerId="LiveId" clId="{2345AA29-D5AE-4783-9A1B-7E86E6AD882B}" dt="2018-05-09T07:21:05.604" v="2304" actId="165"/>
          <ac:picMkLst>
            <pc:docMk/>
            <pc:sldMk cId="789831365" sldId="260"/>
            <ac:picMk id="30" creationId="{01943241-4B54-4C17-8347-3054AF216E7D}"/>
          </ac:picMkLst>
        </pc:picChg>
        <pc:picChg chg="mod topLvl">
          <ac:chgData name="li li" userId="3d7a94fd48c86d40" providerId="LiveId" clId="{2345AA29-D5AE-4783-9A1B-7E86E6AD882B}" dt="2018-05-09T07:21:05.604" v="2304" actId="165"/>
          <ac:picMkLst>
            <pc:docMk/>
            <pc:sldMk cId="789831365" sldId="260"/>
            <ac:picMk id="32" creationId="{6363A3F4-60B6-4C1C-84BF-A2C4F646DDDD}"/>
          </ac:picMkLst>
        </pc:picChg>
        <pc:picChg chg="mod topLvl">
          <ac:chgData name="li li" userId="3d7a94fd48c86d40" providerId="LiveId" clId="{2345AA29-D5AE-4783-9A1B-7E86E6AD882B}" dt="2018-05-09T07:21:05.604" v="2304" actId="165"/>
          <ac:picMkLst>
            <pc:docMk/>
            <pc:sldMk cId="789831365" sldId="260"/>
            <ac:picMk id="33" creationId="{9948575D-D31C-40A8-BC63-AB06A8E34076}"/>
          </ac:picMkLst>
        </pc:picChg>
        <pc:picChg chg="mod topLvl">
          <ac:chgData name="li li" userId="3d7a94fd48c86d40" providerId="LiveId" clId="{2345AA29-D5AE-4783-9A1B-7E86E6AD882B}" dt="2018-05-09T07:21:05.604" v="2304" actId="165"/>
          <ac:picMkLst>
            <pc:docMk/>
            <pc:sldMk cId="789831365" sldId="260"/>
            <ac:picMk id="35" creationId="{C985420C-4733-497B-A7D9-21900B72646A}"/>
          </ac:picMkLst>
        </pc:picChg>
        <pc:picChg chg="mod topLvl">
          <ac:chgData name="li li" userId="3d7a94fd48c86d40" providerId="LiveId" clId="{2345AA29-D5AE-4783-9A1B-7E86E6AD882B}" dt="2018-05-09T07:21:05.604" v="2304" actId="165"/>
          <ac:picMkLst>
            <pc:docMk/>
            <pc:sldMk cId="789831365" sldId="260"/>
            <ac:picMk id="36" creationId="{1D17AED6-0DFD-46FB-996E-9B14085F8F51}"/>
          </ac:picMkLst>
        </pc:picChg>
        <pc:picChg chg="mod topLvl">
          <ac:chgData name="li li" userId="3d7a94fd48c86d40" providerId="LiveId" clId="{2345AA29-D5AE-4783-9A1B-7E86E6AD882B}" dt="2018-05-09T07:21:05.604" v="2304" actId="165"/>
          <ac:picMkLst>
            <pc:docMk/>
            <pc:sldMk cId="789831365" sldId="260"/>
            <ac:picMk id="39" creationId="{44B68347-18B0-4EAB-9EE9-401298310B4B}"/>
          </ac:picMkLst>
        </pc:picChg>
        <pc:picChg chg="mod topLvl">
          <ac:chgData name="li li" userId="3d7a94fd48c86d40" providerId="LiveId" clId="{2345AA29-D5AE-4783-9A1B-7E86E6AD882B}" dt="2018-05-09T07:21:05.604" v="2304" actId="165"/>
          <ac:picMkLst>
            <pc:docMk/>
            <pc:sldMk cId="789831365" sldId="260"/>
            <ac:picMk id="40" creationId="{9446F52C-7D4C-4535-A606-1D6C01A7CD1F}"/>
          </ac:picMkLst>
        </pc:picChg>
        <pc:picChg chg="mod topLvl">
          <ac:chgData name="li li" userId="3d7a94fd48c86d40" providerId="LiveId" clId="{2345AA29-D5AE-4783-9A1B-7E86E6AD882B}" dt="2018-05-09T07:21:05.604" v="2304" actId="165"/>
          <ac:picMkLst>
            <pc:docMk/>
            <pc:sldMk cId="789831365" sldId="260"/>
            <ac:picMk id="43" creationId="{7857D091-015F-4CC0-B6E4-D0A60076E95B}"/>
          </ac:picMkLst>
        </pc:picChg>
        <pc:picChg chg="mod topLvl">
          <ac:chgData name="li li" userId="3d7a94fd48c86d40" providerId="LiveId" clId="{2345AA29-D5AE-4783-9A1B-7E86E6AD882B}" dt="2018-05-09T07:21:05.604" v="2304" actId="165"/>
          <ac:picMkLst>
            <pc:docMk/>
            <pc:sldMk cId="789831365" sldId="260"/>
            <ac:picMk id="44" creationId="{24910FF9-F255-45FF-83BF-EC58CF394F6E}"/>
          </ac:picMkLst>
        </pc:picChg>
        <pc:picChg chg="add mod">
          <ac:chgData name="li li" userId="3d7a94fd48c86d40" providerId="LiveId" clId="{2345AA29-D5AE-4783-9A1B-7E86E6AD882B}" dt="2018-05-09T07:22:12.632" v="2344" actId="164"/>
          <ac:picMkLst>
            <pc:docMk/>
            <pc:sldMk cId="789831365" sldId="260"/>
            <ac:picMk id="61" creationId="{5402ADEC-A6BA-4902-9F46-4E50E53A0161}"/>
          </ac:picMkLst>
        </pc:picChg>
        <pc:picChg chg="add mod">
          <ac:chgData name="li li" userId="3d7a94fd48c86d40" providerId="LiveId" clId="{2345AA29-D5AE-4783-9A1B-7E86E6AD882B}" dt="2018-05-21T05:04:11.222" v="2460" actId="1038"/>
          <ac:picMkLst>
            <pc:docMk/>
            <pc:sldMk cId="789831365" sldId="260"/>
            <ac:picMk id="62" creationId="{8F821460-DCFB-4713-B716-90A93C59A023}"/>
          </ac:picMkLst>
        </pc:pic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BE9671E-03B8-47E9-B924-5C3A5890031C}" type="datetimeFigureOut">
              <a:rPr lang="zh-CN" altLang="en-US" smtClean="0"/>
              <a:t>2019/3/29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753F99F-8E1B-4791-847B-CCFA1753569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3783431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753F99F-8E1B-4791-847B-CCFA17535696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7569458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7560171-53B2-4AAB-BB32-1DB6D27464D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376F73D7-D794-4A47-B734-39B78FB1CA6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6EB5980-D286-4528-B20C-38CCA5E633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A28747-1EF4-43EB-BEF9-C47B88C90F04}" type="datetimeFigureOut">
              <a:rPr lang="zh-CN" altLang="en-US" smtClean="0"/>
              <a:t>2019/3/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04EDFEE-2DB9-45A8-9841-FBA4C32D1D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8CE9B86-2DBD-45BD-A030-52CDB168F2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C18E12-CCB6-4D5E-9256-642272C653E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045527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FE74F1A-FA78-4710-8B14-DCE87E79208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4FF9E0BF-2DC4-4689-9BB2-0DEE3B97FBF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79E6CA7-F929-4C2D-8128-B86E7171BF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A28747-1EF4-43EB-BEF9-C47B88C90F04}" type="datetimeFigureOut">
              <a:rPr lang="zh-CN" altLang="en-US" smtClean="0"/>
              <a:t>2019/3/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6CD3650-E4B9-4C9D-8BFE-9B21834F21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29235D5-12D1-4FE8-A7FA-33A629C009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C18E12-CCB6-4D5E-9256-642272C653E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367038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63A11762-7478-44A8-82AB-42013816501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EDD2038D-F2C4-4D20-90B2-07C99EF5A4C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506655E-B8A6-46EA-9A18-B5B7E84F3F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A28747-1EF4-43EB-BEF9-C47B88C90F04}" type="datetimeFigureOut">
              <a:rPr lang="zh-CN" altLang="en-US" smtClean="0"/>
              <a:t>2019/3/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568C52C-3445-4CF3-A572-134110EB2B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0DCF22B-FAE4-47EC-8CB7-8C3F3043DA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C18E12-CCB6-4D5E-9256-642272C653E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286481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E55B13D-DB71-44E8-8165-DC84A198D15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B042799E-2889-41E6-93FD-08723E22EA8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E21B6FD-F0B5-44B2-BC97-F81AD587A3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A28747-1EF4-43EB-BEF9-C47B88C90F04}" type="datetimeFigureOut">
              <a:rPr lang="zh-CN" altLang="en-US" smtClean="0"/>
              <a:t>2019/3/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6646EB5-46DD-4DB7-A45A-5CBCEDFBF9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A5B04C9-5F84-4847-947A-65D663AE26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C18E12-CCB6-4D5E-9256-642272C653E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836897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49AD717-7525-41E3-8628-7134B0D3BEC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30B454D6-E326-42B7-88B2-070DC56EE2D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B1D2918-B6DE-4E28-B6E3-73AA44C891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A28747-1EF4-43EB-BEF9-C47B88C90F04}" type="datetimeFigureOut">
              <a:rPr lang="zh-CN" altLang="en-US" smtClean="0"/>
              <a:t>2019/3/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ADD6EC1-CE1B-4F9A-94B3-E2BBD4C49C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D47E0A2-D6E4-4039-8CDE-0EE58DCED6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C18E12-CCB6-4D5E-9256-642272C653E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807590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E8099F0-CE48-40FF-BE80-B44165F8DF7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E42734E3-A607-4CB3-9BA2-0EAF0DD24E6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3015D079-265C-4A35-AA9E-E201D2AD1C7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A944EE48-97EB-45A9-93F2-4680DC9131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A28747-1EF4-43EB-BEF9-C47B88C90F04}" type="datetimeFigureOut">
              <a:rPr lang="zh-CN" altLang="en-US" smtClean="0"/>
              <a:t>2019/3/2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06495CEC-315A-49B6-8F01-AFB7418E69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96C2E491-0CB5-4BFC-A2A0-E6699DCBD2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C18E12-CCB6-4D5E-9256-642272C653E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397313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3D3E836-E794-4E62-8A15-810B32A568B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5C961F16-E8A8-42B1-A439-16C43EBF879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71737287-8A69-452D-B9B6-791966360DC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A3D6A76F-B9BC-41C7-AF14-C61170AE596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96AA4028-7683-4937-ACB4-2D95D3046A2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F3AB537D-F1D9-491B-82F0-B2D73590E6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A28747-1EF4-43EB-BEF9-C47B88C90F04}" type="datetimeFigureOut">
              <a:rPr lang="zh-CN" altLang="en-US" smtClean="0"/>
              <a:t>2019/3/29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48E8FEC7-4220-4D2A-A6C3-AAA464453D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F2A6D8B6-EDDC-4791-BDC0-A1A08A64DA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C18E12-CCB6-4D5E-9256-642272C653E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014015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2524EFB-93AD-4F74-8AD1-1AB3C80CCA8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BBB9523F-5C7C-4495-B31D-53551BF1E7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A28747-1EF4-43EB-BEF9-C47B88C90F04}" type="datetimeFigureOut">
              <a:rPr lang="zh-CN" altLang="en-US" smtClean="0"/>
              <a:t>2019/3/29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13A0BDF5-FF85-4F01-99F4-F28DEB6C11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E4348E29-BB07-4E61-9735-E3FD7F71FA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C18E12-CCB6-4D5E-9256-642272C653E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901464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31CCB5D5-C563-41DD-B005-0F6DE69EFD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A28747-1EF4-43EB-BEF9-C47B88C90F04}" type="datetimeFigureOut">
              <a:rPr lang="zh-CN" altLang="en-US" smtClean="0"/>
              <a:t>2019/3/29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AD666E31-9FB3-420C-A748-6E82895F4A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4A94FB30-E555-45FD-81DD-8ED5C1A451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C18E12-CCB6-4D5E-9256-642272C653E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003265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144C301-CA32-4F44-9A61-DDF374A344A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667A7128-2B59-47E1-8DE3-EA61088287F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6FBDF0B5-834E-4691-9DD4-4EDFA61AA55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DADB207E-98D3-430F-8E4D-9AE86EF5F8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A28747-1EF4-43EB-BEF9-C47B88C90F04}" type="datetimeFigureOut">
              <a:rPr lang="zh-CN" altLang="en-US" smtClean="0"/>
              <a:t>2019/3/2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48FE78D5-188D-4CD0-B5AF-A59824C1A2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3F0604DF-2552-4988-AD5C-1E87942B2F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C18E12-CCB6-4D5E-9256-642272C653E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639976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5733E8F-2273-4CFD-988D-70EF30FEA65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63FC665C-4C2F-4E3A-BDB9-5E272869439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8F871941-6B6F-414B-A3E0-5803588D5D2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FF151456-DCEF-4431-B02A-5B63C96274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A28747-1EF4-43EB-BEF9-C47B88C90F04}" type="datetimeFigureOut">
              <a:rPr lang="zh-CN" altLang="en-US" smtClean="0"/>
              <a:t>2019/3/2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07C24728-5A90-40AC-8A8A-7BF75D1093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B684D934-5484-446B-A935-C8E2C18A4B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C18E12-CCB6-4D5E-9256-642272C653E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59150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A158C9C3-3616-4978-92B9-D0776EC93A7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450BFD16-ECB8-4B0F-BA67-B45A5BECB16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A46BB14-B13C-4CE6-8674-2B8CFF4F1E0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A28747-1EF4-43EB-BEF9-C47B88C90F04}" type="datetimeFigureOut">
              <a:rPr lang="zh-CN" altLang="en-US" smtClean="0"/>
              <a:t>2019/3/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AB203F7-A2F4-4C13-9945-ADAC8DE8E33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6843A7D-9008-48AF-9835-0C0A3459CD6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C18E12-CCB6-4D5E-9256-642272C653E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183524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1.png"/><Relationship Id="rId18" Type="http://schemas.openxmlformats.org/officeDocument/2006/relationships/image" Target="../media/image16.png"/><Relationship Id="rId26" Type="http://schemas.openxmlformats.org/officeDocument/2006/relationships/image" Target="../media/image24.emf"/><Relationship Id="rId39" Type="http://schemas.openxmlformats.org/officeDocument/2006/relationships/image" Target="../media/image37.emf"/><Relationship Id="rId3" Type="http://schemas.openxmlformats.org/officeDocument/2006/relationships/image" Target="../media/image1.png"/><Relationship Id="rId21" Type="http://schemas.openxmlformats.org/officeDocument/2006/relationships/image" Target="../media/image19.png"/><Relationship Id="rId34" Type="http://schemas.openxmlformats.org/officeDocument/2006/relationships/image" Target="../media/image32.emf"/><Relationship Id="rId42" Type="http://schemas.openxmlformats.org/officeDocument/2006/relationships/image" Target="../media/image40.emf"/><Relationship Id="rId7" Type="http://schemas.openxmlformats.org/officeDocument/2006/relationships/image" Target="../media/image5.png"/><Relationship Id="rId12" Type="http://schemas.openxmlformats.org/officeDocument/2006/relationships/image" Target="../media/image10.png"/><Relationship Id="rId17" Type="http://schemas.openxmlformats.org/officeDocument/2006/relationships/image" Target="../media/image15.png"/><Relationship Id="rId25" Type="http://schemas.openxmlformats.org/officeDocument/2006/relationships/image" Target="../media/image23.emf"/><Relationship Id="rId33" Type="http://schemas.openxmlformats.org/officeDocument/2006/relationships/image" Target="../media/image31.emf"/><Relationship Id="rId38" Type="http://schemas.openxmlformats.org/officeDocument/2006/relationships/image" Target="../media/image36.emf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png"/><Relationship Id="rId20" Type="http://schemas.openxmlformats.org/officeDocument/2006/relationships/image" Target="../media/image18.png"/><Relationship Id="rId29" Type="http://schemas.openxmlformats.org/officeDocument/2006/relationships/image" Target="../media/image27.emf"/><Relationship Id="rId41" Type="http://schemas.openxmlformats.org/officeDocument/2006/relationships/image" Target="../media/image39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24" Type="http://schemas.openxmlformats.org/officeDocument/2006/relationships/image" Target="../media/image22.png"/><Relationship Id="rId32" Type="http://schemas.openxmlformats.org/officeDocument/2006/relationships/image" Target="../media/image30.emf"/><Relationship Id="rId37" Type="http://schemas.openxmlformats.org/officeDocument/2006/relationships/image" Target="../media/image35.emf"/><Relationship Id="rId40" Type="http://schemas.openxmlformats.org/officeDocument/2006/relationships/image" Target="../media/image38.emf"/><Relationship Id="rId5" Type="http://schemas.openxmlformats.org/officeDocument/2006/relationships/image" Target="../media/image3.png"/><Relationship Id="rId15" Type="http://schemas.openxmlformats.org/officeDocument/2006/relationships/image" Target="../media/image13.png"/><Relationship Id="rId23" Type="http://schemas.openxmlformats.org/officeDocument/2006/relationships/image" Target="../media/image21.png"/><Relationship Id="rId28" Type="http://schemas.openxmlformats.org/officeDocument/2006/relationships/image" Target="../media/image26.emf"/><Relationship Id="rId36" Type="http://schemas.openxmlformats.org/officeDocument/2006/relationships/image" Target="../media/image34.emf"/><Relationship Id="rId10" Type="http://schemas.openxmlformats.org/officeDocument/2006/relationships/image" Target="../media/image8.png"/><Relationship Id="rId19" Type="http://schemas.openxmlformats.org/officeDocument/2006/relationships/image" Target="../media/image17.png"/><Relationship Id="rId31" Type="http://schemas.openxmlformats.org/officeDocument/2006/relationships/image" Target="../media/image29.emf"/><Relationship Id="rId44" Type="http://schemas.openxmlformats.org/officeDocument/2006/relationships/image" Target="../media/image42.emf"/><Relationship Id="rId4" Type="http://schemas.openxmlformats.org/officeDocument/2006/relationships/image" Target="../media/image2.png"/><Relationship Id="rId9" Type="http://schemas.openxmlformats.org/officeDocument/2006/relationships/image" Target="../media/image7.png"/><Relationship Id="rId14" Type="http://schemas.openxmlformats.org/officeDocument/2006/relationships/image" Target="../media/image12.png"/><Relationship Id="rId22" Type="http://schemas.openxmlformats.org/officeDocument/2006/relationships/image" Target="../media/image20.png"/><Relationship Id="rId27" Type="http://schemas.openxmlformats.org/officeDocument/2006/relationships/image" Target="../media/image25.emf"/><Relationship Id="rId30" Type="http://schemas.openxmlformats.org/officeDocument/2006/relationships/image" Target="../media/image28.emf"/><Relationship Id="rId35" Type="http://schemas.openxmlformats.org/officeDocument/2006/relationships/image" Target="../media/image33.emf"/><Relationship Id="rId43" Type="http://schemas.openxmlformats.org/officeDocument/2006/relationships/image" Target="../media/image41.em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47.png"/><Relationship Id="rId13" Type="http://schemas.openxmlformats.org/officeDocument/2006/relationships/image" Target="../media/image52.png"/><Relationship Id="rId18" Type="http://schemas.openxmlformats.org/officeDocument/2006/relationships/image" Target="../media/image57.png"/><Relationship Id="rId26" Type="http://schemas.openxmlformats.org/officeDocument/2006/relationships/image" Target="../media/image65.emf"/><Relationship Id="rId39" Type="http://schemas.openxmlformats.org/officeDocument/2006/relationships/image" Target="../media/image78.emf"/><Relationship Id="rId3" Type="http://schemas.openxmlformats.org/officeDocument/2006/relationships/image" Target="../media/image15.png"/><Relationship Id="rId21" Type="http://schemas.openxmlformats.org/officeDocument/2006/relationships/image" Target="../media/image60.png"/><Relationship Id="rId34" Type="http://schemas.openxmlformats.org/officeDocument/2006/relationships/image" Target="../media/image73.emf"/><Relationship Id="rId42" Type="http://schemas.openxmlformats.org/officeDocument/2006/relationships/image" Target="../media/image81.emf"/><Relationship Id="rId7" Type="http://schemas.openxmlformats.org/officeDocument/2006/relationships/image" Target="../media/image46.png"/><Relationship Id="rId12" Type="http://schemas.openxmlformats.org/officeDocument/2006/relationships/image" Target="../media/image51.png"/><Relationship Id="rId17" Type="http://schemas.openxmlformats.org/officeDocument/2006/relationships/image" Target="../media/image56.png"/><Relationship Id="rId25" Type="http://schemas.openxmlformats.org/officeDocument/2006/relationships/image" Target="../media/image64.emf"/><Relationship Id="rId33" Type="http://schemas.openxmlformats.org/officeDocument/2006/relationships/image" Target="../media/image72.emf"/><Relationship Id="rId38" Type="http://schemas.openxmlformats.org/officeDocument/2006/relationships/image" Target="../media/image77.emf"/><Relationship Id="rId2" Type="http://schemas.openxmlformats.org/officeDocument/2006/relationships/image" Target="../media/image14.png"/><Relationship Id="rId16" Type="http://schemas.openxmlformats.org/officeDocument/2006/relationships/image" Target="../media/image55.png"/><Relationship Id="rId20" Type="http://schemas.openxmlformats.org/officeDocument/2006/relationships/image" Target="../media/image59.png"/><Relationship Id="rId29" Type="http://schemas.openxmlformats.org/officeDocument/2006/relationships/image" Target="../media/image68.emf"/><Relationship Id="rId41" Type="http://schemas.openxmlformats.org/officeDocument/2006/relationships/image" Target="../media/image80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5.png"/><Relationship Id="rId11" Type="http://schemas.openxmlformats.org/officeDocument/2006/relationships/image" Target="../media/image50.png"/><Relationship Id="rId24" Type="http://schemas.openxmlformats.org/officeDocument/2006/relationships/image" Target="../media/image63.emf"/><Relationship Id="rId32" Type="http://schemas.openxmlformats.org/officeDocument/2006/relationships/image" Target="../media/image71.emf"/><Relationship Id="rId37" Type="http://schemas.openxmlformats.org/officeDocument/2006/relationships/image" Target="../media/image76.emf"/><Relationship Id="rId40" Type="http://schemas.openxmlformats.org/officeDocument/2006/relationships/image" Target="../media/image79.emf"/><Relationship Id="rId5" Type="http://schemas.openxmlformats.org/officeDocument/2006/relationships/image" Target="../media/image44.png"/><Relationship Id="rId15" Type="http://schemas.openxmlformats.org/officeDocument/2006/relationships/image" Target="../media/image54.png"/><Relationship Id="rId23" Type="http://schemas.openxmlformats.org/officeDocument/2006/relationships/image" Target="../media/image62.png"/><Relationship Id="rId28" Type="http://schemas.openxmlformats.org/officeDocument/2006/relationships/image" Target="../media/image67.emf"/><Relationship Id="rId36" Type="http://schemas.openxmlformats.org/officeDocument/2006/relationships/image" Target="../media/image75.emf"/><Relationship Id="rId10" Type="http://schemas.openxmlformats.org/officeDocument/2006/relationships/image" Target="../media/image49.png"/><Relationship Id="rId19" Type="http://schemas.openxmlformats.org/officeDocument/2006/relationships/image" Target="../media/image58.png"/><Relationship Id="rId31" Type="http://schemas.openxmlformats.org/officeDocument/2006/relationships/image" Target="../media/image70.emf"/><Relationship Id="rId4" Type="http://schemas.openxmlformats.org/officeDocument/2006/relationships/image" Target="../media/image43.png"/><Relationship Id="rId9" Type="http://schemas.openxmlformats.org/officeDocument/2006/relationships/image" Target="../media/image48.png"/><Relationship Id="rId14" Type="http://schemas.openxmlformats.org/officeDocument/2006/relationships/image" Target="../media/image53.png"/><Relationship Id="rId22" Type="http://schemas.openxmlformats.org/officeDocument/2006/relationships/image" Target="../media/image61.png"/><Relationship Id="rId27" Type="http://schemas.openxmlformats.org/officeDocument/2006/relationships/image" Target="../media/image66.emf"/><Relationship Id="rId30" Type="http://schemas.openxmlformats.org/officeDocument/2006/relationships/image" Target="../media/image69.emf"/><Relationship Id="rId35" Type="http://schemas.openxmlformats.org/officeDocument/2006/relationships/image" Target="../media/image74.emf"/><Relationship Id="rId43" Type="http://schemas.openxmlformats.org/officeDocument/2006/relationships/image" Target="../media/image82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87.png"/><Relationship Id="rId13" Type="http://schemas.openxmlformats.org/officeDocument/2006/relationships/image" Target="../media/image92.png"/><Relationship Id="rId18" Type="http://schemas.openxmlformats.org/officeDocument/2006/relationships/image" Target="../media/image97.png"/><Relationship Id="rId26" Type="http://schemas.openxmlformats.org/officeDocument/2006/relationships/image" Target="../media/image105.emf"/><Relationship Id="rId39" Type="http://schemas.openxmlformats.org/officeDocument/2006/relationships/image" Target="../media/image118.emf"/><Relationship Id="rId3" Type="http://schemas.openxmlformats.org/officeDocument/2006/relationships/image" Target="../media/image84.png"/><Relationship Id="rId21" Type="http://schemas.openxmlformats.org/officeDocument/2006/relationships/image" Target="../media/image100.png"/><Relationship Id="rId34" Type="http://schemas.openxmlformats.org/officeDocument/2006/relationships/image" Target="../media/image113.emf"/><Relationship Id="rId42" Type="http://schemas.openxmlformats.org/officeDocument/2006/relationships/image" Target="../media/image121.emf"/><Relationship Id="rId7" Type="http://schemas.openxmlformats.org/officeDocument/2006/relationships/image" Target="../media/image15.png"/><Relationship Id="rId12" Type="http://schemas.openxmlformats.org/officeDocument/2006/relationships/image" Target="../media/image91.png"/><Relationship Id="rId17" Type="http://schemas.openxmlformats.org/officeDocument/2006/relationships/image" Target="../media/image96.png"/><Relationship Id="rId25" Type="http://schemas.openxmlformats.org/officeDocument/2006/relationships/image" Target="../media/image104.emf"/><Relationship Id="rId33" Type="http://schemas.openxmlformats.org/officeDocument/2006/relationships/image" Target="../media/image112.emf"/><Relationship Id="rId38" Type="http://schemas.openxmlformats.org/officeDocument/2006/relationships/image" Target="../media/image117.emf"/><Relationship Id="rId2" Type="http://schemas.openxmlformats.org/officeDocument/2006/relationships/image" Target="../media/image83.png"/><Relationship Id="rId16" Type="http://schemas.openxmlformats.org/officeDocument/2006/relationships/image" Target="../media/image95.png"/><Relationship Id="rId20" Type="http://schemas.openxmlformats.org/officeDocument/2006/relationships/image" Target="../media/image99.png"/><Relationship Id="rId29" Type="http://schemas.openxmlformats.org/officeDocument/2006/relationships/image" Target="../media/image108.emf"/><Relationship Id="rId41" Type="http://schemas.openxmlformats.org/officeDocument/2006/relationships/image" Target="../media/image120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4.png"/><Relationship Id="rId11" Type="http://schemas.openxmlformats.org/officeDocument/2006/relationships/image" Target="../media/image90.png"/><Relationship Id="rId24" Type="http://schemas.openxmlformats.org/officeDocument/2006/relationships/image" Target="../media/image103.emf"/><Relationship Id="rId32" Type="http://schemas.openxmlformats.org/officeDocument/2006/relationships/image" Target="../media/image111.emf"/><Relationship Id="rId37" Type="http://schemas.openxmlformats.org/officeDocument/2006/relationships/image" Target="../media/image116.emf"/><Relationship Id="rId40" Type="http://schemas.openxmlformats.org/officeDocument/2006/relationships/image" Target="../media/image119.emf"/><Relationship Id="rId5" Type="http://schemas.openxmlformats.org/officeDocument/2006/relationships/image" Target="../media/image86.png"/><Relationship Id="rId15" Type="http://schemas.openxmlformats.org/officeDocument/2006/relationships/image" Target="../media/image94.png"/><Relationship Id="rId23" Type="http://schemas.openxmlformats.org/officeDocument/2006/relationships/image" Target="../media/image102.png"/><Relationship Id="rId28" Type="http://schemas.openxmlformats.org/officeDocument/2006/relationships/image" Target="../media/image107.emf"/><Relationship Id="rId36" Type="http://schemas.openxmlformats.org/officeDocument/2006/relationships/image" Target="../media/image115.emf"/><Relationship Id="rId10" Type="http://schemas.openxmlformats.org/officeDocument/2006/relationships/image" Target="../media/image89.png"/><Relationship Id="rId19" Type="http://schemas.openxmlformats.org/officeDocument/2006/relationships/image" Target="../media/image98.png"/><Relationship Id="rId31" Type="http://schemas.openxmlformats.org/officeDocument/2006/relationships/image" Target="../media/image110.emf"/><Relationship Id="rId4" Type="http://schemas.openxmlformats.org/officeDocument/2006/relationships/image" Target="../media/image85.png"/><Relationship Id="rId9" Type="http://schemas.openxmlformats.org/officeDocument/2006/relationships/image" Target="../media/image88.png"/><Relationship Id="rId14" Type="http://schemas.openxmlformats.org/officeDocument/2006/relationships/image" Target="../media/image93.png"/><Relationship Id="rId22" Type="http://schemas.openxmlformats.org/officeDocument/2006/relationships/image" Target="../media/image101.png"/><Relationship Id="rId27" Type="http://schemas.openxmlformats.org/officeDocument/2006/relationships/image" Target="../media/image106.emf"/><Relationship Id="rId30" Type="http://schemas.openxmlformats.org/officeDocument/2006/relationships/image" Target="../media/image109.emf"/><Relationship Id="rId35" Type="http://schemas.openxmlformats.org/officeDocument/2006/relationships/image" Target="../media/image114.emf"/><Relationship Id="rId43" Type="http://schemas.openxmlformats.org/officeDocument/2006/relationships/image" Target="../media/image122.em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9.png"/><Relationship Id="rId13" Type="http://schemas.openxmlformats.org/officeDocument/2006/relationships/image" Target="../media/image134.png"/><Relationship Id="rId18" Type="http://schemas.openxmlformats.org/officeDocument/2006/relationships/image" Target="../media/image139.png"/><Relationship Id="rId26" Type="http://schemas.openxmlformats.org/officeDocument/2006/relationships/image" Target="../media/image145.emf"/><Relationship Id="rId39" Type="http://schemas.openxmlformats.org/officeDocument/2006/relationships/image" Target="../media/image158.emf"/><Relationship Id="rId3" Type="http://schemas.openxmlformats.org/officeDocument/2006/relationships/image" Target="../media/image124.png"/><Relationship Id="rId21" Type="http://schemas.openxmlformats.org/officeDocument/2006/relationships/image" Target="../media/image142.png"/><Relationship Id="rId34" Type="http://schemas.openxmlformats.org/officeDocument/2006/relationships/image" Target="../media/image153.emf"/><Relationship Id="rId42" Type="http://schemas.openxmlformats.org/officeDocument/2006/relationships/image" Target="../media/image161.emf"/><Relationship Id="rId7" Type="http://schemas.openxmlformats.org/officeDocument/2006/relationships/image" Target="../media/image128.png"/><Relationship Id="rId12" Type="http://schemas.openxmlformats.org/officeDocument/2006/relationships/image" Target="../media/image133.png"/><Relationship Id="rId17" Type="http://schemas.openxmlformats.org/officeDocument/2006/relationships/image" Target="../media/image138.png"/><Relationship Id="rId25" Type="http://schemas.openxmlformats.org/officeDocument/2006/relationships/image" Target="../media/image144.emf"/><Relationship Id="rId33" Type="http://schemas.openxmlformats.org/officeDocument/2006/relationships/image" Target="../media/image152.emf"/><Relationship Id="rId38" Type="http://schemas.openxmlformats.org/officeDocument/2006/relationships/image" Target="../media/image157.emf"/><Relationship Id="rId2" Type="http://schemas.openxmlformats.org/officeDocument/2006/relationships/image" Target="../media/image123.png"/><Relationship Id="rId16" Type="http://schemas.openxmlformats.org/officeDocument/2006/relationships/image" Target="../media/image137.png"/><Relationship Id="rId20" Type="http://schemas.openxmlformats.org/officeDocument/2006/relationships/image" Target="../media/image141.png"/><Relationship Id="rId29" Type="http://schemas.openxmlformats.org/officeDocument/2006/relationships/image" Target="../media/image148.emf"/><Relationship Id="rId41" Type="http://schemas.openxmlformats.org/officeDocument/2006/relationships/image" Target="../media/image160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27.png"/><Relationship Id="rId11" Type="http://schemas.openxmlformats.org/officeDocument/2006/relationships/image" Target="../media/image132.png"/><Relationship Id="rId24" Type="http://schemas.openxmlformats.org/officeDocument/2006/relationships/image" Target="../media/image143.emf"/><Relationship Id="rId32" Type="http://schemas.openxmlformats.org/officeDocument/2006/relationships/image" Target="../media/image151.emf"/><Relationship Id="rId37" Type="http://schemas.openxmlformats.org/officeDocument/2006/relationships/image" Target="../media/image156.emf"/><Relationship Id="rId40" Type="http://schemas.openxmlformats.org/officeDocument/2006/relationships/image" Target="../media/image159.emf"/><Relationship Id="rId5" Type="http://schemas.openxmlformats.org/officeDocument/2006/relationships/image" Target="../media/image126.png"/><Relationship Id="rId15" Type="http://schemas.openxmlformats.org/officeDocument/2006/relationships/image" Target="../media/image136.png"/><Relationship Id="rId23" Type="http://schemas.openxmlformats.org/officeDocument/2006/relationships/image" Target="../media/image15.png"/><Relationship Id="rId28" Type="http://schemas.openxmlformats.org/officeDocument/2006/relationships/image" Target="../media/image147.emf"/><Relationship Id="rId36" Type="http://schemas.openxmlformats.org/officeDocument/2006/relationships/image" Target="../media/image155.emf"/><Relationship Id="rId10" Type="http://schemas.openxmlformats.org/officeDocument/2006/relationships/image" Target="../media/image131.png"/><Relationship Id="rId19" Type="http://schemas.openxmlformats.org/officeDocument/2006/relationships/image" Target="../media/image140.png"/><Relationship Id="rId31" Type="http://schemas.openxmlformats.org/officeDocument/2006/relationships/image" Target="../media/image150.emf"/><Relationship Id="rId4" Type="http://schemas.openxmlformats.org/officeDocument/2006/relationships/image" Target="../media/image125.png"/><Relationship Id="rId9" Type="http://schemas.openxmlformats.org/officeDocument/2006/relationships/image" Target="../media/image130.png"/><Relationship Id="rId14" Type="http://schemas.openxmlformats.org/officeDocument/2006/relationships/image" Target="../media/image135.png"/><Relationship Id="rId22" Type="http://schemas.openxmlformats.org/officeDocument/2006/relationships/image" Target="../media/image14.png"/><Relationship Id="rId27" Type="http://schemas.openxmlformats.org/officeDocument/2006/relationships/image" Target="../media/image146.emf"/><Relationship Id="rId30" Type="http://schemas.openxmlformats.org/officeDocument/2006/relationships/image" Target="../media/image149.emf"/><Relationship Id="rId35" Type="http://schemas.openxmlformats.org/officeDocument/2006/relationships/image" Target="../media/image154.emf"/><Relationship Id="rId43" Type="http://schemas.openxmlformats.org/officeDocument/2006/relationships/image" Target="../media/image16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>
            <a:extLst>
              <a:ext uri="{FF2B5EF4-FFF2-40B4-BE49-F238E27FC236}">
                <a16:creationId xmlns:a16="http://schemas.microsoft.com/office/drawing/2014/main" id="{0F319039-92D9-4270-8B65-1106A4C2DA99}"/>
              </a:ext>
            </a:extLst>
          </p:cNvPr>
          <p:cNvGrpSpPr/>
          <p:nvPr/>
        </p:nvGrpSpPr>
        <p:grpSpPr>
          <a:xfrm>
            <a:off x="1" y="47625"/>
            <a:ext cx="12328985" cy="6787083"/>
            <a:chOff x="1" y="57150"/>
            <a:chExt cx="12328985" cy="6787083"/>
          </a:xfrm>
        </p:grpSpPr>
        <p:pic>
          <p:nvPicPr>
            <p:cNvPr id="17" name="图片 16">
              <a:extLst>
                <a:ext uri="{FF2B5EF4-FFF2-40B4-BE49-F238E27FC236}">
                  <a16:creationId xmlns:a16="http://schemas.microsoft.com/office/drawing/2014/main" id="{38FA655B-23E0-4813-9256-F2BC68E5E767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360000" y="4821333"/>
              <a:ext cx="1943349" cy="1566000"/>
            </a:xfrm>
            <a:prstGeom prst="rect">
              <a:avLst/>
            </a:prstGeom>
          </p:spPr>
        </p:pic>
        <p:sp>
          <p:nvSpPr>
            <p:cNvPr id="66" name="文本框 65">
              <a:extLst>
                <a:ext uri="{FF2B5EF4-FFF2-40B4-BE49-F238E27FC236}">
                  <a16:creationId xmlns:a16="http://schemas.microsoft.com/office/drawing/2014/main" id="{ED468AB6-F891-4F97-B5E0-EB340DF76014}"/>
                </a:ext>
              </a:extLst>
            </p:cNvPr>
            <p:cNvSpPr txBox="1"/>
            <p:nvPr/>
          </p:nvSpPr>
          <p:spPr>
            <a:xfrm>
              <a:off x="11383372" y="1216899"/>
              <a:ext cx="844676" cy="5078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ladder Urothelial Carcinoma </a:t>
              </a:r>
              <a:endParaRPr lang="zh-CN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7" name="文本框 66">
              <a:extLst>
                <a:ext uri="{FF2B5EF4-FFF2-40B4-BE49-F238E27FC236}">
                  <a16:creationId xmlns:a16="http://schemas.microsoft.com/office/drawing/2014/main" id="{036F5477-69B7-41E3-A38B-D3B0AFE45118}"/>
                </a:ext>
              </a:extLst>
            </p:cNvPr>
            <p:cNvSpPr txBox="1"/>
            <p:nvPr/>
          </p:nvSpPr>
          <p:spPr>
            <a:xfrm>
              <a:off x="11383200" y="2812378"/>
              <a:ext cx="844676" cy="5078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reast Invasive Carcinoma</a:t>
              </a:r>
              <a:endParaRPr lang="zh-CN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9" name="文本框 68">
              <a:extLst>
                <a:ext uri="{FF2B5EF4-FFF2-40B4-BE49-F238E27FC236}">
                  <a16:creationId xmlns:a16="http://schemas.microsoft.com/office/drawing/2014/main" id="{365B7DC8-D43E-4302-9855-4A884537F91F}"/>
                </a:ext>
              </a:extLst>
            </p:cNvPr>
            <p:cNvSpPr txBox="1"/>
            <p:nvPr/>
          </p:nvSpPr>
          <p:spPr>
            <a:xfrm>
              <a:off x="11159753" y="5900396"/>
              <a:ext cx="116923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lioblastoma Multiforme</a:t>
              </a:r>
              <a:endParaRPr lang="zh-CN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49" name="图片 48">
              <a:extLst>
                <a:ext uri="{FF2B5EF4-FFF2-40B4-BE49-F238E27FC236}">
                  <a16:creationId xmlns:a16="http://schemas.microsoft.com/office/drawing/2014/main" id="{A92027E4-64C0-496C-9B97-5C73084B2D97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072" y="4856959"/>
              <a:ext cx="2036079" cy="1565155"/>
            </a:xfrm>
            <a:prstGeom prst="rect">
              <a:avLst/>
            </a:prstGeom>
          </p:spPr>
        </p:pic>
        <p:pic>
          <p:nvPicPr>
            <p:cNvPr id="33" name="图片 32">
              <a:extLst>
                <a:ext uri="{FF2B5EF4-FFF2-40B4-BE49-F238E27FC236}">
                  <a16:creationId xmlns:a16="http://schemas.microsoft.com/office/drawing/2014/main" id="{FA395E19-B23C-4453-85FC-46941985F433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1054" y="1631573"/>
              <a:ext cx="2023178" cy="1565155"/>
            </a:xfrm>
            <a:prstGeom prst="rect">
              <a:avLst/>
            </a:prstGeom>
          </p:spPr>
        </p:pic>
        <p:pic>
          <p:nvPicPr>
            <p:cNvPr id="5" name="图片 4">
              <a:extLst>
                <a:ext uri="{FF2B5EF4-FFF2-40B4-BE49-F238E27FC236}">
                  <a16:creationId xmlns:a16="http://schemas.microsoft.com/office/drawing/2014/main" id="{53CD8DA8-F391-4C57-9432-1BD0553FE498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" y="82521"/>
              <a:ext cx="2032319" cy="1565155"/>
            </a:xfrm>
            <a:prstGeom prst="rect">
              <a:avLst/>
            </a:prstGeom>
          </p:spPr>
        </p:pic>
        <p:sp>
          <p:nvSpPr>
            <p:cNvPr id="70" name="文本框 69">
              <a:extLst>
                <a:ext uri="{FF2B5EF4-FFF2-40B4-BE49-F238E27FC236}">
                  <a16:creationId xmlns:a16="http://schemas.microsoft.com/office/drawing/2014/main" id="{3FD1F979-3C15-476F-A658-A7F235713658}"/>
                </a:ext>
              </a:extLst>
            </p:cNvPr>
            <p:cNvSpPr txBox="1"/>
            <p:nvPr/>
          </p:nvSpPr>
          <p:spPr>
            <a:xfrm>
              <a:off x="930680" y="6387333"/>
              <a:ext cx="1078521" cy="2230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LH1</a:t>
              </a:r>
              <a:endParaRPr lang="zh-CN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16" name="图片 15">
              <a:extLst>
                <a:ext uri="{FF2B5EF4-FFF2-40B4-BE49-F238E27FC236}">
                  <a16:creationId xmlns:a16="http://schemas.microsoft.com/office/drawing/2014/main" id="{0B493EFB-3D23-4A82-B113-5A82583B3E10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020000" y="57150"/>
              <a:ext cx="2025000" cy="1565155"/>
            </a:xfrm>
            <a:prstGeom prst="rect">
              <a:avLst/>
            </a:prstGeom>
          </p:spPr>
        </p:pic>
        <p:pic>
          <p:nvPicPr>
            <p:cNvPr id="39" name="图片 38">
              <a:extLst>
                <a:ext uri="{FF2B5EF4-FFF2-40B4-BE49-F238E27FC236}">
                  <a16:creationId xmlns:a16="http://schemas.microsoft.com/office/drawing/2014/main" id="{7DE6171F-BF0F-4B5C-AE63-6F989C2D2391}"/>
                </a:ext>
              </a:extLst>
            </p:cNvPr>
            <p:cNvPicPr>
              <a:picLocks noChangeAspect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020000" y="1657086"/>
              <a:ext cx="2023790" cy="1565155"/>
            </a:xfrm>
            <a:prstGeom prst="rect">
              <a:avLst/>
            </a:prstGeom>
          </p:spPr>
        </p:pic>
        <p:pic>
          <p:nvPicPr>
            <p:cNvPr id="47" name="图片 46">
              <a:extLst>
                <a:ext uri="{FF2B5EF4-FFF2-40B4-BE49-F238E27FC236}">
                  <a16:creationId xmlns:a16="http://schemas.microsoft.com/office/drawing/2014/main" id="{A42CD7F2-D9FB-4DFD-8B14-321955DB6882}"/>
                </a:ext>
              </a:extLst>
            </p:cNvPr>
            <p:cNvPicPr>
              <a:picLocks noChangeAspect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020000" y="3257023"/>
              <a:ext cx="2003875" cy="1565155"/>
            </a:xfrm>
            <a:prstGeom prst="rect">
              <a:avLst/>
            </a:prstGeom>
          </p:spPr>
        </p:pic>
        <p:pic>
          <p:nvPicPr>
            <p:cNvPr id="55" name="图片 54">
              <a:extLst>
                <a:ext uri="{FF2B5EF4-FFF2-40B4-BE49-F238E27FC236}">
                  <a16:creationId xmlns:a16="http://schemas.microsoft.com/office/drawing/2014/main" id="{272F96D1-B8F2-43BC-B938-A3F8F9A0C413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020000" y="4856959"/>
              <a:ext cx="2018320" cy="1565155"/>
            </a:xfrm>
            <a:prstGeom prst="rect">
              <a:avLst/>
            </a:prstGeom>
          </p:spPr>
        </p:pic>
        <p:sp>
          <p:nvSpPr>
            <p:cNvPr id="71" name="文本框 70">
              <a:extLst>
                <a:ext uri="{FF2B5EF4-FFF2-40B4-BE49-F238E27FC236}">
                  <a16:creationId xmlns:a16="http://schemas.microsoft.com/office/drawing/2014/main" id="{D2D7A332-77C2-4CE7-81BE-C68A0E8C7B5D}"/>
                </a:ext>
              </a:extLst>
            </p:cNvPr>
            <p:cNvSpPr txBox="1"/>
            <p:nvPr/>
          </p:nvSpPr>
          <p:spPr>
            <a:xfrm>
              <a:off x="7813080" y="6387333"/>
              <a:ext cx="1078521" cy="2230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MS2</a:t>
              </a:r>
              <a:endParaRPr lang="zh-CN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35" name="图片 34">
              <a:extLst>
                <a:ext uri="{FF2B5EF4-FFF2-40B4-BE49-F238E27FC236}">
                  <a16:creationId xmlns:a16="http://schemas.microsoft.com/office/drawing/2014/main" id="{11BE5B32-92C2-482C-9300-61793DC20A5E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340000" y="1657086"/>
              <a:ext cx="2005141" cy="1565155"/>
            </a:xfrm>
            <a:prstGeom prst="rect">
              <a:avLst/>
            </a:prstGeom>
          </p:spPr>
        </p:pic>
        <p:pic>
          <p:nvPicPr>
            <p:cNvPr id="43" name="图片 42">
              <a:extLst>
                <a:ext uri="{FF2B5EF4-FFF2-40B4-BE49-F238E27FC236}">
                  <a16:creationId xmlns:a16="http://schemas.microsoft.com/office/drawing/2014/main" id="{95464C73-45FD-4F09-A195-7B02B3E2FA62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339095" y="3256178"/>
              <a:ext cx="2022560" cy="1565155"/>
            </a:xfrm>
            <a:prstGeom prst="rect">
              <a:avLst/>
            </a:prstGeom>
          </p:spPr>
        </p:pic>
        <p:pic>
          <p:nvPicPr>
            <p:cNvPr id="51" name="图片 50">
              <a:extLst>
                <a:ext uri="{FF2B5EF4-FFF2-40B4-BE49-F238E27FC236}">
                  <a16:creationId xmlns:a16="http://schemas.microsoft.com/office/drawing/2014/main" id="{F00AC756-07A1-475A-9434-8C988F01F5D1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340000" y="4856959"/>
              <a:ext cx="2022560" cy="1565155"/>
            </a:xfrm>
            <a:prstGeom prst="rect">
              <a:avLst/>
            </a:prstGeom>
          </p:spPr>
        </p:pic>
        <p:sp>
          <p:nvSpPr>
            <p:cNvPr id="72" name="文本框 71">
              <a:extLst>
                <a:ext uri="{FF2B5EF4-FFF2-40B4-BE49-F238E27FC236}">
                  <a16:creationId xmlns:a16="http://schemas.microsoft.com/office/drawing/2014/main" id="{7E559086-4121-4485-B7BA-26056684237C}"/>
                </a:ext>
              </a:extLst>
            </p:cNvPr>
            <p:cNvSpPr txBox="1"/>
            <p:nvPr/>
          </p:nvSpPr>
          <p:spPr>
            <a:xfrm>
              <a:off x="3219034" y="6387333"/>
              <a:ext cx="1078521" cy="2230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SH2</a:t>
              </a:r>
              <a:endParaRPr lang="zh-CN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37" name="图片 36">
              <a:extLst>
                <a:ext uri="{FF2B5EF4-FFF2-40B4-BE49-F238E27FC236}">
                  <a16:creationId xmlns:a16="http://schemas.microsoft.com/office/drawing/2014/main" id="{712F5884-3C60-4F47-BCE7-93C1802A6266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680000" y="1657086"/>
              <a:ext cx="2022575" cy="1565155"/>
            </a:xfrm>
            <a:prstGeom prst="rect">
              <a:avLst/>
            </a:prstGeom>
          </p:spPr>
        </p:pic>
        <p:pic>
          <p:nvPicPr>
            <p:cNvPr id="45" name="图片 44">
              <a:extLst>
                <a:ext uri="{FF2B5EF4-FFF2-40B4-BE49-F238E27FC236}">
                  <a16:creationId xmlns:a16="http://schemas.microsoft.com/office/drawing/2014/main" id="{3EE1BAF5-9036-4402-B960-4A41148740D6}"/>
                </a:ext>
              </a:extLst>
            </p:cNvPr>
            <p:cNvPicPr>
              <a:picLocks noChangeAspect="1"/>
            </p:cNvPicPr>
            <p:nvPr/>
          </p:nvPicPr>
          <p:blipFill>
            <a:blip r:embed="rId1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680000" y="3257023"/>
              <a:ext cx="2020749" cy="1565155"/>
            </a:xfrm>
            <a:prstGeom prst="rect">
              <a:avLst/>
            </a:prstGeom>
          </p:spPr>
        </p:pic>
        <p:pic>
          <p:nvPicPr>
            <p:cNvPr id="106" name="图片 105">
              <a:extLst>
                <a:ext uri="{FF2B5EF4-FFF2-40B4-BE49-F238E27FC236}">
                  <a16:creationId xmlns:a16="http://schemas.microsoft.com/office/drawing/2014/main" id="{AC95B704-1E95-4FC2-87AF-9582B31B6B14}"/>
                </a:ext>
              </a:extLst>
            </p:cNvPr>
            <p:cNvPicPr>
              <a:picLocks noChangeAspect="1"/>
            </p:cNvPicPr>
            <p:nvPr/>
          </p:nvPicPr>
          <p:blipFill>
            <a:blip r:embed="rId1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900044" y="6685475"/>
              <a:ext cx="1289116" cy="158758"/>
            </a:xfrm>
            <a:prstGeom prst="rect">
              <a:avLst/>
            </a:prstGeom>
          </p:spPr>
        </p:pic>
        <p:pic>
          <p:nvPicPr>
            <p:cNvPr id="108" name="图片 107">
              <a:extLst>
                <a:ext uri="{FF2B5EF4-FFF2-40B4-BE49-F238E27FC236}">
                  <a16:creationId xmlns:a16="http://schemas.microsoft.com/office/drawing/2014/main" id="{0FD55338-E78C-41DE-B9AE-373C7474D0F9}"/>
                </a:ext>
              </a:extLst>
            </p:cNvPr>
            <p:cNvPicPr>
              <a:picLocks noChangeAspect="1"/>
            </p:cNvPicPr>
            <p:nvPr/>
          </p:nvPicPr>
          <p:blipFill>
            <a:blip r:embed="rId1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559313" y="6663850"/>
              <a:ext cx="1428823" cy="171459"/>
            </a:xfrm>
            <a:prstGeom prst="rect">
              <a:avLst/>
            </a:prstGeom>
          </p:spPr>
        </p:pic>
        <p:pic>
          <p:nvPicPr>
            <p:cNvPr id="8" name="图片 7">
              <a:extLst>
                <a:ext uri="{FF2B5EF4-FFF2-40B4-BE49-F238E27FC236}">
                  <a16:creationId xmlns:a16="http://schemas.microsoft.com/office/drawing/2014/main" id="{A5691991-B6F3-4DB1-9C87-2615ED90B771}"/>
                </a:ext>
              </a:extLst>
            </p:cNvPr>
            <p:cNvPicPr>
              <a:picLocks noChangeAspect="1"/>
            </p:cNvPicPr>
            <p:nvPr/>
          </p:nvPicPr>
          <p:blipFill>
            <a:blip r:embed="rId1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331125" y="82521"/>
              <a:ext cx="1956324" cy="1566000"/>
            </a:xfrm>
            <a:prstGeom prst="rect">
              <a:avLst/>
            </a:prstGeom>
          </p:spPr>
        </p:pic>
        <p:pic>
          <p:nvPicPr>
            <p:cNvPr id="10" name="图片 9">
              <a:extLst>
                <a:ext uri="{FF2B5EF4-FFF2-40B4-BE49-F238E27FC236}">
                  <a16:creationId xmlns:a16="http://schemas.microsoft.com/office/drawing/2014/main" id="{692AF0C6-3FB7-4411-A6BA-7149D8FB4DD9}"/>
                </a:ext>
              </a:extLst>
            </p:cNvPr>
            <p:cNvPicPr>
              <a:picLocks noChangeAspect="1"/>
            </p:cNvPicPr>
            <p:nvPr/>
          </p:nvPicPr>
          <p:blipFill>
            <a:blip r:embed="rId1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360000" y="1647676"/>
              <a:ext cx="1940529" cy="1566000"/>
            </a:xfrm>
            <a:prstGeom prst="rect">
              <a:avLst/>
            </a:prstGeom>
          </p:spPr>
        </p:pic>
        <p:sp>
          <p:nvSpPr>
            <p:cNvPr id="58" name="文本框 57">
              <a:extLst>
                <a:ext uri="{FF2B5EF4-FFF2-40B4-BE49-F238E27FC236}">
                  <a16:creationId xmlns:a16="http://schemas.microsoft.com/office/drawing/2014/main" id="{71FCC91F-3ED8-439D-A808-735D6AB09F27}"/>
                </a:ext>
              </a:extLst>
            </p:cNvPr>
            <p:cNvSpPr txBox="1"/>
            <p:nvPr/>
          </p:nvSpPr>
          <p:spPr>
            <a:xfrm>
              <a:off x="10149920" y="6387333"/>
              <a:ext cx="107852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 genes</a:t>
              </a:r>
              <a:endParaRPr lang="zh-CN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78" name="组合 77">
              <a:extLst>
                <a:ext uri="{FF2B5EF4-FFF2-40B4-BE49-F238E27FC236}">
                  <a16:creationId xmlns:a16="http://schemas.microsoft.com/office/drawing/2014/main" id="{CBAE31F3-0B59-4601-9536-D9F7FEA714B1}"/>
                </a:ext>
              </a:extLst>
            </p:cNvPr>
            <p:cNvGrpSpPr/>
            <p:nvPr/>
          </p:nvGrpSpPr>
          <p:grpSpPr>
            <a:xfrm>
              <a:off x="2340000" y="57150"/>
              <a:ext cx="4358320" cy="1565155"/>
              <a:chOff x="2340000" y="0"/>
              <a:chExt cx="4358320" cy="1565155"/>
            </a:xfrm>
          </p:grpSpPr>
          <p:pic>
            <p:nvPicPr>
              <p:cNvPr id="12" name="图片 11">
                <a:extLst>
                  <a:ext uri="{FF2B5EF4-FFF2-40B4-BE49-F238E27FC236}">
                    <a16:creationId xmlns:a16="http://schemas.microsoft.com/office/drawing/2014/main" id="{5E2FD90E-425B-485B-B1C1-52F8945008B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0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340000" y="0"/>
                <a:ext cx="2020150" cy="1565155"/>
              </a:xfrm>
              <a:prstGeom prst="rect">
                <a:avLst/>
              </a:prstGeom>
            </p:spPr>
          </p:pic>
          <p:pic>
            <p:nvPicPr>
              <p:cNvPr id="14" name="图片 13">
                <a:extLst>
                  <a:ext uri="{FF2B5EF4-FFF2-40B4-BE49-F238E27FC236}">
                    <a16:creationId xmlns:a16="http://schemas.microsoft.com/office/drawing/2014/main" id="{BF73CBAA-41E5-4062-A88E-EA3B228FCD7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1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680000" y="0"/>
                <a:ext cx="2018320" cy="1565155"/>
              </a:xfrm>
              <a:prstGeom prst="rect">
                <a:avLst/>
              </a:prstGeom>
            </p:spPr>
          </p:pic>
        </p:grpSp>
        <p:pic>
          <p:nvPicPr>
            <p:cNvPr id="41" name="图片 40">
              <a:extLst>
                <a:ext uri="{FF2B5EF4-FFF2-40B4-BE49-F238E27FC236}">
                  <a16:creationId xmlns:a16="http://schemas.microsoft.com/office/drawing/2014/main" id="{D3A9974A-5628-4524-91B2-FD11824D896E}"/>
                </a:ext>
              </a:extLst>
            </p:cNvPr>
            <p:cNvPicPr>
              <a:picLocks noChangeAspect="1"/>
            </p:cNvPicPr>
            <p:nvPr/>
          </p:nvPicPr>
          <p:blipFill>
            <a:blip r:embed="rId2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5038" y="3257023"/>
              <a:ext cx="2012288" cy="1565155"/>
            </a:xfrm>
            <a:prstGeom prst="rect">
              <a:avLst/>
            </a:prstGeom>
          </p:spPr>
        </p:pic>
        <p:grpSp>
          <p:nvGrpSpPr>
            <p:cNvPr id="80" name="组合 79">
              <a:extLst>
                <a:ext uri="{FF2B5EF4-FFF2-40B4-BE49-F238E27FC236}">
                  <a16:creationId xmlns:a16="http://schemas.microsoft.com/office/drawing/2014/main" id="{BB805CEC-1018-4B12-A9B5-3DE55D630932}"/>
                </a:ext>
              </a:extLst>
            </p:cNvPr>
            <p:cNvGrpSpPr/>
            <p:nvPr/>
          </p:nvGrpSpPr>
          <p:grpSpPr>
            <a:xfrm>
              <a:off x="9360000" y="3187460"/>
              <a:ext cx="2959891" cy="1566539"/>
              <a:chOff x="9360000" y="3130310"/>
              <a:chExt cx="2959891" cy="1566539"/>
            </a:xfrm>
          </p:grpSpPr>
          <p:sp>
            <p:nvSpPr>
              <p:cNvPr id="68" name="文本框 67">
                <a:extLst>
                  <a:ext uri="{FF2B5EF4-FFF2-40B4-BE49-F238E27FC236}">
                    <a16:creationId xmlns:a16="http://schemas.microsoft.com/office/drawing/2014/main" id="{9240592A-3492-4F66-9A73-C3AE65EC6B07}"/>
                  </a:ext>
                </a:extLst>
              </p:cNvPr>
              <p:cNvSpPr txBox="1"/>
              <p:nvPr/>
            </p:nvSpPr>
            <p:spPr>
              <a:xfrm>
                <a:off x="11241370" y="4327517"/>
                <a:ext cx="107852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sophageal Adenocarcinoma</a:t>
                </a:r>
                <a:endParaRPr lang="zh-CN" alt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pic>
            <p:nvPicPr>
              <p:cNvPr id="13" name="图片 12">
                <a:extLst>
                  <a:ext uri="{FF2B5EF4-FFF2-40B4-BE49-F238E27FC236}">
                    <a16:creationId xmlns:a16="http://schemas.microsoft.com/office/drawing/2014/main" id="{9DD3D374-E7F7-4EFC-89D9-CA7AA5B4E33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9360000" y="3130310"/>
                <a:ext cx="1945211" cy="1566000"/>
              </a:xfrm>
              <a:prstGeom prst="rect">
                <a:avLst/>
              </a:prstGeom>
            </p:spPr>
          </p:pic>
        </p:grpSp>
        <p:grpSp>
          <p:nvGrpSpPr>
            <p:cNvPr id="81" name="组合 80">
              <a:extLst>
                <a:ext uri="{FF2B5EF4-FFF2-40B4-BE49-F238E27FC236}">
                  <a16:creationId xmlns:a16="http://schemas.microsoft.com/office/drawing/2014/main" id="{9268CC44-385D-49BF-801F-6120892F1D24}"/>
                </a:ext>
              </a:extLst>
            </p:cNvPr>
            <p:cNvGrpSpPr/>
            <p:nvPr/>
          </p:nvGrpSpPr>
          <p:grpSpPr>
            <a:xfrm>
              <a:off x="4680000" y="4856959"/>
              <a:ext cx="2004324" cy="1753391"/>
              <a:chOff x="4680000" y="4799809"/>
              <a:chExt cx="2004324" cy="1753391"/>
            </a:xfrm>
          </p:grpSpPr>
          <p:pic>
            <p:nvPicPr>
              <p:cNvPr id="53" name="图片 52">
                <a:extLst>
                  <a:ext uri="{FF2B5EF4-FFF2-40B4-BE49-F238E27FC236}">
                    <a16:creationId xmlns:a16="http://schemas.microsoft.com/office/drawing/2014/main" id="{077BF0AE-8EF6-4A69-AF20-90F633EFC1E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680000" y="4799809"/>
                <a:ext cx="2004324" cy="1565155"/>
              </a:xfrm>
              <a:prstGeom prst="rect">
                <a:avLst/>
              </a:prstGeom>
            </p:spPr>
          </p:pic>
          <p:sp>
            <p:nvSpPr>
              <p:cNvPr id="73" name="文本框 72">
                <a:extLst>
                  <a:ext uri="{FF2B5EF4-FFF2-40B4-BE49-F238E27FC236}">
                    <a16:creationId xmlns:a16="http://schemas.microsoft.com/office/drawing/2014/main" id="{CD8F9CF8-BFB7-42DA-82D7-F8B281DDF588}"/>
                  </a:ext>
                </a:extLst>
              </p:cNvPr>
              <p:cNvSpPr txBox="1"/>
              <p:nvPr/>
            </p:nvSpPr>
            <p:spPr>
              <a:xfrm>
                <a:off x="5424120" y="6330183"/>
                <a:ext cx="1078521" cy="22301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SH6</a:t>
                </a:r>
                <a:endParaRPr lang="zh-CN" alt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pic>
          <p:nvPicPr>
            <p:cNvPr id="3" name="图片 2">
              <a:extLst>
                <a:ext uri="{FF2B5EF4-FFF2-40B4-BE49-F238E27FC236}">
                  <a16:creationId xmlns:a16="http://schemas.microsoft.com/office/drawing/2014/main" id="{45822CF0-05C3-44C1-91CB-21C8181FAF86}"/>
                </a:ext>
              </a:extLst>
            </p:cNvPr>
            <p:cNvPicPr>
              <a:picLocks noChangeAspect="1"/>
            </p:cNvPicPr>
            <p:nvPr/>
          </p:nvPicPr>
          <p:blipFill>
            <a:blip r:embed="rId25"/>
            <a:stretch>
              <a:fillRect/>
            </a:stretch>
          </p:blipFill>
          <p:spPr>
            <a:xfrm>
              <a:off x="468468" y="82521"/>
              <a:ext cx="1973578" cy="540000"/>
            </a:xfrm>
            <a:prstGeom prst="rect">
              <a:avLst/>
            </a:prstGeom>
          </p:spPr>
        </p:pic>
        <p:pic>
          <p:nvPicPr>
            <p:cNvPr id="6" name="图片 5">
              <a:extLst>
                <a:ext uri="{FF2B5EF4-FFF2-40B4-BE49-F238E27FC236}">
                  <a16:creationId xmlns:a16="http://schemas.microsoft.com/office/drawing/2014/main" id="{567A4FD4-1396-4A3A-A4CB-9F890096C1D8}"/>
                </a:ext>
              </a:extLst>
            </p:cNvPr>
            <p:cNvPicPr>
              <a:picLocks noChangeAspect="1"/>
            </p:cNvPicPr>
            <p:nvPr/>
          </p:nvPicPr>
          <p:blipFill>
            <a:blip r:embed="rId26"/>
            <a:stretch>
              <a:fillRect/>
            </a:stretch>
          </p:blipFill>
          <p:spPr>
            <a:xfrm>
              <a:off x="2808000" y="82350"/>
              <a:ext cx="1973577" cy="540000"/>
            </a:xfrm>
            <a:prstGeom prst="rect">
              <a:avLst/>
            </a:prstGeom>
          </p:spPr>
        </p:pic>
        <p:pic>
          <p:nvPicPr>
            <p:cNvPr id="11" name="图片 10">
              <a:extLst>
                <a:ext uri="{FF2B5EF4-FFF2-40B4-BE49-F238E27FC236}">
                  <a16:creationId xmlns:a16="http://schemas.microsoft.com/office/drawing/2014/main" id="{F99012D5-0ADA-44DE-81E7-E56478D62BF8}"/>
                </a:ext>
              </a:extLst>
            </p:cNvPr>
            <p:cNvPicPr>
              <a:picLocks noChangeAspect="1"/>
            </p:cNvPicPr>
            <p:nvPr/>
          </p:nvPicPr>
          <p:blipFill>
            <a:blip r:embed="rId27"/>
            <a:stretch>
              <a:fillRect/>
            </a:stretch>
          </p:blipFill>
          <p:spPr>
            <a:xfrm>
              <a:off x="5148000" y="82350"/>
              <a:ext cx="1971496" cy="540000"/>
            </a:xfrm>
            <a:prstGeom prst="rect">
              <a:avLst/>
            </a:prstGeom>
          </p:spPr>
        </p:pic>
        <p:pic>
          <p:nvPicPr>
            <p:cNvPr id="19" name="图片 18">
              <a:extLst>
                <a:ext uri="{FF2B5EF4-FFF2-40B4-BE49-F238E27FC236}">
                  <a16:creationId xmlns:a16="http://schemas.microsoft.com/office/drawing/2014/main" id="{70C93D78-0BC9-40B3-B921-54ABC2AF47BC}"/>
                </a:ext>
              </a:extLst>
            </p:cNvPr>
            <p:cNvPicPr>
              <a:picLocks noChangeAspect="1"/>
            </p:cNvPicPr>
            <p:nvPr/>
          </p:nvPicPr>
          <p:blipFill>
            <a:blip r:embed="rId28"/>
            <a:stretch>
              <a:fillRect/>
            </a:stretch>
          </p:blipFill>
          <p:spPr>
            <a:xfrm>
              <a:off x="7488000" y="82350"/>
              <a:ext cx="1973578" cy="540000"/>
            </a:xfrm>
            <a:prstGeom prst="rect">
              <a:avLst/>
            </a:prstGeom>
          </p:spPr>
        </p:pic>
        <p:pic>
          <p:nvPicPr>
            <p:cNvPr id="22" name="图片 21">
              <a:extLst>
                <a:ext uri="{FF2B5EF4-FFF2-40B4-BE49-F238E27FC236}">
                  <a16:creationId xmlns:a16="http://schemas.microsoft.com/office/drawing/2014/main" id="{A1AEC085-1CA6-4FA3-9DCA-2252CEFF4CD9}"/>
                </a:ext>
              </a:extLst>
            </p:cNvPr>
            <p:cNvPicPr>
              <a:picLocks noChangeAspect="1"/>
            </p:cNvPicPr>
            <p:nvPr/>
          </p:nvPicPr>
          <p:blipFill>
            <a:blip r:embed="rId29"/>
            <a:stretch>
              <a:fillRect/>
            </a:stretch>
          </p:blipFill>
          <p:spPr>
            <a:xfrm>
              <a:off x="9828000" y="82350"/>
              <a:ext cx="1973578" cy="540000"/>
            </a:xfrm>
            <a:prstGeom prst="rect">
              <a:avLst/>
            </a:prstGeom>
          </p:spPr>
        </p:pic>
        <p:pic>
          <p:nvPicPr>
            <p:cNvPr id="28" name="图片 27">
              <a:extLst>
                <a:ext uri="{FF2B5EF4-FFF2-40B4-BE49-F238E27FC236}">
                  <a16:creationId xmlns:a16="http://schemas.microsoft.com/office/drawing/2014/main" id="{FE8F9A95-7794-45B3-B043-BC5C10551E81}"/>
                </a:ext>
              </a:extLst>
            </p:cNvPr>
            <p:cNvPicPr>
              <a:picLocks noChangeAspect="1"/>
            </p:cNvPicPr>
            <p:nvPr/>
          </p:nvPicPr>
          <p:blipFill>
            <a:blip r:embed="rId30"/>
            <a:stretch>
              <a:fillRect/>
            </a:stretch>
          </p:blipFill>
          <p:spPr>
            <a:xfrm>
              <a:off x="468000" y="1630350"/>
              <a:ext cx="1973578" cy="540000"/>
            </a:xfrm>
            <a:prstGeom prst="rect">
              <a:avLst/>
            </a:prstGeom>
          </p:spPr>
        </p:pic>
        <p:pic>
          <p:nvPicPr>
            <p:cNvPr id="36" name="图片 35">
              <a:extLst>
                <a:ext uri="{FF2B5EF4-FFF2-40B4-BE49-F238E27FC236}">
                  <a16:creationId xmlns:a16="http://schemas.microsoft.com/office/drawing/2014/main" id="{9CF3A764-721E-46CD-BDFF-7329EE012BFE}"/>
                </a:ext>
              </a:extLst>
            </p:cNvPr>
            <p:cNvPicPr>
              <a:picLocks noChangeAspect="1"/>
            </p:cNvPicPr>
            <p:nvPr/>
          </p:nvPicPr>
          <p:blipFill>
            <a:blip r:embed="rId31"/>
            <a:stretch>
              <a:fillRect/>
            </a:stretch>
          </p:blipFill>
          <p:spPr>
            <a:xfrm>
              <a:off x="2808000" y="1630350"/>
              <a:ext cx="1973578" cy="540000"/>
            </a:xfrm>
            <a:prstGeom prst="rect">
              <a:avLst/>
            </a:prstGeom>
          </p:spPr>
        </p:pic>
        <p:pic>
          <p:nvPicPr>
            <p:cNvPr id="44" name="图片 43">
              <a:extLst>
                <a:ext uri="{FF2B5EF4-FFF2-40B4-BE49-F238E27FC236}">
                  <a16:creationId xmlns:a16="http://schemas.microsoft.com/office/drawing/2014/main" id="{2D42503A-0F8A-433A-8D60-AA3767C796A6}"/>
                </a:ext>
              </a:extLst>
            </p:cNvPr>
            <p:cNvPicPr>
              <a:picLocks noChangeAspect="1"/>
            </p:cNvPicPr>
            <p:nvPr/>
          </p:nvPicPr>
          <p:blipFill>
            <a:blip r:embed="rId32"/>
            <a:stretch>
              <a:fillRect/>
            </a:stretch>
          </p:blipFill>
          <p:spPr>
            <a:xfrm>
              <a:off x="5148000" y="1630350"/>
              <a:ext cx="1973578" cy="540000"/>
            </a:xfrm>
            <a:prstGeom prst="rect">
              <a:avLst/>
            </a:prstGeom>
          </p:spPr>
        </p:pic>
        <p:pic>
          <p:nvPicPr>
            <p:cNvPr id="52" name="图片 51">
              <a:extLst>
                <a:ext uri="{FF2B5EF4-FFF2-40B4-BE49-F238E27FC236}">
                  <a16:creationId xmlns:a16="http://schemas.microsoft.com/office/drawing/2014/main" id="{3B44C44C-4F7A-4634-AB02-50504E89B652}"/>
                </a:ext>
              </a:extLst>
            </p:cNvPr>
            <p:cNvPicPr>
              <a:picLocks noChangeAspect="1"/>
            </p:cNvPicPr>
            <p:nvPr/>
          </p:nvPicPr>
          <p:blipFill>
            <a:blip r:embed="rId33"/>
            <a:stretch>
              <a:fillRect/>
            </a:stretch>
          </p:blipFill>
          <p:spPr>
            <a:xfrm>
              <a:off x="7488000" y="1630350"/>
              <a:ext cx="1973578" cy="540000"/>
            </a:xfrm>
            <a:prstGeom prst="rect">
              <a:avLst/>
            </a:prstGeom>
          </p:spPr>
        </p:pic>
        <p:pic>
          <p:nvPicPr>
            <p:cNvPr id="62" name="图片 61">
              <a:extLst>
                <a:ext uri="{FF2B5EF4-FFF2-40B4-BE49-F238E27FC236}">
                  <a16:creationId xmlns:a16="http://schemas.microsoft.com/office/drawing/2014/main" id="{1CDB7B49-CB53-4705-9BB4-E29A5C0743BB}"/>
                </a:ext>
              </a:extLst>
            </p:cNvPr>
            <p:cNvPicPr>
              <a:picLocks noChangeAspect="1"/>
            </p:cNvPicPr>
            <p:nvPr/>
          </p:nvPicPr>
          <p:blipFill>
            <a:blip r:embed="rId34"/>
            <a:stretch>
              <a:fillRect/>
            </a:stretch>
          </p:blipFill>
          <p:spPr>
            <a:xfrm>
              <a:off x="9828000" y="1630350"/>
              <a:ext cx="1973578" cy="540000"/>
            </a:xfrm>
            <a:prstGeom prst="rect">
              <a:avLst/>
            </a:prstGeom>
          </p:spPr>
        </p:pic>
        <p:pic>
          <p:nvPicPr>
            <p:cNvPr id="83" name="图片 82">
              <a:extLst>
                <a:ext uri="{FF2B5EF4-FFF2-40B4-BE49-F238E27FC236}">
                  <a16:creationId xmlns:a16="http://schemas.microsoft.com/office/drawing/2014/main" id="{DA4A6E16-86E9-40AA-B95A-5DA3ABE60D89}"/>
                </a:ext>
              </a:extLst>
            </p:cNvPr>
            <p:cNvPicPr>
              <a:picLocks noChangeAspect="1"/>
            </p:cNvPicPr>
            <p:nvPr/>
          </p:nvPicPr>
          <p:blipFill>
            <a:blip r:embed="rId35"/>
            <a:stretch>
              <a:fillRect/>
            </a:stretch>
          </p:blipFill>
          <p:spPr>
            <a:xfrm>
              <a:off x="468000" y="3250350"/>
              <a:ext cx="1973578" cy="540000"/>
            </a:xfrm>
            <a:prstGeom prst="rect">
              <a:avLst/>
            </a:prstGeom>
          </p:spPr>
        </p:pic>
        <p:pic>
          <p:nvPicPr>
            <p:cNvPr id="85" name="图片 84">
              <a:extLst>
                <a:ext uri="{FF2B5EF4-FFF2-40B4-BE49-F238E27FC236}">
                  <a16:creationId xmlns:a16="http://schemas.microsoft.com/office/drawing/2014/main" id="{E7F1E6A2-2168-4A2B-80ED-B2D2059EE126}"/>
                </a:ext>
              </a:extLst>
            </p:cNvPr>
            <p:cNvPicPr>
              <a:picLocks noChangeAspect="1"/>
            </p:cNvPicPr>
            <p:nvPr/>
          </p:nvPicPr>
          <p:blipFill>
            <a:blip r:embed="rId36"/>
            <a:stretch>
              <a:fillRect/>
            </a:stretch>
          </p:blipFill>
          <p:spPr>
            <a:xfrm>
              <a:off x="2808000" y="3250350"/>
              <a:ext cx="1973578" cy="540000"/>
            </a:xfrm>
            <a:prstGeom prst="rect">
              <a:avLst/>
            </a:prstGeom>
          </p:spPr>
        </p:pic>
        <p:pic>
          <p:nvPicPr>
            <p:cNvPr id="87" name="图片 86">
              <a:extLst>
                <a:ext uri="{FF2B5EF4-FFF2-40B4-BE49-F238E27FC236}">
                  <a16:creationId xmlns:a16="http://schemas.microsoft.com/office/drawing/2014/main" id="{4F2D37D6-D314-4852-B73C-3D29CE803C58}"/>
                </a:ext>
              </a:extLst>
            </p:cNvPr>
            <p:cNvPicPr>
              <a:picLocks noChangeAspect="1"/>
            </p:cNvPicPr>
            <p:nvPr/>
          </p:nvPicPr>
          <p:blipFill>
            <a:blip r:embed="rId37"/>
            <a:stretch>
              <a:fillRect/>
            </a:stretch>
          </p:blipFill>
          <p:spPr>
            <a:xfrm>
              <a:off x="5148000" y="3250350"/>
              <a:ext cx="1973578" cy="540000"/>
            </a:xfrm>
            <a:prstGeom prst="rect">
              <a:avLst/>
            </a:prstGeom>
          </p:spPr>
        </p:pic>
        <p:pic>
          <p:nvPicPr>
            <p:cNvPr id="89" name="图片 88">
              <a:extLst>
                <a:ext uri="{FF2B5EF4-FFF2-40B4-BE49-F238E27FC236}">
                  <a16:creationId xmlns:a16="http://schemas.microsoft.com/office/drawing/2014/main" id="{8EF83A46-BD53-464C-A8EE-0F38FC8A74AC}"/>
                </a:ext>
              </a:extLst>
            </p:cNvPr>
            <p:cNvPicPr>
              <a:picLocks noChangeAspect="1"/>
            </p:cNvPicPr>
            <p:nvPr/>
          </p:nvPicPr>
          <p:blipFill>
            <a:blip r:embed="rId38"/>
            <a:stretch>
              <a:fillRect/>
            </a:stretch>
          </p:blipFill>
          <p:spPr>
            <a:xfrm>
              <a:off x="7488000" y="3250350"/>
              <a:ext cx="1973578" cy="540000"/>
            </a:xfrm>
            <a:prstGeom prst="rect">
              <a:avLst/>
            </a:prstGeom>
          </p:spPr>
        </p:pic>
        <p:pic>
          <p:nvPicPr>
            <p:cNvPr id="91" name="图片 90">
              <a:extLst>
                <a:ext uri="{FF2B5EF4-FFF2-40B4-BE49-F238E27FC236}">
                  <a16:creationId xmlns:a16="http://schemas.microsoft.com/office/drawing/2014/main" id="{1286C07A-8F78-4884-BD03-09D9717B487E}"/>
                </a:ext>
              </a:extLst>
            </p:cNvPr>
            <p:cNvPicPr>
              <a:picLocks noChangeAspect="1"/>
            </p:cNvPicPr>
            <p:nvPr/>
          </p:nvPicPr>
          <p:blipFill>
            <a:blip r:embed="rId39"/>
            <a:stretch>
              <a:fillRect/>
            </a:stretch>
          </p:blipFill>
          <p:spPr>
            <a:xfrm>
              <a:off x="9828000" y="3250350"/>
              <a:ext cx="1973578" cy="540000"/>
            </a:xfrm>
            <a:prstGeom prst="rect">
              <a:avLst/>
            </a:prstGeom>
          </p:spPr>
        </p:pic>
        <p:pic>
          <p:nvPicPr>
            <p:cNvPr id="93" name="图片 92">
              <a:extLst>
                <a:ext uri="{FF2B5EF4-FFF2-40B4-BE49-F238E27FC236}">
                  <a16:creationId xmlns:a16="http://schemas.microsoft.com/office/drawing/2014/main" id="{4A07B230-BBC6-4844-9A96-F23EDD879FAE}"/>
                </a:ext>
              </a:extLst>
            </p:cNvPr>
            <p:cNvPicPr>
              <a:picLocks noChangeAspect="1"/>
            </p:cNvPicPr>
            <p:nvPr/>
          </p:nvPicPr>
          <p:blipFill>
            <a:blip r:embed="rId40"/>
            <a:stretch>
              <a:fillRect/>
            </a:stretch>
          </p:blipFill>
          <p:spPr>
            <a:xfrm>
              <a:off x="468000" y="4848750"/>
              <a:ext cx="1973578" cy="540000"/>
            </a:xfrm>
            <a:prstGeom prst="rect">
              <a:avLst/>
            </a:prstGeom>
          </p:spPr>
        </p:pic>
        <p:pic>
          <p:nvPicPr>
            <p:cNvPr id="95" name="图片 94">
              <a:extLst>
                <a:ext uri="{FF2B5EF4-FFF2-40B4-BE49-F238E27FC236}">
                  <a16:creationId xmlns:a16="http://schemas.microsoft.com/office/drawing/2014/main" id="{3F6FF6BB-26FD-4084-972B-83E27D6D9CC7}"/>
                </a:ext>
              </a:extLst>
            </p:cNvPr>
            <p:cNvPicPr>
              <a:picLocks noChangeAspect="1"/>
            </p:cNvPicPr>
            <p:nvPr/>
          </p:nvPicPr>
          <p:blipFill>
            <a:blip r:embed="rId41"/>
            <a:stretch>
              <a:fillRect/>
            </a:stretch>
          </p:blipFill>
          <p:spPr>
            <a:xfrm>
              <a:off x="2807999" y="4848750"/>
              <a:ext cx="1973578" cy="540000"/>
            </a:xfrm>
            <a:prstGeom prst="rect">
              <a:avLst/>
            </a:prstGeom>
          </p:spPr>
        </p:pic>
        <p:pic>
          <p:nvPicPr>
            <p:cNvPr id="98" name="图片 97">
              <a:extLst>
                <a:ext uri="{FF2B5EF4-FFF2-40B4-BE49-F238E27FC236}">
                  <a16:creationId xmlns:a16="http://schemas.microsoft.com/office/drawing/2014/main" id="{ED3083B0-D35A-4795-8569-32EB6DC26B3F}"/>
                </a:ext>
              </a:extLst>
            </p:cNvPr>
            <p:cNvPicPr>
              <a:picLocks noChangeAspect="1"/>
            </p:cNvPicPr>
            <p:nvPr/>
          </p:nvPicPr>
          <p:blipFill>
            <a:blip r:embed="rId42"/>
            <a:stretch>
              <a:fillRect/>
            </a:stretch>
          </p:blipFill>
          <p:spPr>
            <a:xfrm>
              <a:off x="5148000" y="4848750"/>
              <a:ext cx="1973578" cy="540000"/>
            </a:xfrm>
            <a:prstGeom prst="rect">
              <a:avLst/>
            </a:prstGeom>
          </p:spPr>
        </p:pic>
        <p:pic>
          <p:nvPicPr>
            <p:cNvPr id="100" name="图片 99">
              <a:extLst>
                <a:ext uri="{FF2B5EF4-FFF2-40B4-BE49-F238E27FC236}">
                  <a16:creationId xmlns:a16="http://schemas.microsoft.com/office/drawing/2014/main" id="{0982F259-C8A0-4E21-AA5C-D867C6C64C42}"/>
                </a:ext>
              </a:extLst>
            </p:cNvPr>
            <p:cNvPicPr>
              <a:picLocks noChangeAspect="1"/>
            </p:cNvPicPr>
            <p:nvPr/>
          </p:nvPicPr>
          <p:blipFill>
            <a:blip r:embed="rId43"/>
            <a:stretch>
              <a:fillRect/>
            </a:stretch>
          </p:blipFill>
          <p:spPr>
            <a:xfrm>
              <a:off x="7488000" y="4848750"/>
              <a:ext cx="1973578" cy="540000"/>
            </a:xfrm>
            <a:prstGeom prst="rect">
              <a:avLst/>
            </a:prstGeom>
          </p:spPr>
        </p:pic>
        <p:pic>
          <p:nvPicPr>
            <p:cNvPr id="102" name="图片 101">
              <a:extLst>
                <a:ext uri="{FF2B5EF4-FFF2-40B4-BE49-F238E27FC236}">
                  <a16:creationId xmlns:a16="http://schemas.microsoft.com/office/drawing/2014/main" id="{3666B09A-03BF-4597-BF61-EAC8CB7F52DD}"/>
                </a:ext>
              </a:extLst>
            </p:cNvPr>
            <p:cNvPicPr>
              <a:picLocks noChangeAspect="1"/>
            </p:cNvPicPr>
            <p:nvPr/>
          </p:nvPicPr>
          <p:blipFill>
            <a:blip r:embed="rId44"/>
            <a:stretch>
              <a:fillRect/>
            </a:stretch>
          </p:blipFill>
          <p:spPr>
            <a:xfrm>
              <a:off x="9828000" y="4848750"/>
              <a:ext cx="1973578" cy="54000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61317135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>
            <a:extLst>
              <a:ext uri="{FF2B5EF4-FFF2-40B4-BE49-F238E27FC236}">
                <a16:creationId xmlns:a16="http://schemas.microsoft.com/office/drawing/2014/main" id="{8C22B18F-C015-43A8-A75B-78732A8A6CAE}"/>
              </a:ext>
            </a:extLst>
          </p:cNvPr>
          <p:cNvGrpSpPr/>
          <p:nvPr/>
        </p:nvGrpSpPr>
        <p:grpSpPr>
          <a:xfrm>
            <a:off x="0" y="63300"/>
            <a:ext cx="12419130" cy="6761883"/>
            <a:chOff x="0" y="25200"/>
            <a:chExt cx="12419130" cy="6761883"/>
          </a:xfrm>
        </p:grpSpPr>
        <p:sp>
          <p:nvSpPr>
            <p:cNvPr id="5" name="文本框 4">
              <a:extLst>
                <a:ext uri="{FF2B5EF4-FFF2-40B4-BE49-F238E27FC236}">
                  <a16:creationId xmlns:a16="http://schemas.microsoft.com/office/drawing/2014/main" id="{4EB527AC-F0A8-4129-8CAE-A3D1F1924313}"/>
                </a:ext>
              </a:extLst>
            </p:cNvPr>
            <p:cNvSpPr txBox="1"/>
            <p:nvPr/>
          </p:nvSpPr>
          <p:spPr>
            <a:xfrm>
              <a:off x="11152117" y="1141297"/>
              <a:ext cx="1190689" cy="5078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ead and Neck Squamous Cell Carcinoma </a:t>
              </a:r>
              <a:endParaRPr lang="zh-CN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" name="文本框 5">
              <a:extLst>
                <a:ext uri="{FF2B5EF4-FFF2-40B4-BE49-F238E27FC236}">
                  <a16:creationId xmlns:a16="http://schemas.microsoft.com/office/drawing/2014/main" id="{F0342969-4392-48A1-87D2-A132D4F04ABD}"/>
                </a:ext>
              </a:extLst>
            </p:cNvPr>
            <p:cNvSpPr txBox="1"/>
            <p:nvPr/>
          </p:nvSpPr>
          <p:spPr>
            <a:xfrm>
              <a:off x="11228441" y="2742518"/>
              <a:ext cx="119068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idney Chromophobe </a:t>
              </a:r>
              <a:endParaRPr lang="zh-CN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文本框 6">
              <a:extLst>
                <a:ext uri="{FF2B5EF4-FFF2-40B4-BE49-F238E27FC236}">
                  <a16:creationId xmlns:a16="http://schemas.microsoft.com/office/drawing/2014/main" id="{FB66408A-1D3E-48DB-B1DC-B13F1650AC6E}"/>
                </a:ext>
              </a:extLst>
            </p:cNvPr>
            <p:cNvSpPr txBox="1"/>
            <p:nvPr/>
          </p:nvSpPr>
          <p:spPr>
            <a:xfrm>
              <a:off x="11223457" y="4296523"/>
              <a:ext cx="1190689" cy="5078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iver </a:t>
              </a:r>
            </a:p>
            <a:p>
              <a:pPr algn="ctr"/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epatocellular Carcinoma </a:t>
              </a:r>
              <a:endParaRPr lang="zh-CN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文本框 7">
              <a:extLst>
                <a:ext uri="{FF2B5EF4-FFF2-40B4-BE49-F238E27FC236}">
                  <a16:creationId xmlns:a16="http://schemas.microsoft.com/office/drawing/2014/main" id="{EDBA89AD-1A2B-45A8-B2BD-A817EF054EF4}"/>
                </a:ext>
              </a:extLst>
            </p:cNvPr>
            <p:cNvSpPr txBox="1"/>
            <p:nvPr/>
          </p:nvSpPr>
          <p:spPr>
            <a:xfrm>
              <a:off x="11152117" y="6022989"/>
              <a:ext cx="119068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ung Adenocarcinoma </a:t>
              </a:r>
              <a:endParaRPr lang="zh-CN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46" name="图片 45">
              <a:extLst>
                <a:ext uri="{FF2B5EF4-FFF2-40B4-BE49-F238E27FC236}">
                  <a16:creationId xmlns:a16="http://schemas.microsoft.com/office/drawing/2014/main" id="{0360250B-B419-449E-9AB0-79DF9F392AF5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900044" y="6628325"/>
              <a:ext cx="1289116" cy="158758"/>
            </a:xfrm>
            <a:prstGeom prst="rect">
              <a:avLst/>
            </a:prstGeom>
          </p:spPr>
        </p:pic>
        <p:pic>
          <p:nvPicPr>
            <p:cNvPr id="47" name="图片 46">
              <a:extLst>
                <a:ext uri="{FF2B5EF4-FFF2-40B4-BE49-F238E27FC236}">
                  <a16:creationId xmlns:a16="http://schemas.microsoft.com/office/drawing/2014/main" id="{B31BFEE3-CE4A-4E7A-87C1-4947A989CDC5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559313" y="6606700"/>
              <a:ext cx="1428823" cy="171459"/>
            </a:xfrm>
            <a:prstGeom prst="rect">
              <a:avLst/>
            </a:prstGeom>
          </p:spPr>
        </p:pic>
        <p:pic>
          <p:nvPicPr>
            <p:cNvPr id="14" name="图片 13">
              <a:extLst>
                <a:ext uri="{FF2B5EF4-FFF2-40B4-BE49-F238E27FC236}">
                  <a16:creationId xmlns:a16="http://schemas.microsoft.com/office/drawing/2014/main" id="{35AC36A9-B988-4116-A690-66CA62A5E6FD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0" y="25200"/>
              <a:ext cx="1942870" cy="1566000"/>
            </a:xfrm>
            <a:prstGeom prst="rect">
              <a:avLst/>
            </a:prstGeom>
          </p:spPr>
        </p:pic>
        <p:pic>
          <p:nvPicPr>
            <p:cNvPr id="22" name="图片 21">
              <a:extLst>
                <a:ext uri="{FF2B5EF4-FFF2-40B4-BE49-F238E27FC236}">
                  <a16:creationId xmlns:a16="http://schemas.microsoft.com/office/drawing/2014/main" id="{CC17A50D-0408-4AC6-8D4F-5389032E9215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0" y="1598400"/>
              <a:ext cx="1952783" cy="1566000"/>
            </a:xfrm>
            <a:prstGeom prst="rect">
              <a:avLst/>
            </a:prstGeom>
          </p:spPr>
        </p:pic>
        <p:pic>
          <p:nvPicPr>
            <p:cNvPr id="38" name="图片 37">
              <a:extLst>
                <a:ext uri="{FF2B5EF4-FFF2-40B4-BE49-F238E27FC236}">
                  <a16:creationId xmlns:a16="http://schemas.microsoft.com/office/drawing/2014/main" id="{6C925F81-FA6D-4A75-92E1-6265879A94BD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0" y="4798800"/>
              <a:ext cx="1935295" cy="1566000"/>
            </a:xfrm>
            <a:prstGeom prst="rect">
              <a:avLst/>
            </a:prstGeom>
          </p:spPr>
        </p:pic>
        <p:sp>
          <p:nvSpPr>
            <p:cNvPr id="48" name="文本框 47">
              <a:extLst>
                <a:ext uri="{FF2B5EF4-FFF2-40B4-BE49-F238E27FC236}">
                  <a16:creationId xmlns:a16="http://schemas.microsoft.com/office/drawing/2014/main" id="{374B877B-93BC-4435-825E-1BC3072C3342}"/>
                </a:ext>
              </a:extLst>
            </p:cNvPr>
            <p:cNvSpPr txBox="1"/>
            <p:nvPr/>
          </p:nvSpPr>
          <p:spPr>
            <a:xfrm>
              <a:off x="930680" y="6330183"/>
              <a:ext cx="1078521" cy="2230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LH1</a:t>
              </a:r>
              <a:endParaRPr lang="zh-CN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24" name="图片 23">
              <a:extLst>
                <a:ext uri="{FF2B5EF4-FFF2-40B4-BE49-F238E27FC236}">
                  <a16:creationId xmlns:a16="http://schemas.microsoft.com/office/drawing/2014/main" id="{A961A0CE-6DA5-42AE-986C-DB9972D7F9F8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340000" y="1598400"/>
              <a:ext cx="1949847" cy="1566000"/>
            </a:xfrm>
            <a:prstGeom prst="rect">
              <a:avLst/>
            </a:prstGeom>
          </p:spPr>
        </p:pic>
        <p:pic>
          <p:nvPicPr>
            <p:cNvPr id="40" name="图片 39">
              <a:extLst>
                <a:ext uri="{FF2B5EF4-FFF2-40B4-BE49-F238E27FC236}">
                  <a16:creationId xmlns:a16="http://schemas.microsoft.com/office/drawing/2014/main" id="{5002C336-BA3D-4F71-B6DE-D45DCAD7BDF9}"/>
                </a:ext>
              </a:extLst>
            </p:cNvPr>
            <p:cNvPicPr>
              <a:picLocks noChangeAspect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340000" y="4798800"/>
              <a:ext cx="1941652" cy="1566000"/>
            </a:xfrm>
            <a:prstGeom prst="rect">
              <a:avLst/>
            </a:prstGeom>
          </p:spPr>
        </p:pic>
        <p:sp>
          <p:nvSpPr>
            <p:cNvPr id="49" name="文本框 48">
              <a:extLst>
                <a:ext uri="{FF2B5EF4-FFF2-40B4-BE49-F238E27FC236}">
                  <a16:creationId xmlns:a16="http://schemas.microsoft.com/office/drawing/2014/main" id="{448A78B7-4073-4FA4-AD94-7E8F27DDEF40}"/>
                </a:ext>
              </a:extLst>
            </p:cNvPr>
            <p:cNvSpPr txBox="1"/>
            <p:nvPr/>
          </p:nvSpPr>
          <p:spPr>
            <a:xfrm>
              <a:off x="3219034" y="6330183"/>
              <a:ext cx="1078521" cy="2230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SH2</a:t>
              </a:r>
              <a:endParaRPr lang="zh-CN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18" name="图片 17">
              <a:extLst>
                <a:ext uri="{FF2B5EF4-FFF2-40B4-BE49-F238E27FC236}">
                  <a16:creationId xmlns:a16="http://schemas.microsoft.com/office/drawing/2014/main" id="{BFE89F43-6D77-41C3-B21C-EDCF87B01BE1}"/>
                </a:ext>
              </a:extLst>
            </p:cNvPr>
            <p:cNvPicPr>
              <a:picLocks noChangeAspect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680000" y="25200"/>
              <a:ext cx="1961049" cy="1566000"/>
            </a:xfrm>
            <a:prstGeom prst="rect">
              <a:avLst/>
            </a:prstGeom>
          </p:spPr>
        </p:pic>
        <p:pic>
          <p:nvPicPr>
            <p:cNvPr id="26" name="图片 25">
              <a:extLst>
                <a:ext uri="{FF2B5EF4-FFF2-40B4-BE49-F238E27FC236}">
                  <a16:creationId xmlns:a16="http://schemas.microsoft.com/office/drawing/2014/main" id="{D03BB8ED-7F9A-4ECE-BFAC-CD323EDBD1E0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680000" y="1598400"/>
              <a:ext cx="1960435" cy="1566000"/>
            </a:xfrm>
            <a:prstGeom prst="rect">
              <a:avLst/>
            </a:prstGeom>
          </p:spPr>
        </p:pic>
        <p:pic>
          <p:nvPicPr>
            <p:cNvPr id="34" name="图片 33">
              <a:extLst>
                <a:ext uri="{FF2B5EF4-FFF2-40B4-BE49-F238E27FC236}">
                  <a16:creationId xmlns:a16="http://schemas.microsoft.com/office/drawing/2014/main" id="{3B0DDD21-8D92-4BC5-BF4D-E56C411184EC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680000" y="3200400"/>
              <a:ext cx="1951043" cy="1566000"/>
            </a:xfrm>
            <a:prstGeom prst="rect">
              <a:avLst/>
            </a:prstGeom>
          </p:spPr>
        </p:pic>
        <p:pic>
          <p:nvPicPr>
            <p:cNvPr id="42" name="图片 41">
              <a:extLst>
                <a:ext uri="{FF2B5EF4-FFF2-40B4-BE49-F238E27FC236}">
                  <a16:creationId xmlns:a16="http://schemas.microsoft.com/office/drawing/2014/main" id="{CBC8C696-B0EE-46D1-98CE-F875E638C9D9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680000" y="4798800"/>
              <a:ext cx="1951043" cy="1566000"/>
            </a:xfrm>
            <a:prstGeom prst="rect">
              <a:avLst/>
            </a:prstGeom>
          </p:spPr>
        </p:pic>
        <p:sp>
          <p:nvSpPr>
            <p:cNvPr id="50" name="文本框 49">
              <a:extLst>
                <a:ext uri="{FF2B5EF4-FFF2-40B4-BE49-F238E27FC236}">
                  <a16:creationId xmlns:a16="http://schemas.microsoft.com/office/drawing/2014/main" id="{AF6AB94A-6DA6-4DA4-A159-B8021763B922}"/>
                </a:ext>
              </a:extLst>
            </p:cNvPr>
            <p:cNvSpPr txBox="1"/>
            <p:nvPr/>
          </p:nvSpPr>
          <p:spPr>
            <a:xfrm>
              <a:off x="5424120" y="6330183"/>
              <a:ext cx="1078521" cy="2230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SH6</a:t>
              </a:r>
              <a:endParaRPr lang="zh-CN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20" name="图片 19">
              <a:extLst>
                <a:ext uri="{FF2B5EF4-FFF2-40B4-BE49-F238E27FC236}">
                  <a16:creationId xmlns:a16="http://schemas.microsoft.com/office/drawing/2014/main" id="{E7DF944E-1B49-486D-B843-97548BEEF49C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020000" y="25200"/>
              <a:ext cx="1960453" cy="1566000"/>
            </a:xfrm>
            <a:prstGeom prst="rect">
              <a:avLst/>
            </a:prstGeom>
          </p:spPr>
        </p:pic>
        <p:pic>
          <p:nvPicPr>
            <p:cNvPr id="28" name="图片 27">
              <a:extLst>
                <a:ext uri="{FF2B5EF4-FFF2-40B4-BE49-F238E27FC236}">
                  <a16:creationId xmlns:a16="http://schemas.microsoft.com/office/drawing/2014/main" id="{72151227-A4BC-4667-BD22-7755407C3CE7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020000" y="1598400"/>
              <a:ext cx="1958676" cy="1566000"/>
            </a:xfrm>
            <a:prstGeom prst="rect">
              <a:avLst/>
            </a:prstGeom>
          </p:spPr>
        </p:pic>
        <p:pic>
          <p:nvPicPr>
            <p:cNvPr id="36" name="图片 35">
              <a:extLst>
                <a:ext uri="{FF2B5EF4-FFF2-40B4-BE49-F238E27FC236}">
                  <a16:creationId xmlns:a16="http://schemas.microsoft.com/office/drawing/2014/main" id="{AB18E8BC-A1AD-495B-8FA5-423F3F7F49BB}"/>
                </a:ext>
              </a:extLst>
            </p:cNvPr>
            <p:cNvPicPr>
              <a:picLocks noChangeAspect="1"/>
            </p:cNvPicPr>
            <p:nvPr/>
          </p:nvPicPr>
          <p:blipFill>
            <a:blip r:embed="rId1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020000" y="3200400"/>
              <a:ext cx="1961621" cy="1566000"/>
            </a:xfrm>
            <a:prstGeom prst="rect">
              <a:avLst/>
            </a:prstGeom>
          </p:spPr>
        </p:pic>
        <p:pic>
          <p:nvPicPr>
            <p:cNvPr id="44" name="图片 43">
              <a:extLst>
                <a:ext uri="{FF2B5EF4-FFF2-40B4-BE49-F238E27FC236}">
                  <a16:creationId xmlns:a16="http://schemas.microsoft.com/office/drawing/2014/main" id="{1C068310-2F96-4688-A3DA-C5050094F585}"/>
                </a:ext>
              </a:extLst>
            </p:cNvPr>
            <p:cNvPicPr>
              <a:picLocks noChangeAspect="1"/>
            </p:cNvPicPr>
            <p:nvPr/>
          </p:nvPicPr>
          <p:blipFill>
            <a:blip r:embed="rId1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020000" y="4798800"/>
              <a:ext cx="1953391" cy="1566000"/>
            </a:xfrm>
            <a:prstGeom prst="rect">
              <a:avLst/>
            </a:prstGeom>
          </p:spPr>
        </p:pic>
        <p:sp>
          <p:nvSpPr>
            <p:cNvPr id="51" name="文本框 50">
              <a:extLst>
                <a:ext uri="{FF2B5EF4-FFF2-40B4-BE49-F238E27FC236}">
                  <a16:creationId xmlns:a16="http://schemas.microsoft.com/office/drawing/2014/main" id="{E42E0EF4-3DCD-41CF-A582-1562A916DC30}"/>
                </a:ext>
              </a:extLst>
            </p:cNvPr>
            <p:cNvSpPr txBox="1"/>
            <p:nvPr/>
          </p:nvSpPr>
          <p:spPr>
            <a:xfrm>
              <a:off x="7813080" y="6330183"/>
              <a:ext cx="1078521" cy="2230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MS2</a:t>
              </a:r>
              <a:endParaRPr lang="zh-CN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" name="文本框 34">
              <a:extLst>
                <a:ext uri="{FF2B5EF4-FFF2-40B4-BE49-F238E27FC236}">
                  <a16:creationId xmlns:a16="http://schemas.microsoft.com/office/drawing/2014/main" id="{91910854-5A30-4DAB-B8A3-D797CD56E448}"/>
                </a:ext>
              </a:extLst>
            </p:cNvPr>
            <p:cNvSpPr txBox="1"/>
            <p:nvPr/>
          </p:nvSpPr>
          <p:spPr>
            <a:xfrm>
              <a:off x="10149920" y="6330183"/>
              <a:ext cx="107852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 genes</a:t>
              </a:r>
              <a:endParaRPr lang="zh-CN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11" name="图片 10">
              <a:extLst>
                <a:ext uri="{FF2B5EF4-FFF2-40B4-BE49-F238E27FC236}">
                  <a16:creationId xmlns:a16="http://schemas.microsoft.com/office/drawing/2014/main" id="{AFCBAF14-AA5D-4688-A8A3-560B3627A707}"/>
                </a:ext>
              </a:extLst>
            </p:cNvPr>
            <p:cNvPicPr>
              <a:picLocks noChangeAspect="1"/>
            </p:cNvPicPr>
            <p:nvPr/>
          </p:nvPicPr>
          <p:blipFill>
            <a:blip r:embed="rId1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331200" y="25200"/>
              <a:ext cx="1945708" cy="1566000"/>
            </a:xfrm>
            <a:prstGeom prst="rect">
              <a:avLst/>
            </a:prstGeom>
          </p:spPr>
        </p:pic>
        <p:pic>
          <p:nvPicPr>
            <p:cNvPr id="13" name="图片 12">
              <a:extLst>
                <a:ext uri="{FF2B5EF4-FFF2-40B4-BE49-F238E27FC236}">
                  <a16:creationId xmlns:a16="http://schemas.microsoft.com/office/drawing/2014/main" id="{316E98FF-F807-470F-978E-C5E424B44CE5}"/>
                </a:ext>
              </a:extLst>
            </p:cNvPr>
            <p:cNvPicPr>
              <a:picLocks noChangeAspect="1"/>
            </p:cNvPicPr>
            <p:nvPr/>
          </p:nvPicPr>
          <p:blipFill>
            <a:blip r:embed="rId1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331200" y="1598400"/>
              <a:ext cx="1942870" cy="1566000"/>
            </a:xfrm>
            <a:prstGeom prst="rect">
              <a:avLst/>
            </a:prstGeom>
          </p:spPr>
        </p:pic>
        <p:pic>
          <p:nvPicPr>
            <p:cNvPr id="17" name="图片 16">
              <a:extLst>
                <a:ext uri="{FF2B5EF4-FFF2-40B4-BE49-F238E27FC236}">
                  <a16:creationId xmlns:a16="http://schemas.microsoft.com/office/drawing/2014/main" id="{0CF522B4-E4B0-4EAD-8ABB-7531E3E619F6}"/>
                </a:ext>
              </a:extLst>
            </p:cNvPr>
            <p:cNvPicPr>
              <a:picLocks noChangeAspect="1"/>
            </p:cNvPicPr>
            <p:nvPr/>
          </p:nvPicPr>
          <p:blipFill>
            <a:blip r:embed="rId1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331200" y="3200400"/>
              <a:ext cx="1952811" cy="1566000"/>
            </a:xfrm>
            <a:prstGeom prst="rect">
              <a:avLst/>
            </a:prstGeom>
          </p:spPr>
        </p:pic>
        <p:pic>
          <p:nvPicPr>
            <p:cNvPr id="21" name="图片 20">
              <a:extLst>
                <a:ext uri="{FF2B5EF4-FFF2-40B4-BE49-F238E27FC236}">
                  <a16:creationId xmlns:a16="http://schemas.microsoft.com/office/drawing/2014/main" id="{5D93B257-5861-4A00-8AD2-91BF84B431FB}"/>
                </a:ext>
              </a:extLst>
            </p:cNvPr>
            <p:cNvPicPr>
              <a:picLocks noChangeAspect="1"/>
            </p:cNvPicPr>
            <p:nvPr/>
          </p:nvPicPr>
          <p:blipFill>
            <a:blip r:embed="rId2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331200" y="4798800"/>
              <a:ext cx="1964575" cy="1566000"/>
            </a:xfrm>
            <a:prstGeom prst="rect">
              <a:avLst/>
            </a:prstGeom>
          </p:spPr>
        </p:pic>
        <p:pic>
          <p:nvPicPr>
            <p:cNvPr id="16" name="图片 15">
              <a:extLst>
                <a:ext uri="{FF2B5EF4-FFF2-40B4-BE49-F238E27FC236}">
                  <a16:creationId xmlns:a16="http://schemas.microsoft.com/office/drawing/2014/main" id="{28DEE7EC-E4A5-4675-9F1A-540EDE679A0E}"/>
                </a:ext>
              </a:extLst>
            </p:cNvPr>
            <p:cNvPicPr>
              <a:picLocks noChangeAspect="1"/>
            </p:cNvPicPr>
            <p:nvPr/>
          </p:nvPicPr>
          <p:blipFill>
            <a:blip r:embed="rId2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340000" y="25200"/>
              <a:ext cx="1934057" cy="1566000"/>
            </a:xfrm>
            <a:prstGeom prst="rect">
              <a:avLst/>
            </a:prstGeom>
          </p:spPr>
        </p:pic>
        <p:pic>
          <p:nvPicPr>
            <p:cNvPr id="30" name="图片 29">
              <a:extLst>
                <a:ext uri="{FF2B5EF4-FFF2-40B4-BE49-F238E27FC236}">
                  <a16:creationId xmlns:a16="http://schemas.microsoft.com/office/drawing/2014/main" id="{BDCEFE3A-36E1-41F5-AF22-D5827F754121}"/>
                </a:ext>
              </a:extLst>
            </p:cNvPr>
            <p:cNvPicPr>
              <a:picLocks noChangeAspect="1"/>
            </p:cNvPicPr>
            <p:nvPr/>
          </p:nvPicPr>
          <p:blipFill>
            <a:blip r:embed="rId2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0" y="3200400"/>
              <a:ext cx="1947552" cy="1566000"/>
            </a:xfrm>
            <a:prstGeom prst="rect">
              <a:avLst/>
            </a:prstGeom>
          </p:spPr>
        </p:pic>
        <p:pic>
          <p:nvPicPr>
            <p:cNvPr id="32" name="图片 31">
              <a:extLst>
                <a:ext uri="{FF2B5EF4-FFF2-40B4-BE49-F238E27FC236}">
                  <a16:creationId xmlns:a16="http://schemas.microsoft.com/office/drawing/2014/main" id="{D9EA22DE-5D7A-463E-B2BF-3FA38E03C184}"/>
                </a:ext>
              </a:extLst>
            </p:cNvPr>
            <p:cNvPicPr>
              <a:picLocks noChangeAspect="1"/>
            </p:cNvPicPr>
            <p:nvPr/>
          </p:nvPicPr>
          <p:blipFill>
            <a:blip r:embed="rId2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340000" y="3200400"/>
              <a:ext cx="1945778" cy="1566000"/>
            </a:xfrm>
            <a:prstGeom prst="rect">
              <a:avLst/>
            </a:prstGeom>
          </p:spPr>
        </p:pic>
        <p:pic>
          <p:nvPicPr>
            <p:cNvPr id="9" name="图片 8">
              <a:extLst>
                <a:ext uri="{FF2B5EF4-FFF2-40B4-BE49-F238E27FC236}">
                  <a16:creationId xmlns:a16="http://schemas.microsoft.com/office/drawing/2014/main" id="{0D0EF627-87DD-49EA-9036-CAFF8D4A93D2}"/>
                </a:ext>
              </a:extLst>
            </p:cNvPr>
            <p:cNvPicPr>
              <a:picLocks noChangeAspect="1"/>
            </p:cNvPicPr>
            <p:nvPr/>
          </p:nvPicPr>
          <p:blipFill>
            <a:blip r:embed="rId24"/>
            <a:stretch>
              <a:fillRect/>
            </a:stretch>
          </p:blipFill>
          <p:spPr>
            <a:xfrm>
              <a:off x="468000" y="25200"/>
              <a:ext cx="1973578" cy="540000"/>
            </a:xfrm>
            <a:prstGeom prst="rect">
              <a:avLst/>
            </a:prstGeom>
          </p:spPr>
        </p:pic>
        <p:pic>
          <p:nvPicPr>
            <p:cNvPr id="12" name="图片 11">
              <a:extLst>
                <a:ext uri="{FF2B5EF4-FFF2-40B4-BE49-F238E27FC236}">
                  <a16:creationId xmlns:a16="http://schemas.microsoft.com/office/drawing/2014/main" id="{400C000A-8BAC-4DEF-87EE-6ABF1924351B}"/>
                </a:ext>
              </a:extLst>
            </p:cNvPr>
            <p:cNvPicPr>
              <a:picLocks noChangeAspect="1"/>
            </p:cNvPicPr>
            <p:nvPr/>
          </p:nvPicPr>
          <p:blipFill>
            <a:blip r:embed="rId25"/>
            <a:stretch>
              <a:fillRect/>
            </a:stretch>
          </p:blipFill>
          <p:spPr>
            <a:xfrm>
              <a:off x="2808000" y="25200"/>
              <a:ext cx="1973578" cy="540000"/>
            </a:xfrm>
            <a:prstGeom prst="rect">
              <a:avLst/>
            </a:prstGeom>
          </p:spPr>
        </p:pic>
        <p:pic>
          <p:nvPicPr>
            <p:cNvPr id="19" name="图片 18">
              <a:extLst>
                <a:ext uri="{FF2B5EF4-FFF2-40B4-BE49-F238E27FC236}">
                  <a16:creationId xmlns:a16="http://schemas.microsoft.com/office/drawing/2014/main" id="{F943DACF-EFED-4585-8292-3E1985FBBE6D}"/>
                </a:ext>
              </a:extLst>
            </p:cNvPr>
            <p:cNvPicPr>
              <a:picLocks noChangeAspect="1"/>
            </p:cNvPicPr>
            <p:nvPr/>
          </p:nvPicPr>
          <p:blipFill>
            <a:blip r:embed="rId26"/>
            <a:stretch>
              <a:fillRect/>
            </a:stretch>
          </p:blipFill>
          <p:spPr>
            <a:xfrm>
              <a:off x="5148000" y="25200"/>
              <a:ext cx="1973578" cy="540000"/>
            </a:xfrm>
            <a:prstGeom prst="rect">
              <a:avLst/>
            </a:prstGeom>
          </p:spPr>
        </p:pic>
        <p:pic>
          <p:nvPicPr>
            <p:cNvPr id="27" name="图片 26">
              <a:extLst>
                <a:ext uri="{FF2B5EF4-FFF2-40B4-BE49-F238E27FC236}">
                  <a16:creationId xmlns:a16="http://schemas.microsoft.com/office/drawing/2014/main" id="{27AE1217-BD0D-40A7-BF0E-91411963A320}"/>
                </a:ext>
              </a:extLst>
            </p:cNvPr>
            <p:cNvPicPr>
              <a:picLocks noChangeAspect="1"/>
            </p:cNvPicPr>
            <p:nvPr/>
          </p:nvPicPr>
          <p:blipFill>
            <a:blip r:embed="rId27"/>
            <a:stretch>
              <a:fillRect/>
            </a:stretch>
          </p:blipFill>
          <p:spPr>
            <a:xfrm>
              <a:off x="7488000" y="25200"/>
              <a:ext cx="1973578" cy="540000"/>
            </a:xfrm>
            <a:prstGeom prst="rect">
              <a:avLst/>
            </a:prstGeom>
          </p:spPr>
        </p:pic>
        <p:pic>
          <p:nvPicPr>
            <p:cNvPr id="45" name="图片 44">
              <a:extLst>
                <a:ext uri="{FF2B5EF4-FFF2-40B4-BE49-F238E27FC236}">
                  <a16:creationId xmlns:a16="http://schemas.microsoft.com/office/drawing/2014/main" id="{DE73DA05-3563-493A-8B66-355DCCF170A3}"/>
                </a:ext>
              </a:extLst>
            </p:cNvPr>
            <p:cNvPicPr>
              <a:picLocks noChangeAspect="1"/>
            </p:cNvPicPr>
            <p:nvPr/>
          </p:nvPicPr>
          <p:blipFill>
            <a:blip r:embed="rId28"/>
            <a:stretch>
              <a:fillRect/>
            </a:stretch>
          </p:blipFill>
          <p:spPr>
            <a:xfrm>
              <a:off x="9828000" y="25200"/>
              <a:ext cx="1973578" cy="540000"/>
            </a:xfrm>
            <a:prstGeom prst="rect">
              <a:avLst/>
            </a:prstGeom>
          </p:spPr>
        </p:pic>
        <p:pic>
          <p:nvPicPr>
            <p:cNvPr id="54" name="图片 53">
              <a:extLst>
                <a:ext uri="{FF2B5EF4-FFF2-40B4-BE49-F238E27FC236}">
                  <a16:creationId xmlns:a16="http://schemas.microsoft.com/office/drawing/2014/main" id="{9865B7C0-D195-4F4F-BE5F-F87D8B61D620}"/>
                </a:ext>
              </a:extLst>
            </p:cNvPr>
            <p:cNvPicPr>
              <a:picLocks noChangeAspect="1"/>
            </p:cNvPicPr>
            <p:nvPr/>
          </p:nvPicPr>
          <p:blipFill>
            <a:blip r:embed="rId29"/>
            <a:stretch>
              <a:fillRect/>
            </a:stretch>
          </p:blipFill>
          <p:spPr>
            <a:xfrm>
              <a:off x="468000" y="2448000"/>
              <a:ext cx="1973578" cy="540000"/>
            </a:xfrm>
            <a:prstGeom prst="rect">
              <a:avLst/>
            </a:prstGeom>
          </p:spPr>
        </p:pic>
        <p:pic>
          <p:nvPicPr>
            <p:cNvPr id="57" name="图片 56">
              <a:extLst>
                <a:ext uri="{FF2B5EF4-FFF2-40B4-BE49-F238E27FC236}">
                  <a16:creationId xmlns:a16="http://schemas.microsoft.com/office/drawing/2014/main" id="{B9727356-246B-460C-9680-A48A325CE650}"/>
                </a:ext>
              </a:extLst>
            </p:cNvPr>
            <p:cNvPicPr>
              <a:picLocks noChangeAspect="1"/>
            </p:cNvPicPr>
            <p:nvPr/>
          </p:nvPicPr>
          <p:blipFill>
            <a:blip r:embed="rId30"/>
            <a:stretch>
              <a:fillRect/>
            </a:stretch>
          </p:blipFill>
          <p:spPr>
            <a:xfrm>
              <a:off x="2808000" y="2448000"/>
              <a:ext cx="1973578" cy="540000"/>
            </a:xfrm>
            <a:prstGeom prst="rect">
              <a:avLst/>
            </a:prstGeom>
          </p:spPr>
        </p:pic>
        <p:pic>
          <p:nvPicPr>
            <p:cNvPr id="63" name="图片 62">
              <a:extLst>
                <a:ext uri="{FF2B5EF4-FFF2-40B4-BE49-F238E27FC236}">
                  <a16:creationId xmlns:a16="http://schemas.microsoft.com/office/drawing/2014/main" id="{F7EF3092-8FEC-4B2F-B8B1-93B3053AD777}"/>
                </a:ext>
              </a:extLst>
            </p:cNvPr>
            <p:cNvPicPr>
              <a:picLocks noChangeAspect="1"/>
            </p:cNvPicPr>
            <p:nvPr/>
          </p:nvPicPr>
          <p:blipFill>
            <a:blip r:embed="rId31"/>
            <a:stretch>
              <a:fillRect/>
            </a:stretch>
          </p:blipFill>
          <p:spPr>
            <a:xfrm>
              <a:off x="5148000" y="2448000"/>
              <a:ext cx="1973578" cy="540000"/>
            </a:xfrm>
            <a:prstGeom prst="rect">
              <a:avLst/>
            </a:prstGeom>
          </p:spPr>
        </p:pic>
        <p:pic>
          <p:nvPicPr>
            <p:cNvPr id="67" name="图片 66">
              <a:extLst>
                <a:ext uri="{FF2B5EF4-FFF2-40B4-BE49-F238E27FC236}">
                  <a16:creationId xmlns:a16="http://schemas.microsoft.com/office/drawing/2014/main" id="{304F385C-FA21-4952-BAF9-50565DE370FB}"/>
                </a:ext>
              </a:extLst>
            </p:cNvPr>
            <p:cNvPicPr>
              <a:picLocks noChangeAspect="1"/>
            </p:cNvPicPr>
            <p:nvPr/>
          </p:nvPicPr>
          <p:blipFill>
            <a:blip r:embed="rId32"/>
            <a:stretch>
              <a:fillRect/>
            </a:stretch>
          </p:blipFill>
          <p:spPr>
            <a:xfrm>
              <a:off x="7488000" y="2448000"/>
              <a:ext cx="1973578" cy="540000"/>
            </a:xfrm>
            <a:prstGeom prst="rect">
              <a:avLst/>
            </a:prstGeom>
          </p:spPr>
        </p:pic>
        <p:pic>
          <p:nvPicPr>
            <p:cNvPr id="71" name="图片 70">
              <a:extLst>
                <a:ext uri="{FF2B5EF4-FFF2-40B4-BE49-F238E27FC236}">
                  <a16:creationId xmlns:a16="http://schemas.microsoft.com/office/drawing/2014/main" id="{A93B723C-C344-478D-8675-72396415F0CC}"/>
                </a:ext>
              </a:extLst>
            </p:cNvPr>
            <p:cNvPicPr>
              <a:picLocks noChangeAspect="1"/>
            </p:cNvPicPr>
            <p:nvPr/>
          </p:nvPicPr>
          <p:blipFill>
            <a:blip r:embed="rId33"/>
            <a:stretch>
              <a:fillRect/>
            </a:stretch>
          </p:blipFill>
          <p:spPr>
            <a:xfrm>
              <a:off x="9828000" y="2448000"/>
              <a:ext cx="1973578" cy="540000"/>
            </a:xfrm>
            <a:prstGeom prst="rect">
              <a:avLst/>
            </a:prstGeom>
          </p:spPr>
        </p:pic>
        <p:pic>
          <p:nvPicPr>
            <p:cNvPr id="75" name="图片 74">
              <a:extLst>
                <a:ext uri="{FF2B5EF4-FFF2-40B4-BE49-F238E27FC236}">
                  <a16:creationId xmlns:a16="http://schemas.microsoft.com/office/drawing/2014/main" id="{00AF0EAF-3E61-43BC-AF24-61C030E933C9}"/>
                </a:ext>
              </a:extLst>
            </p:cNvPr>
            <p:cNvPicPr>
              <a:picLocks noChangeAspect="1"/>
            </p:cNvPicPr>
            <p:nvPr/>
          </p:nvPicPr>
          <p:blipFill>
            <a:blip r:embed="rId34"/>
            <a:stretch>
              <a:fillRect/>
            </a:stretch>
          </p:blipFill>
          <p:spPr>
            <a:xfrm>
              <a:off x="468000" y="3193200"/>
              <a:ext cx="1973578" cy="540000"/>
            </a:xfrm>
            <a:prstGeom prst="rect">
              <a:avLst/>
            </a:prstGeom>
          </p:spPr>
        </p:pic>
        <p:pic>
          <p:nvPicPr>
            <p:cNvPr id="79" name="图片 78">
              <a:extLst>
                <a:ext uri="{FF2B5EF4-FFF2-40B4-BE49-F238E27FC236}">
                  <a16:creationId xmlns:a16="http://schemas.microsoft.com/office/drawing/2014/main" id="{EC0D4B23-56A4-4607-904A-B2C9C79C00FD}"/>
                </a:ext>
              </a:extLst>
            </p:cNvPr>
            <p:cNvPicPr>
              <a:picLocks noChangeAspect="1"/>
            </p:cNvPicPr>
            <p:nvPr/>
          </p:nvPicPr>
          <p:blipFill>
            <a:blip r:embed="rId35"/>
            <a:stretch>
              <a:fillRect/>
            </a:stretch>
          </p:blipFill>
          <p:spPr>
            <a:xfrm>
              <a:off x="2808000" y="3193200"/>
              <a:ext cx="1973578" cy="540000"/>
            </a:xfrm>
            <a:prstGeom prst="rect">
              <a:avLst/>
            </a:prstGeom>
          </p:spPr>
        </p:pic>
        <p:pic>
          <p:nvPicPr>
            <p:cNvPr id="86" name="图片 85">
              <a:extLst>
                <a:ext uri="{FF2B5EF4-FFF2-40B4-BE49-F238E27FC236}">
                  <a16:creationId xmlns:a16="http://schemas.microsoft.com/office/drawing/2014/main" id="{387B9FAC-1141-4D6C-AB23-1AAB0659AB44}"/>
                </a:ext>
              </a:extLst>
            </p:cNvPr>
            <p:cNvPicPr>
              <a:picLocks noChangeAspect="1"/>
            </p:cNvPicPr>
            <p:nvPr/>
          </p:nvPicPr>
          <p:blipFill>
            <a:blip r:embed="rId36"/>
            <a:stretch>
              <a:fillRect/>
            </a:stretch>
          </p:blipFill>
          <p:spPr>
            <a:xfrm>
              <a:off x="5148000" y="3193200"/>
              <a:ext cx="1973578" cy="540000"/>
            </a:xfrm>
            <a:prstGeom prst="rect">
              <a:avLst/>
            </a:prstGeom>
          </p:spPr>
        </p:pic>
        <p:pic>
          <p:nvPicPr>
            <p:cNvPr id="88" name="图片 87">
              <a:extLst>
                <a:ext uri="{FF2B5EF4-FFF2-40B4-BE49-F238E27FC236}">
                  <a16:creationId xmlns:a16="http://schemas.microsoft.com/office/drawing/2014/main" id="{48BA8D39-7D46-4C17-A56F-2EE2981E4E75}"/>
                </a:ext>
              </a:extLst>
            </p:cNvPr>
            <p:cNvPicPr>
              <a:picLocks noChangeAspect="1"/>
            </p:cNvPicPr>
            <p:nvPr/>
          </p:nvPicPr>
          <p:blipFill>
            <a:blip r:embed="rId37"/>
            <a:stretch>
              <a:fillRect/>
            </a:stretch>
          </p:blipFill>
          <p:spPr>
            <a:xfrm>
              <a:off x="7488000" y="3193200"/>
              <a:ext cx="1973578" cy="540000"/>
            </a:xfrm>
            <a:prstGeom prst="rect">
              <a:avLst/>
            </a:prstGeom>
          </p:spPr>
        </p:pic>
        <p:pic>
          <p:nvPicPr>
            <p:cNvPr id="90" name="图片 89">
              <a:extLst>
                <a:ext uri="{FF2B5EF4-FFF2-40B4-BE49-F238E27FC236}">
                  <a16:creationId xmlns:a16="http://schemas.microsoft.com/office/drawing/2014/main" id="{DC21FEB2-03FB-4D74-BF04-40C977BDAEFC}"/>
                </a:ext>
              </a:extLst>
            </p:cNvPr>
            <p:cNvPicPr>
              <a:picLocks noChangeAspect="1"/>
            </p:cNvPicPr>
            <p:nvPr/>
          </p:nvPicPr>
          <p:blipFill>
            <a:blip r:embed="rId38"/>
            <a:stretch>
              <a:fillRect/>
            </a:stretch>
          </p:blipFill>
          <p:spPr>
            <a:xfrm>
              <a:off x="9828000" y="3193200"/>
              <a:ext cx="1973578" cy="540000"/>
            </a:xfrm>
            <a:prstGeom prst="rect">
              <a:avLst/>
            </a:prstGeom>
          </p:spPr>
        </p:pic>
        <p:pic>
          <p:nvPicPr>
            <p:cNvPr id="92" name="图片 91">
              <a:extLst>
                <a:ext uri="{FF2B5EF4-FFF2-40B4-BE49-F238E27FC236}">
                  <a16:creationId xmlns:a16="http://schemas.microsoft.com/office/drawing/2014/main" id="{C82A5D8E-5F1B-41EB-B97F-D5A546BEF6DD}"/>
                </a:ext>
              </a:extLst>
            </p:cNvPr>
            <p:cNvPicPr>
              <a:picLocks noChangeAspect="1"/>
            </p:cNvPicPr>
            <p:nvPr/>
          </p:nvPicPr>
          <p:blipFill>
            <a:blip r:embed="rId39"/>
            <a:stretch>
              <a:fillRect/>
            </a:stretch>
          </p:blipFill>
          <p:spPr>
            <a:xfrm>
              <a:off x="468000" y="5616000"/>
              <a:ext cx="1973578" cy="540000"/>
            </a:xfrm>
            <a:prstGeom prst="rect">
              <a:avLst/>
            </a:prstGeom>
          </p:spPr>
        </p:pic>
        <p:pic>
          <p:nvPicPr>
            <p:cNvPr id="94" name="图片 93">
              <a:extLst>
                <a:ext uri="{FF2B5EF4-FFF2-40B4-BE49-F238E27FC236}">
                  <a16:creationId xmlns:a16="http://schemas.microsoft.com/office/drawing/2014/main" id="{BBCC795A-4F27-42C3-9684-FB4CD4AE4FB6}"/>
                </a:ext>
              </a:extLst>
            </p:cNvPr>
            <p:cNvPicPr>
              <a:picLocks noChangeAspect="1"/>
            </p:cNvPicPr>
            <p:nvPr/>
          </p:nvPicPr>
          <p:blipFill>
            <a:blip r:embed="rId40"/>
            <a:stretch>
              <a:fillRect/>
            </a:stretch>
          </p:blipFill>
          <p:spPr>
            <a:xfrm>
              <a:off x="2808000" y="4791600"/>
              <a:ext cx="1973578" cy="540000"/>
            </a:xfrm>
            <a:prstGeom prst="rect">
              <a:avLst/>
            </a:prstGeom>
          </p:spPr>
        </p:pic>
        <p:pic>
          <p:nvPicPr>
            <p:cNvPr id="96" name="图片 95">
              <a:extLst>
                <a:ext uri="{FF2B5EF4-FFF2-40B4-BE49-F238E27FC236}">
                  <a16:creationId xmlns:a16="http://schemas.microsoft.com/office/drawing/2014/main" id="{A5D9C4C2-DB83-40DC-AC60-8B954B725F0F}"/>
                </a:ext>
              </a:extLst>
            </p:cNvPr>
            <p:cNvPicPr>
              <a:picLocks noChangeAspect="1"/>
            </p:cNvPicPr>
            <p:nvPr/>
          </p:nvPicPr>
          <p:blipFill>
            <a:blip r:embed="rId41"/>
            <a:stretch>
              <a:fillRect/>
            </a:stretch>
          </p:blipFill>
          <p:spPr>
            <a:xfrm>
              <a:off x="5148000" y="5616000"/>
              <a:ext cx="1973578" cy="540000"/>
            </a:xfrm>
            <a:prstGeom prst="rect">
              <a:avLst/>
            </a:prstGeom>
          </p:spPr>
        </p:pic>
        <p:pic>
          <p:nvPicPr>
            <p:cNvPr id="98" name="图片 97">
              <a:extLst>
                <a:ext uri="{FF2B5EF4-FFF2-40B4-BE49-F238E27FC236}">
                  <a16:creationId xmlns:a16="http://schemas.microsoft.com/office/drawing/2014/main" id="{CFAA33D8-F39F-4739-B104-A85270CA507D}"/>
                </a:ext>
              </a:extLst>
            </p:cNvPr>
            <p:cNvPicPr>
              <a:picLocks noChangeAspect="1"/>
            </p:cNvPicPr>
            <p:nvPr/>
          </p:nvPicPr>
          <p:blipFill>
            <a:blip r:embed="rId42"/>
            <a:stretch>
              <a:fillRect/>
            </a:stretch>
          </p:blipFill>
          <p:spPr>
            <a:xfrm>
              <a:off x="7488000" y="5616000"/>
              <a:ext cx="1973578" cy="540000"/>
            </a:xfrm>
            <a:prstGeom prst="rect">
              <a:avLst/>
            </a:prstGeom>
          </p:spPr>
        </p:pic>
        <p:pic>
          <p:nvPicPr>
            <p:cNvPr id="100" name="图片 99">
              <a:extLst>
                <a:ext uri="{FF2B5EF4-FFF2-40B4-BE49-F238E27FC236}">
                  <a16:creationId xmlns:a16="http://schemas.microsoft.com/office/drawing/2014/main" id="{BCAD70D2-996D-4F88-9C9B-4617AF62034E}"/>
                </a:ext>
              </a:extLst>
            </p:cNvPr>
            <p:cNvPicPr>
              <a:picLocks noChangeAspect="1"/>
            </p:cNvPicPr>
            <p:nvPr/>
          </p:nvPicPr>
          <p:blipFill>
            <a:blip r:embed="rId43"/>
            <a:stretch>
              <a:fillRect/>
            </a:stretch>
          </p:blipFill>
          <p:spPr>
            <a:xfrm>
              <a:off x="9828000" y="5616000"/>
              <a:ext cx="1973578" cy="54000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71437444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>
            <a:extLst>
              <a:ext uri="{FF2B5EF4-FFF2-40B4-BE49-F238E27FC236}">
                <a16:creationId xmlns:a16="http://schemas.microsoft.com/office/drawing/2014/main" id="{EBCD5CEB-E159-486C-9720-767C65C7F917}"/>
              </a:ext>
            </a:extLst>
          </p:cNvPr>
          <p:cNvGrpSpPr/>
          <p:nvPr/>
        </p:nvGrpSpPr>
        <p:grpSpPr>
          <a:xfrm>
            <a:off x="0" y="53775"/>
            <a:ext cx="12422632" cy="6761883"/>
            <a:chOff x="0" y="25200"/>
            <a:chExt cx="12422632" cy="6761883"/>
          </a:xfrm>
        </p:grpSpPr>
        <p:sp>
          <p:nvSpPr>
            <p:cNvPr id="34" name="文本框 33">
              <a:extLst>
                <a:ext uri="{FF2B5EF4-FFF2-40B4-BE49-F238E27FC236}">
                  <a16:creationId xmlns:a16="http://schemas.microsoft.com/office/drawing/2014/main" id="{FED6F35A-35CD-4882-A17E-F76DF62E6B88}"/>
                </a:ext>
              </a:extLst>
            </p:cNvPr>
            <p:cNvSpPr txBox="1"/>
            <p:nvPr/>
          </p:nvSpPr>
          <p:spPr>
            <a:xfrm>
              <a:off x="10149920" y="6330183"/>
              <a:ext cx="107852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 genes</a:t>
              </a:r>
              <a:endParaRPr lang="zh-CN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23" name="图片 22">
              <a:extLst>
                <a:ext uri="{FF2B5EF4-FFF2-40B4-BE49-F238E27FC236}">
                  <a16:creationId xmlns:a16="http://schemas.microsoft.com/office/drawing/2014/main" id="{33C9B594-8B8A-478F-B397-56031CAD008A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331200" y="25200"/>
              <a:ext cx="1955739" cy="1566000"/>
            </a:xfrm>
            <a:prstGeom prst="rect">
              <a:avLst/>
            </a:prstGeom>
          </p:spPr>
        </p:pic>
        <p:pic>
          <p:nvPicPr>
            <p:cNvPr id="27" name="图片 26">
              <a:extLst>
                <a:ext uri="{FF2B5EF4-FFF2-40B4-BE49-F238E27FC236}">
                  <a16:creationId xmlns:a16="http://schemas.microsoft.com/office/drawing/2014/main" id="{335FD575-6B05-4A35-B501-BAC38C864450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331200" y="1598400"/>
              <a:ext cx="1953973" cy="1566000"/>
            </a:xfrm>
            <a:prstGeom prst="rect">
              <a:avLst/>
            </a:prstGeom>
          </p:spPr>
        </p:pic>
        <p:pic>
          <p:nvPicPr>
            <p:cNvPr id="31" name="图片 30">
              <a:extLst>
                <a:ext uri="{FF2B5EF4-FFF2-40B4-BE49-F238E27FC236}">
                  <a16:creationId xmlns:a16="http://schemas.microsoft.com/office/drawing/2014/main" id="{15C45F00-CA7C-488E-9CED-A3AFCDE6E8D0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331200" y="3200400"/>
              <a:ext cx="1961621" cy="1566000"/>
            </a:xfrm>
            <a:prstGeom prst="rect">
              <a:avLst/>
            </a:prstGeom>
          </p:spPr>
        </p:pic>
        <p:pic>
          <p:nvPicPr>
            <p:cNvPr id="35" name="图片 34">
              <a:extLst>
                <a:ext uri="{FF2B5EF4-FFF2-40B4-BE49-F238E27FC236}">
                  <a16:creationId xmlns:a16="http://schemas.microsoft.com/office/drawing/2014/main" id="{AFE38163-A7FB-43FB-8944-E9F9DB5EAAB5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331200" y="4798800"/>
              <a:ext cx="1953367" cy="1566000"/>
            </a:xfrm>
            <a:prstGeom prst="rect">
              <a:avLst/>
            </a:prstGeom>
          </p:spPr>
        </p:pic>
        <p:pic>
          <p:nvPicPr>
            <p:cNvPr id="3" name="图片 2">
              <a:extLst>
                <a:ext uri="{FF2B5EF4-FFF2-40B4-BE49-F238E27FC236}">
                  <a16:creationId xmlns:a16="http://schemas.microsoft.com/office/drawing/2014/main" id="{A3FD2853-2F02-4DFC-84D6-1E322418A279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900044" y="6628325"/>
              <a:ext cx="1289116" cy="158758"/>
            </a:xfrm>
            <a:prstGeom prst="rect">
              <a:avLst/>
            </a:prstGeom>
          </p:spPr>
        </p:pic>
        <p:pic>
          <p:nvPicPr>
            <p:cNvPr id="4" name="图片 3">
              <a:extLst>
                <a:ext uri="{FF2B5EF4-FFF2-40B4-BE49-F238E27FC236}">
                  <a16:creationId xmlns:a16="http://schemas.microsoft.com/office/drawing/2014/main" id="{EB39CE57-9EAC-4FD1-B144-882322AD877F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559313" y="6606700"/>
              <a:ext cx="1428823" cy="171459"/>
            </a:xfrm>
            <a:prstGeom prst="rect">
              <a:avLst/>
            </a:prstGeom>
          </p:spPr>
        </p:pic>
        <p:sp>
          <p:nvSpPr>
            <p:cNvPr id="9" name="文本框 8">
              <a:extLst>
                <a:ext uri="{FF2B5EF4-FFF2-40B4-BE49-F238E27FC236}">
                  <a16:creationId xmlns:a16="http://schemas.microsoft.com/office/drawing/2014/main" id="{264C7D05-A4A8-45C1-9F8D-AC4433ABDEC3}"/>
                </a:ext>
              </a:extLst>
            </p:cNvPr>
            <p:cNvSpPr txBox="1"/>
            <p:nvPr/>
          </p:nvSpPr>
          <p:spPr>
            <a:xfrm>
              <a:off x="11157464" y="1212868"/>
              <a:ext cx="11684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ancreatic Adenocarcinoma</a:t>
              </a:r>
              <a:endParaRPr lang="zh-CN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文本框 9">
              <a:extLst>
                <a:ext uri="{FF2B5EF4-FFF2-40B4-BE49-F238E27FC236}">
                  <a16:creationId xmlns:a16="http://schemas.microsoft.com/office/drawing/2014/main" id="{09DB2E7D-932C-4F92-BDDE-3DC207943EFF}"/>
                </a:ext>
              </a:extLst>
            </p:cNvPr>
            <p:cNvSpPr txBox="1"/>
            <p:nvPr/>
          </p:nvSpPr>
          <p:spPr>
            <a:xfrm>
              <a:off x="11214311" y="2775454"/>
              <a:ext cx="11684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rostate Adenocarcinoma </a:t>
              </a:r>
              <a:endParaRPr lang="zh-CN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文本框 10">
              <a:extLst>
                <a:ext uri="{FF2B5EF4-FFF2-40B4-BE49-F238E27FC236}">
                  <a16:creationId xmlns:a16="http://schemas.microsoft.com/office/drawing/2014/main" id="{5E456FB8-2C36-42E0-9337-E53488825FCA}"/>
                </a:ext>
              </a:extLst>
            </p:cNvPr>
            <p:cNvSpPr txBox="1"/>
            <p:nvPr/>
          </p:nvSpPr>
          <p:spPr>
            <a:xfrm>
              <a:off x="11214311" y="4430219"/>
              <a:ext cx="11684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kin Cutaneous Melanoma </a:t>
              </a:r>
              <a:endParaRPr lang="zh-CN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文本框 11">
              <a:extLst>
                <a:ext uri="{FF2B5EF4-FFF2-40B4-BE49-F238E27FC236}">
                  <a16:creationId xmlns:a16="http://schemas.microsoft.com/office/drawing/2014/main" id="{BD666712-99E7-4056-AC8A-ABFE8E26539F}"/>
                </a:ext>
              </a:extLst>
            </p:cNvPr>
            <p:cNvSpPr txBox="1"/>
            <p:nvPr/>
          </p:nvSpPr>
          <p:spPr>
            <a:xfrm>
              <a:off x="11254232" y="6008038"/>
              <a:ext cx="11684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arcoma </a:t>
              </a:r>
              <a:endParaRPr lang="zh-CN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" name="文本框 4">
              <a:extLst>
                <a:ext uri="{FF2B5EF4-FFF2-40B4-BE49-F238E27FC236}">
                  <a16:creationId xmlns:a16="http://schemas.microsoft.com/office/drawing/2014/main" id="{A2C6C48B-AC14-432E-B498-35EA8A961C9E}"/>
                </a:ext>
              </a:extLst>
            </p:cNvPr>
            <p:cNvSpPr txBox="1"/>
            <p:nvPr/>
          </p:nvSpPr>
          <p:spPr>
            <a:xfrm>
              <a:off x="930680" y="6330183"/>
              <a:ext cx="1078521" cy="2230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LH1</a:t>
              </a:r>
              <a:endParaRPr lang="zh-CN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14" name="图片 13">
              <a:extLst>
                <a:ext uri="{FF2B5EF4-FFF2-40B4-BE49-F238E27FC236}">
                  <a16:creationId xmlns:a16="http://schemas.microsoft.com/office/drawing/2014/main" id="{0AAD148A-CE7B-4D20-AD29-6E0C8AA6B295}"/>
                </a:ext>
              </a:extLst>
            </p:cNvPr>
            <p:cNvPicPr>
              <a:picLocks noChangeAspect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0" y="25200"/>
              <a:ext cx="1959266" cy="1566000"/>
            </a:xfrm>
            <a:prstGeom prst="rect">
              <a:avLst/>
            </a:prstGeom>
          </p:spPr>
        </p:pic>
        <p:pic>
          <p:nvPicPr>
            <p:cNvPr id="22" name="图片 21">
              <a:extLst>
                <a:ext uri="{FF2B5EF4-FFF2-40B4-BE49-F238E27FC236}">
                  <a16:creationId xmlns:a16="http://schemas.microsoft.com/office/drawing/2014/main" id="{B32F1441-213D-4243-AA42-6D64A638B856}"/>
                </a:ext>
              </a:extLst>
            </p:cNvPr>
            <p:cNvPicPr>
              <a:picLocks noChangeAspect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0" y="1598400"/>
              <a:ext cx="1939970" cy="1566000"/>
            </a:xfrm>
            <a:prstGeom prst="rect">
              <a:avLst/>
            </a:prstGeom>
          </p:spPr>
        </p:pic>
        <p:pic>
          <p:nvPicPr>
            <p:cNvPr id="30" name="图片 29">
              <a:extLst>
                <a:ext uri="{FF2B5EF4-FFF2-40B4-BE49-F238E27FC236}">
                  <a16:creationId xmlns:a16="http://schemas.microsoft.com/office/drawing/2014/main" id="{110B5CCF-06CE-4B0A-99DF-807EC1277785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0" y="3200400"/>
              <a:ext cx="1964575" cy="1566000"/>
            </a:xfrm>
            <a:prstGeom prst="rect">
              <a:avLst/>
            </a:prstGeom>
          </p:spPr>
        </p:pic>
        <p:pic>
          <p:nvPicPr>
            <p:cNvPr id="41" name="图片 40">
              <a:extLst>
                <a:ext uri="{FF2B5EF4-FFF2-40B4-BE49-F238E27FC236}">
                  <a16:creationId xmlns:a16="http://schemas.microsoft.com/office/drawing/2014/main" id="{92F6704F-1E6F-4613-B32B-068521294389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0" y="4798800"/>
              <a:ext cx="1955142" cy="1566000"/>
            </a:xfrm>
            <a:prstGeom prst="rect">
              <a:avLst/>
            </a:prstGeom>
          </p:spPr>
        </p:pic>
        <p:pic>
          <p:nvPicPr>
            <p:cNvPr id="16" name="图片 15">
              <a:extLst>
                <a:ext uri="{FF2B5EF4-FFF2-40B4-BE49-F238E27FC236}">
                  <a16:creationId xmlns:a16="http://schemas.microsoft.com/office/drawing/2014/main" id="{77DB3502-F068-4BCF-A354-AECB5702027F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340000" y="25200"/>
              <a:ext cx="1958091" cy="1566000"/>
            </a:xfrm>
            <a:prstGeom prst="rect">
              <a:avLst/>
            </a:prstGeom>
          </p:spPr>
        </p:pic>
        <p:pic>
          <p:nvPicPr>
            <p:cNvPr id="32" name="图片 31">
              <a:extLst>
                <a:ext uri="{FF2B5EF4-FFF2-40B4-BE49-F238E27FC236}">
                  <a16:creationId xmlns:a16="http://schemas.microsoft.com/office/drawing/2014/main" id="{C98B9769-4085-44D6-AE48-1587257041C0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340000" y="3200400"/>
              <a:ext cx="1962481" cy="1566000"/>
            </a:xfrm>
            <a:prstGeom prst="rect">
              <a:avLst/>
            </a:prstGeom>
          </p:spPr>
        </p:pic>
        <p:sp>
          <p:nvSpPr>
            <p:cNvPr id="7" name="文本框 6">
              <a:extLst>
                <a:ext uri="{FF2B5EF4-FFF2-40B4-BE49-F238E27FC236}">
                  <a16:creationId xmlns:a16="http://schemas.microsoft.com/office/drawing/2014/main" id="{832CB6D3-B7BA-4FD1-8A75-D39E1B412A90}"/>
                </a:ext>
              </a:extLst>
            </p:cNvPr>
            <p:cNvSpPr txBox="1"/>
            <p:nvPr/>
          </p:nvSpPr>
          <p:spPr>
            <a:xfrm>
              <a:off x="5424120" y="6330183"/>
              <a:ext cx="1078521" cy="2230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SH6</a:t>
              </a:r>
              <a:endParaRPr lang="zh-CN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18" name="图片 17">
              <a:extLst>
                <a:ext uri="{FF2B5EF4-FFF2-40B4-BE49-F238E27FC236}">
                  <a16:creationId xmlns:a16="http://schemas.microsoft.com/office/drawing/2014/main" id="{CC140376-5F1E-46DD-82CF-D9463FBBE593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680000" y="25200"/>
              <a:ext cx="1951043" cy="1566000"/>
            </a:xfrm>
            <a:prstGeom prst="rect">
              <a:avLst/>
            </a:prstGeom>
          </p:spPr>
        </p:pic>
        <p:pic>
          <p:nvPicPr>
            <p:cNvPr id="26" name="图片 25">
              <a:extLst>
                <a:ext uri="{FF2B5EF4-FFF2-40B4-BE49-F238E27FC236}">
                  <a16:creationId xmlns:a16="http://schemas.microsoft.com/office/drawing/2014/main" id="{D13EAF73-7872-4A51-A779-833162433E29}"/>
                </a:ext>
              </a:extLst>
            </p:cNvPr>
            <p:cNvPicPr>
              <a:picLocks noChangeAspect="1"/>
            </p:cNvPicPr>
            <p:nvPr/>
          </p:nvPicPr>
          <p:blipFill>
            <a:blip r:embed="rId1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680000" y="1598400"/>
              <a:ext cx="1952202" cy="1566000"/>
            </a:xfrm>
            <a:prstGeom prst="rect">
              <a:avLst/>
            </a:prstGeom>
          </p:spPr>
        </p:pic>
        <p:pic>
          <p:nvPicPr>
            <p:cNvPr id="36" name="图片 35">
              <a:extLst>
                <a:ext uri="{FF2B5EF4-FFF2-40B4-BE49-F238E27FC236}">
                  <a16:creationId xmlns:a16="http://schemas.microsoft.com/office/drawing/2014/main" id="{77C76196-2823-4267-991F-764855522F1B}"/>
                </a:ext>
              </a:extLst>
            </p:cNvPr>
            <p:cNvPicPr>
              <a:picLocks noChangeAspect="1"/>
            </p:cNvPicPr>
            <p:nvPr/>
          </p:nvPicPr>
          <p:blipFill>
            <a:blip r:embed="rId1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680000" y="3200400"/>
              <a:ext cx="1964618" cy="1566000"/>
            </a:xfrm>
            <a:prstGeom prst="rect">
              <a:avLst/>
            </a:prstGeom>
          </p:spPr>
        </p:pic>
        <p:pic>
          <p:nvPicPr>
            <p:cNvPr id="45" name="图片 44">
              <a:extLst>
                <a:ext uri="{FF2B5EF4-FFF2-40B4-BE49-F238E27FC236}">
                  <a16:creationId xmlns:a16="http://schemas.microsoft.com/office/drawing/2014/main" id="{E421A4B4-7A4A-4CC4-9CDA-B4436D57C427}"/>
                </a:ext>
              </a:extLst>
            </p:cNvPr>
            <p:cNvPicPr>
              <a:picLocks noChangeAspect="1"/>
            </p:cNvPicPr>
            <p:nvPr/>
          </p:nvPicPr>
          <p:blipFill>
            <a:blip r:embed="rId1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680000" y="4798800"/>
              <a:ext cx="1958091" cy="1566000"/>
            </a:xfrm>
            <a:prstGeom prst="rect">
              <a:avLst/>
            </a:prstGeom>
          </p:spPr>
        </p:pic>
        <p:sp>
          <p:nvSpPr>
            <p:cNvPr id="8" name="文本框 7">
              <a:extLst>
                <a:ext uri="{FF2B5EF4-FFF2-40B4-BE49-F238E27FC236}">
                  <a16:creationId xmlns:a16="http://schemas.microsoft.com/office/drawing/2014/main" id="{F7362119-5E2D-4F1B-894C-8B15B2087B14}"/>
                </a:ext>
              </a:extLst>
            </p:cNvPr>
            <p:cNvSpPr txBox="1"/>
            <p:nvPr/>
          </p:nvSpPr>
          <p:spPr>
            <a:xfrm>
              <a:off x="7813080" y="6330183"/>
              <a:ext cx="1078521" cy="2230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MS2</a:t>
              </a:r>
              <a:endParaRPr lang="zh-CN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28" name="图片 27">
              <a:extLst>
                <a:ext uri="{FF2B5EF4-FFF2-40B4-BE49-F238E27FC236}">
                  <a16:creationId xmlns:a16="http://schemas.microsoft.com/office/drawing/2014/main" id="{41857FEB-052F-46C0-9C3B-45BF4584A8C7}"/>
                </a:ext>
              </a:extLst>
            </p:cNvPr>
            <p:cNvPicPr>
              <a:picLocks noChangeAspect="1"/>
            </p:cNvPicPr>
            <p:nvPr/>
          </p:nvPicPr>
          <p:blipFill>
            <a:blip r:embed="rId1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020000" y="1598400"/>
              <a:ext cx="1966384" cy="1566000"/>
            </a:xfrm>
            <a:prstGeom prst="rect">
              <a:avLst/>
            </a:prstGeom>
          </p:spPr>
        </p:pic>
        <p:pic>
          <p:nvPicPr>
            <p:cNvPr id="38" name="图片 37">
              <a:extLst>
                <a:ext uri="{FF2B5EF4-FFF2-40B4-BE49-F238E27FC236}">
                  <a16:creationId xmlns:a16="http://schemas.microsoft.com/office/drawing/2014/main" id="{7E798A0E-4CA2-4EDE-B1DA-1030B71F2E7E}"/>
                </a:ext>
              </a:extLst>
            </p:cNvPr>
            <p:cNvPicPr>
              <a:picLocks noChangeAspect="1"/>
            </p:cNvPicPr>
            <p:nvPr/>
          </p:nvPicPr>
          <p:blipFill>
            <a:blip r:embed="rId1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020000" y="3200400"/>
              <a:ext cx="1948696" cy="1566000"/>
            </a:xfrm>
            <a:prstGeom prst="rect">
              <a:avLst/>
            </a:prstGeom>
          </p:spPr>
        </p:pic>
        <p:pic>
          <p:nvPicPr>
            <p:cNvPr id="47" name="图片 46">
              <a:extLst>
                <a:ext uri="{FF2B5EF4-FFF2-40B4-BE49-F238E27FC236}">
                  <a16:creationId xmlns:a16="http://schemas.microsoft.com/office/drawing/2014/main" id="{FA5FED11-1822-487A-A8EA-E4C09407C9EC}"/>
                </a:ext>
              </a:extLst>
            </p:cNvPr>
            <p:cNvPicPr>
              <a:picLocks noChangeAspect="1"/>
            </p:cNvPicPr>
            <p:nvPr/>
          </p:nvPicPr>
          <p:blipFill>
            <a:blip r:embed="rId2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020000" y="4798800"/>
              <a:ext cx="1975349" cy="1566000"/>
            </a:xfrm>
            <a:prstGeom prst="rect">
              <a:avLst/>
            </a:prstGeom>
          </p:spPr>
        </p:pic>
        <p:pic>
          <p:nvPicPr>
            <p:cNvPr id="20" name="图片 19">
              <a:extLst>
                <a:ext uri="{FF2B5EF4-FFF2-40B4-BE49-F238E27FC236}">
                  <a16:creationId xmlns:a16="http://schemas.microsoft.com/office/drawing/2014/main" id="{559B9982-45A2-49C6-9963-B30AD0DEEEB3}"/>
                </a:ext>
              </a:extLst>
            </p:cNvPr>
            <p:cNvPicPr>
              <a:picLocks noChangeAspect="1"/>
            </p:cNvPicPr>
            <p:nvPr/>
          </p:nvPicPr>
          <p:blipFill>
            <a:blip r:embed="rId2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020000" y="25200"/>
              <a:ext cx="1958087" cy="1566000"/>
            </a:xfrm>
            <a:prstGeom prst="rect">
              <a:avLst/>
            </a:prstGeom>
          </p:spPr>
        </p:pic>
        <p:pic>
          <p:nvPicPr>
            <p:cNvPr id="24" name="图片 23">
              <a:extLst>
                <a:ext uri="{FF2B5EF4-FFF2-40B4-BE49-F238E27FC236}">
                  <a16:creationId xmlns:a16="http://schemas.microsoft.com/office/drawing/2014/main" id="{DE30FC1E-8795-4F80-8F5B-1B6DEB872A85}"/>
                </a:ext>
              </a:extLst>
            </p:cNvPr>
            <p:cNvPicPr>
              <a:picLocks noChangeAspect="1"/>
            </p:cNvPicPr>
            <p:nvPr/>
          </p:nvPicPr>
          <p:blipFill>
            <a:blip r:embed="rId2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340000" y="1598400"/>
              <a:ext cx="1953973" cy="1566000"/>
            </a:xfrm>
            <a:prstGeom prst="rect">
              <a:avLst/>
            </a:prstGeom>
          </p:spPr>
        </p:pic>
        <p:grpSp>
          <p:nvGrpSpPr>
            <p:cNvPr id="88" name="组合 87">
              <a:extLst>
                <a:ext uri="{FF2B5EF4-FFF2-40B4-BE49-F238E27FC236}">
                  <a16:creationId xmlns:a16="http://schemas.microsoft.com/office/drawing/2014/main" id="{96A06CAD-8564-4834-A31A-B1578DDF003F}"/>
                </a:ext>
              </a:extLst>
            </p:cNvPr>
            <p:cNvGrpSpPr/>
            <p:nvPr/>
          </p:nvGrpSpPr>
          <p:grpSpPr>
            <a:xfrm>
              <a:off x="2340000" y="4798800"/>
              <a:ext cx="1957555" cy="1754400"/>
              <a:chOff x="2340000" y="4798800"/>
              <a:chExt cx="1957555" cy="1754400"/>
            </a:xfrm>
          </p:grpSpPr>
          <p:sp>
            <p:nvSpPr>
              <p:cNvPr id="6" name="文本框 5">
                <a:extLst>
                  <a:ext uri="{FF2B5EF4-FFF2-40B4-BE49-F238E27FC236}">
                    <a16:creationId xmlns:a16="http://schemas.microsoft.com/office/drawing/2014/main" id="{06B9D8AD-3BD7-44D1-997E-EAA9076BD25F}"/>
                  </a:ext>
                </a:extLst>
              </p:cNvPr>
              <p:cNvSpPr txBox="1"/>
              <p:nvPr/>
            </p:nvSpPr>
            <p:spPr>
              <a:xfrm>
                <a:off x="3219034" y="6330183"/>
                <a:ext cx="1078521" cy="22301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SH2</a:t>
                </a:r>
                <a:endParaRPr lang="zh-CN" alt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pic>
            <p:nvPicPr>
              <p:cNvPr id="43" name="图片 42">
                <a:extLst>
                  <a:ext uri="{FF2B5EF4-FFF2-40B4-BE49-F238E27FC236}">
                    <a16:creationId xmlns:a16="http://schemas.microsoft.com/office/drawing/2014/main" id="{CCBB06B0-ABD8-4729-95C2-F44CA6DF648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340000" y="4798800"/>
                <a:ext cx="1953367" cy="1566000"/>
              </a:xfrm>
              <a:prstGeom prst="rect">
                <a:avLst/>
              </a:prstGeom>
            </p:spPr>
          </p:pic>
        </p:grpSp>
        <p:pic>
          <p:nvPicPr>
            <p:cNvPr id="13" name="图片 12">
              <a:extLst>
                <a:ext uri="{FF2B5EF4-FFF2-40B4-BE49-F238E27FC236}">
                  <a16:creationId xmlns:a16="http://schemas.microsoft.com/office/drawing/2014/main" id="{0798BBF7-A9E2-4DFC-8885-5826403F5CAD}"/>
                </a:ext>
              </a:extLst>
            </p:cNvPr>
            <p:cNvPicPr>
              <a:picLocks noChangeAspect="1"/>
            </p:cNvPicPr>
            <p:nvPr/>
          </p:nvPicPr>
          <p:blipFill>
            <a:blip r:embed="rId24"/>
            <a:stretch>
              <a:fillRect/>
            </a:stretch>
          </p:blipFill>
          <p:spPr>
            <a:xfrm>
              <a:off x="468000" y="25200"/>
              <a:ext cx="1973578" cy="540000"/>
            </a:xfrm>
            <a:prstGeom prst="rect">
              <a:avLst/>
            </a:prstGeom>
          </p:spPr>
        </p:pic>
        <p:pic>
          <p:nvPicPr>
            <p:cNvPr id="17" name="图片 16">
              <a:extLst>
                <a:ext uri="{FF2B5EF4-FFF2-40B4-BE49-F238E27FC236}">
                  <a16:creationId xmlns:a16="http://schemas.microsoft.com/office/drawing/2014/main" id="{D1E4941F-6091-45AA-8E37-475774B4681D}"/>
                </a:ext>
              </a:extLst>
            </p:cNvPr>
            <p:cNvPicPr>
              <a:picLocks noChangeAspect="1"/>
            </p:cNvPicPr>
            <p:nvPr/>
          </p:nvPicPr>
          <p:blipFill>
            <a:blip r:embed="rId25"/>
            <a:stretch>
              <a:fillRect/>
            </a:stretch>
          </p:blipFill>
          <p:spPr>
            <a:xfrm>
              <a:off x="2808000" y="25200"/>
              <a:ext cx="1973578" cy="540000"/>
            </a:xfrm>
            <a:prstGeom prst="rect">
              <a:avLst/>
            </a:prstGeom>
          </p:spPr>
        </p:pic>
        <p:pic>
          <p:nvPicPr>
            <p:cNvPr id="21" name="图片 20">
              <a:extLst>
                <a:ext uri="{FF2B5EF4-FFF2-40B4-BE49-F238E27FC236}">
                  <a16:creationId xmlns:a16="http://schemas.microsoft.com/office/drawing/2014/main" id="{C66399A8-DF90-49A0-860C-D98014C854BF}"/>
                </a:ext>
              </a:extLst>
            </p:cNvPr>
            <p:cNvPicPr>
              <a:picLocks noChangeAspect="1"/>
            </p:cNvPicPr>
            <p:nvPr/>
          </p:nvPicPr>
          <p:blipFill>
            <a:blip r:embed="rId26"/>
            <a:stretch>
              <a:fillRect/>
            </a:stretch>
          </p:blipFill>
          <p:spPr>
            <a:xfrm>
              <a:off x="5148000" y="25200"/>
              <a:ext cx="1973578" cy="540000"/>
            </a:xfrm>
            <a:prstGeom prst="rect">
              <a:avLst/>
            </a:prstGeom>
          </p:spPr>
        </p:pic>
        <p:pic>
          <p:nvPicPr>
            <p:cNvPr id="29" name="图片 28">
              <a:extLst>
                <a:ext uri="{FF2B5EF4-FFF2-40B4-BE49-F238E27FC236}">
                  <a16:creationId xmlns:a16="http://schemas.microsoft.com/office/drawing/2014/main" id="{F035B67A-8E1B-4303-9E87-93FCDE5627D2}"/>
                </a:ext>
              </a:extLst>
            </p:cNvPr>
            <p:cNvPicPr>
              <a:picLocks noChangeAspect="1"/>
            </p:cNvPicPr>
            <p:nvPr/>
          </p:nvPicPr>
          <p:blipFill>
            <a:blip r:embed="rId27"/>
            <a:stretch>
              <a:fillRect/>
            </a:stretch>
          </p:blipFill>
          <p:spPr>
            <a:xfrm>
              <a:off x="7488000" y="25200"/>
              <a:ext cx="1973578" cy="540000"/>
            </a:xfrm>
            <a:prstGeom prst="rect">
              <a:avLst/>
            </a:prstGeom>
          </p:spPr>
        </p:pic>
        <p:pic>
          <p:nvPicPr>
            <p:cNvPr id="37" name="图片 36">
              <a:extLst>
                <a:ext uri="{FF2B5EF4-FFF2-40B4-BE49-F238E27FC236}">
                  <a16:creationId xmlns:a16="http://schemas.microsoft.com/office/drawing/2014/main" id="{DE0A0648-8DD1-42A7-9298-F1A852A306F8}"/>
                </a:ext>
              </a:extLst>
            </p:cNvPr>
            <p:cNvPicPr>
              <a:picLocks noChangeAspect="1"/>
            </p:cNvPicPr>
            <p:nvPr/>
          </p:nvPicPr>
          <p:blipFill>
            <a:blip r:embed="rId28"/>
            <a:stretch>
              <a:fillRect/>
            </a:stretch>
          </p:blipFill>
          <p:spPr>
            <a:xfrm>
              <a:off x="9828000" y="25200"/>
              <a:ext cx="1973578" cy="540000"/>
            </a:xfrm>
            <a:prstGeom prst="rect">
              <a:avLst/>
            </a:prstGeom>
          </p:spPr>
        </p:pic>
        <p:pic>
          <p:nvPicPr>
            <p:cNvPr id="44" name="图片 43">
              <a:extLst>
                <a:ext uri="{FF2B5EF4-FFF2-40B4-BE49-F238E27FC236}">
                  <a16:creationId xmlns:a16="http://schemas.microsoft.com/office/drawing/2014/main" id="{CF0E0274-3B91-475A-8B8C-3603056AB330}"/>
                </a:ext>
              </a:extLst>
            </p:cNvPr>
            <p:cNvPicPr>
              <a:picLocks noChangeAspect="1"/>
            </p:cNvPicPr>
            <p:nvPr/>
          </p:nvPicPr>
          <p:blipFill>
            <a:blip r:embed="rId29"/>
            <a:stretch>
              <a:fillRect/>
            </a:stretch>
          </p:blipFill>
          <p:spPr>
            <a:xfrm>
              <a:off x="468000" y="2448000"/>
              <a:ext cx="1973578" cy="540000"/>
            </a:xfrm>
            <a:prstGeom prst="rect">
              <a:avLst/>
            </a:prstGeom>
          </p:spPr>
        </p:pic>
        <p:pic>
          <p:nvPicPr>
            <p:cNvPr id="49" name="图片 48">
              <a:extLst>
                <a:ext uri="{FF2B5EF4-FFF2-40B4-BE49-F238E27FC236}">
                  <a16:creationId xmlns:a16="http://schemas.microsoft.com/office/drawing/2014/main" id="{FDFED46B-861E-4728-BBDD-A0DD8D66345D}"/>
                </a:ext>
              </a:extLst>
            </p:cNvPr>
            <p:cNvPicPr>
              <a:picLocks noChangeAspect="1"/>
            </p:cNvPicPr>
            <p:nvPr/>
          </p:nvPicPr>
          <p:blipFill>
            <a:blip r:embed="rId30"/>
            <a:stretch>
              <a:fillRect/>
            </a:stretch>
          </p:blipFill>
          <p:spPr>
            <a:xfrm>
              <a:off x="2808000" y="2448000"/>
              <a:ext cx="1973578" cy="540000"/>
            </a:xfrm>
            <a:prstGeom prst="rect">
              <a:avLst/>
            </a:prstGeom>
          </p:spPr>
        </p:pic>
        <p:pic>
          <p:nvPicPr>
            <p:cNvPr id="53" name="图片 52">
              <a:extLst>
                <a:ext uri="{FF2B5EF4-FFF2-40B4-BE49-F238E27FC236}">
                  <a16:creationId xmlns:a16="http://schemas.microsoft.com/office/drawing/2014/main" id="{7BDDD7EB-84CB-4E49-8C91-3441D47564E3}"/>
                </a:ext>
              </a:extLst>
            </p:cNvPr>
            <p:cNvPicPr>
              <a:picLocks noChangeAspect="1"/>
            </p:cNvPicPr>
            <p:nvPr/>
          </p:nvPicPr>
          <p:blipFill>
            <a:blip r:embed="rId31"/>
            <a:stretch>
              <a:fillRect/>
            </a:stretch>
          </p:blipFill>
          <p:spPr>
            <a:xfrm>
              <a:off x="5148000" y="2448000"/>
              <a:ext cx="1973578" cy="540000"/>
            </a:xfrm>
            <a:prstGeom prst="rect">
              <a:avLst/>
            </a:prstGeom>
          </p:spPr>
        </p:pic>
        <p:pic>
          <p:nvPicPr>
            <p:cNvPr id="56" name="图片 55">
              <a:extLst>
                <a:ext uri="{FF2B5EF4-FFF2-40B4-BE49-F238E27FC236}">
                  <a16:creationId xmlns:a16="http://schemas.microsoft.com/office/drawing/2014/main" id="{3ECD4485-52EC-4709-831A-58ABE0A12421}"/>
                </a:ext>
              </a:extLst>
            </p:cNvPr>
            <p:cNvPicPr>
              <a:picLocks noChangeAspect="1"/>
            </p:cNvPicPr>
            <p:nvPr/>
          </p:nvPicPr>
          <p:blipFill>
            <a:blip r:embed="rId32"/>
            <a:stretch>
              <a:fillRect/>
            </a:stretch>
          </p:blipFill>
          <p:spPr>
            <a:xfrm>
              <a:off x="7488000" y="2447309"/>
              <a:ext cx="1973578" cy="540000"/>
            </a:xfrm>
            <a:prstGeom prst="rect">
              <a:avLst/>
            </a:prstGeom>
          </p:spPr>
        </p:pic>
        <p:pic>
          <p:nvPicPr>
            <p:cNvPr id="62" name="图片 61">
              <a:extLst>
                <a:ext uri="{FF2B5EF4-FFF2-40B4-BE49-F238E27FC236}">
                  <a16:creationId xmlns:a16="http://schemas.microsoft.com/office/drawing/2014/main" id="{230501CA-EE19-4218-B557-49200CEDFAD4}"/>
                </a:ext>
              </a:extLst>
            </p:cNvPr>
            <p:cNvPicPr>
              <a:picLocks noChangeAspect="1"/>
            </p:cNvPicPr>
            <p:nvPr/>
          </p:nvPicPr>
          <p:blipFill>
            <a:blip r:embed="rId33"/>
            <a:stretch>
              <a:fillRect/>
            </a:stretch>
          </p:blipFill>
          <p:spPr>
            <a:xfrm>
              <a:off x="9828000" y="2448000"/>
              <a:ext cx="1973578" cy="540000"/>
            </a:xfrm>
            <a:prstGeom prst="rect">
              <a:avLst/>
            </a:prstGeom>
          </p:spPr>
        </p:pic>
        <p:pic>
          <p:nvPicPr>
            <p:cNvPr id="66" name="图片 65">
              <a:extLst>
                <a:ext uri="{FF2B5EF4-FFF2-40B4-BE49-F238E27FC236}">
                  <a16:creationId xmlns:a16="http://schemas.microsoft.com/office/drawing/2014/main" id="{FE6F5B12-09BC-449C-A9F6-A39826FAA4DA}"/>
                </a:ext>
              </a:extLst>
            </p:cNvPr>
            <p:cNvPicPr>
              <a:picLocks noChangeAspect="1"/>
            </p:cNvPicPr>
            <p:nvPr/>
          </p:nvPicPr>
          <p:blipFill>
            <a:blip r:embed="rId34"/>
            <a:stretch>
              <a:fillRect/>
            </a:stretch>
          </p:blipFill>
          <p:spPr>
            <a:xfrm>
              <a:off x="468000" y="3193200"/>
              <a:ext cx="1973578" cy="540000"/>
            </a:xfrm>
            <a:prstGeom prst="rect">
              <a:avLst/>
            </a:prstGeom>
          </p:spPr>
        </p:pic>
        <p:pic>
          <p:nvPicPr>
            <p:cNvPr id="70" name="图片 69">
              <a:extLst>
                <a:ext uri="{FF2B5EF4-FFF2-40B4-BE49-F238E27FC236}">
                  <a16:creationId xmlns:a16="http://schemas.microsoft.com/office/drawing/2014/main" id="{94A044B1-B19A-4DCF-9537-FEB12762EAC6}"/>
                </a:ext>
              </a:extLst>
            </p:cNvPr>
            <p:cNvPicPr>
              <a:picLocks noChangeAspect="1"/>
            </p:cNvPicPr>
            <p:nvPr/>
          </p:nvPicPr>
          <p:blipFill>
            <a:blip r:embed="rId35"/>
            <a:stretch>
              <a:fillRect/>
            </a:stretch>
          </p:blipFill>
          <p:spPr>
            <a:xfrm>
              <a:off x="2808000" y="3193200"/>
              <a:ext cx="1973578" cy="540000"/>
            </a:xfrm>
            <a:prstGeom prst="rect">
              <a:avLst/>
            </a:prstGeom>
          </p:spPr>
        </p:pic>
        <p:pic>
          <p:nvPicPr>
            <p:cNvPr id="74" name="图片 73">
              <a:extLst>
                <a:ext uri="{FF2B5EF4-FFF2-40B4-BE49-F238E27FC236}">
                  <a16:creationId xmlns:a16="http://schemas.microsoft.com/office/drawing/2014/main" id="{47B66317-F6AF-45BA-AC5E-5829FA37E376}"/>
                </a:ext>
              </a:extLst>
            </p:cNvPr>
            <p:cNvPicPr>
              <a:picLocks noChangeAspect="1"/>
            </p:cNvPicPr>
            <p:nvPr/>
          </p:nvPicPr>
          <p:blipFill>
            <a:blip r:embed="rId36"/>
            <a:stretch>
              <a:fillRect/>
            </a:stretch>
          </p:blipFill>
          <p:spPr>
            <a:xfrm>
              <a:off x="5148000" y="3193200"/>
              <a:ext cx="1973578" cy="540000"/>
            </a:xfrm>
            <a:prstGeom prst="rect">
              <a:avLst/>
            </a:prstGeom>
          </p:spPr>
        </p:pic>
        <p:pic>
          <p:nvPicPr>
            <p:cNvPr id="76" name="图片 75">
              <a:extLst>
                <a:ext uri="{FF2B5EF4-FFF2-40B4-BE49-F238E27FC236}">
                  <a16:creationId xmlns:a16="http://schemas.microsoft.com/office/drawing/2014/main" id="{21F47C4D-7BC4-44C6-A20F-0D7E36C59918}"/>
                </a:ext>
              </a:extLst>
            </p:cNvPr>
            <p:cNvPicPr>
              <a:picLocks noChangeAspect="1"/>
            </p:cNvPicPr>
            <p:nvPr/>
          </p:nvPicPr>
          <p:blipFill>
            <a:blip r:embed="rId37"/>
            <a:stretch>
              <a:fillRect/>
            </a:stretch>
          </p:blipFill>
          <p:spPr>
            <a:xfrm>
              <a:off x="7452000" y="3193200"/>
              <a:ext cx="1973578" cy="540000"/>
            </a:xfrm>
            <a:prstGeom prst="rect">
              <a:avLst/>
            </a:prstGeom>
          </p:spPr>
        </p:pic>
        <p:pic>
          <p:nvPicPr>
            <p:cNvPr id="80" name="图片 79">
              <a:extLst>
                <a:ext uri="{FF2B5EF4-FFF2-40B4-BE49-F238E27FC236}">
                  <a16:creationId xmlns:a16="http://schemas.microsoft.com/office/drawing/2014/main" id="{1E4848B0-12C5-42F8-937F-DE762371A855}"/>
                </a:ext>
              </a:extLst>
            </p:cNvPr>
            <p:cNvPicPr>
              <a:picLocks noChangeAspect="1"/>
            </p:cNvPicPr>
            <p:nvPr/>
          </p:nvPicPr>
          <p:blipFill>
            <a:blip r:embed="rId38"/>
            <a:stretch>
              <a:fillRect/>
            </a:stretch>
          </p:blipFill>
          <p:spPr>
            <a:xfrm>
              <a:off x="9828000" y="3193200"/>
              <a:ext cx="1973578" cy="540000"/>
            </a:xfrm>
            <a:prstGeom prst="rect">
              <a:avLst/>
            </a:prstGeom>
          </p:spPr>
        </p:pic>
        <p:pic>
          <p:nvPicPr>
            <p:cNvPr id="90" name="图片 89">
              <a:extLst>
                <a:ext uri="{FF2B5EF4-FFF2-40B4-BE49-F238E27FC236}">
                  <a16:creationId xmlns:a16="http://schemas.microsoft.com/office/drawing/2014/main" id="{212AB5D8-C369-47D1-B94B-BD06457B2E74}"/>
                </a:ext>
              </a:extLst>
            </p:cNvPr>
            <p:cNvPicPr>
              <a:picLocks noChangeAspect="1"/>
            </p:cNvPicPr>
            <p:nvPr/>
          </p:nvPicPr>
          <p:blipFill>
            <a:blip r:embed="rId39"/>
            <a:stretch>
              <a:fillRect/>
            </a:stretch>
          </p:blipFill>
          <p:spPr>
            <a:xfrm>
              <a:off x="468000" y="4791600"/>
              <a:ext cx="1973578" cy="540000"/>
            </a:xfrm>
            <a:prstGeom prst="rect">
              <a:avLst/>
            </a:prstGeom>
          </p:spPr>
        </p:pic>
        <p:pic>
          <p:nvPicPr>
            <p:cNvPr id="92" name="图片 91">
              <a:extLst>
                <a:ext uri="{FF2B5EF4-FFF2-40B4-BE49-F238E27FC236}">
                  <a16:creationId xmlns:a16="http://schemas.microsoft.com/office/drawing/2014/main" id="{190CFA3F-44FE-4BA2-A8CE-3036B1B504A4}"/>
                </a:ext>
              </a:extLst>
            </p:cNvPr>
            <p:cNvPicPr>
              <a:picLocks noChangeAspect="1"/>
            </p:cNvPicPr>
            <p:nvPr/>
          </p:nvPicPr>
          <p:blipFill>
            <a:blip r:embed="rId40"/>
            <a:stretch>
              <a:fillRect/>
            </a:stretch>
          </p:blipFill>
          <p:spPr>
            <a:xfrm>
              <a:off x="2808000" y="4791600"/>
              <a:ext cx="1973578" cy="540000"/>
            </a:xfrm>
            <a:prstGeom prst="rect">
              <a:avLst/>
            </a:prstGeom>
          </p:spPr>
        </p:pic>
        <p:pic>
          <p:nvPicPr>
            <p:cNvPr id="94" name="图片 93">
              <a:extLst>
                <a:ext uri="{FF2B5EF4-FFF2-40B4-BE49-F238E27FC236}">
                  <a16:creationId xmlns:a16="http://schemas.microsoft.com/office/drawing/2014/main" id="{E4DE1470-B0C0-4FE8-BB11-0F702497CE4D}"/>
                </a:ext>
              </a:extLst>
            </p:cNvPr>
            <p:cNvPicPr>
              <a:picLocks noChangeAspect="1"/>
            </p:cNvPicPr>
            <p:nvPr/>
          </p:nvPicPr>
          <p:blipFill>
            <a:blip r:embed="rId41"/>
            <a:stretch>
              <a:fillRect/>
            </a:stretch>
          </p:blipFill>
          <p:spPr>
            <a:xfrm>
              <a:off x="5148000" y="4791600"/>
              <a:ext cx="1973578" cy="540000"/>
            </a:xfrm>
            <a:prstGeom prst="rect">
              <a:avLst/>
            </a:prstGeom>
          </p:spPr>
        </p:pic>
        <p:pic>
          <p:nvPicPr>
            <p:cNvPr id="96" name="图片 95">
              <a:extLst>
                <a:ext uri="{FF2B5EF4-FFF2-40B4-BE49-F238E27FC236}">
                  <a16:creationId xmlns:a16="http://schemas.microsoft.com/office/drawing/2014/main" id="{4F6F4BDD-D38C-405A-94F4-F874697E1F04}"/>
                </a:ext>
              </a:extLst>
            </p:cNvPr>
            <p:cNvPicPr>
              <a:picLocks noChangeAspect="1"/>
            </p:cNvPicPr>
            <p:nvPr/>
          </p:nvPicPr>
          <p:blipFill>
            <a:blip r:embed="rId42"/>
            <a:stretch>
              <a:fillRect/>
            </a:stretch>
          </p:blipFill>
          <p:spPr>
            <a:xfrm>
              <a:off x="7452000" y="4791600"/>
              <a:ext cx="1973578" cy="540000"/>
            </a:xfrm>
            <a:prstGeom prst="rect">
              <a:avLst/>
            </a:prstGeom>
          </p:spPr>
        </p:pic>
        <p:pic>
          <p:nvPicPr>
            <p:cNvPr id="98" name="图片 97">
              <a:extLst>
                <a:ext uri="{FF2B5EF4-FFF2-40B4-BE49-F238E27FC236}">
                  <a16:creationId xmlns:a16="http://schemas.microsoft.com/office/drawing/2014/main" id="{22428338-A3D2-425C-BF00-B73D67FEEC69}"/>
                </a:ext>
              </a:extLst>
            </p:cNvPr>
            <p:cNvPicPr>
              <a:picLocks noChangeAspect="1"/>
            </p:cNvPicPr>
            <p:nvPr/>
          </p:nvPicPr>
          <p:blipFill>
            <a:blip r:embed="rId43"/>
            <a:stretch>
              <a:fillRect/>
            </a:stretch>
          </p:blipFill>
          <p:spPr>
            <a:xfrm>
              <a:off x="9828247" y="4791600"/>
              <a:ext cx="1973578" cy="54000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65489790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>
            <a:extLst>
              <a:ext uri="{FF2B5EF4-FFF2-40B4-BE49-F238E27FC236}">
                <a16:creationId xmlns:a16="http://schemas.microsoft.com/office/drawing/2014/main" id="{678B84C5-017F-4A98-8E69-A1B56A589663}"/>
              </a:ext>
            </a:extLst>
          </p:cNvPr>
          <p:cNvGrpSpPr/>
          <p:nvPr/>
        </p:nvGrpSpPr>
        <p:grpSpPr>
          <a:xfrm>
            <a:off x="0" y="82350"/>
            <a:ext cx="12351441" cy="6761883"/>
            <a:chOff x="0" y="91875"/>
            <a:chExt cx="12351441" cy="6761883"/>
          </a:xfrm>
        </p:grpSpPr>
        <p:sp>
          <p:nvSpPr>
            <p:cNvPr id="9" name="文本框 8">
              <a:extLst>
                <a:ext uri="{FF2B5EF4-FFF2-40B4-BE49-F238E27FC236}">
                  <a16:creationId xmlns:a16="http://schemas.microsoft.com/office/drawing/2014/main" id="{89C1CCCC-C5DF-4D2E-BAEB-353ECE01FED2}"/>
                </a:ext>
              </a:extLst>
            </p:cNvPr>
            <p:cNvSpPr txBox="1"/>
            <p:nvPr/>
          </p:nvSpPr>
          <p:spPr>
            <a:xfrm>
              <a:off x="11183041" y="1306543"/>
              <a:ext cx="11684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tomach Adenocarcinoma</a:t>
              </a:r>
              <a:endParaRPr lang="zh-CN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文本框 9">
              <a:extLst>
                <a:ext uri="{FF2B5EF4-FFF2-40B4-BE49-F238E27FC236}">
                  <a16:creationId xmlns:a16="http://schemas.microsoft.com/office/drawing/2014/main" id="{DF459E47-613F-4B41-A52E-FFAB56743D89}"/>
                </a:ext>
              </a:extLst>
            </p:cNvPr>
            <p:cNvSpPr txBox="1"/>
            <p:nvPr/>
          </p:nvSpPr>
          <p:spPr>
            <a:xfrm>
              <a:off x="11412000" y="2852127"/>
              <a:ext cx="770851" cy="5078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esticular Germ Cell Tumors</a:t>
              </a:r>
              <a:endParaRPr lang="zh-CN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文本框 10">
              <a:extLst>
                <a:ext uri="{FF2B5EF4-FFF2-40B4-BE49-F238E27FC236}">
                  <a16:creationId xmlns:a16="http://schemas.microsoft.com/office/drawing/2014/main" id="{E65F402D-53E8-4765-81BA-A62F9B4ABBF4}"/>
                </a:ext>
              </a:extLst>
            </p:cNvPr>
            <p:cNvSpPr txBox="1"/>
            <p:nvPr/>
          </p:nvSpPr>
          <p:spPr>
            <a:xfrm>
              <a:off x="11412000" y="4470975"/>
              <a:ext cx="77085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hyroid Carcinoma </a:t>
              </a:r>
              <a:endParaRPr lang="zh-CN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文本框 11">
              <a:extLst>
                <a:ext uri="{FF2B5EF4-FFF2-40B4-BE49-F238E27FC236}">
                  <a16:creationId xmlns:a16="http://schemas.microsoft.com/office/drawing/2014/main" id="{70E9510A-E9E2-4E2E-8936-9E56F6C001D2}"/>
                </a:ext>
              </a:extLst>
            </p:cNvPr>
            <p:cNvSpPr txBox="1"/>
            <p:nvPr/>
          </p:nvSpPr>
          <p:spPr>
            <a:xfrm>
              <a:off x="11296178" y="6042347"/>
              <a:ext cx="95441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Uterine Carcinosarcoma</a:t>
              </a:r>
              <a:endParaRPr lang="zh-CN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13" name="组合 12">
              <a:extLst>
                <a:ext uri="{FF2B5EF4-FFF2-40B4-BE49-F238E27FC236}">
                  <a16:creationId xmlns:a16="http://schemas.microsoft.com/office/drawing/2014/main" id="{0CDCF96C-5BAE-4AA9-A5FC-3ECE9FCBC6DA}"/>
                </a:ext>
              </a:extLst>
            </p:cNvPr>
            <p:cNvGrpSpPr/>
            <p:nvPr/>
          </p:nvGrpSpPr>
          <p:grpSpPr>
            <a:xfrm>
              <a:off x="0" y="120675"/>
              <a:ext cx="2009201" cy="6528000"/>
              <a:chOff x="0" y="54000"/>
              <a:chExt cx="2009201" cy="6528000"/>
            </a:xfrm>
          </p:grpSpPr>
          <p:sp>
            <p:nvSpPr>
              <p:cNvPr id="5" name="文本框 4">
                <a:extLst>
                  <a:ext uri="{FF2B5EF4-FFF2-40B4-BE49-F238E27FC236}">
                    <a16:creationId xmlns:a16="http://schemas.microsoft.com/office/drawing/2014/main" id="{8DBF6B4C-BEF6-4603-A7C3-EFF633D97264}"/>
                  </a:ext>
                </a:extLst>
              </p:cNvPr>
              <p:cNvSpPr txBox="1"/>
              <p:nvPr/>
            </p:nvSpPr>
            <p:spPr>
              <a:xfrm>
                <a:off x="930680" y="6358983"/>
                <a:ext cx="1078521" cy="22301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LH1</a:t>
                </a:r>
                <a:endParaRPr lang="zh-CN" alt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pic>
            <p:nvPicPr>
              <p:cNvPr id="14" name="图片 13">
                <a:extLst>
                  <a:ext uri="{FF2B5EF4-FFF2-40B4-BE49-F238E27FC236}">
                    <a16:creationId xmlns:a16="http://schemas.microsoft.com/office/drawing/2014/main" id="{4C9968AD-CFE1-4763-A2D6-172C1C4AA36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0" y="54000"/>
                <a:ext cx="1959266" cy="1566000"/>
              </a:xfrm>
              <a:prstGeom prst="rect">
                <a:avLst/>
              </a:prstGeom>
            </p:spPr>
          </p:pic>
          <p:pic>
            <p:nvPicPr>
              <p:cNvPr id="23" name="图片 22">
                <a:extLst>
                  <a:ext uri="{FF2B5EF4-FFF2-40B4-BE49-F238E27FC236}">
                    <a16:creationId xmlns:a16="http://schemas.microsoft.com/office/drawing/2014/main" id="{C3D1F259-5B4A-4323-9434-356D12F07F4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5200" y="1627200"/>
                <a:ext cx="1965779" cy="1566000"/>
              </a:xfrm>
              <a:prstGeom prst="rect">
                <a:avLst/>
              </a:prstGeom>
            </p:spPr>
          </p:pic>
          <p:pic>
            <p:nvPicPr>
              <p:cNvPr id="31" name="图片 30">
                <a:extLst>
                  <a:ext uri="{FF2B5EF4-FFF2-40B4-BE49-F238E27FC236}">
                    <a16:creationId xmlns:a16="http://schemas.microsoft.com/office/drawing/2014/main" id="{8BC450BF-0529-460A-AB0C-00B7835E7A4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5200" y="3229200"/>
                <a:ext cx="1965177" cy="1566000"/>
              </a:xfrm>
              <a:prstGeom prst="rect">
                <a:avLst/>
              </a:prstGeom>
            </p:spPr>
          </p:pic>
          <p:pic>
            <p:nvPicPr>
              <p:cNvPr id="39" name="图片 38">
                <a:extLst>
                  <a:ext uri="{FF2B5EF4-FFF2-40B4-BE49-F238E27FC236}">
                    <a16:creationId xmlns:a16="http://schemas.microsoft.com/office/drawing/2014/main" id="{2CCA85F7-7324-40DE-A515-97967A06DD3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5200" y="4827600"/>
                <a:ext cx="1953391" cy="1566000"/>
              </a:xfrm>
              <a:prstGeom prst="rect">
                <a:avLst/>
              </a:prstGeom>
            </p:spPr>
          </p:pic>
        </p:grpSp>
        <p:grpSp>
          <p:nvGrpSpPr>
            <p:cNvPr id="15" name="组合 14">
              <a:extLst>
                <a:ext uri="{FF2B5EF4-FFF2-40B4-BE49-F238E27FC236}">
                  <a16:creationId xmlns:a16="http://schemas.microsoft.com/office/drawing/2014/main" id="{3CF95868-F3BC-4CA4-8629-886F2B6CC1FE}"/>
                </a:ext>
              </a:extLst>
            </p:cNvPr>
            <p:cNvGrpSpPr/>
            <p:nvPr/>
          </p:nvGrpSpPr>
          <p:grpSpPr>
            <a:xfrm>
              <a:off x="2340000" y="120675"/>
              <a:ext cx="1962217" cy="6528000"/>
              <a:chOff x="3060000" y="54000"/>
              <a:chExt cx="1962217" cy="6528000"/>
            </a:xfrm>
          </p:grpSpPr>
          <p:sp>
            <p:nvSpPr>
              <p:cNvPr id="6" name="文本框 5">
                <a:extLst>
                  <a:ext uri="{FF2B5EF4-FFF2-40B4-BE49-F238E27FC236}">
                    <a16:creationId xmlns:a16="http://schemas.microsoft.com/office/drawing/2014/main" id="{2FDF4D24-51FB-4131-A3F7-1512B2F7BDDA}"/>
                  </a:ext>
                </a:extLst>
              </p:cNvPr>
              <p:cNvSpPr txBox="1"/>
              <p:nvPr/>
            </p:nvSpPr>
            <p:spPr>
              <a:xfrm>
                <a:off x="3939034" y="6358983"/>
                <a:ext cx="1078521" cy="22301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SH2</a:t>
                </a:r>
                <a:endParaRPr lang="zh-CN" alt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pic>
            <p:nvPicPr>
              <p:cNvPr id="16" name="图片 15">
                <a:extLst>
                  <a:ext uri="{FF2B5EF4-FFF2-40B4-BE49-F238E27FC236}">
                    <a16:creationId xmlns:a16="http://schemas.microsoft.com/office/drawing/2014/main" id="{91D9DA41-B204-4599-9D93-A0A1325130A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060000" y="54000"/>
                <a:ext cx="1941090" cy="1566000"/>
              </a:xfrm>
              <a:prstGeom prst="rect">
                <a:avLst/>
              </a:prstGeom>
            </p:spPr>
          </p:pic>
          <p:pic>
            <p:nvPicPr>
              <p:cNvPr id="25" name="图片 24">
                <a:extLst>
                  <a:ext uri="{FF2B5EF4-FFF2-40B4-BE49-F238E27FC236}">
                    <a16:creationId xmlns:a16="http://schemas.microsoft.com/office/drawing/2014/main" id="{A7798304-20D0-49C4-BEDC-78C0574B8A9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060000" y="1627200"/>
                <a:ext cx="1962217" cy="1566000"/>
              </a:xfrm>
              <a:prstGeom prst="rect">
                <a:avLst/>
              </a:prstGeom>
            </p:spPr>
          </p:pic>
          <p:pic>
            <p:nvPicPr>
              <p:cNvPr id="33" name="图片 32">
                <a:extLst>
                  <a:ext uri="{FF2B5EF4-FFF2-40B4-BE49-F238E27FC236}">
                    <a16:creationId xmlns:a16="http://schemas.microsoft.com/office/drawing/2014/main" id="{A1853B95-00B9-492B-B2A1-92D52548363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060000" y="3229200"/>
                <a:ext cx="1958087" cy="1566000"/>
              </a:xfrm>
              <a:prstGeom prst="rect">
                <a:avLst/>
              </a:prstGeom>
            </p:spPr>
          </p:pic>
          <p:pic>
            <p:nvPicPr>
              <p:cNvPr id="41" name="图片 40">
                <a:extLst>
                  <a:ext uri="{FF2B5EF4-FFF2-40B4-BE49-F238E27FC236}">
                    <a16:creationId xmlns:a16="http://schemas.microsoft.com/office/drawing/2014/main" id="{8F50B0BD-16A4-45D5-9655-9E2F2BBFA27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060000" y="4827600"/>
                <a:ext cx="1958683" cy="1566000"/>
              </a:xfrm>
              <a:prstGeom prst="rect">
                <a:avLst/>
              </a:prstGeom>
            </p:spPr>
          </p:pic>
        </p:grpSp>
        <p:grpSp>
          <p:nvGrpSpPr>
            <p:cNvPr id="17" name="组合 16">
              <a:extLst>
                <a:ext uri="{FF2B5EF4-FFF2-40B4-BE49-F238E27FC236}">
                  <a16:creationId xmlns:a16="http://schemas.microsoft.com/office/drawing/2014/main" id="{A9090A6F-E877-4B5F-8B33-C10C5A317F7F}"/>
                </a:ext>
              </a:extLst>
            </p:cNvPr>
            <p:cNvGrpSpPr/>
            <p:nvPr/>
          </p:nvGrpSpPr>
          <p:grpSpPr>
            <a:xfrm>
              <a:off x="4680000" y="120675"/>
              <a:ext cx="1968145" cy="6528000"/>
              <a:chOff x="6120000" y="54000"/>
              <a:chExt cx="1968145" cy="6528000"/>
            </a:xfrm>
          </p:grpSpPr>
          <p:sp>
            <p:nvSpPr>
              <p:cNvPr id="7" name="文本框 6">
                <a:extLst>
                  <a:ext uri="{FF2B5EF4-FFF2-40B4-BE49-F238E27FC236}">
                    <a16:creationId xmlns:a16="http://schemas.microsoft.com/office/drawing/2014/main" id="{434F75C7-4E6C-4687-8EFC-EA499B17DA9D}"/>
                  </a:ext>
                </a:extLst>
              </p:cNvPr>
              <p:cNvSpPr txBox="1"/>
              <p:nvPr/>
            </p:nvSpPr>
            <p:spPr>
              <a:xfrm>
                <a:off x="6864120" y="6358983"/>
                <a:ext cx="1078521" cy="22301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SH6</a:t>
                </a:r>
                <a:endParaRPr lang="zh-CN" alt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pic>
            <p:nvPicPr>
              <p:cNvPr id="19" name="图片 18">
                <a:extLst>
                  <a:ext uri="{FF2B5EF4-FFF2-40B4-BE49-F238E27FC236}">
                    <a16:creationId xmlns:a16="http://schemas.microsoft.com/office/drawing/2014/main" id="{ACCD8A90-9F6E-4458-87D1-D948176DFC6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0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120000" y="54000"/>
                <a:ext cx="1961049" cy="1566000"/>
              </a:xfrm>
              <a:prstGeom prst="rect">
                <a:avLst/>
              </a:prstGeom>
            </p:spPr>
          </p:pic>
          <p:pic>
            <p:nvPicPr>
              <p:cNvPr id="27" name="图片 26">
                <a:extLst>
                  <a:ext uri="{FF2B5EF4-FFF2-40B4-BE49-F238E27FC236}">
                    <a16:creationId xmlns:a16="http://schemas.microsoft.com/office/drawing/2014/main" id="{286D59DA-1D17-4E64-A190-0D1A6D0AFA0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1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120000" y="1627200"/>
                <a:ext cx="1951586" cy="1566000"/>
              </a:xfrm>
              <a:prstGeom prst="rect">
                <a:avLst/>
              </a:prstGeom>
            </p:spPr>
          </p:pic>
          <p:pic>
            <p:nvPicPr>
              <p:cNvPr id="35" name="图片 34">
                <a:extLst>
                  <a:ext uri="{FF2B5EF4-FFF2-40B4-BE49-F238E27FC236}">
                    <a16:creationId xmlns:a16="http://schemas.microsoft.com/office/drawing/2014/main" id="{CC58C8E9-6F08-4670-9344-F7B9D34D955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120000" y="3229200"/>
                <a:ext cx="1946919" cy="1566000"/>
              </a:xfrm>
              <a:prstGeom prst="rect">
                <a:avLst/>
              </a:prstGeom>
            </p:spPr>
          </p:pic>
          <p:pic>
            <p:nvPicPr>
              <p:cNvPr id="43" name="图片 42">
                <a:extLst>
                  <a:ext uri="{FF2B5EF4-FFF2-40B4-BE49-F238E27FC236}">
                    <a16:creationId xmlns:a16="http://schemas.microsoft.com/office/drawing/2014/main" id="{0A7314F0-F3E8-495E-B1F1-EC36E57BF6F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120000" y="4827600"/>
                <a:ext cx="1968145" cy="1566000"/>
              </a:xfrm>
              <a:prstGeom prst="rect">
                <a:avLst/>
              </a:prstGeom>
            </p:spPr>
          </p:pic>
        </p:grpSp>
        <p:grpSp>
          <p:nvGrpSpPr>
            <p:cNvPr id="18" name="组合 17">
              <a:extLst>
                <a:ext uri="{FF2B5EF4-FFF2-40B4-BE49-F238E27FC236}">
                  <a16:creationId xmlns:a16="http://schemas.microsoft.com/office/drawing/2014/main" id="{DDB38682-9AB5-4C76-B536-345E8CAC5531}"/>
                </a:ext>
              </a:extLst>
            </p:cNvPr>
            <p:cNvGrpSpPr/>
            <p:nvPr/>
          </p:nvGrpSpPr>
          <p:grpSpPr>
            <a:xfrm>
              <a:off x="7020000" y="120675"/>
              <a:ext cx="1961621" cy="6528000"/>
              <a:chOff x="9180000" y="54000"/>
              <a:chExt cx="1961621" cy="6528000"/>
            </a:xfrm>
          </p:grpSpPr>
          <p:sp>
            <p:nvSpPr>
              <p:cNvPr id="8" name="文本框 7">
                <a:extLst>
                  <a:ext uri="{FF2B5EF4-FFF2-40B4-BE49-F238E27FC236}">
                    <a16:creationId xmlns:a16="http://schemas.microsoft.com/office/drawing/2014/main" id="{10E100B5-6D97-4EBD-91BA-14FEDE4301C3}"/>
                  </a:ext>
                </a:extLst>
              </p:cNvPr>
              <p:cNvSpPr txBox="1"/>
              <p:nvPr/>
            </p:nvSpPr>
            <p:spPr>
              <a:xfrm>
                <a:off x="9973080" y="6358983"/>
                <a:ext cx="1078521" cy="22301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MS2</a:t>
                </a:r>
                <a:endParaRPr lang="zh-CN" alt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pic>
            <p:nvPicPr>
              <p:cNvPr id="21" name="图片 20">
                <a:extLst>
                  <a:ext uri="{FF2B5EF4-FFF2-40B4-BE49-F238E27FC236}">
                    <a16:creationId xmlns:a16="http://schemas.microsoft.com/office/drawing/2014/main" id="{B1CF4F17-2CF4-4D9B-9BB2-8CB0F80193A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9180000" y="54000"/>
                <a:ext cx="1959858" cy="1566000"/>
              </a:xfrm>
              <a:prstGeom prst="rect">
                <a:avLst/>
              </a:prstGeom>
            </p:spPr>
          </p:pic>
          <p:pic>
            <p:nvPicPr>
              <p:cNvPr id="29" name="图片 28">
                <a:extLst>
                  <a:ext uri="{FF2B5EF4-FFF2-40B4-BE49-F238E27FC236}">
                    <a16:creationId xmlns:a16="http://schemas.microsoft.com/office/drawing/2014/main" id="{E8825178-8C70-4CA6-9C9A-CDF6174F866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9180000" y="1627200"/>
                <a:ext cx="1958683" cy="1566000"/>
              </a:xfrm>
              <a:prstGeom prst="rect">
                <a:avLst/>
              </a:prstGeom>
            </p:spPr>
          </p:pic>
          <p:pic>
            <p:nvPicPr>
              <p:cNvPr id="37" name="图片 36">
                <a:extLst>
                  <a:ext uri="{FF2B5EF4-FFF2-40B4-BE49-F238E27FC236}">
                    <a16:creationId xmlns:a16="http://schemas.microsoft.com/office/drawing/2014/main" id="{5F53773D-A328-4514-9173-D3E65A7C288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9180000" y="3229200"/>
                <a:ext cx="1957500" cy="1566000"/>
              </a:xfrm>
              <a:prstGeom prst="rect">
                <a:avLst/>
              </a:prstGeom>
            </p:spPr>
          </p:pic>
          <p:pic>
            <p:nvPicPr>
              <p:cNvPr id="46" name="图片 45">
                <a:extLst>
                  <a:ext uri="{FF2B5EF4-FFF2-40B4-BE49-F238E27FC236}">
                    <a16:creationId xmlns:a16="http://schemas.microsoft.com/office/drawing/2014/main" id="{BBBE6E9C-39FA-488E-A6D8-532A443B1EB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9180000" y="4827600"/>
                <a:ext cx="1961621" cy="1566000"/>
              </a:xfrm>
              <a:prstGeom prst="rect">
                <a:avLst/>
              </a:prstGeom>
            </p:spPr>
          </p:pic>
        </p:grpSp>
        <p:sp>
          <p:nvSpPr>
            <p:cNvPr id="34" name="文本框 33">
              <a:extLst>
                <a:ext uri="{FF2B5EF4-FFF2-40B4-BE49-F238E27FC236}">
                  <a16:creationId xmlns:a16="http://schemas.microsoft.com/office/drawing/2014/main" id="{02182ED5-8AD7-4F88-8F81-95E9BD197D11}"/>
                </a:ext>
              </a:extLst>
            </p:cNvPr>
            <p:cNvSpPr txBox="1"/>
            <p:nvPr/>
          </p:nvSpPr>
          <p:spPr>
            <a:xfrm>
              <a:off x="10149920" y="6396858"/>
              <a:ext cx="107852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 genes</a:t>
              </a:r>
              <a:endParaRPr lang="zh-CN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22" name="图片 21">
              <a:extLst>
                <a:ext uri="{FF2B5EF4-FFF2-40B4-BE49-F238E27FC236}">
                  <a16:creationId xmlns:a16="http://schemas.microsoft.com/office/drawing/2014/main" id="{C3603B3F-8798-409A-B4E4-86C327F3032A}"/>
                </a:ext>
              </a:extLst>
            </p:cNvPr>
            <p:cNvPicPr>
              <a:picLocks noChangeAspect="1"/>
            </p:cNvPicPr>
            <p:nvPr/>
          </p:nvPicPr>
          <p:blipFill>
            <a:blip r:embed="rId1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331200" y="117716"/>
              <a:ext cx="1945211" cy="1566000"/>
            </a:xfrm>
            <a:prstGeom prst="rect">
              <a:avLst/>
            </a:prstGeom>
          </p:spPr>
        </p:pic>
        <p:pic>
          <p:nvPicPr>
            <p:cNvPr id="26" name="图片 25">
              <a:extLst>
                <a:ext uri="{FF2B5EF4-FFF2-40B4-BE49-F238E27FC236}">
                  <a16:creationId xmlns:a16="http://schemas.microsoft.com/office/drawing/2014/main" id="{6B4BEF62-04E8-4391-9292-5C0AE3293C15}"/>
                </a:ext>
              </a:extLst>
            </p:cNvPr>
            <p:cNvPicPr>
              <a:picLocks noChangeAspect="1"/>
            </p:cNvPicPr>
            <p:nvPr/>
          </p:nvPicPr>
          <p:blipFill>
            <a:blip r:embed="rId1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331200" y="1693875"/>
              <a:ext cx="1951586" cy="1566000"/>
            </a:xfrm>
            <a:prstGeom prst="rect">
              <a:avLst/>
            </a:prstGeom>
          </p:spPr>
        </p:pic>
        <p:pic>
          <p:nvPicPr>
            <p:cNvPr id="30" name="图片 29">
              <a:extLst>
                <a:ext uri="{FF2B5EF4-FFF2-40B4-BE49-F238E27FC236}">
                  <a16:creationId xmlns:a16="http://schemas.microsoft.com/office/drawing/2014/main" id="{A99C91D4-C03A-4088-86BB-40E053A5A634}"/>
                </a:ext>
              </a:extLst>
            </p:cNvPr>
            <p:cNvPicPr>
              <a:picLocks noChangeAspect="1"/>
            </p:cNvPicPr>
            <p:nvPr/>
          </p:nvPicPr>
          <p:blipFill>
            <a:blip r:embed="rId2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331200" y="3295875"/>
              <a:ext cx="1949271" cy="1566000"/>
            </a:xfrm>
            <a:prstGeom prst="rect">
              <a:avLst/>
            </a:prstGeom>
          </p:spPr>
        </p:pic>
        <p:pic>
          <p:nvPicPr>
            <p:cNvPr id="36" name="图片 35">
              <a:extLst>
                <a:ext uri="{FF2B5EF4-FFF2-40B4-BE49-F238E27FC236}">
                  <a16:creationId xmlns:a16="http://schemas.microsoft.com/office/drawing/2014/main" id="{7E379B18-18D3-46CA-B76F-A6BD6B9D7278}"/>
                </a:ext>
              </a:extLst>
            </p:cNvPr>
            <p:cNvPicPr>
              <a:picLocks noChangeAspect="1"/>
            </p:cNvPicPr>
            <p:nvPr/>
          </p:nvPicPr>
          <p:blipFill>
            <a:blip r:embed="rId2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331200" y="4894275"/>
              <a:ext cx="1940529" cy="1566000"/>
            </a:xfrm>
            <a:prstGeom prst="rect">
              <a:avLst/>
            </a:prstGeom>
          </p:spPr>
        </p:pic>
        <p:pic>
          <p:nvPicPr>
            <p:cNvPr id="66" name="图片 65">
              <a:extLst>
                <a:ext uri="{FF2B5EF4-FFF2-40B4-BE49-F238E27FC236}">
                  <a16:creationId xmlns:a16="http://schemas.microsoft.com/office/drawing/2014/main" id="{871679BC-6023-49D0-B2CE-1E9EDFD8F269}"/>
                </a:ext>
              </a:extLst>
            </p:cNvPr>
            <p:cNvPicPr>
              <a:picLocks noChangeAspect="1"/>
            </p:cNvPicPr>
            <p:nvPr/>
          </p:nvPicPr>
          <p:blipFill>
            <a:blip r:embed="rId2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900044" y="6695000"/>
              <a:ext cx="1289116" cy="158758"/>
            </a:xfrm>
            <a:prstGeom prst="rect">
              <a:avLst/>
            </a:prstGeom>
          </p:spPr>
        </p:pic>
        <p:pic>
          <p:nvPicPr>
            <p:cNvPr id="68" name="图片 67">
              <a:extLst>
                <a:ext uri="{FF2B5EF4-FFF2-40B4-BE49-F238E27FC236}">
                  <a16:creationId xmlns:a16="http://schemas.microsoft.com/office/drawing/2014/main" id="{B3714D6D-4171-4EAA-ABB1-5D4534AC1007}"/>
                </a:ext>
              </a:extLst>
            </p:cNvPr>
            <p:cNvPicPr>
              <a:picLocks noChangeAspect="1"/>
            </p:cNvPicPr>
            <p:nvPr/>
          </p:nvPicPr>
          <p:blipFill>
            <a:blip r:embed="rId2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559313" y="6673375"/>
              <a:ext cx="1428823" cy="171459"/>
            </a:xfrm>
            <a:prstGeom prst="rect">
              <a:avLst/>
            </a:prstGeom>
          </p:spPr>
        </p:pic>
        <p:pic>
          <p:nvPicPr>
            <p:cNvPr id="4" name="图片 3">
              <a:extLst>
                <a:ext uri="{FF2B5EF4-FFF2-40B4-BE49-F238E27FC236}">
                  <a16:creationId xmlns:a16="http://schemas.microsoft.com/office/drawing/2014/main" id="{EC446AE5-55C2-42FF-ABF1-C0E2A3EA476B}"/>
                </a:ext>
              </a:extLst>
            </p:cNvPr>
            <p:cNvPicPr>
              <a:picLocks noChangeAspect="1"/>
            </p:cNvPicPr>
            <p:nvPr/>
          </p:nvPicPr>
          <p:blipFill>
            <a:blip r:embed="rId24"/>
            <a:stretch>
              <a:fillRect/>
            </a:stretch>
          </p:blipFill>
          <p:spPr>
            <a:xfrm>
              <a:off x="468000" y="91875"/>
              <a:ext cx="1973578" cy="540000"/>
            </a:xfrm>
            <a:prstGeom prst="rect">
              <a:avLst/>
            </a:prstGeom>
          </p:spPr>
        </p:pic>
        <p:pic>
          <p:nvPicPr>
            <p:cNvPr id="24" name="图片 23">
              <a:extLst>
                <a:ext uri="{FF2B5EF4-FFF2-40B4-BE49-F238E27FC236}">
                  <a16:creationId xmlns:a16="http://schemas.microsoft.com/office/drawing/2014/main" id="{F82FE60A-F1BA-4246-A25E-6FAC7ACEAAA1}"/>
                </a:ext>
              </a:extLst>
            </p:cNvPr>
            <p:cNvPicPr>
              <a:picLocks noChangeAspect="1"/>
            </p:cNvPicPr>
            <p:nvPr/>
          </p:nvPicPr>
          <p:blipFill>
            <a:blip r:embed="rId25"/>
            <a:stretch>
              <a:fillRect/>
            </a:stretch>
          </p:blipFill>
          <p:spPr>
            <a:xfrm>
              <a:off x="2808000" y="91875"/>
              <a:ext cx="1973578" cy="540000"/>
            </a:xfrm>
            <a:prstGeom prst="rect">
              <a:avLst/>
            </a:prstGeom>
          </p:spPr>
        </p:pic>
        <p:pic>
          <p:nvPicPr>
            <p:cNvPr id="32" name="图片 31">
              <a:extLst>
                <a:ext uri="{FF2B5EF4-FFF2-40B4-BE49-F238E27FC236}">
                  <a16:creationId xmlns:a16="http://schemas.microsoft.com/office/drawing/2014/main" id="{A5D11A4F-67C1-427B-81EF-1DB60027CD27}"/>
                </a:ext>
              </a:extLst>
            </p:cNvPr>
            <p:cNvPicPr>
              <a:picLocks noChangeAspect="1"/>
            </p:cNvPicPr>
            <p:nvPr/>
          </p:nvPicPr>
          <p:blipFill>
            <a:blip r:embed="rId26"/>
            <a:stretch>
              <a:fillRect/>
            </a:stretch>
          </p:blipFill>
          <p:spPr>
            <a:xfrm>
              <a:off x="5148000" y="91875"/>
              <a:ext cx="1973578" cy="540000"/>
            </a:xfrm>
            <a:prstGeom prst="rect">
              <a:avLst/>
            </a:prstGeom>
          </p:spPr>
        </p:pic>
        <p:pic>
          <p:nvPicPr>
            <p:cNvPr id="42" name="图片 41">
              <a:extLst>
                <a:ext uri="{FF2B5EF4-FFF2-40B4-BE49-F238E27FC236}">
                  <a16:creationId xmlns:a16="http://schemas.microsoft.com/office/drawing/2014/main" id="{6E74156D-9CA6-4130-ACC2-DDD3EE5CC06B}"/>
                </a:ext>
              </a:extLst>
            </p:cNvPr>
            <p:cNvPicPr>
              <a:picLocks noChangeAspect="1"/>
            </p:cNvPicPr>
            <p:nvPr/>
          </p:nvPicPr>
          <p:blipFill>
            <a:blip r:embed="rId27"/>
            <a:stretch>
              <a:fillRect/>
            </a:stretch>
          </p:blipFill>
          <p:spPr>
            <a:xfrm>
              <a:off x="7452000" y="91875"/>
              <a:ext cx="1973578" cy="540000"/>
            </a:xfrm>
            <a:prstGeom prst="rect">
              <a:avLst/>
            </a:prstGeom>
          </p:spPr>
        </p:pic>
        <p:pic>
          <p:nvPicPr>
            <p:cNvPr id="47" name="图片 46">
              <a:extLst>
                <a:ext uri="{FF2B5EF4-FFF2-40B4-BE49-F238E27FC236}">
                  <a16:creationId xmlns:a16="http://schemas.microsoft.com/office/drawing/2014/main" id="{BC187BBB-B9DE-47BB-AEF0-94EE2BFB415E}"/>
                </a:ext>
              </a:extLst>
            </p:cNvPr>
            <p:cNvPicPr>
              <a:picLocks noChangeAspect="1"/>
            </p:cNvPicPr>
            <p:nvPr/>
          </p:nvPicPr>
          <p:blipFill>
            <a:blip r:embed="rId28"/>
            <a:stretch>
              <a:fillRect/>
            </a:stretch>
          </p:blipFill>
          <p:spPr>
            <a:xfrm>
              <a:off x="9828000" y="91875"/>
              <a:ext cx="1973578" cy="540000"/>
            </a:xfrm>
            <a:prstGeom prst="rect">
              <a:avLst/>
            </a:prstGeom>
          </p:spPr>
        </p:pic>
        <p:pic>
          <p:nvPicPr>
            <p:cNvPr id="51" name="图片 50">
              <a:extLst>
                <a:ext uri="{FF2B5EF4-FFF2-40B4-BE49-F238E27FC236}">
                  <a16:creationId xmlns:a16="http://schemas.microsoft.com/office/drawing/2014/main" id="{6B725B10-3C37-46DD-9574-43B9BA7E8A50}"/>
                </a:ext>
              </a:extLst>
            </p:cNvPr>
            <p:cNvPicPr>
              <a:picLocks noChangeAspect="1"/>
            </p:cNvPicPr>
            <p:nvPr/>
          </p:nvPicPr>
          <p:blipFill>
            <a:blip r:embed="rId29"/>
            <a:stretch>
              <a:fillRect/>
            </a:stretch>
          </p:blipFill>
          <p:spPr>
            <a:xfrm>
              <a:off x="468000" y="2571608"/>
              <a:ext cx="1973578" cy="540000"/>
            </a:xfrm>
            <a:prstGeom prst="rect">
              <a:avLst/>
            </a:prstGeom>
          </p:spPr>
        </p:pic>
        <p:pic>
          <p:nvPicPr>
            <p:cNvPr id="61" name="图片 60">
              <a:extLst>
                <a:ext uri="{FF2B5EF4-FFF2-40B4-BE49-F238E27FC236}">
                  <a16:creationId xmlns:a16="http://schemas.microsoft.com/office/drawing/2014/main" id="{ED1FB275-B28C-4E61-89C0-C4B37882A9F7}"/>
                </a:ext>
              </a:extLst>
            </p:cNvPr>
            <p:cNvPicPr>
              <a:picLocks noChangeAspect="1"/>
            </p:cNvPicPr>
            <p:nvPr/>
          </p:nvPicPr>
          <p:blipFill>
            <a:blip r:embed="rId30"/>
            <a:stretch>
              <a:fillRect/>
            </a:stretch>
          </p:blipFill>
          <p:spPr>
            <a:xfrm>
              <a:off x="2808000" y="2572275"/>
              <a:ext cx="1973578" cy="540000"/>
            </a:xfrm>
            <a:prstGeom prst="rect">
              <a:avLst/>
            </a:prstGeom>
          </p:spPr>
        </p:pic>
        <p:pic>
          <p:nvPicPr>
            <p:cNvPr id="64" name="图片 63">
              <a:extLst>
                <a:ext uri="{FF2B5EF4-FFF2-40B4-BE49-F238E27FC236}">
                  <a16:creationId xmlns:a16="http://schemas.microsoft.com/office/drawing/2014/main" id="{1B395486-D758-49EE-BC59-AA98DA20F4CB}"/>
                </a:ext>
              </a:extLst>
            </p:cNvPr>
            <p:cNvPicPr>
              <a:picLocks noChangeAspect="1"/>
            </p:cNvPicPr>
            <p:nvPr/>
          </p:nvPicPr>
          <p:blipFill>
            <a:blip r:embed="rId31"/>
            <a:stretch>
              <a:fillRect/>
            </a:stretch>
          </p:blipFill>
          <p:spPr>
            <a:xfrm>
              <a:off x="5148000" y="2572275"/>
              <a:ext cx="1973578" cy="540000"/>
            </a:xfrm>
            <a:prstGeom prst="rect">
              <a:avLst/>
            </a:prstGeom>
          </p:spPr>
        </p:pic>
        <p:pic>
          <p:nvPicPr>
            <p:cNvPr id="72" name="图片 71">
              <a:extLst>
                <a:ext uri="{FF2B5EF4-FFF2-40B4-BE49-F238E27FC236}">
                  <a16:creationId xmlns:a16="http://schemas.microsoft.com/office/drawing/2014/main" id="{93F8AEF2-07A8-4E65-9DC1-D798939C924E}"/>
                </a:ext>
              </a:extLst>
            </p:cNvPr>
            <p:cNvPicPr>
              <a:picLocks noChangeAspect="1"/>
            </p:cNvPicPr>
            <p:nvPr/>
          </p:nvPicPr>
          <p:blipFill>
            <a:blip r:embed="rId32"/>
            <a:stretch>
              <a:fillRect/>
            </a:stretch>
          </p:blipFill>
          <p:spPr>
            <a:xfrm>
              <a:off x="7452000" y="2572275"/>
              <a:ext cx="1973578" cy="540000"/>
            </a:xfrm>
            <a:prstGeom prst="rect">
              <a:avLst/>
            </a:prstGeom>
          </p:spPr>
        </p:pic>
        <p:pic>
          <p:nvPicPr>
            <p:cNvPr id="75" name="图片 74">
              <a:extLst>
                <a:ext uri="{FF2B5EF4-FFF2-40B4-BE49-F238E27FC236}">
                  <a16:creationId xmlns:a16="http://schemas.microsoft.com/office/drawing/2014/main" id="{43F704FC-8041-4802-A4E3-DEFD134CA602}"/>
                </a:ext>
              </a:extLst>
            </p:cNvPr>
            <p:cNvPicPr>
              <a:picLocks noChangeAspect="1"/>
            </p:cNvPicPr>
            <p:nvPr/>
          </p:nvPicPr>
          <p:blipFill>
            <a:blip r:embed="rId33"/>
            <a:stretch>
              <a:fillRect/>
            </a:stretch>
          </p:blipFill>
          <p:spPr>
            <a:xfrm>
              <a:off x="9828000" y="2570475"/>
              <a:ext cx="1973578" cy="540000"/>
            </a:xfrm>
            <a:prstGeom prst="rect">
              <a:avLst/>
            </a:prstGeom>
          </p:spPr>
        </p:pic>
        <p:pic>
          <p:nvPicPr>
            <p:cNvPr id="79" name="图片 78">
              <a:extLst>
                <a:ext uri="{FF2B5EF4-FFF2-40B4-BE49-F238E27FC236}">
                  <a16:creationId xmlns:a16="http://schemas.microsoft.com/office/drawing/2014/main" id="{EB281F1E-459E-4488-A39B-A56EFBA65980}"/>
                </a:ext>
              </a:extLst>
            </p:cNvPr>
            <p:cNvPicPr>
              <a:picLocks noChangeAspect="1"/>
            </p:cNvPicPr>
            <p:nvPr/>
          </p:nvPicPr>
          <p:blipFill>
            <a:blip r:embed="rId34"/>
            <a:stretch>
              <a:fillRect/>
            </a:stretch>
          </p:blipFill>
          <p:spPr>
            <a:xfrm>
              <a:off x="468000" y="4098675"/>
              <a:ext cx="1973578" cy="540000"/>
            </a:xfrm>
            <a:prstGeom prst="rect">
              <a:avLst/>
            </a:prstGeom>
          </p:spPr>
        </p:pic>
        <p:pic>
          <p:nvPicPr>
            <p:cNvPr id="82" name="图片 81">
              <a:extLst>
                <a:ext uri="{FF2B5EF4-FFF2-40B4-BE49-F238E27FC236}">
                  <a16:creationId xmlns:a16="http://schemas.microsoft.com/office/drawing/2014/main" id="{3B1C9C59-6F5E-4133-BF9B-07E2A06828BB}"/>
                </a:ext>
              </a:extLst>
            </p:cNvPr>
            <p:cNvPicPr>
              <a:picLocks noChangeAspect="1"/>
            </p:cNvPicPr>
            <p:nvPr/>
          </p:nvPicPr>
          <p:blipFill>
            <a:blip r:embed="rId35"/>
            <a:stretch>
              <a:fillRect/>
            </a:stretch>
          </p:blipFill>
          <p:spPr>
            <a:xfrm>
              <a:off x="2808000" y="4098675"/>
              <a:ext cx="1973578" cy="540000"/>
            </a:xfrm>
            <a:prstGeom prst="rect">
              <a:avLst/>
            </a:prstGeom>
          </p:spPr>
        </p:pic>
        <p:pic>
          <p:nvPicPr>
            <p:cNvPr id="85" name="图片 84">
              <a:extLst>
                <a:ext uri="{FF2B5EF4-FFF2-40B4-BE49-F238E27FC236}">
                  <a16:creationId xmlns:a16="http://schemas.microsoft.com/office/drawing/2014/main" id="{5A53E976-0774-4A83-A2CB-78F66DEFCEE5}"/>
                </a:ext>
              </a:extLst>
            </p:cNvPr>
            <p:cNvPicPr>
              <a:picLocks noChangeAspect="1"/>
            </p:cNvPicPr>
            <p:nvPr/>
          </p:nvPicPr>
          <p:blipFill>
            <a:blip r:embed="rId36"/>
            <a:stretch>
              <a:fillRect/>
            </a:stretch>
          </p:blipFill>
          <p:spPr>
            <a:xfrm>
              <a:off x="5148000" y="4098675"/>
              <a:ext cx="1973578" cy="540000"/>
            </a:xfrm>
            <a:prstGeom prst="rect">
              <a:avLst/>
            </a:prstGeom>
          </p:spPr>
        </p:pic>
        <p:pic>
          <p:nvPicPr>
            <p:cNvPr id="88" name="图片 87">
              <a:extLst>
                <a:ext uri="{FF2B5EF4-FFF2-40B4-BE49-F238E27FC236}">
                  <a16:creationId xmlns:a16="http://schemas.microsoft.com/office/drawing/2014/main" id="{CCC52C08-B8C6-46E8-BA6A-53F845ED7A2D}"/>
                </a:ext>
              </a:extLst>
            </p:cNvPr>
            <p:cNvPicPr>
              <a:picLocks noChangeAspect="1"/>
            </p:cNvPicPr>
            <p:nvPr/>
          </p:nvPicPr>
          <p:blipFill>
            <a:blip r:embed="rId37"/>
            <a:stretch>
              <a:fillRect/>
            </a:stretch>
          </p:blipFill>
          <p:spPr>
            <a:xfrm>
              <a:off x="7452000" y="4098675"/>
              <a:ext cx="1973578" cy="540000"/>
            </a:xfrm>
            <a:prstGeom prst="rect">
              <a:avLst/>
            </a:prstGeom>
          </p:spPr>
        </p:pic>
        <p:pic>
          <p:nvPicPr>
            <p:cNvPr id="90" name="图片 89">
              <a:extLst>
                <a:ext uri="{FF2B5EF4-FFF2-40B4-BE49-F238E27FC236}">
                  <a16:creationId xmlns:a16="http://schemas.microsoft.com/office/drawing/2014/main" id="{641C215C-0A76-4937-969A-75907BB0C2A6}"/>
                </a:ext>
              </a:extLst>
            </p:cNvPr>
            <p:cNvPicPr>
              <a:picLocks noChangeAspect="1"/>
            </p:cNvPicPr>
            <p:nvPr/>
          </p:nvPicPr>
          <p:blipFill>
            <a:blip r:embed="rId38"/>
            <a:stretch>
              <a:fillRect/>
            </a:stretch>
          </p:blipFill>
          <p:spPr>
            <a:xfrm>
              <a:off x="9828000" y="4098675"/>
              <a:ext cx="1973578" cy="540000"/>
            </a:xfrm>
            <a:prstGeom prst="rect">
              <a:avLst/>
            </a:prstGeom>
          </p:spPr>
        </p:pic>
        <p:pic>
          <p:nvPicPr>
            <p:cNvPr id="92" name="图片 91">
              <a:extLst>
                <a:ext uri="{FF2B5EF4-FFF2-40B4-BE49-F238E27FC236}">
                  <a16:creationId xmlns:a16="http://schemas.microsoft.com/office/drawing/2014/main" id="{03D889CA-50CF-4DC4-BC2D-64797DC22103}"/>
                </a:ext>
              </a:extLst>
            </p:cNvPr>
            <p:cNvPicPr>
              <a:picLocks noChangeAspect="1"/>
            </p:cNvPicPr>
            <p:nvPr/>
          </p:nvPicPr>
          <p:blipFill>
            <a:blip r:embed="rId39"/>
            <a:stretch>
              <a:fillRect/>
            </a:stretch>
          </p:blipFill>
          <p:spPr>
            <a:xfrm>
              <a:off x="468000" y="5718675"/>
              <a:ext cx="1973578" cy="540000"/>
            </a:xfrm>
            <a:prstGeom prst="rect">
              <a:avLst/>
            </a:prstGeom>
          </p:spPr>
        </p:pic>
        <p:pic>
          <p:nvPicPr>
            <p:cNvPr id="95" name="图片 94">
              <a:extLst>
                <a:ext uri="{FF2B5EF4-FFF2-40B4-BE49-F238E27FC236}">
                  <a16:creationId xmlns:a16="http://schemas.microsoft.com/office/drawing/2014/main" id="{08431530-0E52-43C1-BCC7-29E1B0F1987D}"/>
                </a:ext>
              </a:extLst>
            </p:cNvPr>
            <p:cNvPicPr>
              <a:picLocks noChangeAspect="1"/>
            </p:cNvPicPr>
            <p:nvPr/>
          </p:nvPicPr>
          <p:blipFill>
            <a:blip r:embed="rId40"/>
            <a:stretch>
              <a:fillRect/>
            </a:stretch>
          </p:blipFill>
          <p:spPr>
            <a:xfrm>
              <a:off x="2808000" y="5718675"/>
              <a:ext cx="1973578" cy="540000"/>
            </a:xfrm>
            <a:prstGeom prst="rect">
              <a:avLst/>
            </a:prstGeom>
          </p:spPr>
        </p:pic>
        <p:pic>
          <p:nvPicPr>
            <p:cNvPr id="98" name="图片 97">
              <a:extLst>
                <a:ext uri="{FF2B5EF4-FFF2-40B4-BE49-F238E27FC236}">
                  <a16:creationId xmlns:a16="http://schemas.microsoft.com/office/drawing/2014/main" id="{86945307-062E-4ECD-9BE9-962EA20A7DCF}"/>
                </a:ext>
              </a:extLst>
            </p:cNvPr>
            <p:cNvPicPr>
              <a:picLocks noChangeAspect="1"/>
            </p:cNvPicPr>
            <p:nvPr/>
          </p:nvPicPr>
          <p:blipFill>
            <a:blip r:embed="rId41"/>
            <a:stretch>
              <a:fillRect/>
            </a:stretch>
          </p:blipFill>
          <p:spPr>
            <a:xfrm>
              <a:off x="5148000" y="5718675"/>
              <a:ext cx="1973578" cy="540000"/>
            </a:xfrm>
            <a:prstGeom prst="rect">
              <a:avLst/>
            </a:prstGeom>
          </p:spPr>
        </p:pic>
        <p:pic>
          <p:nvPicPr>
            <p:cNvPr id="100" name="图片 99">
              <a:extLst>
                <a:ext uri="{FF2B5EF4-FFF2-40B4-BE49-F238E27FC236}">
                  <a16:creationId xmlns:a16="http://schemas.microsoft.com/office/drawing/2014/main" id="{A8F5BA80-6E17-4520-990F-96DBA0B28A14}"/>
                </a:ext>
              </a:extLst>
            </p:cNvPr>
            <p:cNvPicPr>
              <a:picLocks noChangeAspect="1"/>
            </p:cNvPicPr>
            <p:nvPr/>
          </p:nvPicPr>
          <p:blipFill>
            <a:blip r:embed="rId42"/>
            <a:stretch>
              <a:fillRect/>
            </a:stretch>
          </p:blipFill>
          <p:spPr>
            <a:xfrm>
              <a:off x="7452000" y="5718675"/>
              <a:ext cx="1973578" cy="540000"/>
            </a:xfrm>
            <a:prstGeom prst="rect">
              <a:avLst/>
            </a:prstGeom>
          </p:spPr>
        </p:pic>
        <p:pic>
          <p:nvPicPr>
            <p:cNvPr id="102" name="图片 101">
              <a:extLst>
                <a:ext uri="{FF2B5EF4-FFF2-40B4-BE49-F238E27FC236}">
                  <a16:creationId xmlns:a16="http://schemas.microsoft.com/office/drawing/2014/main" id="{B262500C-17DB-4412-B813-ABC13061C6C0}"/>
                </a:ext>
              </a:extLst>
            </p:cNvPr>
            <p:cNvPicPr>
              <a:picLocks noChangeAspect="1"/>
            </p:cNvPicPr>
            <p:nvPr/>
          </p:nvPicPr>
          <p:blipFill>
            <a:blip r:embed="rId43"/>
            <a:stretch>
              <a:fillRect/>
            </a:stretch>
          </p:blipFill>
          <p:spPr>
            <a:xfrm>
              <a:off x="9828000" y="5718675"/>
              <a:ext cx="1973578" cy="54000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2068795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522</TotalTime>
  <Words>66</Words>
  <Application>Microsoft Office PowerPoint</Application>
  <PresentationFormat>宽屏</PresentationFormat>
  <Paragraphs>38</Paragraphs>
  <Slides>4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9" baseType="lpstr">
      <vt:lpstr>等线</vt:lpstr>
      <vt:lpstr>等线 Light</vt:lpstr>
      <vt:lpstr>Arial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i li</dc:creator>
  <cp:lastModifiedBy>lilyl</cp:lastModifiedBy>
  <cp:revision>70</cp:revision>
  <dcterms:created xsi:type="dcterms:W3CDTF">2018-05-07T11:22:47Z</dcterms:created>
  <dcterms:modified xsi:type="dcterms:W3CDTF">2019-03-29T10:33:34Z</dcterms:modified>
</cp:coreProperties>
</file>